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openxmlformats.org/officeDocument/2006/relationships/custom-properties" Target="docProps/custom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9"/>
  </p:notesMasterIdLst>
  <p:sldIdLst>
    <p:sldId id="270" r:id="rId5"/>
    <p:sldId id="271" r:id="rId6"/>
    <p:sldId id="272" r:id="rId7"/>
    <p:sldId id="273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10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19"/>
    <p:restoredTop sz="94565"/>
  </p:normalViewPr>
  <p:slideViewPr>
    <p:cSldViewPr snapToGrid="0">
      <p:cViewPr>
        <p:scale>
          <a:sx n="139" d="100"/>
          <a:sy n="139" d="100"/>
        </p:scale>
        <p:origin x="198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842173-572C-844C-ACB5-170B4C2DF8A6}" type="datetimeFigureOut">
              <a:rPr lang="en-US" smtClean="0"/>
              <a:t>10/29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6FBBF6-FC53-F64B-9223-2455692EF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4907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6FBBF6-FC53-F64B-9223-2455692EF2B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1691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1EC6-5B4F-4A9B-BAC8-834720628AD2}" type="datetimeFigureOut">
              <a:rPr lang="en-US" smtClean="0"/>
              <a:t>10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D8F0C-AFDF-46E3-B1BC-B975F91C5B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268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1EC6-5B4F-4A9B-BAC8-834720628AD2}" type="datetimeFigureOut">
              <a:rPr lang="en-US" smtClean="0"/>
              <a:t>10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D8F0C-AFDF-46E3-B1BC-B975F91C5B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274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1EC6-5B4F-4A9B-BAC8-834720628AD2}" type="datetimeFigureOut">
              <a:rPr lang="en-US" smtClean="0"/>
              <a:t>10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D8F0C-AFDF-46E3-B1BC-B975F91C5B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821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1EC6-5B4F-4A9B-BAC8-834720628AD2}" type="datetimeFigureOut">
              <a:rPr lang="en-US" smtClean="0"/>
              <a:t>10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D8F0C-AFDF-46E3-B1BC-B975F91C5B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679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1EC6-5B4F-4A9B-BAC8-834720628AD2}" type="datetimeFigureOut">
              <a:rPr lang="en-US" smtClean="0"/>
              <a:t>10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D8F0C-AFDF-46E3-B1BC-B975F91C5B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686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1EC6-5B4F-4A9B-BAC8-834720628AD2}" type="datetimeFigureOut">
              <a:rPr lang="en-US" smtClean="0"/>
              <a:t>10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D8F0C-AFDF-46E3-B1BC-B975F91C5B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61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1EC6-5B4F-4A9B-BAC8-834720628AD2}" type="datetimeFigureOut">
              <a:rPr lang="en-US" smtClean="0"/>
              <a:t>10/29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D8F0C-AFDF-46E3-B1BC-B975F91C5B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1025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1EC6-5B4F-4A9B-BAC8-834720628AD2}" type="datetimeFigureOut">
              <a:rPr lang="en-US" smtClean="0"/>
              <a:t>10/29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D8F0C-AFDF-46E3-B1BC-B975F91C5B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889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1EC6-5B4F-4A9B-BAC8-834720628AD2}" type="datetimeFigureOut">
              <a:rPr lang="en-US" smtClean="0"/>
              <a:t>10/29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D8F0C-AFDF-46E3-B1BC-B975F91C5B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477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1EC6-5B4F-4A9B-BAC8-834720628AD2}" type="datetimeFigureOut">
              <a:rPr lang="en-US" smtClean="0"/>
              <a:t>10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D8F0C-AFDF-46E3-B1BC-B975F91C5B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039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1EC6-5B4F-4A9B-BAC8-834720628AD2}" type="datetimeFigureOut">
              <a:rPr lang="en-US" smtClean="0"/>
              <a:t>10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D8F0C-AFDF-46E3-B1BC-B975F91C5B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451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A1EC6-5B4F-4A9B-BAC8-834720628AD2}" type="datetimeFigureOut">
              <a:rPr lang="en-US" smtClean="0"/>
              <a:t>10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9D8F0C-AFDF-46E3-B1BC-B975F91C5B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427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8F7594-59F8-1F37-C57A-5261DC64F4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7591" y="3624245"/>
            <a:ext cx="6262818" cy="796927"/>
          </a:xfrm>
        </p:spPr>
        <p:txBody>
          <a:bodyPr>
            <a:norm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. Fig 1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hylogenetic tree of phytoplasma samples ordered from International Phytoplasma Working Group (IPWG; Bologna, Italy). Alignment is based on 16S gene sequence pulled from NCBI-BLAST, with no outgroup. </a:t>
            </a:r>
          </a:p>
        </p:txBody>
      </p:sp>
      <p:pic>
        <p:nvPicPr>
          <p:cNvPr id="5" name="Content Placeholder 4" descr="A close-up of a text&#10;&#10;Description automatically generated">
            <a:extLst>
              <a:ext uri="{FF2B5EF4-FFF2-40B4-BE49-F238E27FC236}">
                <a16:creationId xmlns:a16="http://schemas.microsoft.com/office/drawing/2014/main" id="{67001F0C-277A-A670-CE72-6A87156D073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81"/>
          <a:stretch/>
        </p:blipFill>
        <p:spPr>
          <a:xfrm>
            <a:off x="297591" y="761682"/>
            <a:ext cx="6262818" cy="2577567"/>
          </a:xfrm>
        </p:spPr>
      </p:pic>
    </p:spTree>
    <p:extLst>
      <p:ext uri="{BB962C8B-B14F-4D97-AF65-F5344CB8AC3E}">
        <p14:creationId xmlns:p14="http://schemas.microsoft.com/office/powerpoint/2010/main" val="4159994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BBD0E44F-3DDD-A2B3-994B-A7B076B7571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rcRect r="26581"/>
          <a:stretch/>
        </p:blipFill>
        <p:spPr>
          <a:xfrm>
            <a:off x="1254053" y="2467894"/>
            <a:ext cx="4022040" cy="268249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8FAE4A9-4C5B-D99D-0B81-A9E05CED913E}"/>
              </a:ext>
            </a:extLst>
          </p:cNvPr>
          <p:cNvSpPr txBox="1"/>
          <p:nvPr/>
        </p:nvSpPr>
        <p:spPr>
          <a:xfrm>
            <a:off x="525969" y="5332858"/>
            <a:ext cx="5478209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. Fig 2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 cleavage assay for Cas12a  orthologs and variants at Cas12a-Site 1. RNPs (5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Cas12a protein; 62.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crRNA) were incubated for 2 hours at 37° C with 1xNEB CutSmart buffer and 10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phytoplasma 16S amplicons. While Mb2Cas12a and Mb2Cas12a-RVRR did cleave target DNA just like the other Cas12a nucleases, in our fluorescence-based detection tests these variants did not appear to perform nearly as well as all the other variants at similar concentrations and was hence excluded from further testing.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01CDF4D-E631-8BCA-312F-79399DFB6FC5}"/>
              </a:ext>
            </a:extLst>
          </p:cNvPr>
          <p:cNvSpPr txBox="1"/>
          <p:nvPr/>
        </p:nvSpPr>
        <p:spPr>
          <a:xfrm rot="18056052">
            <a:off x="1990805" y="1963431"/>
            <a:ext cx="9637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bCas12a-V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9AEB269-53AD-991E-A623-8A9BCE6D6C71}"/>
              </a:ext>
            </a:extLst>
          </p:cNvPr>
          <p:cNvSpPr txBox="1"/>
          <p:nvPr/>
        </p:nvSpPr>
        <p:spPr>
          <a:xfrm rot="18056052">
            <a:off x="2320412" y="1913929"/>
            <a:ext cx="1079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bCas12a-Ultr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C32C1AD-E61F-3595-8C0D-539B305242BA}"/>
              </a:ext>
            </a:extLst>
          </p:cNvPr>
          <p:cNvSpPr txBox="1"/>
          <p:nvPr/>
        </p:nvSpPr>
        <p:spPr>
          <a:xfrm rot="18056052">
            <a:off x="2589765" y="1849305"/>
            <a:ext cx="1229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rCas12a (MAD7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F633C20-1685-18BA-D04F-2407E5A22D18}"/>
              </a:ext>
            </a:extLst>
          </p:cNvPr>
          <p:cNvSpPr txBox="1"/>
          <p:nvPr/>
        </p:nvSpPr>
        <p:spPr>
          <a:xfrm rot="18056052">
            <a:off x="2783766" y="1528245"/>
            <a:ext cx="19784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bCas12a-D156R (ttLbCas12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7D228B4-9096-1E05-657F-DBB6F53B5DA5}"/>
              </a:ext>
            </a:extLst>
          </p:cNvPr>
          <p:cNvSpPr txBox="1"/>
          <p:nvPr/>
        </p:nvSpPr>
        <p:spPr>
          <a:xfrm rot="18056052">
            <a:off x="3345699" y="1915803"/>
            <a:ext cx="10855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bCas12a-RVQ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6B6DBBC-63C7-F4E7-DCC5-645E6010537A}"/>
              </a:ext>
            </a:extLst>
          </p:cNvPr>
          <p:cNvSpPr txBox="1"/>
          <p:nvPr/>
        </p:nvSpPr>
        <p:spPr>
          <a:xfrm rot="18056052">
            <a:off x="3684035" y="1874744"/>
            <a:ext cx="11705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bCas12a-RVQV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7DBDE73-7ED9-8E04-9868-D98C9F2652A7}"/>
              </a:ext>
            </a:extLst>
          </p:cNvPr>
          <p:cNvSpPr txBox="1"/>
          <p:nvPr/>
        </p:nvSpPr>
        <p:spPr>
          <a:xfrm rot="18056052">
            <a:off x="3987512" y="1844683"/>
            <a:ext cx="12554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bCas12a-RVQVK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5630F4C-4873-403B-58B1-5245F392021B}"/>
              </a:ext>
            </a:extLst>
          </p:cNvPr>
          <p:cNvSpPr txBox="1"/>
          <p:nvPr/>
        </p:nvSpPr>
        <p:spPr>
          <a:xfrm rot="18056052">
            <a:off x="4451106" y="2002002"/>
            <a:ext cx="8723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b2Cas12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43718D0-A6E3-E05A-A6CE-28224CF25A1A}"/>
              </a:ext>
            </a:extLst>
          </p:cNvPr>
          <p:cNvSpPr txBox="1"/>
          <p:nvPr/>
        </p:nvSpPr>
        <p:spPr>
          <a:xfrm rot="18056052">
            <a:off x="4674879" y="1852078"/>
            <a:ext cx="12795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b2Cas12a-RVRR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ECE2F7FD-25C4-2CB5-DC01-CA69F6D6AEE3}"/>
              </a:ext>
            </a:extLst>
          </p:cNvPr>
          <p:cNvCxnSpPr/>
          <p:nvPr/>
        </p:nvCxnSpPr>
        <p:spPr>
          <a:xfrm flipH="1">
            <a:off x="5314637" y="3619893"/>
            <a:ext cx="26270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FEE1C164-A14C-92E9-8FD9-44D5023F270E}"/>
              </a:ext>
            </a:extLst>
          </p:cNvPr>
          <p:cNvCxnSpPr/>
          <p:nvPr/>
        </p:nvCxnSpPr>
        <p:spPr>
          <a:xfrm flipH="1">
            <a:off x="5314637" y="3725159"/>
            <a:ext cx="26270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C87C9483-37BB-EADF-748D-2BE87FE00490}"/>
              </a:ext>
            </a:extLst>
          </p:cNvPr>
          <p:cNvSpPr txBox="1"/>
          <p:nvPr/>
        </p:nvSpPr>
        <p:spPr>
          <a:xfrm>
            <a:off x="5577344" y="3547531"/>
            <a:ext cx="8274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ut bands</a:t>
            </a:r>
          </a:p>
        </p:txBody>
      </p:sp>
    </p:spTree>
    <p:extLst>
      <p:ext uri="{BB962C8B-B14F-4D97-AF65-F5344CB8AC3E}">
        <p14:creationId xmlns:p14="http://schemas.microsoft.com/office/powerpoint/2010/main" val="3066653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Graphical user interface, chart&#10;&#10;Description automatically generated">
            <a:extLst>
              <a:ext uri="{FF2B5EF4-FFF2-40B4-BE49-F238E27FC236}">
                <a16:creationId xmlns:a16="http://schemas.microsoft.com/office/drawing/2014/main" id="{8F1F7035-D64D-9585-7E76-161ED03A5B9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rcRect l="2687" r="7900"/>
          <a:stretch/>
        </p:blipFill>
        <p:spPr>
          <a:xfrm>
            <a:off x="904972" y="267379"/>
            <a:ext cx="4769963" cy="3210373"/>
          </a:xfrm>
          <a:prstGeom prst="rect">
            <a:avLst/>
          </a:prstGeom>
        </p:spPr>
      </p:pic>
      <p:pic>
        <p:nvPicPr>
          <p:cNvPr id="5" name="Picture 4" descr="Table&#10;&#10;Description automatically generated">
            <a:extLst>
              <a:ext uri="{FF2B5EF4-FFF2-40B4-BE49-F238E27FC236}">
                <a16:creationId xmlns:a16="http://schemas.microsoft.com/office/drawing/2014/main" id="{CCED2072-FBAD-A9F3-8B71-52B3DDE46EDE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6137"/>
          <a:stretch/>
        </p:blipFill>
        <p:spPr>
          <a:xfrm>
            <a:off x="806057" y="3590872"/>
            <a:ext cx="4967792" cy="135819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45B95D0-A3D3-161A-072B-085D5EE36873}"/>
              </a:ext>
            </a:extLst>
          </p:cNvPr>
          <p:cNvSpPr txBox="1"/>
          <p:nvPr/>
        </p:nvSpPr>
        <p:spPr>
          <a:xfrm>
            <a:off x="146304" y="5266944"/>
            <a:ext cx="645261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. Fig. 3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qPCR data to confirm phytoplasma presence from our ordered sampled from IPWG. qPCR was performed for identification of phytoplasma 23S gene. Ct values of 13&lt;Ct&lt;38.00 are considered positive identification. Protocol from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odget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et al. 2009. </a:t>
            </a:r>
          </a:p>
        </p:txBody>
      </p:sp>
    </p:spTree>
    <p:extLst>
      <p:ext uri="{BB962C8B-B14F-4D97-AF65-F5344CB8AC3E}">
        <p14:creationId xmlns:p14="http://schemas.microsoft.com/office/powerpoint/2010/main" val="12148407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F983F0-2448-1365-36BF-5BB8BF6766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 dirty="0"/>
          </a:p>
        </p:txBody>
      </p:sp>
      <p:grpSp>
        <p:nvGrpSpPr>
          <p:cNvPr id="12" name="Group 11" descr="sacscsadcadscd&#10;">
            <a:extLst>
              <a:ext uri="{FF2B5EF4-FFF2-40B4-BE49-F238E27FC236}">
                <a16:creationId xmlns:a16="http://schemas.microsoft.com/office/drawing/2014/main" id="{DE466BE6-B0ED-111B-D7A5-7342D4C8047F}"/>
              </a:ext>
            </a:extLst>
          </p:cNvPr>
          <p:cNvGrpSpPr/>
          <p:nvPr/>
        </p:nvGrpSpPr>
        <p:grpSpPr>
          <a:xfrm>
            <a:off x="76994" y="476642"/>
            <a:ext cx="6579982" cy="2245234"/>
            <a:chOff x="76994" y="476642"/>
            <a:chExt cx="6579982" cy="224523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E607779-5965-BB56-53FF-8BB4A749381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6994" y="476642"/>
              <a:ext cx="6579982" cy="1122617"/>
            </a:xfrm>
            <a:prstGeom prst="rect">
              <a:avLst/>
            </a:prstGeom>
          </p:spPr>
        </p:pic>
        <p:pic>
          <p:nvPicPr>
            <p:cNvPr id="7" name="Picture 6" descr="dcdcd">
              <a:extLst>
                <a:ext uri="{FF2B5EF4-FFF2-40B4-BE49-F238E27FC236}">
                  <a16:creationId xmlns:a16="http://schemas.microsoft.com/office/drawing/2014/main" id="{3C7E71E5-5B4A-9E79-2CBC-84F392D5193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43"/>
            <a:stretch/>
          </p:blipFill>
          <p:spPr>
            <a:xfrm>
              <a:off x="76994" y="1599259"/>
              <a:ext cx="6568747" cy="1122617"/>
            </a:xfrm>
            <a:prstGeom prst="rect">
              <a:avLst/>
            </a:prstGeom>
          </p:spPr>
        </p:pic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759E6FE5-B1D4-561C-04ED-F401EFDEC1F9}"/>
              </a:ext>
            </a:extLst>
          </p:cNvPr>
          <p:cNvSpPr txBox="1"/>
          <p:nvPr/>
        </p:nvSpPr>
        <p:spPr>
          <a:xfrm>
            <a:off x="135059" y="2776705"/>
            <a:ext cx="645261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. Fig. 4. Protein Alignment of 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LbCas12a Variant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otein alignment to demonstrate the differences on the amino chain for each of our LbCas12a variants. LbCas12a-WT is used as the consensus sequence. ErCas12a (MAD7) is not pictured since this ortholog is very different in sequence to standard LbCas12a-WT </a:t>
            </a:r>
          </a:p>
        </p:txBody>
      </p:sp>
    </p:spTree>
    <p:extLst>
      <p:ext uri="{BB962C8B-B14F-4D97-AF65-F5344CB8AC3E}">
        <p14:creationId xmlns:p14="http://schemas.microsoft.com/office/powerpoint/2010/main" val="5492521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CBD85F14-19F7-40E8-A016-E9397AEBFD57}">
  <we:reference id="wa200006038" version="1.0.0.2" store="en-US" storeType="OMEX"/>
  <we:alternateReferences>
    <we:reference id="wa200006038" version="1.0.0.2" store="" storeType="OMEX"/>
  </we:alternateReferences>
  <we:properties>
    <we:property name="653ff98195bceb0adf7c4a2b_1700004632562" value="{&quot;id&quot;:&quot;29624460-9e29-43ed-9fa1-df39a86059b0&quot;,&quot;objects&quot;:{&quot;29624460-9e29-43ed-9fa1-df39a86059b0&quot;:{&quot;id&quot;:&quot;29624460-9e29-43ed-9fa1-df39a86059b0&quot;,&quot;type&quot;:&quot;FIGURE_OBJECT&quot;,&quot;document&quot;:{&quot;type&quot;:&quot;DOCUMENT_GROUP&quot;,&quot;canvasType&quot;:&quot;FIGURE&quot;,&quot;units&quot;:&quot;in&quot;}},&quot;ac6bbc99-dab5-4198-8172-3bf6cecd2fed&quot;:{&quot;id&quot;:&quot;ac6bbc99-dab5-4198-8172-3bf6cecd2fe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29624460-9e29-43ed-9fa1-df39a86059b0&quot;,&quot;type&quot;:&quot;FRAME&quot;,&quot;order&quot;:&quot;5&quot;}},&quot;8b5f97cd-db4d-4dae-bbb0-2a539bcf7a97&quot;:{&quot;id&quot;:&quot;8b5f97cd-db4d-4dae-bbb0-2a539bcf7a97&quot;,&quot;type&quot;:&quot;FIGURE_OBJECT&quot;,&quot;document&quot;:{&quot;type&quot;:&quot;FIGURE&quot;,&quot;canvasType&quot;:&quot;FIGURE&quot;,&quot;units&quot;:&quot;in&quot;},&quot;parent&quot;:{&quot;parentId&quot;:&quot;29624460-9e29-43ed-9fa1-df39a86059b0&quot;,&quot;type&quot;:&quot;DOCUMENT&quot;,&quot;order&quot;:&quot;5&quot;}},&quot;0ca9b0a6-6b17-45be-8b3e-d3d79b4820f5&quot;:{&quot;id&quot;:&quot;0ca9b0a6-6b17-45be-8b3e-d3d79b4820f5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8b5f97cd-db4d-4dae-bbb0-2a539bcf7a97&quot;,&quot;order&quot;:&quot;5&quot;}},&quot;17cbdaff-6280-4f44-b0b6-13176af82a1b&quot;:{&quot;id&quot;:&quot;17cbdaff-6280-4f44-b0b6-13176af82a1b&quot;,&quot;type&quot;:&quot;FIGURE_OBJECT&quot;,&quot;guide&quot;:{&quot;type&quot;:&quot;GRID&quot;,&quot;distance&quot;:0.5,&quot;units&quot;:&quot;in&quot;},&quot;parent&quot;:{&quot;parentId&quot;:&quot;29624460-9e29-43ed-9fa1-df39a86059b0&quot;,&quot;type&quot;:&quot;GUIDE&quot;,&quot;order&quot;:&quot;5&quot;}},&quot;ceb8ad80-6cf4-487e-abe0-015904b52ca8&quot;:{&quot;id&quot;:&quot;ceb8ad80-6cf4-487e-abe0-015904b52ca8&quot;,&quot;type&quot;:&quot;FIGURE_OBJECT&quot;,&quot;parent&quot;:{&quot;type&quot;:&quot;CHILD&quot;,&quot;parentId&quot;:&quot;8b5f97cd-db4d-4dae-bbb0-2a539bcf7a97&quot;,&quot;order&quot;:&quot;5&quot;},&quot;source&quot;:{&quot;id&quot;:&quot;6079e4ef7103ca00a005857a&quot;,&quot;type&quot;:&quot;TEMPLATES&quot;},&quot;relativeTransform&quot;:{&quot;translate&quot;:{&quot;x&quot;:100.52691098659348,&quot;y&quot;:-33.339517183685786},&quot;rotate&quot;:0,&quot;skewX&quot;:0,&quot;scale&quot;:{&quot;x&quot;:1,&quot;y&quot;:1}}},&quot;a6f2de6f-e57d-42f2-9b60-d1ee56c88625&quot;:{&quot;id&quot;:&quot;a6f2de6f-e57d-42f2-9b60-d1ee56c88625&quot;,&quot;type&quot;:&quot;FIGURE_OBJECT&quot;,&quot;relativeTransform&quot;:{&quot;translate&quot;:{&quot;x&quot;:-80.74375047211056,&quot;y&quot;:-218.7533422239925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6,&quot;color&quot;:&quot;black&quot;,&quot;fontWeight&quot;:&quot;normal&quot;,&quot;fontStyle&quot;:&quot;normal&quot;,&quot;decoration&quot;:&quot;none&quot;,&quot;script&quot;:&quot;none&quot;},&quot;range&quot;:[0,57]}],&quot;text&quot;:&quot;Infected insect vector feeds on phloem of a healthy plant.&quot;}],&quot;verticalAlign&quot;:&quot;TOP&quot;,&quot;_lastCaretLocation&quot;:{&quot;lineIndex&quot;:0,&quot;runIndex&quot;:-1,&quot;charIndex&quot;:-1,&quot;endOfLine&quot;:true}},&quot;format&quot;:&quot;BETTER_TEXT&quot;,&quot;size&quot;:{&quot;x&quot;:145.51802158997904,&quot;y&quot;:73.24},&quot;targetSize&quot;:{&quot;x&quot;:127.32826889123166,&quot;y&quot;:28.389375},&quot;verticalAlign&quot;:&quot;TOP&quot;},&quot;parent&quot;:{&quot;type&quot;:&quot;CHILD&quot;,&quot;parentId&quot;:&quot;ceb8ad80-6cf4-487e-abe0-015904b52ca8&quot;,&quot;order&quot;:&quot;9999999999998&quot;}},&quot;4a02a5a9-91d8-409c-b22e-a77c90b2d8b3&quot;:{&quot;type&quot;:&quot;FIGURE_OBJECT&quot;,&quot;id&quot;:&quot;4a02a5a9-91d8-409c-b22e-a77c90b2d8b3&quot;,&quot;relativeTransform&quot;:{&quot;translate&quot;:{&quot;x&quot;:-173.62721400827706,&quot;y&quot;:-239.15028918817262},&quot;rotate&quot;:0,&quot;skewX&quot;:0,&quot;scale&quot;:{&quot;x&quot;:1,&quot;y&quot;:1}},&quot;layout&quot;:{&quot;sizeRatio&quot;:{&quot;x&quot;:0.88,&quot;y&quot;:0.88},&quot;keepAspectRatio&quot;:true},&quot;opacity&quot;:1,&quot;path&quot;:{&quot;type&quot;:&quot;ELLIPSE&quot;,&quot;size&quot;:{&quot;x&quot;:21.33078012502493,&quot;y&quot;:21.330780125024905}},&quot;pathStyles&quot;:[{&quot;type&quot;:&quot;FILL&quot;,&quot;fillStyle&quot;:&quot;rgba(255,255,255,1)&quot;},{&quot;type&quot;:&quot;STROKE&quot;,&quot;strokeStyle&quot;:&quot;rgba(0,0,0,1)&quot;,&quot;lineWidth&quot;:1.422052008334994,&quot;lineJoin&quot;:&quot;round&quot;}],&quot;isLocked&quot;:false,&quot;parent&quot;:{&quot;type&quot;:&quot;CHILD&quot;,&quot;parentId&quot;:&quot;ceb8ad80-6cf4-487e-abe0-015904b52ca8&quot;,&quot;order&quot;:&quot;9999999999999&quot;}},&quot;a03849bf-245b-4e01-b21f-2e2a73945a29&quot;:{&quot;type&quot;:&quot;FIGURE_OBJECT&quot;,&quot;id&quot;:&quot;a03849bf-245b-4e01-b21f-2e2a73945a29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4,&quot;color&quot;:&quot;black&quot;,&quot;fontWeight&quot;:&quot;normal&quot;,&quot;fontStyle&quot;:&quot;normal&quot;,&quot;decoration&quot;:&quot;none&quot;,&quot;script&quot;:&quot;none&quot;},&quot;range&quot;:[0,0]}],&quot;text&quot;:&quot;1&quot;,&quot;baseStyle&quot;:{&quot;fontFamily&quot;:&quot;Roboto&quot;,&quot;fontSize&quot;:14,&quot;color&quot;:&quot;black&quot;,&quot;fontWeight&quot;:&quot;normal&quot;,&quot;fontStyle&quot;:&quot;normal&quot;,&quot;decoration&quot;:&quot;none&quot;,&quot;script&quot;:&quot;none&quot;}}],&quot;verticalAlign&quot;:&quot;TOP&quot;},&quot;size&quot;:{&quot;x&quot;:18.145383626354516,&quot;y&quot;:16.625},&quot;targetSize&quot;:{&quot;x&quot;:15.877210673060201,&quot;y&quot;:2},&quot;format&quot;:&quot;BETTER_TEXT&quot;,&quot;verticalAlign&quot;:&quot;TOP&quot;},&quot;parent&quot;:{&quot;type&quot;:&quot;CHILD&quot;,&quot;parentId&quot;:&quot;4a02a5a9-91d8-409c-b22e-a77c90b2d8b3&quot;,&quot;order&quot;:&quot;5&quot;}},&quot;eb152d76-7813-4339-a24f-779d0bc23fd8&quot;:{&quot;id&quot;:&quot;eb152d76-7813-4339-a24f-779d0bc23fd8&quot;,&quot;type&quot;:&quot;FIGURE_OBJECT&quot;,&quot;relativeTransform&quot;:{&quot;translate&quot;:{&quot;x&quot;:239.61617076791262,&quot;y&quot;:15.818684561407967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6,&quot;color&quot;:&quot;black&quot;,&quot;fontWeight&quot;:&quot;normal&quot;,&quot;fontStyle&quot;:&quot;normal&quot;,&quot;decoration&quot;:&quot;none&quot;,&quot;script&quot;:&quot;none&quot;},&quot;range&quot;:[0,52]}],&quot;text&quot;:&quot;Phytoplasma harbor in phloem feeding on particulates.&quot;}],&quot;verticalAlign&quot;:&quot;TOP&quot;,&quot;_lastCaretLocation&quot;:{&quot;lineIndex&quot;:0,&quot;runIndex&quot;:-1,&quot;charIndex&quot;:-1,&quot;endOfLine&quot;:true}},&quot;format&quot;:&quot;BETTER_TEXT&quot;,&quot;size&quot;:{&quot;x&quot;:142.82889805713342,&quot;y&quot;:73.24},&quot;targetSize&quot;:{&quot;x&quot;:124.97528579999174,&quot;y&quot;:28.389375},&quot;verticalAlign&quot;:&quot;TOP&quot;},&quot;parent&quot;:{&quot;type&quot;:&quot;CHILD&quot;,&quot;parentId&quot;:&quot;ceb8ad80-6cf4-487e-abe0-015904b52ca8&quot;,&quot;order&quot;:&quot;99999999999992&quot;}},&quot;bed3f163-09e7-43ac-9dba-0807b6801132&quot;:{&quot;type&quot;:&quot;FIGURE_OBJECT&quot;,&quot;id&quot;:&quot;bed3f163-09e7-43ac-9dba-0807b6801132&quot;,&quot;relativeTransform&quot;:{&quot;translate&quot;:{&quot;x&quot;:149.8417695539219,&quot;y&quot;:-7.05984835652167},&quot;rotate&quot;:0},&quot;layout&quot;:{&quot;sizeRatio&quot;:{&quot;x&quot;:0.88,&quot;y&quot;:0.88},&quot;keepAspectRatio&quot;:true},&quot;opacity&quot;:1,&quot;path&quot;:{&quot;type&quot;:&quot;ELLIPSE&quot;,&quot;size&quot;:{&quot;x&quot;:21.33078012502493,&quot;y&quot;:21.330780125024905}},&quot;pathStyles&quot;:[{&quot;type&quot;:&quot;FILL&quot;,&quot;fillStyle&quot;:&quot;rgba(255,255,255,1)&quot;},{&quot;type&quot;:&quot;STROKE&quot;,&quot;strokeStyle&quot;:&quot;rgba(0,0,0,1)&quot;,&quot;lineWidth&quot;:1.422052008334994,&quot;lineJoin&quot;:&quot;round&quot;}],&quot;isLocked&quot;:false,&quot;parent&quot;:{&quot;type&quot;:&quot;CHILD&quot;,&quot;parentId&quot;:&quot;ceb8ad80-6cf4-487e-abe0-015904b52ca8&quot;,&quot;order&quot;:&quot;99999999999995&quot;}},&quot;3f0a02be-85c4-49ed-9120-5fb849a3e340&quot;:{&quot;type&quot;:&quot;FIGURE_OBJECT&quot;,&quot;id&quot;:&quot;3f0a02be-85c4-49ed-9120-5fb849a3e340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4,&quot;color&quot;:&quot;black&quot;,&quot;fontWeight&quot;:&quot;normal&quot;,&quot;fontStyle&quot;:&quot;normal&quot;,&quot;decoration&quot;:&quot;none&quot;,&quot;script&quot;:&quot;none&quot;},&quot;range&quot;:[0,0]}],&quot;text&quot;:&quot;2&quot;,&quot;baseStyle&quot;:{&quot;fontFamily&quot;:&quot;Roboto&quot;,&quot;fontSize&quot;:14,&quot;color&quot;:&quot;black&quot;,&quot;fontWeight&quot;:&quot;normal&quot;,&quot;fontStyle&quot;:&quot;normal&quot;,&quot;decoration&quot;:&quot;none&quot;,&quot;script&quot;:&quot;none&quot;}}],&quot;verticalAlign&quot;:&quot;TOP&quot;},&quot;size&quot;:{&quot;x&quot;:18.145383626354516,&quot;y&quot;:16.625},&quot;targetSize&quot;:{&quot;x&quot;:15.877210673060201,&quot;y&quot;:2},&quot;format&quot;:&quot;BETTER_TEXT&quot;,&quot;verticalAlign&quot;:&quot;TOP&quot;},&quot;parent&quot;:{&quot;type&quot;:&quot;CHILD&quot;,&quot;parentId&quot;:&quot;bed3f163-09e7-43ac-9dba-0807b6801132&quot;,&quot;order&quot;:&quot;5&quot;}},&quot;ee068cd3-2e94-4e38-b506-b0e1a2be1989&quot;:{&quot;id&quot;:&quot;ee068cd3-2e94-4e38-b506-b0e1a2be1989&quot;,&quot;type&quot;:&quot;FIGURE_OBJECT&quot;,&quot;relativeTransform&quot;:{&quot;translate&quot;:{&quot;x&quot;:221.5494780066664,&quot;y&quot;:198.16798094772435},&quot;rotate&quot;:0},&quot;text&quot;:{&quot;textData&quot;:{&quot;lineSpacing&quot;:&quot;normal&quot;,&quot;alignment&quot;:&quot;left&quot;,&quot;lines&quot;:[{&quot;runs&quot;:[{&quot;style&quot;:{&quot;fontFamily&quot;:&quot;Roboto&quot;,&quot;fontSize&quot;:16,&quot;color&quot;:&quot;black&quot;,&quot;fontWeight&quot;:&quot;normal&quot;,&quot;fontStyle&quot;:&quot;normal&quot;,&quot;decoration&quot;:&quot;none&quot;,&quot;script&quot;:&quot;none&quot;},&quot;range&quot;:[0,76]}],&quot;text&quot;:&quot;Phytoplasma multiplies in plant host. Host compartmentalizes to halt spread. &quot;}],&quot;verticalAlign&quot;:&quot;TOP&quot;,&quot;_lastCaretLocation&quot;:{&quot;lineIndex&quot;:0,&quot;runIndex&quot;:0,&quot;charIndex&quot;:60}},&quot;format&quot;:&quot;BETTER_TEXT&quot;,&quot;size&quot;:{&quot;x&quot;:178.9627435641863,&quot;y&quot;:91.32},&quot;targetSize&quot;:{&quot;x&quot;:178.9627435641863,&quot;y&quot;:91.32},&quot;verticalAlign&quot;:&quot;TOP&quot;},&quot;parent&quot;:{&quot;type&quot;:&quot;CHILD&quot;,&quot;parentId&quot;:&quot;ceb8ad80-6cf4-487e-abe0-015904b52ca8&quot;,&quot;order&quot;:&quot;99999999999996&quot;}},&quot;76c6732b-1f18-454b-aae7-39dbdbaee038&quot;:{&quot;type&quot;:&quot;FIGURE_OBJECT&quot;,&quot;id&quot;:&quot;76c6732b-1f18-454b-aae7-39dbdbaee038&quot;,&quot;relativeTransform&quot;:{&quot;translate&quot;:{&quot;x&quot;:114.49546425704578,&quot;y&quot;:163.57587101023674},&quot;rotate&quot;:0},&quot;layout&quot;:{&quot;sizeRatio&quot;:{&quot;x&quot;:0.88,&quot;y&quot;:0.88},&quot;keepAspectRatio&quot;:true},&quot;opacity&quot;:1,&quot;path&quot;:{&quot;type&quot;:&quot;ELLIPSE&quot;,&quot;size&quot;:{&quot;x&quot;:21.33078012502493,&quot;y&quot;:21.330780125024905}},&quot;pathStyles&quot;:[{&quot;type&quot;:&quot;FILL&quot;,&quot;fillStyle&quot;:&quot;rgba(255,255,255,1)&quot;},{&quot;type&quot;:&quot;STROKE&quot;,&quot;strokeStyle&quot;:&quot;rgba(0,0,0,1)&quot;,&quot;lineWidth&quot;:1.422052008334994,&quot;lineJoin&quot;:&quot;round&quot;}],&quot;isLocked&quot;:false,&quot;parent&quot;:{&quot;type&quot;:&quot;CHILD&quot;,&quot;parentId&quot;:&quot;ceb8ad80-6cf4-487e-abe0-015904b52ca8&quot;,&quot;order&quot;:&quot;99999999999997&quot;}},&quot;76e3a281-f4fa-418b-9ef4-a6999b2bd343&quot;:{&quot;type&quot;:&quot;FIGURE_OBJECT&quot;,&quot;id&quot;:&quot;76e3a281-f4fa-418b-9ef4-a6999b2bd343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4,&quot;color&quot;:&quot;black&quot;,&quot;fontWeight&quot;:&quot;normal&quot;,&quot;fontStyle&quot;:&quot;normal&quot;,&quot;decoration&quot;:&quot;none&quot;,&quot;script&quot;:&quot;none&quot;},&quot;range&quot;:[0,0]}],&quot;text&quot;:&quot;3&quot;,&quot;baseStyle&quot;:{&quot;fontFamily&quot;:&quot;Roboto&quot;,&quot;fontSize&quot;:14,&quot;color&quot;:&quot;black&quot;,&quot;fontWeight&quot;:&quot;normal&quot;,&quot;fontStyle&quot;:&quot;normal&quot;,&quot;decoration&quot;:&quot;none&quot;,&quot;script&quot;:&quot;none&quot;}}],&quot;verticalAlign&quot;:&quot;TOP&quot;},&quot;size&quot;:{&quot;x&quot;:18.145383626354516,&quot;y&quot;:16.625},&quot;targetSize&quot;:{&quot;x&quot;:15.877210673060201,&quot;y&quot;:2},&quot;format&quot;:&quot;BETTER_TEXT&quot;,&quot;verticalAlign&quot;:&quot;TOP&quot;},&quot;parent&quot;:{&quot;type&quot;:&quot;CHILD&quot;,&quot;parentId&quot;:&quot;76c6732b-1f18-454b-aae7-39dbdbaee038&quot;,&quot;order&quot;:&quot;5&quot;}},&quot;8b6bf4e0-923f-49c9-b7f7-408600d48ed0&quot;:{&quot;id&quot;:&quot;8b6bf4e0-923f-49c9-b7f7-408600d48ed0&quot;,&quot;type&quot;:&quot;FIGURE_OBJECT&quot;,&quot;relativeTransform&quot;:{&quot;translate&quot;:{&quot;x&quot;:-378.24023588209957,&quot;y&quot;:209.10814728950174},&quot;rotate&quot;:0},&quot;text&quot;:{&quot;textData&quot;:{&quot;lineSpacing&quot;:&quot;normal&quot;,&quot;alignment&quot;:&quot;left&quot;,&quot;lines&quot;:[{&quot;runs&quot;:[{&quot;style&quot;:{&quot;fontFamily&quot;:&quot;Roboto&quot;,&quot;fontSize&quot;:16,&quot;color&quot;:&quot;black&quot;,&quot;fontWeight&quot;:&quot;normal&quot;,&quot;fontStyle&quot;:&quot;normal&quot;,&quot;decoration&quot;:&quot;none&quot;,&quot;script&quot;:&quot;none&quot;},&quot;range&quot;:[0,79]}],&quot;text&quot;:&quot;A healthy-presenting plant could be heavily infested before stress signs appear.&quot;}],&quot;verticalAlign&quot;:&quot;TOP&quot;,&quot;_lastCaretLocation&quot;:{&quot;lineIndex&quot;:0,&quot;runIndex&quot;:-1,&quot;charIndex&quot;:-1,&quot;endOfLine&quot;:true}},&quot;format&quot;:&quot;BETTER_TEXT&quot;,&quot;size&quot;:{&quot;x&quot;:158.93857127427293,&quot;y&quot;:91.32},&quot;targetSize&quot;:{&quot;x&quot;:158.93857127427293,&quot;y&quot;:91.32},&quot;verticalAlign&quot;:&quot;TOP&quot;},&quot;parent&quot;:{&quot;type&quot;:&quot;CHILD&quot;,&quot;parentId&quot;:&quot;ceb8ad80-6cf4-487e-abe0-015904b52ca8&quot;,&quot;order&quot;:&quot;999999999999975&quot;}},&quot;901de502-16c8-4b34-a573-5d6fee9a92ca&quot;:{&quot;type&quot;:&quot;FIGURE_OBJECT&quot;,&quot;id&quot;:&quot;901de502-16c8-4b34-a573-5d6fee9a92ca&quot;,&quot;relativeTransform&quot;:{&quot;translate&quot;:{&quot;x&quot;:-475.0513312023182,&quot;y&quot;:174.4719537397558},&quot;rotate&quot;:0},&quot;layout&quot;:{&quot;sizeRatio&quot;:{&quot;x&quot;:0.88,&quot;y&quot;:0.88},&quot;keepAspectRatio&quot;:true},&quot;opacity&quot;:1,&quot;path&quot;:{&quot;type&quot;:&quot;ELLIPSE&quot;,&quot;size&quot;:{&quot;x&quot;:21.33078012502493,&quot;y&quot;:21.330780125024905}},&quot;pathStyles&quot;:[{&quot;type&quot;:&quot;FILL&quot;,&quot;fillStyle&quot;:&quot;rgba(255,255,255,1)&quot;},{&quot;type&quot;:&quot;STROKE&quot;,&quot;strokeStyle&quot;:&quot;rgba(0,0,0,1)&quot;,&quot;lineWidth&quot;:1.422052008334994,&quot;lineJoin&quot;:&quot;round&quot;}],&quot;isLocked&quot;:false,&quot;parent&quot;:{&quot;type&quot;:&quot;CHILD&quot;,&quot;parentId&quot;:&quot;ceb8ad80-6cf4-487e-abe0-015904b52ca8&quot;,&quot;order&quot;:&quot;99999999999998&quot;}},&quot;7c2ff31f-b77c-4d42-90dc-4e39935d3b22&quot;:{&quot;type&quot;:&quot;FIGURE_OBJECT&quot;,&quot;id&quot;:&quot;7c2ff31f-b77c-4d42-90dc-4e39935d3b22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4,&quot;color&quot;:&quot;black&quot;,&quot;fontWeight&quot;:&quot;normal&quot;,&quot;fontStyle&quot;:&quot;normal&quot;,&quot;decoration&quot;:&quot;none&quot;,&quot;script&quot;:&quot;none&quot;},&quot;range&quot;:[0,0]}],&quot;text&quot;:&quot;4&quot;,&quot;baseStyle&quot;:{&quot;fontFamily&quot;:&quot;Roboto&quot;,&quot;fontSize&quot;:14,&quot;color&quot;:&quot;black&quot;,&quot;fontWeight&quot;:&quot;normal&quot;,&quot;fontStyle&quot;:&quot;normal&quot;,&quot;decoration&quot;:&quot;none&quot;,&quot;script&quot;:&quot;none&quot;}}],&quot;verticalAlign&quot;:&quot;TOP&quot;},&quot;size&quot;:{&quot;x&quot;:18.145383626354516,&quot;y&quot;:16.625},&quot;targetSize&quot;:{&quot;x&quot;:15.877210673060201,&quot;y&quot;:2},&quot;format&quot;:&quot;BETTER_TEXT&quot;,&quot;verticalAlign&quot;:&quot;TOP&quot;},&quot;parent&quot;:{&quot;type&quot;:&quot;CHILD&quot;,&quot;parentId&quot;:&quot;901de502-16c8-4b34-a573-5d6fee9a92ca&quot;,&quot;order&quot;:&quot;5&quot;}},&quot;c8c2b0e9-8df9-4770-be24-2c8551efbc4e&quot;:{&quot;id&quot;:&quot;c8c2b0e9-8df9-4770-be24-2c8551efbc4e&quot;,&quot;type&quot;:&quot;FIGURE_OBJECT&quot;,&quot;relativeTransform&quot;:{&quot;translate&quot;:{&quot;x&quot;:-416.49680708320045,&quot;y&quot;:33.28030404994789},&quot;rotate&quot;:0},&quot;text&quot;:{&quot;textData&quot;:{&quot;lineSpacing&quot;:&quot;normal&quot;,&quot;alignment&quot;:&quot;left&quot;,&quot;lines&quot;:[{&quot;runs&quot;:[{&quot;style&quot;:{&quot;fontFamily&quot;:&quot;Roboto&quot;,&quot;fontSize&quot;:16,&quot;color&quot;:&quot;black&quot;,&quot;fontWeight&quot;:&quot;normal&quot;,&quot;fontStyle&quot;:&quot;normal&quot;,&quot;decoration&quot;:&quot;none&quot;,&quot;script&quot;:&quot;none&quot;},&quot;range&quot;:[0,66]}],&quot;text&quot;:&quot;Unremoved infected plants can continue to inoculate insect vectors.&quot;}],&quot;verticalAlign&quot;:&quot;TOP&quot;,&quot;_lastCaretLocation&quot;:{&quot;lineIndex&quot;:0,&quot;runIndex&quot;:0,&quot;charIndex&quot;:0}},&quot;format&quot;:&quot;BETTER_TEXT&quot;,&quot;size&quot;:{&quot;x&quot;:143.55118776210014,&quot;y&quot;:91.32},&quot;targetSize&quot;:{&quot;x&quot;:125.60728929183762,&quot;y&quot;:28.389375},&quot;verticalAlign&quot;:&quot;TOP&quot;},&quot;parent&quot;:{&quot;type&quot;:&quot;CHILD&quot;,&quot;parentId&quot;:&quot;ceb8ad80-6cf4-487e-abe0-015904b52ca8&quot;,&quot;order&quot;:&quot;999999999999985&quot;}},&quot;aa5e440b-2780-4d67-91e2-20d205cfe274&quot;:{&quot;type&quot;:&quot;FIGURE_OBJECT&quot;,&quot;id&quot;:&quot;aa5e440b-2780-4d67-91e2-20d205cfe274&quot;,&quot;relativeTransform&quot;:{&quot;translate&quot;:{&quot;x&quot;:-505.8667632880613,&quot;y&quot;:-0.6009706110557747},&quot;rotate&quot;:0},&quot;layout&quot;:{&quot;sizeRatio&quot;:{&quot;x&quot;:0.88,&quot;y&quot;:0.88},&quot;keepAspectRatio&quot;:true},&quot;opacity&quot;:1,&quot;path&quot;:{&quot;type&quot;:&quot;ELLIPSE&quot;,&quot;size&quot;:{&quot;x&quot;:21.33078012502493,&quot;y&quot;:21.330780125024905}},&quot;pathStyles&quot;:[{&quot;type&quot;:&quot;FILL&quot;,&quot;fillStyle&quot;:&quot;rgba(255,255,255,1)&quot;},{&quot;type&quot;:&quot;STROKE&quot;,&quot;strokeStyle&quot;:&quot;rgba(0,0,0,1)&quot;,&quot;lineWidth&quot;:1.422052008334994,&quot;lineJoin&quot;:&quot;round&quot;}],&quot;isLocked&quot;:false,&quot;parent&quot;:{&quot;type&quot;:&quot;CHILD&quot;,&quot;parentId&quot;:&quot;ceb8ad80-6cf4-487e-abe0-015904b52ca8&quot;,&quot;order&quot;:&quot;99999999999999&quot;}},&quot;455e0c22-3615-43be-bd2b-a7ac7eafc471&quot;:{&quot;type&quot;:&quot;FIGURE_OBJECT&quot;,&quot;id&quot;:&quot;455e0c22-3615-43be-bd2b-a7ac7eafc471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4,&quot;color&quot;:&quot;black&quot;,&quot;fontWeight&quot;:&quot;normal&quot;,&quot;fontStyle&quot;:&quot;normal&quot;,&quot;decoration&quot;:&quot;none&quot;,&quot;script&quot;:&quot;none&quot;},&quot;range&quot;:[0,0]}],&quot;text&quot;:&quot;6&quot;}],&quot;verticalAlign&quot;:&quot;TOP&quot;,&quot;_lastCaretLocation&quot;:{&quot;lineIndex&quot;:0,&quot;runIndex&quot;:-1,&quot;charIndex&quot;:-1,&quot;endOfLine&quot;:true}},&quot;size&quot;:{&quot;x&quot;:18.145383626354516,&quot;y&quot;:16},&quot;targetSize&quot;:{&quot;x&quot;:15.877210673060201,&quot;y&quot;:2},&quot;format&quot;:&quot;BETTER_TEXT&quot;,&quot;verticalAlign&quot;:&quot;TOP&quot;},&quot;parent&quot;:{&quot;type&quot;:&quot;CHILD&quot;,&quot;parentId&quot;:&quot;aa5e440b-2780-4d67-91e2-20d205cfe274&quot;,&quot;order&quot;:&quot;5&quot;}},&quot;945eb1a3-ad5c-44af-81d0-75d0f718ab83&quot;:{&quot;type&quot;:&quot;FIGURE_OBJECT&quot;,&quot;id&quot;:&quot;945eb1a3-ad5c-44af-81d0-75d0f718ab83&quot;,&quot;parent&quot;:{&quot;type&quot;:&quot;CHILD&quot;,&quot;parentId&quot;:&quot;ceb8ad80-6cf4-487e-abe0-015904b52ca8&quot;,&quot;order&quot;:&quot;999998&quot;},&quot;relativeTransform&quot;:{&quot;translate&quot;:{&quot;x&quot;:-51.78472833297197,&quot;y&quot;:22.668308850185106},&quot;rotate&quot;:0}},&quot;2b96e7da-8f1c-48cc-bc9a-202f67b2b789&quot;:{&quot;type&quot;:&quot;FIGURE_OBJECT&quot;,&quot;id&quot;:&quot;2b96e7da-8f1c-48cc-bc9a-202f67b2b789&quot;,&quot;relativeTransform&quot;:{&quot;translate&quot;:{&quot;x&quot;:-48.381584821272845,&quot;y&quot;:36.455949651133146},&quot;rotate&quot;:0},&quot;opacity&quot;:1,&quot;path&quot;:{&quot;type&quot;:&quot;ARC&quot;,&quot;size&quot;:{&quot;x&quot;:359.6230159764342,&quot;y&quot;:359.6230159764341},&quot;startAngle&quot;:-2.4716275318836325,&quot;sweepAngle&quot;:0.4263194518520965,&quot;selectedObjectIds&quot;:[&quot;fed43b8d-6ac7-4aa7-81fd-3807a75aa3c4&quot;]},&quot;pathStyles&quot;:[{&quot;type&quot;:&quot;FILL&quot;,&quot;fillStyle&quot;:&quot;rgba(0,0,0,0)&quot;},{&quot;type&quot;:&quot;STROKE&quot;,&quot;strokeStyle&quot;:&quot;#232323&quot;,&quot;lineWidth&quot;:2.077193896850261,&quot;lineJoin&quot;:&quot;round&quot;}],&quot;isLocked&quot;:false,&quot;parent&quot;:{&quot;type&quot;:&quot;CHILD&quot;,&quot;parentId&quot;:&quot;945eb1a3-ad5c-44af-81d0-75d0f718ab83&quot;,&quot;order&quot;:&quot;2&quot;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},&quot;8dffc87a-81e6-4c88-9d7e-92a261f70a83&quot;:{&quot;type&quot;:&quot;FIGURE_OBJECT&quot;,&quot;id&quot;:&quot;8dffc87a-81e6-4c88-9d7e-92a261f70a83&quot;,&quot;relativeTransform&quot;:{&quot;translate&quot;:{&quot;x&quot;:-48.381584821272845,&quot;y&quot;:36.455949651133146},&quot;rotate&quot;:0},&quot;opacity&quot;:1,&quot;path&quot;:{&quot;type&quot;:&quot;ARC&quot;,&quot;size&quot;:{&quot;x&quot;:359.6230159764342,&quot;y&quot;:359.6230159764341},&quot;startAngle&quot;:-1.0911364310986518,&quot;sweepAngle&quot;:0.4277984597039506,&quot;selectedObjectIds&quot;:[&quot;1f251a76-c18e-445d-ad62-dbe600a1f62c&quot;]},&quot;pathStyles&quot;:[{&quot;type&quot;:&quot;STROKE&quot;,&quot;strokeStyle&quot;:&quot;#232323&quot;,&quot;lineWidth&quot;:2.077193896850261,&quot;lineJoin&quot;:&quot;round&quot;},{&quot;type&quot;:&quot;FILL&quot;,&quot;fillStyle&quot;:&quot;rgba(0,0,0,0)&quot;}],&quot;isLocked&quot;:false,&quot;parent&quot;:{&quot;type&quot;:&quot;CHILD&quot;,&quot;parentId&quot;:&quot;945eb1a3-ad5c-44af-81d0-75d0f718ab83&quot;,&quot;order&quot;:&quot;4&quot;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},&quot;f8c9ce1c-61a0-4c27-9f60-a7c11f6f8e0d&quot;:{&quot;type&quot;:&quot;FIGURE_OBJECT&quot;,&quot;id&quot;:&quot;f8c9ce1c-61a0-4c27-9f60-a7c11f6f8e0d&quot;,&quot;relativeTransform&quot;:{&quot;translate&quot;:{&quot;x&quot;:-48.381584821272845,&quot;y&quot;:36.455949651133146},&quot;rotate&quot;:0},&quot;opacity&quot;:1,&quot;path&quot;:{&quot;type&quot;:&quot;ARC&quot;,&quot;size&quot;:{&quot;x&quot;:359.6230159764342,&quot;y&quot;:359.6230159764341},&quot;startAngle&quot;:2.7966851869450666,&quot;sweepAngle&quot;:0.3008793584557887,&quot;selectedObjectIds&quot;:[&quot;038abb91-74a2-4f1f-a5fa-7ef874c0d6d5&quot;]},&quot;pathStyles&quot;:[{&quot;type&quot;:&quot;STROKE&quot;,&quot;strokeStyle&quot;:&quot;#232323&quot;,&quot;lineWidth&quot;:2.077193896850261,&quot;lineJoin&quot;:&quot;round&quot;},{&quot;type&quot;:&quot;FILL&quot;,&quot;fillStyle&quot;:&quot;rgba(0,0,0,0)&quot;}],&quot;isLocked&quot;:false,&quot;parent&quot;:{&quot;type&quot;:&quot;CHILD&quot;,&quot;parentId&quot;:&quot;945eb1a3-ad5c-44af-81d0-75d0f718ab83&quot;,&quot;order&quot;:&quot;7&quot;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},&quot;6d8f118f-4f45-4d70-b93e-da67297216a5&quot;:{&quot;type&quot;:&quot;FIGURE_OBJECT&quot;,&quot;id&quot;:&quot;6d8f118f-4f45-4d70-b93e-da67297216a5&quot;,&quot;relativeTransform&quot;:{&quot;translate&quot;:{&quot;x&quot;:-48.381584821272845,&quot;y&quot;:36.455949651133146},&quot;rotate&quot;:0},&quot;opacity&quot;:1,&quot;path&quot;:{&quot;type&quot;:&quot;ARC&quot;,&quot;size&quot;:{&quot;x&quot;:359.6230159764342,&quot;y&quot;:359.6230159764341},&quot;startAngle&quot;:0.03832930893094516,&quot;sweepAngle&quot;:0.304551386248737,&quot;selectedObjectIds&quot;:[&quot;66552c21-5815-4995-b750-8a8a4f25ca8e&quot;]},&quot;pathStyles&quot;:[{&quot;type&quot;:&quot;STROKE&quot;,&quot;strokeStyle&quot;:&quot;#232323&quot;,&quot;lineWidth&quot;:2.077193896850261,&quot;lineJoin&quot;:&quot;round&quot;},{&quot;type&quot;:&quot;FILL&quot;,&quot;fillStyle&quot;:&quot;rgba(0,0,0,0)&quot;}],&quot;isLocked&quot;:false,&quot;parent&quot;:{&quot;type&quot;:&quot;CHILD&quot;,&quot;parentId&quot;:&quot;945eb1a3-ad5c-44af-81d0-75d0f718ab83&quot;,&quot;order&quot;:&quot;5&quot;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},&quot;331d7b38-ca43-4f8d-bd83-438ba64fac88&quot;:{&quot;type&quot;:&quot;FIGURE_OBJECT&quot;,&quot;id&quot;:&quot;331d7b38-ca43-4f8d-bd83-438ba64fac88&quot;,&quot;relativeTransform&quot;:{&quot;translate&quot;:{&quot;x&quot;:-48.381584821272845,&quot;y&quot;:36.455949651133146},&quot;rotate&quot;:0},&quot;opacity&quot;:1,&quot;path&quot;:{&quot;type&quot;:&quot;ARC&quot;,&quot;size&quot;:{&quot;x&quot;:359.6230159764342,&quot;y&quot;:359.6230159764341},&quot;startAngle&quot;:1.1383179659587481,&quot;sweepAngle&quot;:0.8367116580546652,&quot;selectedObjectIds&quot;:[&quot;ff18759b-23cf-4459-9496-a957e9f4418b&quot;]},&quot;pathStyles&quot;:[{&quot;type&quot;:&quot;STROKE&quot;,&quot;strokeStyle&quot;:&quot;#232323&quot;,&quot;lineWidth&quot;:2.077193896850261,&quot;lineJoin&quot;:&quot;round&quot;},{&quot;type&quot;:&quot;FILL&quot;,&quot;fillStyle&quot;:&quot;rgba(0,0,0,0)&quot;}],&quot;isLocked&quot;:false,&quot;parent&quot;:{&quot;type&quot;:&quot;CHILD&quot;,&quot;parentId&quot;:&quot;945eb1a3-ad5c-44af-81d0-75d0f718ab83&quot;,&quot;order&quot;:&quot;6&quot;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},&quot;0425b773-4b30-4508-9168-614e7d1afdcf&quot;:{&quot;id&quot;:&quot;0425b773-4b30-4508-9168-614e7d1afdcf&quot;,&quot;name&quot;:&quot;Tomato plant (wilted)&quot;,&quot;displayName&quot;:&quot;&quot;,&quot;type&quot;:&quot;FIGURE_OBJECT&quot;,&quot;relativeTransform&quot;:{&quot;translate&quot;:{&quot;x&quot;:-191.30708661417322,&quot;y&quot;:-42.000000000000014},&quot;rotate&quot;:0,&quot;skewX&quot;:0,&quot;scale&quot;:{&quot;x&quot;:0.4892388451443571,&quot;y&quot;:0.4892388451443571}},&quot;image&quot;:{&quot;url&quot;:&quot;https://icons.biorender.com/biorender/6536c86b816dc5a1c72aadb5/20231023192547/image/tomato-plant-wilted.png&quot;,&quot;fallbackUrl&quot;:&quot;https://res.cloudinary.com/dlcjuc3ej/image/upload/v1698089147/yrqufh9xxpik9t2z9xjz.svg#/keystone/api/icons/6536c86b816dc5a1c72aadb5/20231023192547/image/tomato-plant-wilted.svg&quot;,&quot;isPremium&quot;:true,&quot;size&quot;:{&quot;x&quot;:150,&quot;y&quot;:272.14285714285717}},&quot;source&quot;:{&quot;id&quot;:&quot;6536c86b816dc5a1c72aadb5&quot;,&quot;type&quot;:&quot;ASSETS&quot;},&quot;isPremium&quot;:true,&quot;parent&quot;:{&quot;type&quot;:&quot;CHILD&quot;,&quot;parentId&quot;:&quot;8b5f97cd-db4d-4dae-bbb0-2a539bcf7a97&quot;,&quot;order&quot;:&quot;7&quot;}},&quot;1c8b1c14-a845-49b7-9811-345e47c4cbf1&quot;:{&quot;id&quot;:&quot;1c8b1c14-a845-49b7-9811-345e47c4cbf1&quot;,&quot;name&quot;:&quot;Tomato (young plant)&quot;,&quot;displayName&quot;:&quot;&quot;,&quot;type&quot;:&quot;FIGURE_OBJECT&quot;,&quot;relativeTransform&quot;:{&quot;translate&quot;:{&quot;x&quot;:-2.5789999999999917,&quot;y&quot;:-143.5},&quot;rotate&quot;:0,&quot;skewX&quot;:0,&quot;scale&quot;:{&quot;x&quot;:1.14,&quot;y&quot;:1.14}},&quot;image&quot;:{&quot;url&quot;:&quot;https://icons.biorender.com/biorender/648b3ce6c5ed7f002049b7f7/20230616135452/image/tomato-young-plant-01.png&quot;,&quot;fallbackUrl&quot;:&quot;https://res.cloudinary.com/dlcjuc3ej/image/upload/v1686923692/rkyrynaayxvjxz9ewuuz.svg#/keystone/api/icons/648b3ce6c5ed7f002049b7f7/20230616135452/image/tomato-young-plant-01.svg#/keystone/api/icons/648b3ce6c5ed7f002049b7f7/20230616135452/image/tomato-young-plant-01.svg#/keystone/api/icons/648b3ce6c5ed7f002049b7f7/20230616135452/image/tomato-young-plant-01.svg&quot;,&quot;isPremium&quot;:false,&quot;size&quot;:{&quot;x&quot;:100,&quot;y&quot;:135.71428571428572}},&quot;source&quot;:{&quot;id&quot;:&quot;648b3ce6c5ed7f002049b7f7&quot;,&quot;type&quot;:&quot;ASSETS&quot;},&quot;isPremium&quot;:false,&quot;parent&quot;:{&quot;type&quot;:&quot;CHILD&quot;,&quot;parentId&quot;:&quot;8b5f97cd-db4d-4dae-bbb0-2a539bcf7a97&quot;,&quot;order&quot;:&quot;8&quot;}},&quot;b9e4bff9-3639-4950-ac0c-317fe942a859&quot;:{&quot;id&quot;:&quot;b9e4bff9-3639-4950-ac0c-317fe942a859&quot;,&quot;name&quot;:&quot;Whitefly (lateral)&quot;,&quot;displayName&quot;:&quot;&quot;,&quot;type&quot;:&quot;FIGURE_OBJECT&quot;,&quot;relativeTransform&quot;:{&quot;translate&quot;:{&quot;x&quot;:43.22702708592559,&quot;y&quot;:-175.25643694790065},&quot;rotate&quot;:0.23726853553558666,&quot;skewX&quot;:0,&quot;scale&quot;:{&quot;x&quot;:0.28252629329503187,&quot;y&quot;:0.28252629329503187}},&quot;image&quot;:{&quot;url&quot;:&quot;https://icons.biorender.com/biorender/5e30515c86d7a60028da0f5a/20200128152314/image/whitefly-lateral.png&quot;,&quot;fallbackUrl&quot;:&quot;https://res.cloudinary.com/dlcjuc3ej/image/upload/v1580224994/rtolt1jips2dy0fmmequ.svg#/keystone/api/icons/5e30515c86d7a60028da0f5a/20200128152314/image/whitefly-lateral.svg&quot;,&quot;isPremium&quot;:false,&quot;size&quot;:{&quot;x&quot;:200,&quot;y&quot;:101.63934426229508}},&quot;source&quot;:{&quot;id&quot;:&quot;5e30515c86d7a60028da0f5a&quot;,&quot;type&quot;:&quot;ASSETS&quot;},&quot;isPremium&quot;:false,&quot;parent&quot;:{&quot;type&quot;:&quot;CHILD&quot;,&quot;parentId&quot;:&quot;8b5f97cd-db4d-4dae-bbb0-2a539bcf7a97&quot;,&quot;order&quot;:&quot;9&quot;}},&quot;628dce30-0390-4c0e-9fe9-acf5184163b4&quot;:{&quot;id&quot;:&quot;628dce30-0390-4c0e-9fe9-acf5184163b4&quot;,&quot;name&quot;:&quot;Sieve element&quot;,&quot;displayName&quot;:&quot;&quot;,&quot;type&quot;:&quot;FIGURE_OBJECT&quot;,&quot;relativeTransform&quot;:{&quot;translate&quot;:{&quot;x&quot;:183.24861363636361,&quot;y&quot;:-49},&quot;rotate&quot;:0,&quot;skewX&quot;:0,&quot;scale&quot;:{&quot;x&quot;:0.5632102272727273,&quot;y&quot;:0.5632102272727273}},&quot;image&quot;:{&quot;url&quot;:&quot;https://icons.biorender.com/biorender/60a54f725feb3b00281478ba/20210519175451/image/sieve-element.png&quot;,&quot;fallbackUrl&quot;:&quot;https://res.cloudinary.com/dlcjuc3ej/image/upload/v1621446891/yspzgpiukckygg6btrnk.svg#/keystone/api/icons/60a54f725feb3b00281478ba/20210519175451/image/sieve-element.svg&quot;,&quot;isPremium&quot;:false,&quot;size&quot;:{&quot;x&quot;:120,&quot;y&quot;:281.6}},&quot;source&quot;:{&quot;id&quot;:&quot;60a54f725feb3b00281478ba&quot;,&quot;type&quot;:&quot;ASSETS&quot;},&quot;isPremium&quot;:false,&quot;parent&quot;:{&quot;type&quot;:&quot;CHILD&quot;,&quot;parentId&quot;:&quot;8b5f97cd-db4d-4dae-bbb0-2a539bcf7a97&quot;,&quot;order&quot;:&quot;95&quot;},&quot;styles&quot;:{&quot;vector-hidden&quot;:[{&quot;styleName&quot;:&quot;MONOCHROME_COLOR&quot;,&quot;index&quot;:0,&quot;color&quot;:&quot;#35A618&quot;}]}},&quot;d20fdcd0-8b47-488c-8d7b-8f29208c14a4&quot;:{&quot;id&quot;:&quot;d20fdcd0-8b47-488c-8d7b-8f29208c14a4&quot;,&quot;name&quot;:&quot;Sieve element&quot;,&quot;displayName&quot;:&quot;&quot;,&quot;type&quot;:&quot;FIGURE_OBJECT&quot;,&quot;relativeTransform&quot;:{&quot;translate&quot;:{&quot;x&quot;:115.6643636363636,&quot;y&quot;:156.429},&quot;rotate&quot;:0,&quot;skewX&quot;:0,&quot;scale&quot;:{&quot;x&quot;:0.6022727272727274,&quot;y&quot;:0.6022727272727274}},&quot;image&quot;:{&quot;url&quot;:&quot;https://icons.biorender.com/biorender/60a550ef5feb3b00281478bc/sieve-element.png&quot;,&quot;fallbackUrl&quot;:&quot;https://res.cloudinary.com/dlcjuc3ej/image/upload/v1621446891/wpe66ogmgnzz44hb2v1x.svg#/keystone/api/icons/60a550ef5feb3b00281478bc/sieve-element.svg&quot;,&quot;isPremium&quot;:false,&quot;size&quot;:{&quot;x&quot;:120,&quot;y&quot;:281.6}},&quot;source&quot;:{&quot;id&quot;:&quot;60a54f725feb3b00281478ba&quot;,&quot;type&quot;:&quot;ASSETS&quot;},&quot;isPremium&quot;:false,&quot;parent&quot;:{&quot;type&quot;:&quot;CHILD&quot;,&quot;parentId&quot;:&quot;8b5f97cd-db4d-4dae-bbb0-2a539bcf7a97&quot;,&quot;order&quot;:&quot;97&quot;}},&quot;2088d316-d705-40c3-a3bc-85832b6c716d&quot;:{&quot;id&quot;:&quot;2088d316-d705-40c3-a3bc-85832b6c716d&quot;,&quot;name&quot;:&quot;Coccus&quot;,&quot;displayName&quot;:&quot;&quot;,&quot;type&quot;:&quot;FIGURE_OBJECT&quot;,&quot;relativeTransform&quot;:{&quot;translate&quot;:{&quot;x&quot;:194,&quot;y&quot;:-83.57100000000001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8&quot;}},&quot;0189d6b5-a383-4211-b762-ff1bae264f25&quot;:{&quot;id&quot;:&quot;0189d6b5-a383-4211-b762-ff1bae264f25&quot;,&quot;name&quot;:&quot;Coccus&quot;,&quot;displayName&quot;:&quot;&quot;,&quot;type&quot;:&quot;FIGURE_OBJECT&quot;,&quot;relativeTransform&quot;:{&quot;translate&quot;:{&quot;x&quot;:202,&quot;y&quot;:-42.000000000000014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&quot;}},&quot;14f5515c-b69d-4c72-9083-7caa00591c27&quot;:{&quot;id&quot;:&quot;14f5515c-b69d-4c72-9083-7caa00591c27&quot;,&quot;name&quot;:&quot;Coccus&quot;,&quot;displayName&quot;:&quot;&quot;,&quot;type&quot;:&quot;FIGURE_OBJECT&quot;,&quot;relativeTransform&quot;:{&quot;translate&quot;:{&quot;x&quot;:172,&quot;y&quot;:-21.571000000000012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5&quot;}},&quot;36b9a6a0-ac92-4f99-b835-657cd9b93e9c&quot;:{&quot;id&quot;:&quot;36b9a6a0-ac92-4f99-b835-657cd9b93e9c&quot;,&quot;name&quot;:&quot;Coccus&quot;,&quot;displayName&quot;:&quot;&quot;,&quot;type&quot;:&quot;FIGURE_OBJECT&quot;,&quot;relativeTransform&quot;:{&quot;translate&quot;:{&quot;x&quot;:108,&quot;y&quot;:201.529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7&quot;}},&quot;dae20d1e-7a4a-4474-8088-42060e151ac1&quot;:{&quot;id&quot;:&quot;dae20d1e-7a4a-4474-8088-42060e151ac1&quot;,&quot;name&quot;:&quot;Coccus&quot;,&quot;displayName&quot;:&quot;&quot;,&quot;type&quot;:&quot;FIGURE_OBJECT&quot;,&quot;relativeTransform&quot;:{&quot;translate&quot;:{&quot;x&quot;:129.664,&quot;y&quot;:214.42899999999997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8&quot;}},&quot;1ac9cac6-8464-4f7f-8112-e9392497426d&quot;:{&quot;id&quot;:&quot;1ac9cac6-8464-4f7f-8112-e9392497426d&quot;,&quot;name&quot;:&quot;Coccus&quot;,&quot;displayName&quot;:&quot;&quot;,&quot;type&quot;:&quot;FIGURE_OBJECT&quot;,&quot;relativeTransform&quot;:{&quot;translate&quot;:{&quot;x&quot;:100,&quot;y&quot;:188.42899999999997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&quot;}},&quot;399ef6ce-a301-462b-9e77-d7e97ad78915&quot;:{&quot;id&quot;:&quot;399ef6ce-a301-462b-9e77-d7e97ad78915&quot;,&quot;name&quot;:&quot;Coccus&quot;,&quot;displayName&quot;:&quot;&quot;,&quot;type&quot;:&quot;FIGURE_OBJECT&quot;,&quot;relativeTransform&quot;:{&quot;translate&quot;:{&quot;x&quot;:129.664,&quot;y&quot;:162.42899999999997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5&quot;}},&quot;4fc19dec-32f6-48c6-9d66-e8dbdb947b84&quot;:{&quot;id&quot;:&quot;4fc19dec-32f6-48c6-9d66-e8dbdb947b84&quot;,&quot;name&quot;:&quot;Coccus&quot;,&quot;displayName&quot;:&quot;&quot;,&quot;type&quot;:&quot;FIGURE_OBJECT&quot;,&quot;relativeTransform&quot;:{&quot;translate&quot;:{&quot;x&quot;:100,&quot;y&quot;:155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7&quot;}},&quot;4d9b6b15-815f-4a35-9515-2f189a594447&quot;:{&quot;id&quot;:&quot;4d9b6b15-815f-4a35-9515-2f189a594447&quot;,&quot;name&quot;:&quot;Coccus&quot;,&quot;displayName&quot;:&quot;&quot;,&quot;type&quot;:&quot;FIGURE_OBJECT&quot;,&quot;relativeTransform&quot;:{&quot;translate&quot;:{&quot;x&quot;:136,&quot;y&quot;:188.42899999999997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8&quot;}},&quot;f17db7e0-c188-4b53-8d76-13b64977feac&quot;:{&quot;id&quot;:&quot;f17db7e0-c188-4b53-8d76-13b64977feac&quot;,&quot;name&quot;:&quot;Coccus&quot;,&quot;displayName&quot;:&quot;&quot;,&quot;type&quot;:&quot;FIGURE_OBJECT&quot;,&quot;relativeTransform&quot;:{&quot;translate&quot;:{&quot;x&quot;:129.664,&quot;y&quot;:100.42899999999999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&quot;}},&quot;6560f204-2419-4ee6-9e37-d3aeb8d28818&quot;:{&quot;id&quot;:&quot;6560f204-2419-4ee6-9e37-d3aeb8d28818&quot;,&quot;name&quot;:&quot;Coccus&quot;,&quot;displayName&quot;:&quot;&quot;,&quot;type&quot;:&quot;FIGURE_OBJECT&quot;,&quot;relativeTransform&quot;:{&quot;translate&quot;:{&quot;x&quot;:115.66399999999999,&quot;y&quot;:124.42899999999999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5&quot;}},&quot;a797c331-73f4-4bf2-9fa9-d2f7f2adc8bf&quot;:{&quot;id&quot;:&quot;a797c331-73f4-4bf2-9fa9-d2f7f2adc8bf&quot;,&quot;name&quot;:&quot;Coccus&quot;,&quot;displayName&quot;:&quot;&quot;,&quot;type&quot;:&quot;FIGURE_OBJECT&quot;,&quot;relativeTransform&quot;:{&quot;translate&quot;:{&quot;x&quot;:100,&quot;y&quot;:100.42899999999999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7&quot;}},&quot;4b1f11dc-ae4f-42e4-a3c8-70911f112034&quot;:{&quot;id&quot;:&quot;4b1f11dc-ae4f-42e4-a3c8-70911f112034&quot;,&quot;name&quot;:&quot;Tomato (young plant)&quot;,&quot;displayName&quot;:&quot;&quot;,&quot;type&quot;:&quot;FIGURE_OBJECT&quot;,&quot;relativeTransform&quot;:{&quot;translate&quot;:{&quot;x&quot;:-140.57899999999998,&quot;y&quot;:156.94299999999998},&quot;rotate&quot;:0,&quot;skewX&quot;:0,&quot;scale&quot;:{&quot;x&quot;:1.14,&quot;y&quot;:1.14}},&quot;image&quot;:{&quot;url&quot;:&quot;https://icons.biorender.com/biorender/648b3ce6c5ed7f002049b7f7/20230616135452/image/tomato-young-plant-01.png&quot;,&quot;fallbackUrl&quot;:&quot;https://res.cloudinary.com/dlcjuc3ej/image/upload/v1686923692/rkyrynaayxvjxz9ewuuz.svg#/keystone/api/icons/648b3ce6c5ed7f002049b7f7/20230616135452/image/tomato-young-plant-01.svg#/keystone/api/icons/648b3ce6c5ed7f002049b7f7/20230616135452/image/tomato-young-plant-01.svg#/keystone/api/icons/648b3ce6c5ed7f002049b7f7/20230616135452/image/tomato-young-plant-01.svg&quot;,&quot;isPremium&quot;:false,&quot;size&quot;:{&quot;x&quot;:100,&quot;y&quot;:135.71428571428572}},&quot;source&quot;:{&quot;id&quot;:&quot;648b3ce6c5ed7f002049b7f7&quot;,&quot;type&quot;:&quot;ASSETS&quot;},&quot;isPremium&quot;:false,&quot;parent&quot;:{&quot;type&quot;:&quot;CHILD&quot;,&quot;parentId&quot;:&quot;8b5f97cd-db4d-4dae-bbb0-2a539bcf7a97&quot;,&quot;order&quot;:&quot;99998&quot;}},&quot;180897d9-4bc5-476f-8cc3-ec213578f569&quot;:{&quot;id&quot;:&quot;180897d9-4bc5-476f-8cc3-ec213578f569&quot;,&quot;name&quot;:&quot;Coccus&quot;,&quot;displayName&quot;:&quot;&quot;,&quot;type&quot;:&quot;FIGURE_OBJECT&quot;,&quot;relativeTransform&quot;:{&quot;translate&quot;:{&quot;x&quot;:50.421,&quot;y&quot;:-183.256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&quot;}},&quot;0b2695e4-06c5-428f-af48-5ac909a8608b&quot;:{&quot;id&quot;:&quot;0b2695e4-06c5-428f-af48-5ac909a8608b&quot;,&quot;name&quot;:&quot;Coccus&quot;,&quot;displayName&quot;:&quot;&quot;,&quot;type&quot;:&quot;FIGURE_OBJECT&quot;,&quot;relativeTransform&quot;:{&quot;translate&quot;:{&quot;x&quot;:33,&quot;y&quot;:-175.256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5&quot;}},&quot;3113a3ad-5af6-45eb-9017-b8f74acf80e9&quot;:{&quot;id&quot;:&quot;3113a3ad-5af6-45eb-9017-b8f74acf80e9&quot;,&quot;name&quot;:&quot;Coccus&quot;,&quot;displayName&quot;:&quot;&quot;,&quot;type&quot;:&quot;FIGURE_OBJECT&quot;,&quot;relativeTransform&quot;:{&quot;translate&quot;:{&quot;x&quot;:-132.579,&quot;y&quot;:127.428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7&quot;}},&quot;91417bc7-c322-457c-9dcc-a49e150cbbd2&quot;:{&quot;id&quot;:&quot;91417bc7-c322-457c-9dcc-a49e150cbbd2&quot;,&quot;name&quot;:&quot;Coccus&quot;,&quot;displayName&quot;:&quot;&quot;,&quot;type&quot;:&quot;FIGURE_OBJECT&quot;,&quot;relativeTransform&quot;:{&quot;translate&quot;:{&quot;x&quot;:-140.579,&quot;y&quot;:116.428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8&quot;}},&quot;cf7c7f39-db4d-4337-81aa-923320e6f8a3&quot;:{&quot;id&quot;:&quot;cf7c7f39-db4d-4337-81aa-923320e6f8a3&quot;,&quot;name&quot;:&quot;Coccus&quot;,&quot;displayName&quot;:&quot;&quot;,&quot;type&quot;:&quot;FIGURE_OBJECT&quot;,&quot;relativeTransform&quot;:{&quot;translate&quot;:{&quot;x&quot;:-107,&quot;y&quot;:124.428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&quot;}},&quot;986ff17d-c9b2-424f-914c-8c9bc540d79f&quot;:{&quot;id&quot;:&quot;986ff17d-c9b2-424f-914c-8c9bc540d79f&quot;,&quot;name&quot;:&quot;Coccus&quot;,&quot;displayName&quot;:&quot;&quot;,&quot;type&quot;:&quot;FIGURE_OBJECT&quot;,&quot;relativeTransform&quot;:{&quot;translate&quot;:{&quot;x&quot;:-168,&quot;y&quot;:103.428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5&quot;}},&quot;921c11a9-f574-4abe-9aee-b2e2a271f7e2&quot;:{&quot;id&quot;:&quot;921c11a9-f574-4abe-9aee-b2e2a271f7e2&quot;,&quot;name&quot;:&quot;Coccus&quot;,&quot;displayName&quot;:&quot;&quot;,&quot;type&quot;:&quot;FIGURE_OBJECT&quot;,&quot;relativeTransform&quot;:{&quot;translate&quot;:{&quot;x&quot;:-115,&quot;y&quot;:165.99999999999994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7&quot;}},&quot;d550b143-0088-407e-a413-a483238e19f6&quot;:{&quot;id&quot;:&quot;d550b143-0088-407e-a413-a483238e19f6&quot;,&quot;name&quot;:&quot;Coccus&quot;,&quot;displayName&quot;:&quot;&quot;,&quot;type&quot;:&quot;FIGURE_OBJECT&quot;,&quot;relativeTransform&quot;:{&quot;translate&quot;:{&quot;x&quot;:-132.579,&quot;y&quot;:143.999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8&quot;}},&quot;2be22b21-65f0-40de-bb8f-8ce4d6f6bd22&quot;:{&quot;id&quot;:&quot;2be22b21-65f0-40de-bb8f-8ce4d6f6bd22&quot;,&quot;name&quot;:&quot;Coccus&quot;,&quot;displayName&quot;:&quot;&quot;,&quot;type&quot;:&quot;FIGURE_OBJECT&quot;,&quot;relativeTransform&quot;:{&quot;translate&quot;:{&quot;x&quot;:-168,&quot;y&quot;:143.999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&quot;}},&quot;7c505fc1-ce99-4b9d-a4ec-d2e3fcab54a1&quot;:{&quot;id&quot;:&quot;7c505fc1-ce99-4b9d-a4ec-d2e3fcab54a1&quot;,&quot;name&quot;:&quot;Coccus&quot;,&quot;displayName&quot;:&quot;&quot;,&quot;type&quot;:&quot;FIGURE_OBJECT&quot;,&quot;relativeTransform&quot;:{&quot;translate&quot;:{&quot;x&quot;:-168,&quot;y&quot;:-72.571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5&quot;}},&quot;a3ac4804-8ee5-4744-a1e1-d6aba7572060&quot;:{&quot;id&quot;:&quot;a3ac4804-8ee5-4744-a1e1-d6aba7572060&quot;,&quot;name&quot;:&quot;Coccus&quot;,&quot;displayName&quot;:&quot;&quot;,&quot;type&quot;:&quot;FIGURE_OBJECT&quot;,&quot;relativeTransform&quot;:{&quot;translate&quot;:{&quot;x&quot;:-176,&quot;y&quot;:-47.000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7&quot;}},&quot;9d03a8bb-748e-4e4e-b36b-d1772280a646&quot;:{&quot;id&quot;:&quot;9d03a8bb-748e-4e4e-b36b-d1772280a646&quot;,&quot;name&quot;:&quot;Coccus&quot;,&quot;displayName&quot;:&quot;&quot;,&quot;type&quot;:&quot;FIGURE_OBJECT&quot;,&quot;relativeTransform&quot;:{&quot;translate&quot;:{&quot;x&quot;:-209.579,&quot;y&quot;:-39.000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8&quot;}},&quot;90b26f8a-8a9e-4167-8057-f5c7ced39dfb&quot;:{&quot;id&quot;:&quot;90b26f8a-8a9e-4167-8057-f5c7ced39dfb&quot;,&quot;name&quot;:&quot;Coccus&quot;,&quot;displayName&quot;:&quot;&quot;,&quot;type&quot;:&quot;FIGURE_OBJECT&quot;,&quot;relativeTransform&quot;:{&quot;translate&quot;:{&quot;x&quot;:-100.57900000000001,&quot;y&quot;:156.428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&quot;}},&quot;e6f1891d-4251-482d-a057-b20e5b159b79&quot;:{&quot;id&quot;:&quot;e6f1891d-4251-482d-a057-b20e5b159b79&quot;,&quot;name&quot;:&quot;Coccus&quot;,&quot;displayName&quot;:&quot;&quot;,&quot;type&quot;:&quot;FIGURE_OBJECT&quot;,&quot;relativeTransform&quot;:{&quot;translate&quot;:{&quot;x&quot;:-90.57900000000001,&quot;y&quot;:166.428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5&quot;}},&quot;e1b5c5b0-b2fa-4aa7-b0aa-910dffdd89ec&quot;:{&quot;id&quot;:&quot;e1b5c5b0-b2fa-4aa7-b0aa-910dffdd89ec&quot;,&quot;name&quot;:&quot;Coccus&quot;,&quot;displayName&quot;:&quot;&quot;,&quot;type&quot;:&quot;FIGURE_OBJECT&quot;,&quot;relativeTransform&quot;:{&quot;translate&quot;:{&quot;x&quot;:-201.579,&quot;y&quot;:-83.571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7&quot;}},&quot;25bd227e-d28b-487b-b114-61cce0476e85&quot;:{&quot;id&quot;:&quot;25bd227e-d28b-487b-b114-61cce0476e85&quot;,&quot;name&quot;:&quot;Coccus&quot;,&quot;displayName&quot;:&quot;&quot;,&quot;type&quot;:&quot;FIGURE_OBJECT&quot;,&quot;relativeTransform&quot;:{&quot;translate&quot;:{&quot;x&quot;:-193.579,&quot;y&quot;:-49.000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8&quot;}},&quot;c70be399-54e8-45f6-82b9-2e4942e16519&quot;:{&quot;id&quot;:&quot;c70be399-54e8-45f6-82b9-2e4942e16519&quot;,&quot;name&quot;:&quot;Coccus&quot;,&quot;displayName&quot;:&quot;&quot;,&quot;type&quot;:&quot;FIGURE_OBJECT&quot;,&quot;relativeTransform&quot;:{&quot;translate&quot;:{&quot;x&quot;:-166,&quot;y&quot;:-37.000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&quot;}},&quot;ba38c0b7-00a8-414e-9d3d-a36e928f810d&quot;:{&quot;id&quot;:&quot;ba38c0b7-00a8-414e-9d3d-a36e928f810d&quot;,&quot;name&quot;:&quot;Coccus&quot;,&quot;displayName&quot;:&quot;&quot;,&quot;type&quot;:&quot;FIGURE_OBJECT&quot;,&quot;relativeTransform&quot;:{&quot;translate&quot;:{&quot;x&quot;:-184,&quot;y&quot;:-91.571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5&quot;}},&quot;1f867a01-d8e7-4b1d-a9e8-3b679c83f61b&quot;:{&quot;id&quot;:&quot;1f867a01-d8e7-4b1d-a9e8-3b679c83f61b&quot;,&quot;name&quot;:&quot;Coccus&quot;,&quot;displayName&quot;:&quot;&quot;,&quot;type&quot;:&quot;FIGURE_OBJECT&quot;,&quot;relativeTransform&quot;:{&quot;translate&quot;:{&quot;x&quot;:-192,&quot;y&quot;:-18.571000000000026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7&quot;}},&quot;13a9ca0c-2db9-4228-8eb1-7a86c2e3551a&quot;:{&quot;type&quot;:&quot;FIGURE_OBJECT&quot;,&quot;id&quot;:&quot;13a9ca0c-2db9-4228-8eb1-7a86c2e3551a&quot;,&quot;relativeTransform&quot;:{&quot;translate&quot;:{&quot;x&quot;:0,&quot;y&quot;:0},&quot;rotate&quot;:0,&quot;skewX&quot;:0,&quot;scale&quot;:{&quot;x&quot;:1,&quot;y&quot;:1}},&quot;opacity&quot;:1,&quot;path&quot;:{&quot;type&quot;:&quot;POLY_LINE&quot;,&quot;points&quot;:[{&quot;x&quot;:-83.57899999999998,&quot;y&quot;:79.58585714285712},{&quot;x&quot;:-51.79808571428569,&quot;y&quot;:-17.814971428571436},{&quot;x&quot;:-25,&quot;y&quot;:-85.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Smoothing&quot;:{&quot;type&quot;:&quot;CATMULL_SMOOTHING&quot;,&quot;smoothing&quot;:0.2},&quot;pathMarkers&quot;:{&quot;markerStart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,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b5f97cd-db4d-4dae-bbb0-2a539bcf7a97&quot;,&quot;order&quot;:&quot;9999999998&quot;},&quot;connectorInfo&quot;:{&quot;connectedObjects&quot;:[{&quot;objectId&quot;:&quot;4b1f11dc-ae4f-42e4-a3c8-70911f112034&quot;,&quot;coordinates&quot;:{&quot;x&quot;:1,&quot;y&quot;:0}}],&quot;type&quot;:&quot;QUADRATIC&quot;,&quot;offset&quot;:{&quot;x&quot;:0,&quot;y&quot;:0},&quot;bending&quot;:-0.1,&quot;firstElementIsHead&quot;:true,&quot;customized&quot;:true}},&quot;d14fc1aa-4549-41dc-8421-fb39debc74f3&quot;:{&quot;id&quot;:&quot;d14fc1aa-4549-41dc-8421-fb39debc74f3&quot;,&quot;name&quot;:&quot;Whitefly (lateral)&quot;,&quot;displayName&quot;:&quot;&quot;,&quot;type&quot;:&quot;FIGURE_OBJECT&quot;,&quot;relativeTransform&quot;:{&quot;translate&quot;:{&quot;x&quot;:-113.74297291407441,&quot;y&quot;:66.26156305209933},&quot;rotate&quot;:0.23726853553558666,&quot;skewX&quot;:0,&quot;scale&quot;:{&quot;x&quot;:0.28252629329503187,&quot;y&quot;:0.28252629329503187}},&quot;image&quot;:{&quot;url&quot;:&quot;https://icons.biorender.com/biorender/5e30515c86d7a60028da0f5a/20200128152314/image/whitefly-lateral.png&quot;,&quot;fallbackUrl&quot;:&quot;https://res.cloudinary.com/dlcjuc3ej/image/upload/v1580224994/rtolt1jips2dy0fmmequ.svg#/keystone/api/icons/5e30515c86d7a60028da0f5a/20200128152314/image/whitefly-lateral.svg&quot;,&quot;isPremium&quot;:false,&quot;size&quot;:{&quot;x&quot;:200,&quot;y&quot;:101.63934426229508}},&quot;source&quot;:{&quot;id&quot;:&quot;5e30515c86d7a60028da0f5a&quot;,&quot;type&quot;:&quot;ASSETS&quot;},&quot;isPremium&quot;:false,&quot;parent&quot;:{&quot;type&quot;:&quot;CHILD&quot;,&quot;parentId&quot;:&quot;8b5f97cd-db4d-4dae-bbb0-2a539bcf7a97&quot;,&quot;order&quot;:&quot;9999999999&quot;}},&quot;2256d90e-2c0b-4537-85ab-ae6f5a77e958&quot;:{&quot;id&quot;:&quot;2256d90e-2c0b-4537-85ab-ae6f5a77e958&quot;,&quot;name&quot;:&quot;Whitefly (lateral)&quot;,&quot;displayName&quot;:&quot;&quot;,&quot;type&quot;:&quot;FIGURE_OBJECT&quot;,&quot;relativeTransform&quot;:{&quot;translate&quot;:{&quot;x&quot;:-73.74297291407433,&quot;y&quot;:-39.00043694790062},&quot;rotate&quot;:5.538789924515051,&quot;skewX&quot;:0,&quot;scale&quot;:{&quot;x&quot;:-0.28252629329503187,&quot;y&quot;:0.28252629329503176}},&quot;image&quot;:{&quot;url&quot;:&quot;https://icons.biorender.com/biorender/5e30515c86d7a60028da0f5a/20200128152314/image/whitefly-lateral.png&quot;,&quot;fallbackUrl&quot;:&quot;https://res.cloudinary.com/dlcjuc3ej/image/upload/v1580224994/rtolt1jips2dy0fmmequ.svg#/keystone/api/icons/5e30515c86d7a60028da0f5a/20200128152314/image/whitefly-lateral.svg&quot;,&quot;isPremium&quot;:false,&quot;size&quot;:{&quot;x&quot;:200,&quot;y&quot;:101.63934426229508}},&quot;source&quot;:{&quot;id&quot;:&quot;5e30515c86d7a60028da0f5a&quot;,&quot;type&quot;:&quot;ASSETS&quot;},&quot;isPremium&quot;:false,&quot;parent&quot;:{&quot;type&quot;:&quot;CHILD&quot;,&quot;parentId&quot;:&quot;8b5f97cd-db4d-4dae-bbb0-2a539bcf7a97&quot;,&quot;order&quot;:&quot;99999999995&quot;}},&quot;c935f50d-531d-4af4-96f6-22ea2fe65607&quot;:{&quot;id&quot;:&quot;c935f50d-531d-4af4-96f6-22ea2fe65607&quot;,&quot;name&quot;:&quot;Coccus&quot;,&quot;displayName&quot;:&quot;&quot;,&quot;type&quot;:&quot;FIGURE_OBJECT&quot;,&quot;relativeTransform&quot;:{&quot;translate&quot;:{&quot;x&quot;:-63.57900000000001,&quot;y&quot;:-47.000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97&quot;}},&quot;8baa8c73-acda-4d23-9cc9-56832b50434a&quot;:{&quot;id&quot;:&quot;8baa8c73-acda-4d23-9cc9-56832b50434a&quot;,&quot;name&quot;:&quot;Coccus&quot;,&quot;displayName&quot;:&quot;&quot;,&quot;type&quot;:&quot;FIGURE_OBJECT&quot;,&quot;relativeTransform&quot;:{&quot;translate&quot;:{&quot;x&quot;:-73.743,&quot;y&quot;:-49.000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98&quot;}},&quot;b9449264-8be0-4415-94dc-a40db6aa0c62&quot;:{&quot;id&quot;:&quot;b9449264-8be0-4415-94dc-a40db6aa0c62&quot;,&quot;name&quot;:&quot;Whitefly (lateral)&quot;,&quot;displayName&quot;:&quot;&quot;,&quot;type&quot;:&quot;FIGURE_OBJECT&quot;,&quot;relativeTransform&quot;:{&quot;translate&quot;:{&quot;x&quot;:-209.57897291407434,&quot;y&quot;:-98.59743694790063},&quot;rotate&quot;:5.538789924515051,&quot;skewX&quot;:0,&quot;scale&quot;:{&quot;x&quot;:-0.28252629329503187,&quot;y&quot;:0.28252629329503176}},&quot;image&quot;:{&quot;url&quot;:&quot;https://icons.biorender.com/biorender/5e30515c86d7a60028da0f5a/20200128152314/image/whitefly-lateral.png&quot;,&quot;fallbackUrl&quot;:&quot;https://res.cloudinary.com/dlcjuc3ej/image/upload/v1580224994/rtolt1jips2dy0fmmequ.svg#/keystone/api/icons/5e30515c86d7a60028da0f5a/20200128152314/image/whitefly-lateral.svg&quot;,&quot;isPremium&quot;:false,&quot;size&quot;:{&quot;x&quot;:200,&quot;y&quot;:101.63934426229508}},&quot;source&quot;:{&quot;id&quot;:&quot;5e30515c86d7a60028da0f5a&quot;,&quot;type&quot;:&quot;ASSETS&quot;},&quot;isPremium&quot;:false,&quot;parent&quot;:{&quot;type&quot;:&quot;CHILD&quot;,&quot;parentId&quot;:&quot;8b5f97cd-db4d-4dae-bbb0-2a539bcf7a97&quot;,&quot;order&quot;:&quot;99999999999&quot;}},&quot;c9c3962a-77a1-495c-9456-402c3a7e6f3b&quot;:{&quot;id&quot;:&quot;c9c3962a-77a1-495c-9456-402c3a7e6f3b&quot;,&quot;name&quot;:&quot;Coccus&quot;,&quot;displayName&quot;:&quot;&quot;,&quot;type&quot;:&quot;FIGURE_OBJECT&quot;,&quot;relativeTransform&quot;:{&quot;translate&quot;:{&quot;x&quot;:-200,&quot;y&quot;:-107.571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995&quot;}},&quot;3306f241-b406-4900-baa8-b7c1db13cd90&quot;:{&quot;id&quot;:&quot;3306f241-b406-4900-baa8-b7c1db13cd90&quot;,&quot;name&quot;:&quot;Coccus&quot;,&quot;displayName&quot;:&quot;&quot;,&quot;type&quot;:&quot;FIGURE_OBJECT&quot;,&quot;relativeTransform&quot;:{&quot;translate&quot;:{&quot;x&quot;:-209.579,&quot;y&quot;:-99.571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997&quot;}},&quot;7576c340-83b1-42e0-af43-0f1ea1ae70bd&quot;:{&quot;type&quot;:&quot;FIGURE_OBJECT&quot;,&quot;id&quot;:&quot;7576c340-83b1-42e0-af43-0f1ea1ae70bd&quot;,&quot;relativeTransform&quot;:{&quot;translate&quot;:{&quot;x&quot;:-114.86676328806129,&quot;y&quot;:-1.0029706110557761},&quot;rotate&quot;:0,&quot;skewX&quot;:0,&quot;scale&quot;:{&quot;x&quot;:1,&quot;y&quot;:1}},&quot;layout&quot;:{&quot;sizeRatio&quot;:{&quot;x&quot;:0.88,&quot;y&quot;:0.88},&quot;keepAspectRatio&quot;:true},&quot;opacity&quot;:1,&quot;path&quot;:{&quot;type&quot;:&quot;ELLIPSE&quot;,&quot;size&quot;:{&quot;x&quot;:21.33078012502493,&quot;y&quot;:21.330780125024905}},&quot;pathStyles&quot;:[{&quot;type&quot;:&quot;FILL&quot;,&quot;fillStyle&quot;:&quot;rgba(255,255,255,1)&quot;},{&quot;type&quot;:&quot;STROKE&quot;,&quot;strokeStyle&quot;:&quot;rgba(0,0,0,1)&quot;,&quot;lineWidth&quot;:1.422052008334994,&quot;lineJoin&quot;:&quot;round&quot;}],&quot;isLocked&quot;:false,&quot;parent&quot;:{&quot;type&quot;:&quot;CHILD&quot;,&quot;parentId&quot;:&quot;ceb8ad80-6cf4-487e-abe0-015904b52ca8&quot;,&quot;order&quot;:&quot;999999999999999999&quot;}},&quot;3b71ca34-f895-410d-9a94-111dd0c315bc&quot;:{&quot;type&quot;:&quot;FIGURE_OBJECT&quot;,&quot;id&quot;:&quot;3b71ca34-f895-410d-9a94-111dd0c315bc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4,&quot;color&quot;:&quot;black&quot;,&quot;fontWeight&quot;:&quot;normal&quot;,&quot;fontStyle&quot;:&quot;normal&quot;,&quot;decoration&quot;:&quot;none&quot;,&quot;script&quot;:&quot;none&quot;},&quot;range&quot;:[0,0]}],&quot;text&quot;:&quot;5&quot;}],&quot;verticalAlign&quot;:&quot;TOP&quot;,&quot;_lastCaretLocation&quot;:{&quot;lineIndex&quot;:0,&quot;runIndex&quot;:-1,&quot;charIndex&quot;:-1,&quot;endOfLine&quot;:true}},&quot;size&quot;:{&quot;x&quot;:18.145383626354516,&quot;y&quot;:16},&quot;targetSize&quot;:{&quot;x&quot;:15.877210673060201,&quot;y&quot;:2},&quot;format&quot;:&quot;BETTER_TEXT&quot;,&quot;verticalAlign&quot;:&quot;TOP&quot;},&quot;parent&quot;:{&quot;type&quot;:&quot;CHILD&quot;,&quot;parentId&quot;:&quot;7576c340-83b1-42e0-af43-0f1ea1ae70bd&quot;,&quot;order&quot;:&quot;5&quot;}},&quot;e66517c3-f168-483b-a050-c78851902bae&quot;:{&quot;id&quot;:&quot;e66517c3-f168-483b-a050-c78851902bae&quot;,&quot;type&quot;:&quot;FIGURE_OBJECT&quot;,&quot;relativeTransform&quot;:{&quot;translate&quot;:{&quot;x&quot;:55.5,&quot;y&quot;:6.159999999999997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6,&quot;color&quot;:&quot;black&quot;,&quot;fontWeight&quot;:&quot;normal&quot;,&quot;fontStyle&quot;:&quot;normal&quot;,&quot;decoration&quot;:&quot;none&quot;},&quot;range&quot;:[0,55]}],&quot;text&quot;:&quot;Uninfected insect vectors acquire pathogen when feeding.&quot;,&quot;baseStyle&quot;:{&quot;fontFamily&quot;:&quot;Roboto&quot;,&quot;fontSize&quot;:16,&quot;color&quot;:&quot;black&quot;,&quot;fontWeight&quot;:&quot;normal&quot;,&quot;fontStyle&quot;:&quot;normal&quot;,&quot;decoration&quot;:&quot;none&quot;,&quot;script&quot;:&quot;none&quot;}}],&quot;_lastCaretLocation&quot;:{&quot;lineIndex&quot;:0,&quot;runIndex&quot;:0,&quot;charIndex&quot;:55}},&quot;format&quot;:&quot;BETTER_TEXT&quot;,&quot;size&quot;:{&quot;x&quot;:119,&quot;y&quot;:91.32},&quot;targetSize&quot;:{&quot;x&quot;:119,&quot;y&quot;:40}},&quot;parent&quot;:{&quot;type&quot;:&quot;CHILD&quot;,&quot;parentId&quot;:&quot;8b5f97cd-db4d-4dae-bbb0-2a539bcf7a97&quot;,&quot;order&quot;:&quot;999999999998&quot;}}}}"/>
    <we:property name="653ff98195bceb0adf7c4a2b_1713293003648" value="{&quot;id&quot;:&quot;29624460-9e29-43ed-9fa1-df39a86059b0&quot;,&quot;objects&quot;:{&quot;29624460-9e29-43ed-9fa1-df39a86059b0&quot;:{&quot;id&quot;:&quot;29624460-9e29-43ed-9fa1-df39a86059b0&quot;,&quot;type&quot;:&quot;FIGURE_OBJECT&quot;,&quot;document&quot;:{&quot;type&quot;:&quot;DOCUMENT_GROUP&quot;,&quot;canvasType&quot;:&quot;FIGURE&quot;,&quot;units&quot;:&quot;in&quot;}},&quot;ac6bbc99-dab5-4198-8172-3bf6cecd2fed&quot;:{&quot;id&quot;:&quot;ac6bbc99-dab5-4198-8172-3bf6cecd2fe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29624460-9e29-43ed-9fa1-df39a86059b0&quot;,&quot;type&quot;:&quot;FRAME&quot;,&quot;order&quot;:&quot;5&quot;}},&quot;8b5f97cd-db4d-4dae-bbb0-2a539bcf7a97&quot;:{&quot;id&quot;:&quot;8b5f97cd-db4d-4dae-bbb0-2a539bcf7a97&quot;,&quot;type&quot;:&quot;FIGURE_OBJECT&quot;,&quot;document&quot;:{&quot;type&quot;:&quot;FIGURE&quot;,&quot;canvasType&quot;:&quot;FIGURE&quot;,&quot;units&quot;:&quot;in&quot;},&quot;parent&quot;:{&quot;parentId&quot;:&quot;29624460-9e29-43ed-9fa1-df39a86059b0&quot;,&quot;type&quot;:&quot;DOCUMENT&quot;,&quot;order&quot;:&quot;5&quot;}},&quot;0ca9b0a6-6b17-45be-8b3e-d3d79b4820f5&quot;:{&quot;id&quot;:&quot;0ca9b0a6-6b17-45be-8b3e-d3d79b4820f5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8b5f97cd-db4d-4dae-bbb0-2a539bcf7a97&quot;,&quot;order&quot;:&quot;5&quot;}},&quot;17cbdaff-6280-4f44-b0b6-13176af82a1b&quot;:{&quot;id&quot;:&quot;17cbdaff-6280-4f44-b0b6-13176af82a1b&quot;,&quot;type&quot;:&quot;FIGURE_OBJECT&quot;,&quot;guide&quot;:{&quot;type&quot;:&quot;GRID&quot;,&quot;distance&quot;:0.5,&quot;units&quot;:&quot;in&quot;},&quot;parent&quot;:{&quot;parentId&quot;:&quot;29624460-9e29-43ed-9fa1-df39a86059b0&quot;,&quot;type&quot;:&quot;GUIDE&quot;,&quot;order&quot;:&quot;5&quot;}},&quot;945eb1a3-ad5c-44af-81d0-75d0f718ab83&quot;:{&quot;type&quot;:&quot;FIGURE_OBJECT&quot;,&quot;id&quot;:&quot;945eb1a3-ad5c-44af-81d0-75d0f718ab83&quot;,&quot;parent&quot;:{&quot;type&quot;:&quot;CHILD&quot;,&quot;parentId&quot;:&quot;8b5f97cd-db4d-4dae-bbb0-2a539bcf7a97&quot;,&quot;order&quot;:&quot;3&quot;},&quot;relativeTransform&quot;:{&quot;translate&quot;:{&quot;x&quot;:48.742182653621505,&quot;y&quot;:-10.67120833350068},&quot;rotate&quot;:0,&quot;skewX&quot;:0,&quot;scale&quot;:{&quot;x&quot;:1,&quot;y&quot;:1}}},&quot;2b96e7da-8f1c-48cc-bc9a-202f67b2b789&quot;:{&quot;type&quot;:&quot;FIGURE_OBJECT&quot;,&quot;id&quot;:&quot;2b96e7da-8f1c-48cc-bc9a-202f67b2b789&quot;,&quot;relativeTransform&quot;:{&quot;translate&quot;:{&quot;x&quot;:-48.381584821272845,&quot;y&quot;:36.455949651133146},&quot;rotate&quot;:0},&quot;opacity&quot;:1,&quot;path&quot;:{&quot;type&quot;:&quot;ARC&quot;,&quot;size&quot;:{&quot;x&quot;:359.6230159764342,&quot;y&quot;:359.6230159764341},&quot;startAngle&quot;:-2.4716275318836325,&quot;sweepAngle&quot;:0.4263194518520965,&quot;selectedObjectIds&quot;:[&quot;fed43b8d-6ac7-4aa7-81fd-3807a75aa3c4&quot;]},&quot;pathStyles&quot;:[{&quot;type&quot;:&quot;FILL&quot;,&quot;fillStyle&quot;:&quot;rgba(0,0,0,0)&quot;},{&quot;type&quot;:&quot;STROKE&quot;,&quot;strokeStyle&quot;:&quot;#232323&quot;,&quot;lineWidth&quot;:2.077193896850261,&quot;lineJoin&quot;:&quot;round&quot;}],&quot;isLocked&quot;:false,&quot;parent&quot;:{&quot;type&quot;:&quot;CHILD&quot;,&quot;parentId&quot;:&quot;945eb1a3-ad5c-44af-81d0-75d0f718ab83&quot;,&quot;order&quot;:&quot;2&quot;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},&quot;8dffc87a-81e6-4c88-9d7e-92a261f70a83&quot;:{&quot;type&quot;:&quot;FIGURE_OBJECT&quot;,&quot;id&quot;:&quot;8dffc87a-81e6-4c88-9d7e-92a261f70a83&quot;,&quot;relativeTransform&quot;:{&quot;translate&quot;:{&quot;x&quot;:-48.381584821272845,&quot;y&quot;:36.455949651133146},&quot;rotate&quot;:0},&quot;opacity&quot;:1,&quot;path&quot;:{&quot;type&quot;:&quot;ARC&quot;,&quot;size&quot;:{&quot;x&quot;:359.6230159764342,&quot;y&quot;:359.6230159764341},&quot;startAngle&quot;:-1.0911364310986518,&quot;sweepAngle&quot;:0.4277984597039506,&quot;selectedObjectIds&quot;:[&quot;1f251a76-c18e-445d-ad62-dbe600a1f62c&quot;]},&quot;pathStyles&quot;:[{&quot;type&quot;:&quot;STROKE&quot;,&quot;strokeStyle&quot;:&quot;#232323&quot;,&quot;lineWidth&quot;:2.077193896850261,&quot;lineJoin&quot;:&quot;round&quot;},{&quot;type&quot;:&quot;FILL&quot;,&quot;fillStyle&quot;:&quot;rgba(0,0,0,0)&quot;}],&quot;isLocked&quot;:false,&quot;parent&quot;:{&quot;type&quot;:&quot;CHILD&quot;,&quot;parentId&quot;:&quot;945eb1a3-ad5c-44af-81d0-75d0f718ab83&quot;,&quot;order&quot;:&quot;4&quot;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},&quot;f8c9ce1c-61a0-4c27-9f60-a7c11f6f8e0d&quot;:{&quot;type&quot;:&quot;FIGURE_OBJECT&quot;,&quot;id&quot;:&quot;f8c9ce1c-61a0-4c27-9f60-a7c11f6f8e0d&quot;,&quot;relativeTransform&quot;:{&quot;translate&quot;:{&quot;x&quot;:-48.381584821272845,&quot;y&quot;:36.455949651133146},&quot;rotate&quot;:0},&quot;opacity&quot;:1,&quot;path&quot;:{&quot;type&quot;:&quot;ARC&quot;,&quot;size&quot;:{&quot;x&quot;:359.6230159764342,&quot;y&quot;:359.6230159764341},&quot;startAngle&quot;:2.7966851869450666,&quot;sweepAngle&quot;:0.3008793584557887,&quot;selectedObjectIds&quot;:[&quot;038abb91-74a2-4f1f-a5fa-7ef874c0d6d5&quot;]},&quot;pathStyles&quot;:[{&quot;type&quot;:&quot;STROKE&quot;,&quot;strokeStyle&quot;:&quot;#232323&quot;,&quot;lineWidth&quot;:2.077193896850261,&quot;lineJoin&quot;:&quot;round&quot;},{&quot;type&quot;:&quot;FILL&quot;,&quot;fillStyle&quot;:&quot;rgba(0,0,0,0)&quot;}],&quot;isLocked&quot;:false,&quot;parent&quot;:{&quot;type&quot;:&quot;CHILD&quot;,&quot;parentId&quot;:&quot;945eb1a3-ad5c-44af-81d0-75d0f718ab83&quot;,&quot;order&quot;:&quot;7&quot;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},&quot;6d8f118f-4f45-4d70-b93e-da67297216a5&quot;:{&quot;type&quot;:&quot;FIGURE_OBJECT&quot;,&quot;id&quot;:&quot;6d8f118f-4f45-4d70-b93e-da67297216a5&quot;,&quot;relativeTransform&quot;:{&quot;translate&quot;:{&quot;x&quot;:-48.381584821272845,&quot;y&quot;:36.455949651133146},&quot;rotate&quot;:0},&quot;opacity&quot;:1,&quot;path&quot;:{&quot;type&quot;:&quot;ARC&quot;,&quot;size&quot;:{&quot;x&quot;:359.6230159764342,&quot;y&quot;:359.6230159764341},&quot;startAngle&quot;:0.03832930893094516,&quot;sweepAngle&quot;:0.304551386248737,&quot;selectedObjectIds&quot;:[&quot;66552c21-5815-4995-b750-8a8a4f25ca8e&quot;]},&quot;pathStyles&quot;:[{&quot;type&quot;:&quot;STROKE&quot;,&quot;strokeStyle&quot;:&quot;#232323&quot;,&quot;lineWidth&quot;:2.077193896850261,&quot;lineJoin&quot;:&quot;round&quot;},{&quot;type&quot;:&quot;FILL&quot;,&quot;fillStyle&quot;:&quot;rgba(0,0,0,0)&quot;}],&quot;isLocked&quot;:false,&quot;parent&quot;:{&quot;type&quot;:&quot;CHILD&quot;,&quot;parentId&quot;:&quot;945eb1a3-ad5c-44af-81d0-75d0f718ab83&quot;,&quot;order&quot;:&quot;5&quot;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},&quot;331d7b38-ca43-4f8d-bd83-438ba64fac88&quot;:{&quot;type&quot;:&quot;FIGURE_OBJECT&quot;,&quot;id&quot;:&quot;331d7b38-ca43-4f8d-bd83-438ba64fac88&quot;,&quot;relativeTransform&quot;:{&quot;translate&quot;:{&quot;x&quot;:-48.381584821272845,&quot;y&quot;:36.455949651133146},&quot;rotate&quot;:0},&quot;opacity&quot;:1,&quot;path&quot;:{&quot;type&quot;:&quot;ARC&quot;,&quot;size&quot;:{&quot;x&quot;:359.6230159764342,&quot;y&quot;:359.6230159764341},&quot;startAngle&quot;:1.1383179659587481,&quot;sweepAngle&quot;:0.8367116580546652,&quot;selectedObjectIds&quot;:[&quot;ff18759b-23cf-4459-9496-a957e9f4418b&quot;]},&quot;pathStyles&quot;:[{&quot;type&quot;:&quot;STROKE&quot;,&quot;strokeStyle&quot;:&quot;#232323&quot;,&quot;lineWidth&quot;:2.077193896850261,&quot;lineJoin&quot;:&quot;round&quot;},{&quot;type&quot;:&quot;FILL&quot;,&quot;fillStyle&quot;:&quot;rgba(0,0,0,0)&quot;}],&quot;isLocked&quot;:false,&quot;parent&quot;:{&quot;type&quot;:&quot;CHILD&quot;,&quot;parentId&quot;:&quot;945eb1a3-ad5c-44af-81d0-75d0f718ab83&quot;,&quot;order&quot;:&quot;6&quot;}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},&quot;0425b773-4b30-4508-9168-614e7d1afdcf&quot;:{&quot;id&quot;:&quot;0425b773-4b30-4508-9168-614e7d1afdcf&quot;,&quot;name&quot;:&quot;Tomato plant (wilted)&quot;,&quot;displayName&quot;:&quot;&quot;,&quot;type&quot;:&quot;FIGURE_OBJECT&quot;,&quot;relativeTransform&quot;:{&quot;translate&quot;:{&quot;x&quot;:-191.30708661417322,&quot;y&quot;:-42.000000000000014},&quot;rotate&quot;:0,&quot;skewX&quot;:0,&quot;scale&quot;:{&quot;x&quot;:0.4892388451443571,&quot;y&quot;:0.4892388451443571}},&quot;image&quot;:{&quot;url&quot;:&quot;https://icons.biorender.com/biorender/6536c86b816dc5a1c72aadb5/20231023192547/image/tomato-plant-wilted.png&quot;,&quot;fallbackUrl&quot;:&quot;https://res.cloudinary.com/dlcjuc3ej/image/upload/v1698089147/yrqufh9xxpik9t2z9xjz.svg#/keystone/api/icons/6536c86b816dc5a1c72aadb5/20231023192547/image/tomato-plant-wilted.svg&quot;,&quot;isPremium&quot;:true,&quot;size&quot;:{&quot;x&quot;:150,&quot;y&quot;:272.14285714285717}},&quot;source&quot;:{&quot;id&quot;:&quot;6536c86b816dc5a1c72aadb5&quot;,&quot;type&quot;:&quot;ASSETS&quot;},&quot;isPremium&quot;:true,&quot;parent&quot;:{&quot;type&quot;:&quot;CHILD&quot;,&quot;parentId&quot;:&quot;8b5f97cd-db4d-4dae-bbb0-2a539bcf7a97&quot;,&quot;order&quot;:&quot;7&quot;}},&quot;1c8b1c14-a845-49b7-9811-345e47c4cbf1&quot;:{&quot;id&quot;:&quot;1c8b1c14-a845-49b7-9811-345e47c4cbf1&quot;,&quot;name&quot;:&quot;Tomato (young plant)&quot;,&quot;displayName&quot;:&quot;&quot;,&quot;type&quot;:&quot;FIGURE_OBJECT&quot;,&quot;relativeTransform&quot;:{&quot;translate&quot;:{&quot;x&quot;:-2.5789999999999917,&quot;y&quot;:-143.5},&quot;rotate&quot;:0,&quot;skewX&quot;:0,&quot;scale&quot;:{&quot;x&quot;:1.14,&quot;y&quot;:1.14}},&quot;image&quot;:{&quot;url&quot;:&quot;https://icons.biorender.com/biorender/648b3ce6c5ed7f002049b7f7/20230616135452/image/tomato-young-plant-01.png&quot;,&quot;fallbackUrl&quot;:&quot;https://res.cloudinary.com/dlcjuc3ej/image/upload/v1686923692/rkyrynaayxvjxz9ewuuz.svg#/keystone/api/icons/648b3ce6c5ed7f002049b7f7/20230616135452/image/tomato-young-plant-01.svg#/keystone/api/icons/648b3ce6c5ed7f002049b7f7/20230616135452/image/tomato-young-plant-01.svg#/keystone/api/icons/648b3ce6c5ed7f002049b7f7/20230616135452/image/tomato-young-plant-01.svg&quot;,&quot;isPremium&quot;:false,&quot;size&quot;:{&quot;x&quot;:100,&quot;y&quot;:135.71428571428572}},&quot;source&quot;:{&quot;id&quot;:&quot;648b3ce6c5ed7f002049b7f7&quot;,&quot;type&quot;:&quot;ASSETS&quot;},&quot;isPremium&quot;:false,&quot;parent&quot;:{&quot;type&quot;:&quot;CHILD&quot;,&quot;parentId&quot;:&quot;8b5f97cd-db4d-4dae-bbb0-2a539bcf7a97&quot;,&quot;order&quot;:&quot;8&quot;}},&quot;b9e4bff9-3639-4950-ac0c-317fe942a859&quot;:{&quot;id&quot;:&quot;b9e4bff9-3639-4950-ac0c-317fe942a859&quot;,&quot;name&quot;:&quot;Whitefly (lateral)&quot;,&quot;displayName&quot;:&quot;&quot;,&quot;type&quot;:&quot;FIGURE_OBJECT&quot;,&quot;relativeTransform&quot;:{&quot;translate&quot;:{&quot;x&quot;:43.22702708592559,&quot;y&quot;:-175.25643694790065},&quot;rotate&quot;:0.23726853553558666,&quot;skewX&quot;:0,&quot;scale&quot;:{&quot;x&quot;:0.28252629329503187,&quot;y&quot;:0.28252629329503187}},&quot;image&quot;:{&quot;url&quot;:&quot;https://icons.biorender.com/biorender/5e30515c86d7a60028da0f5a/20200128152314/image/whitefly-lateral.png&quot;,&quot;fallbackUrl&quot;:&quot;https://res.cloudinary.com/dlcjuc3ej/image/upload/v1580224994/rtolt1jips2dy0fmmequ.svg#/keystone/api/icons/5e30515c86d7a60028da0f5a/20200128152314/image/whitefly-lateral.svg&quot;,&quot;isPremium&quot;:false,&quot;size&quot;:{&quot;x&quot;:200,&quot;y&quot;:101.63934426229508}},&quot;source&quot;:{&quot;id&quot;:&quot;5e30515c86d7a60028da0f5a&quot;,&quot;type&quot;:&quot;ASSETS&quot;},&quot;isPremium&quot;:false,&quot;parent&quot;:{&quot;type&quot;:&quot;CHILD&quot;,&quot;parentId&quot;:&quot;8b5f97cd-db4d-4dae-bbb0-2a539bcf7a97&quot;,&quot;order&quot;:&quot;9&quot;}},&quot;628dce30-0390-4c0e-9fe9-acf5184163b4&quot;:{&quot;id&quot;:&quot;628dce30-0390-4c0e-9fe9-acf5184163b4&quot;,&quot;name&quot;:&quot;Sieve element&quot;,&quot;displayName&quot;:&quot;&quot;,&quot;type&quot;:&quot;FIGURE_OBJECT&quot;,&quot;relativeTransform&quot;:{&quot;translate&quot;:{&quot;x&quot;:183.24861363636361,&quot;y&quot;:-49},&quot;rotate&quot;:0,&quot;skewX&quot;:0,&quot;scale&quot;:{&quot;x&quot;:0.5632102272727273,&quot;y&quot;:0.5632102272727273}},&quot;image&quot;:{&quot;url&quot;:&quot;https://icons.biorender.com/biorender/60a54f725feb3b00281478ba/20210519175451/image/sieve-element.png&quot;,&quot;fallbackUrl&quot;:&quot;https://res.cloudinary.com/dlcjuc3ej/image/upload/v1621446891/yspzgpiukckygg6btrnk.svg#/keystone/api/icons/60a54f725feb3b00281478ba/20210519175451/image/sieve-element.svg&quot;,&quot;isPremium&quot;:false,&quot;size&quot;:{&quot;x&quot;:120,&quot;y&quot;:281.6}},&quot;source&quot;:{&quot;id&quot;:&quot;60a54f725feb3b00281478ba&quot;,&quot;type&quot;:&quot;ASSETS&quot;},&quot;isPremium&quot;:false,&quot;parent&quot;:{&quot;type&quot;:&quot;CHILD&quot;,&quot;parentId&quot;:&quot;8b5f97cd-db4d-4dae-bbb0-2a539bcf7a97&quot;,&quot;order&quot;:&quot;95&quot;},&quot;styles&quot;:{&quot;vector-hidden&quot;:[{&quot;styleName&quot;:&quot;MONOCHROME_COLOR&quot;,&quot;index&quot;:0,&quot;color&quot;:&quot;#35A618&quot;}]}},&quot;d20fdcd0-8b47-488c-8d7b-8f29208c14a4&quot;:{&quot;id&quot;:&quot;d20fdcd0-8b47-488c-8d7b-8f29208c14a4&quot;,&quot;name&quot;:&quot;Sieve element&quot;,&quot;displayName&quot;:&quot;&quot;,&quot;type&quot;:&quot;FIGURE_OBJECT&quot;,&quot;relativeTransform&quot;:{&quot;translate&quot;:{&quot;x&quot;:115.6643636363636,&quot;y&quot;:156.429},&quot;rotate&quot;:0,&quot;skewX&quot;:0,&quot;scale&quot;:{&quot;x&quot;:0.6022727272727274,&quot;y&quot;:0.6022727272727274}},&quot;image&quot;:{&quot;url&quot;:&quot;https://icons.biorender.com/biorender/60a550ef5feb3b00281478bc/sieve-element.png&quot;,&quot;fallbackUrl&quot;:&quot;https://res.cloudinary.com/dlcjuc3ej/image/upload/v1621446891/wpe66ogmgnzz44hb2v1x.svg#/keystone/api/icons/60a550ef5feb3b00281478bc/sieve-element.svg&quot;,&quot;isPremium&quot;:false,&quot;size&quot;:{&quot;x&quot;:120,&quot;y&quot;:281.6}},&quot;source&quot;:{&quot;id&quot;:&quot;60a54f725feb3b00281478ba&quot;,&quot;type&quot;:&quot;ASSETS&quot;},&quot;isPremium&quot;:false,&quot;parent&quot;:{&quot;type&quot;:&quot;CHILD&quot;,&quot;parentId&quot;:&quot;8b5f97cd-db4d-4dae-bbb0-2a539bcf7a97&quot;,&quot;order&quot;:&quot;97&quot;}},&quot;2088d316-d705-40c3-a3bc-85832b6c716d&quot;:{&quot;id&quot;:&quot;2088d316-d705-40c3-a3bc-85832b6c716d&quot;,&quot;name&quot;:&quot;Coccus&quot;,&quot;displayName&quot;:&quot;&quot;,&quot;type&quot;:&quot;FIGURE_OBJECT&quot;,&quot;relativeTransform&quot;:{&quot;translate&quot;:{&quot;x&quot;:194,&quot;y&quot;:-83.57100000000001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8&quot;}},&quot;0189d6b5-a383-4211-b762-ff1bae264f25&quot;:{&quot;id&quot;:&quot;0189d6b5-a383-4211-b762-ff1bae264f25&quot;,&quot;name&quot;:&quot;Coccus&quot;,&quot;displayName&quot;:&quot;&quot;,&quot;type&quot;:&quot;FIGURE_OBJECT&quot;,&quot;relativeTransform&quot;:{&quot;translate&quot;:{&quot;x&quot;:202,&quot;y&quot;:-42.000000000000014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&quot;}},&quot;14f5515c-b69d-4c72-9083-7caa00591c27&quot;:{&quot;id&quot;:&quot;14f5515c-b69d-4c72-9083-7caa00591c27&quot;,&quot;name&quot;:&quot;Coccus&quot;,&quot;displayName&quot;:&quot;&quot;,&quot;type&quot;:&quot;FIGURE_OBJECT&quot;,&quot;relativeTransform&quot;:{&quot;translate&quot;:{&quot;x&quot;:172,&quot;y&quot;:-21.571000000000012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5&quot;}},&quot;36b9a6a0-ac92-4f99-b835-657cd9b93e9c&quot;:{&quot;id&quot;:&quot;36b9a6a0-ac92-4f99-b835-657cd9b93e9c&quot;,&quot;name&quot;:&quot;Coccus&quot;,&quot;displayName&quot;:&quot;&quot;,&quot;type&quot;:&quot;FIGURE_OBJECT&quot;,&quot;relativeTransform&quot;:{&quot;translate&quot;:{&quot;x&quot;:108,&quot;y&quot;:201.529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7&quot;}},&quot;dae20d1e-7a4a-4474-8088-42060e151ac1&quot;:{&quot;id&quot;:&quot;dae20d1e-7a4a-4474-8088-42060e151ac1&quot;,&quot;name&quot;:&quot;Coccus&quot;,&quot;displayName&quot;:&quot;&quot;,&quot;type&quot;:&quot;FIGURE_OBJECT&quot;,&quot;relativeTransform&quot;:{&quot;translate&quot;:{&quot;x&quot;:129.664,&quot;y&quot;:214.42899999999997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8&quot;}},&quot;1ac9cac6-8464-4f7f-8112-e9392497426d&quot;:{&quot;id&quot;:&quot;1ac9cac6-8464-4f7f-8112-e9392497426d&quot;,&quot;name&quot;:&quot;Coccus&quot;,&quot;displayName&quot;:&quot;&quot;,&quot;type&quot;:&quot;FIGURE_OBJECT&quot;,&quot;relativeTransform&quot;:{&quot;translate&quot;:{&quot;x&quot;:100,&quot;y&quot;:188.42899999999997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&quot;}},&quot;399ef6ce-a301-462b-9e77-d7e97ad78915&quot;:{&quot;id&quot;:&quot;399ef6ce-a301-462b-9e77-d7e97ad78915&quot;,&quot;name&quot;:&quot;Coccus&quot;,&quot;displayName&quot;:&quot;&quot;,&quot;type&quot;:&quot;FIGURE_OBJECT&quot;,&quot;relativeTransform&quot;:{&quot;translate&quot;:{&quot;x&quot;:129.664,&quot;y&quot;:162.42899999999997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5&quot;}},&quot;4fc19dec-32f6-48c6-9d66-e8dbdb947b84&quot;:{&quot;id&quot;:&quot;4fc19dec-32f6-48c6-9d66-e8dbdb947b84&quot;,&quot;name&quot;:&quot;Coccus&quot;,&quot;displayName&quot;:&quot;&quot;,&quot;type&quot;:&quot;FIGURE_OBJECT&quot;,&quot;relativeTransform&quot;:{&quot;translate&quot;:{&quot;x&quot;:100,&quot;y&quot;:155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7&quot;}},&quot;4d9b6b15-815f-4a35-9515-2f189a594447&quot;:{&quot;id&quot;:&quot;4d9b6b15-815f-4a35-9515-2f189a594447&quot;,&quot;name&quot;:&quot;Coccus&quot;,&quot;displayName&quot;:&quot;&quot;,&quot;type&quot;:&quot;FIGURE_OBJECT&quot;,&quot;relativeTransform&quot;:{&quot;translate&quot;:{&quot;x&quot;:136,&quot;y&quot;:188.42899999999997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8&quot;}},&quot;f17db7e0-c188-4b53-8d76-13b64977feac&quot;:{&quot;id&quot;:&quot;f17db7e0-c188-4b53-8d76-13b64977feac&quot;,&quot;name&quot;:&quot;Coccus&quot;,&quot;displayName&quot;:&quot;&quot;,&quot;type&quot;:&quot;FIGURE_OBJECT&quot;,&quot;relativeTransform&quot;:{&quot;translate&quot;:{&quot;x&quot;:129.664,&quot;y&quot;:100.42899999999999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&quot;}},&quot;6560f204-2419-4ee6-9e37-d3aeb8d28818&quot;:{&quot;id&quot;:&quot;6560f204-2419-4ee6-9e37-d3aeb8d28818&quot;,&quot;name&quot;:&quot;Coccus&quot;,&quot;displayName&quot;:&quot;&quot;,&quot;type&quot;:&quot;FIGURE_OBJECT&quot;,&quot;relativeTransform&quot;:{&quot;translate&quot;:{&quot;x&quot;:115.66399999999999,&quot;y&quot;:124.42899999999999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5&quot;}},&quot;a797c331-73f4-4bf2-9fa9-d2f7f2adc8bf&quot;:{&quot;id&quot;:&quot;a797c331-73f4-4bf2-9fa9-d2f7f2adc8bf&quot;,&quot;name&quot;:&quot;Coccus&quot;,&quot;displayName&quot;:&quot;&quot;,&quot;type&quot;:&quot;FIGURE_OBJECT&quot;,&quot;relativeTransform&quot;:{&quot;translate&quot;:{&quot;x&quot;:100,&quot;y&quot;:100.42899999999999},&quot;rotate&quot;:0,&quot;skewX&quot;:0,&quot;scale&quot;:{&quot;x&quot;:0.2800000000000004,&quot;y&quot;:0.2800000000000004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7&quot;}},&quot;4b1f11dc-ae4f-42e4-a3c8-70911f112034&quot;:{&quot;id&quot;:&quot;4b1f11dc-ae4f-42e4-a3c8-70911f112034&quot;,&quot;name&quot;:&quot;Tomato (young plant)&quot;,&quot;displayName&quot;:&quot;&quot;,&quot;type&quot;:&quot;FIGURE_OBJECT&quot;,&quot;relativeTransform&quot;:{&quot;translate&quot;:{&quot;x&quot;:-140.57899999999998,&quot;y&quot;:156.94299999999998},&quot;rotate&quot;:0,&quot;skewX&quot;:0,&quot;scale&quot;:{&quot;x&quot;:1.14,&quot;y&quot;:1.14}},&quot;image&quot;:{&quot;url&quot;:&quot;https://icons.biorender.com/biorender/648b3ce6c5ed7f002049b7f7/20230616135452/image/tomato-young-plant-01.png&quot;,&quot;fallbackUrl&quot;:&quot;https://res.cloudinary.com/dlcjuc3ej/image/upload/v1686923692/rkyrynaayxvjxz9ewuuz.svg#/keystone/api/icons/648b3ce6c5ed7f002049b7f7/20230616135452/image/tomato-young-plant-01.svg#/keystone/api/icons/648b3ce6c5ed7f002049b7f7/20230616135452/image/tomato-young-plant-01.svg#/keystone/api/icons/648b3ce6c5ed7f002049b7f7/20230616135452/image/tomato-young-plant-01.svg&quot;,&quot;isPremium&quot;:false,&quot;size&quot;:{&quot;x&quot;:100,&quot;y&quot;:135.71428571428572}},&quot;source&quot;:{&quot;id&quot;:&quot;648b3ce6c5ed7f002049b7f7&quot;,&quot;type&quot;:&quot;ASSETS&quot;},&quot;isPremium&quot;:false,&quot;parent&quot;:{&quot;type&quot;:&quot;CHILD&quot;,&quot;parentId&quot;:&quot;8b5f97cd-db4d-4dae-bbb0-2a539bcf7a97&quot;,&quot;order&quot;:&quot;99998&quot;}},&quot;180897d9-4bc5-476f-8cc3-ec213578f569&quot;:{&quot;id&quot;:&quot;180897d9-4bc5-476f-8cc3-ec213578f569&quot;,&quot;name&quot;:&quot;Coccus&quot;,&quot;displayName&quot;:&quot;&quot;,&quot;type&quot;:&quot;FIGURE_OBJECT&quot;,&quot;relativeTransform&quot;:{&quot;translate&quot;:{&quot;x&quot;:50.421,&quot;y&quot;:-183.256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&quot;}},&quot;0b2695e4-06c5-428f-af48-5ac909a8608b&quot;:{&quot;id&quot;:&quot;0b2695e4-06c5-428f-af48-5ac909a8608b&quot;,&quot;name&quot;:&quot;Coccus&quot;,&quot;displayName&quot;:&quot;&quot;,&quot;type&quot;:&quot;FIGURE_OBJECT&quot;,&quot;relativeTransform&quot;:{&quot;translate&quot;:{&quot;x&quot;:33,&quot;y&quot;:-175.256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5&quot;}},&quot;3113a3ad-5af6-45eb-9017-b8f74acf80e9&quot;:{&quot;id&quot;:&quot;3113a3ad-5af6-45eb-9017-b8f74acf80e9&quot;,&quot;name&quot;:&quot;Coccus&quot;,&quot;displayName&quot;:&quot;&quot;,&quot;type&quot;:&quot;FIGURE_OBJECT&quot;,&quot;relativeTransform&quot;:{&quot;translate&quot;:{&quot;x&quot;:-132.579,&quot;y&quot;:127.428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7&quot;}},&quot;91417bc7-c322-457c-9dcc-a49e150cbbd2&quot;:{&quot;id&quot;:&quot;91417bc7-c322-457c-9dcc-a49e150cbbd2&quot;,&quot;name&quot;:&quot;Coccus&quot;,&quot;displayName&quot;:&quot;&quot;,&quot;type&quot;:&quot;FIGURE_OBJECT&quot;,&quot;relativeTransform&quot;:{&quot;translate&quot;:{&quot;x&quot;:-140.579,&quot;y&quot;:116.428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8&quot;}},&quot;cf7c7f39-db4d-4337-81aa-923320e6f8a3&quot;:{&quot;id&quot;:&quot;cf7c7f39-db4d-4337-81aa-923320e6f8a3&quot;,&quot;name&quot;:&quot;Coccus&quot;,&quot;displayName&quot;:&quot;&quot;,&quot;type&quot;:&quot;FIGURE_OBJECT&quot;,&quot;relativeTransform&quot;:{&quot;translate&quot;:{&quot;x&quot;:-107,&quot;y&quot;:124.428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&quot;}},&quot;986ff17d-c9b2-424f-914c-8c9bc540d79f&quot;:{&quot;id&quot;:&quot;986ff17d-c9b2-424f-914c-8c9bc540d79f&quot;,&quot;name&quot;:&quot;Coccus&quot;,&quot;displayName&quot;:&quot;&quot;,&quot;type&quot;:&quot;FIGURE_OBJECT&quot;,&quot;relativeTransform&quot;:{&quot;translate&quot;:{&quot;x&quot;:-168,&quot;y&quot;:103.428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5&quot;}},&quot;921c11a9-f574-4abe-9aee-b2e2a271f7e2&quot;:{&quot;id&quot;:&quot;921c11a9-f574-4abe-9aee-b2e2a271f7e2&quot;,&quot;name&quot;:&quot;Coccus&quot;,&quot;displayName&quot;:&quot;&quot;,&quot;type&quot;:&quot;FIGURE_OBJECT&quot;,&quot;relativeTransform&quot;:{&quot;translate&quot;:{&quot;x&quot;:-115,&quot;y&quot;:165.99999999999994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7&quot;}},&quot;d550b143-0088-407e-a413-a483238e19f6&quot;:{&quot;id&quot;:&quot;d550b143-0088-407e-a413-a483238e19f6&quot;,&quot;name&quot;:&quot;Coccus&quot;,&quot;displayName&quot;:&quot;&quot;,&quot;type&quot;:&quot;FIGURE_OBJECT&quot;,&quot;relativeTransform&quot;:{&quot;translate&quot;:{&quot;x&quot;:-132.579,&quot;y&quot;:143.999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8&quot;}},&quot;2be22b21-65f0-40de-bb8f-8ce4d6f6bd22&quot;:{&quot;id&quot;:&quot;2be22b21-65f0-40de-bb8f-8ce4d6f6bd22&quot;,&quot;name&quot;:&quot;Coccus&quot;,&quot;displayName&quot;:&quot;&quot;,&quot;type&quot;:&quot;FIGURE_OBJECT&quot;,&quot;relativeTransform&quot;:{&quot;translate&quot;:{&quot;x&quot;:-168,&quot;y&quot;:143.999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&quot;}},&quot;7c505fc1-ce99-4b9d-a4ec-d2e3fcab54a1&quot;:{&quot;id&quot;:&quot;7c505fc1-ce99-4b9d-a4ec-d2e3fcab54a1&quot;,&quot;name&quot;:&quot;Coccus&quot;,&quot;displayName&quot;:&quot;&quot;,&quot;type&quot;:&quot;FIGURE_OBJECT&quot;,&quot;relativeTransform&quot;:{&quot;translate&quot;:{&quot;x&quot;:-168,&quot;y&quot;:-72.571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5&quot;}},&quot;a3ac4804-8ee5-4744-a1e1-d6aba7572060&quot;:{&quot;id&quot;:&quot;a3ac4804-8ee5-4744-a1e1-d6aba7572060&quot;,&quot;name&quot;:&quot;Coccus&quot;,&quot;displayName&quot;:&quot;&quot;,&quot;type&quot;:&quot;FIGURE_OBJECT&quot;,&quot;relativeTransform&quot;:{&quot;translate&quot;:{&quot;x&quot;:-176,&quot;y&quot;:-47.000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7&quot;}},&quot;9d03a8bb-748e-4e4e-b36b-d1772280a646&quot;:{&quot;id&quot;:&quot;9d03a8bb-748e-4e4e-b36b-d1772280a646&quot;,&quot;name&quot;:&quot;Coccus&quot;,&quot;displayName&quot;:&quot;&quot;,&quot;type&quot;:&quot;FIGURE_OBJECT&quot;,&quot;relativeTransform&quot;:{&quot;translate&quot;:{&quot;x&quot;:-209.579,&quot;y&quot;:-39.000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8&quot;}},&quot;90b26f8a-8a9e-4167-8057-f5c7ced39dfb&quot;:{&quot;id&quot;:&quot;90b26f8a-8a9e-4167-8057-f5c7ced39dfb&quot;,&quot;name&quot;:&quot;Coccus&quot;,&quot;displayName&quot;:&quot;&quot;,&quot;type&quot;:&quot;FIGURE_OBJECT&quot;,&quot;relativeTransform&quot;:{&quot;translate&quot;:{&quot;x&quot;:-100.57900000000001,&quot;y&quot;:156.428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&quot;}},&quot;e6f1891d-4251-482d-a057-b20e5b159b79&quot;:{&quot;id&quot;:&quot;e6f1891d-4251-482d-a057-b20e5b159b79&quot;,&quot;name&quot;:&quot;Coccus&quot;,&quot;displayName&quot;:&quot;&quot;,&quot;type&quot;:&quot;FIGURE_OBJECT&quot;,&quot;relativeTransform&quot;:{&quot;translate&quot;:{&quot;x&quot;:-90.57900000000001,&quot;y&quot;:166.42899999999997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5&quot;}},&quot;e1b5c5b0-b2fa-4aa7-b0aa-910dffdd89ec&quot;:{&quot;id&quot;:&quot;e1b5c5b0-b2fa-4aa7-b0aa-910dffdd89ec&quot;,&quot;name&quot;:&quot;Coccus&quot;,&quot;displayName&quot;:&quot;&quot;,&quot;type&quot;:&quot;FIGURE_OBJECT&quot;,&quot;relativeTransform&quot;:{&quot;translate&quot;:{&quot;x&quot;:-201.579,&quot;y&quot;:-83.571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7&quot;}},&quot;25bd227e-d28b-487b-b114-61cce0476e85&quot;:{&quot;id&quot;:&quot;25bd227e-d28b-487b-b114-61cce0476e85&quot;,&quot;name&quot;:&quot;Coccus&quot;,&quot;displayName&quot;:&quot;&quot;,&quot;type&quot;:&quot;FIGURE_OBJECT&quot;,&quot;relativeTransform&quot;:{&quot;translate&quot;:{&quot;x&quot;:-193.579,&quot;y&quot;:-49.000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8&quot;}},&quot;c70be399-54e8-45f6-82b9-2e4942e16519&quot;:{&quot;id&quot;:&quot;c70be399-54e8-45f6-82b9-2e4942e16519&quot;,&quot;name&quot;:&quot;Coccus&quot;,&quot;displayName&quot;:&quot;&quot;,&quot;type&quot;:&quot;FIGURE_OBJECT&quot;,&quot;relativeTransform&quot;:{&quot;translate&quot;:{&quot;x&quot;:-166,&quot;y&quot;:-37.000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&quot;}},&quot;ba38c0b7-00a8-414e-9d3d-a36e928f810d&quot;:{&quot;id&quot;:&quot;ba38c0b7-00a8-414e-9d3d-a36e928f810d&quot;,&quot;name&quot;:&quot;Coccus&quot;,&quot;displayName&quot;:&quot;&quot;,&quot;type&quot;:&quot;FIGURE_OBJECT&quot;,&quot;relativeTransform&quot;:{&quot;translate&quot;:{&quot;x&quot;:-184,&quot;y&quot;:-91.571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5&quot;}},&quot;1f867a01-d8e7-4b1d-a9e8-3b679c83f61b&quot;:{&quot;id&quot;:&quot;1f867a01-d8e7-4b1d-a9e8-3b679c83f61b&quot;,&quot;name&quot;:&quot;Coccus&quot;,&quot;displayName&quot;:&quot;&quot;,&quot;type&quot;:&quot;FIGURE_OBJECT&quot;,&quot;relativeTransform&quot;:{&quot;translate&quot;:{&quot;x&quot;:-192,&quot;y&quot;:-18.571000000000026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7&quot;}},&quot;13a9ca0c-2db9-4228-8eb1-7a86c2e3551a&quot;:{&quot;type&quot;:&quot;FIGURE_OBJECT&quot;,&quot;id&quot;:&quot;13a9ca0c-2db9-4228-8eb1-7a86c2e3551a&quot;,&quot;relativeTransform&quot;:{&quot;translate&quot;:{&quot;x&quot;:0,&quot;y&quot;:0},&quot;rotate&quot;:0,&quot;skewX&quot;:0,&quot;scale&quot;:{&quot;x&quot;:1,&quot;y&quot;:1}},&quot;opacity&quot;:1,&quot;path&quot;:{&quot;type&quot;:&quot;POLY_LINE&quot;,&quot;points&quot;:[{&quot;x&quot;:-83.57899999999998,&quot;y&quot;:79.58585714285712},{&quot;x&quot;:-51.79808571428569,&quot;y&quot;:-17.814971428571436},{&quot;x&quot;:-25,&quot;y&quot;:-85.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Smoothing&quot;:{&quot;type&quot;:&quot;CATMULL_SMOOTHING&quot;,&quot;smoothing&quot;:0.2},&quot;pathMarkers&quot;:{&quot;markerStart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,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b5f97cd-db4d-4dae-bbb0-2a539bcf7a97&quot;,&quot;order&quot;:&quot;9999999998&quot;},&quot;connectorInfo&quot;:{&quot;connectedObjects&quot;:[{&quot;objectId&quot;:&quot;4b1f11dc-ae4f-42e4-a3c8-70911f112034&quot;,&quot;coordinates&quot;:{&quot;x&quot;:1,&quot;y&quot;:0}}],&quot;type&quot;:&quot;QUADRATIC&quot;,&quot;offset&quot;:{&quot;x&quot;:0,&quot;y&quot;:0},&quot;bending&quot;:-0.1,&quot;firstElementIsHead&quot;:true,&quot;customized&quot;:true}},&quot;d14fc1aa-4549-41dc-8421-fb39debc74f3&quot;:{&quot;id&quot;:&quot;d14fc1aa-4549-41dc-8421-fb39debc74f3&quot;,&quot;name&quot;:&quot;Whitefly (lateral)&quot;,&quot;displayName&quot;:&quot;&quot;,&quot;type&quot;:&quot;FIGURE_OBJECT&quot;,&quot;relativeTransform&quot;:{&quot;translate&quot;:{&quot;x&quot;:-113.74297291407441,&quot;y&quot;:66.26156305209933},&quot;rotate&quot;:0.23726853553558666,&quot;skewX&quot;:0,&quot;scale&quot;:{&quot;x&quot;:0.28252629329503187,&quot;y&quot;:0.28252629329503187}},&quot;image&quot;:{&quot;url&quot;:&quot;https://icons.biorender.com/biorender/5e30515c86d7a60028da0f5a/20200128152314/image/whitefly-lateral.png&quot;,&quot;fallbackUrl&quot;:&quot;https://res.cloudinary.com/dlcjuc3ej/image/upload/v1580224994/rtolt1jips2dy0fmmequ.svg#/keystone/api/icons/5e30515c86d7a60028da0f5a/20200128152314/image/whitefly-lateral.svg&quot;,&quot;isPremium&quot;:false,&quot;size&quot;:{&quot;x&quot;:200,&quot;y&quot;:101.63934426229508}},&quot;source&quot;:{&quot;id&quot;:&quot;5e30515c86d7a60028da0f5a&quot;,&quot;type&quot;:&quot;ASSETS&quot;},&quot;isPremium&quot;:false,&quot;parent&quot;:{&quot;type&quot;:&quot;CHILD&quot;,&quot;parentId&quot;:&quot;8b5f97cd-db4d-4dae-bbb0-2a539bcf7a97&quot;,&quot;order&quot;:&quot;9999999999&quot;}},&quot;2256d90e-2c0b-4537-85ab-ae6f5a77e958&quot;:{&quot;id&quot;:&quot;2256d90e-2c0b-4537-85ab-ae6f5a77e958&quot;,&quot;name&quot;:&quot;Whitefly (lateral)&quot;,&quot;displayName&quot;:&quot;&quot;,&quot;type&quot;:&quot;FIGURE_OBJECT&quot;,&quot;relativeTransform&quot;:{&quot;translate&quot;:{&quot;x&quot;:-73.74297291407433,&quot;y&quot;:-39.00043694790062},&quot;rotate&quot;:5.538789924515051,&quot;skewX&quot;:0,&quot;scale&quot;:{&quot;x&quot;:-0.28252629329503187,&quot;y&quot;:0.28252629329503176}},&quot;image&quot;:{&quot;url&quot;:&quot;https://icons.biorender.com/biorender/5e30515c86d7a60028da0f5a/20200128152314/image/whitefly-lateral.png&quot;,&quot;fallbackUrl&quot;:&quot;https://res.cloudinary.com/dlcjuc3ej/image/upload/v1580224994/rtolt1jips2dy0fmmequ.svg#/keystone/api/icons/5e30515c86d7a60028da0f5a/20200128152314/image/whitefly-lateral.svg&quot;,&quot;isPremium&quot;:false,&quot;size&quot;:{&quot;x&quot;:200,&quot;y&quot;:101.63934426229508}},&quot;source&quot;:{&quot;id&quot;:&quot;5e30515c86d7a60028da0f5a&quot;,&quot;type&quot;:&quot;ASSETS&quot;},&quot;isPremium&quot;:false,&quot;parent&quot;:{&quot;type&quot;:&quot;CHILD&quot;,&quot;parentId&quot;:&quot;8b5f97cd-db4d-4dae-bbb0-2a539bcf7a97&quot;,&quot;order&quot;:&quot;99999999995&quot;}},&quot;c935f50d-531d-4af4-96f6-22ea2fe65607&quot;:{&quot;id&quot;:&quot;c935f50d-531d-4af4-96f6-22ea2fe65607&quot;,&quot;name&quot;:&quot;Coccus&quot;,&quot;displayName&quot;:&quot;&quot;,&quot;type&quot;:&quot;FIGURE_OBJECT&quot;,&quot;relativeTransform&quot;:{&quot;translate&quot;:{&quot;x&quot;:-63.57900000000001,&quot;y&quot;:-47.000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97&quot;}},&quot;8baa8c73-acda-4d23-9cc9-56832b50434a&quot;:{&quot;id&quot;:&quot;8baa8c73-acda-4d23-9cc9-56832b50434a&quot;,&quot;name&quot;:&quot;Coccus&quot;,&quot;displayName&quot;:&quot;&quot;,&quot;type&quot;:&quot;FIGURE_OBJECT&quot;,&quot;relativeTransform&quot;:{&quot;translate&quot;:{&quot;x&quot;:-73.743,&quot;y&quot;:-49.000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98&quot;}},&quot;b9449264-8be0-4415-94dc-a40db6aa0c62&quot;:{&quot;id&quot;:&quot;b9449264-8be0-4415-94dc-a40db6aa0c62&quot;,&quot;name&quot;:&quot;Whitefly (lateral)&quot;,&quot;displayName&quot;:&quot;&quot;,&quot;type&quot;:&quot;FIGURE_OBJECT&quot;,&quot;relativeTransform&quot;:{&quot;translate&quot;:{&quot;x&quot;:-209.57897291407434,&quot;y&quot;:-98.59743694790063},&quot;rotate&quot;:5.538789924515051,&quot;skewX&quot;:0,&quot;scale&quot;:{&quot;x&quot;:-0.28252629329503187,&quot;y&quot;:0.28252629329503176}},&quot;image&quot;:{&quot;url&quot;:&quot;https://icons.biorender.com/biorender/5e30515c86d7a60028da0f5a/20200128152314/image/whitefly-lateral.png&quot;,&quot;fallbackUrl&quot;:&quot;https://res.cloudinary.com/dlcjuc3ej/image/upload/v1580224994/rtolt1jips2dy0fmmequ.svg#/keystone/api/icons/5e30515c86d7a60028da0f5a/20200128152314/image/whitefly-lateral.svg&quot;,&quot;isPremium&quot;:false,&quot;size&quot;:{&quot;x&quot;:200,&quot;y&quot;:101.63934426229508}},&quot;source&quot;:{&quot;id&quot;:&quot;5e30515c86d7a60028da0f5a&quot;,&quot;type&quot;:&quot;ASSETS&quot;},&quot;isPremium&quot;:false,&quot;parent&quot;:{&quot;type&quot;:&quot;CHILD&quot;,&quot;parentId&quot;:&quot;8b5f97cd-db4d-4dae-bbb0-2a539bcf7a97&quot;,&quot;order&quot;:&quot;99999999999&quot;}},&quot;c9c3962a-77a1-495c-9456-402c3a7e6f3b&quot;:{&quot;id&quot;:&quot;c9c3962a-77a1-495c-9456-402c3a7e6f3b&quot;,&quot;name&quot;:&quot;Coccus&quot;,&quot;displayName&quot;:&quot;&quot;,&quot;type&quot;:&quot;FIGURE_OBJECT&quot;,&quot;relativeTransform&quot;:{&quot;translate&quot;:{&quot;x&quot;:-200,&quot;y&quot;:-107.571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995&quot;}},&quot;3306f241-b406-4900-baa8-b7c1db13cd90&quot;:{&quot;id&quot;:&quot;3306f241-b406-4900-baa8-b7c1db13cd90&quot;,&quot;name&quot;:&quot;Coccus&quot;,&quot;displayName&quot;:&quot;&quot;,&quot;type&quot;:&quot;FIGURE_OBJECT&quot;,&quot;relativeTransform&quot;:{&quot;translate&quot;:{&quot;x&quot;:-209.579,&quot;y&quot;:-99.57100000000003},&quot;rotate&quot;:0,&quot;skewX&quot;:0,&quot;scale&quot;:{&quot;x&quot;:0.16000000000000067,&quot;y&quot;:0.16000000000000067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8b5f97cd-db4d-4dae-bbb0-2a539bcf7a97&quot;,&quot;order&quot;:&quot;999999999997&quot;}}}}"/>
    <we:property name="65400759b77c89622ec39fd8_1700069671583" value="{&quot;id&quot;:&quot;4a437cf1-cc13-41fd-abad-64e9dc1c9b2e&quot;,&quot;objects&quot;:{&quot;4a437cf1-cc13-41fd-abad-64e9dc1c9b2e&quot;:{&quot;id&quot;:&quot;4a437cf1-cc13-41fd-abad-64e9dc1c9b2e&quot;,&quot;type&quot;:&quot;FIGURE_OBJECT&quot;,&quot;document&quot;:{&quot;type&quot;:&quot;DOCUMENT_GROUP&quot;,&quot;canvasType&quot;:&quot;FIGURE&quot;,&quot;units&quot;:&quot;in&quot;}},&quot;3c6ea87e-e7f6-4c95-9926-521492df5164&quot;:{&quot;id&quot;:&quot;3c6ea87e-e7f6-4c95-9926-521492df5164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4a437cf1-cc13-41fd-abad-64e9dc1c9b2e&quot;,&quot;type&quot;:&quot;FRAME&quot;,&quot;order&quot;:&quot;5&quot;}},&quot;7b7e4984-9463-4fc4-81fa-65b50cc23e77&quot;:{&quot;id&quot;:&quot;7b7e4984-9463-4fc4-81fa-65b50cc23e77&quot;,&quot;type&quot;:&quot;FIGURE_OBJECT&quot;,&quot;document&quot;:{&quot;type&quot;:&quot;FIGURE&quot;,&quot;canvasType&quot;:&quot;FIGURE&quot;,&quot;units&quot;:&quot;in&quot;},&quot;parent&quot;:{&quot;parentId&quot;:&quot;4a437cf1-cc13-41fd-abad-64e9dc1c9b2e&quot;,&quot;type&quot;:&quot;DOCUMENT&quot;,&quot;order&quot;:&quot;5&quot;}},&quot;bb5cf74e-6a1b-4043-b7a4-6fd7b3b4616c&quot;:{&quot;id&quot;:&quot;bb5cf74e-6a1b-4043-b7a4-6fd7b3b4616c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7b7e4984-9463-4fc4-81fa-65b50cc23e77&quot;,&quot;order&quot;:&quot;5&quot;}},&quot;3072a4eb-bbd5-436b-9f71-ab373205701f&quot;:{&quot;id&quot;:&quot;3072a4eb-bbd5-436b-9f71-ab373205701f&quot;,&quot;type&quot;:&quot;FIGURE_OBJECT&quot;,&quot;guide&quot;:{&quot;type&quot;:&quot;GRID&quot;,&quot;distance&quot;:0.5,&quot;units&quot;:&quot;in&quot;},&quot;parent&quot;:{&quot;parentId&quot;:&quot;4a437cf1-cc13-41fd-abad-64e9dc1c9b2e&quot;,&quot;type&quot;:&quot;GUIDE&quot;,&quot;order&quot;:&quot;5&quot;}},&quot;d4bd7777-f03e-4a6e-b382-90344361d4d2&quot;:{&quot;id&quot;:&quot;d4bd7777-f03e-4a6e-b382-90344361d4d2&quot;,&quot;name&quot;:&quot;RNA (stem loop, small, short)&quot;,&quot;displayName&quot;:&quot;Short stem loop RNA&quot;,&quot;type&quot;:&quot;FIGURE_OBJECT&quot;,&quot;relativeTransform&quot;:{&quot;translate&quot;:{&quot;x&quot;:-324.2455115423642,&quot;y&quot;:-32.04826847091977},&quot;rotate&quot;:1.5707963267948966,&quot;skewX&quot;:0,&quot;scale&quot;:{&quot;x&quot;:0.9180916249940575,&quot;y&quot;:0.9180916249940575}},&quot;image&quot;:{&quot;url&quot;:&quot;https://icons.biorender.com/biorender/5d2f5bce1900ef0400b1d8a2/rna-stem-loop-small-short.png&quot;,&quot;fallbackUrl&quot;:&quot;https://res.cloudinary.com/dlcjuc3ej/image/upload/v1563384776/izjmqkirucjsajhj1qqa.svg#/keystone/api/icons/5d2f5bce1900ef0400b1d8a2/rna-stem-loop-small-short.svg&quot;,&quot;isPremium&quot;:false,&quot;size&quot;:{&quot;x&quot;:126,&quot;y&quot;:75.95744680851064}},&quot;source&quot;:{&quot;id&quot;:&quot;5d2f5b911900ef0400b1d88e&quot;,&quot;type&quot;:&quot;ASSETS&quot;},&quot;isPremium&quot;:false,&quot;parent&quot;:{&quot;type&quot;:&quot;CHILD&quot;,&quot;parentId&quot;:&quot;0a5fcdb9-49ce-4fbd-9203-bf213888530d&quot;,&quot;order&quot;:&quot;2&quot;}},&quot;9d7158e3-aa76-45f9-85eb-6da1c7f874a7&quot;:{&quot;type&quot;:&quot;FIGURE_OBJECT&quot;,&quot;id&quot;:&quot;9d7158e3-aa76-45f9-85eb-6da1c7f874a7&quot;,&quot;relativeTransform&quot;:{&quot;translate&quot;:{&quot;x&quot;:-310.36273233242946,&quot;y&quot;:33.18167866367205},&quot;rotate&quot;:0},&quot;opacity&quot;:1,&quot;path&quot;:{&quot;type&quot;:&quot;ELLIPSE&quot;,&quot;size&quot;:{&quot;x&quot;:-17.046636965908576,&quot;y&quot;:-17.046636965908558}},&quot;isLocked&quot;:false,&quot;pathStyles&quot;:[{&quot;type&quot;:&quot;FILL&quot;,&quot;fillStyle&quot;:&quot;rgb(155, 155, 155)&quot;},{&quot;type&quot;:&quot;STROKE&quot;,&quot;strokeStyle&quot;:&quot;rgba(0,0,0,0)&quot;,&quot;lineWidth&quot;:2.2666731540783633,&quot;lineJoin&quot;:&quot;round&quot;}],&quot;parent&quot;:{&quot;type&quot;:&quot;CHILD&quot;,&quot;parentId&quot;:&quot;0a5fcdb9-49ce-4fbd-9203-bf213888530d&quot;,&quot;order&quot;:&quot;5&quot;}},&quot;2dcb267b-0053-4045-b25f-bc1086e86a30&quot;:{&quot;type&quot;:&quot;FIGURE_OBJECT&quot;,&quot;id&quot;:&quot;2dcb267b-0053-4045-b25f-bc1086e86a30&quot;,&quot;relativeTransform&quot;:{&quot;translate&quot;:{&quot;x&quot;:-338.12837006749106,&quot;y&quot;:33.18162500091516},&quot;rotate&quot;:0},&quot;opacity&quot;:1,&quot;path&quot;:{&quot;type&quot;:&quot;ELLIPSE&quot;,&quot;size&quot;:{&quot;x&quot;:-17.046636965908576,&quot;y&quot;:-17.046636965908558}},&quot;isLocked&quot;:false,&quot;pathStyles&quot;:[{&quot;type&quot;:&quot;FILL&quot;,&quot;fillStyle&quot;:&quot;rgb(90, 195, 63)&quot;},{&quot;type&quot;:&quot;STROKE&quot;,&quot;strokeStyle&quot;:&quot;rgba(0,0,0,0)&quot;,&quot;lineWidth&quot;:2.2666731540783633,&quot;lineJoin&quot;:&quot;round&quot;}],&quot;parent&quot;:{&quot;type&quot;:&quot;CHILD&quot;,&quot;parentId&quot;:&quot;0a5fcdb9-49ce-4fbd-9203-bf213888530d&quot;,&quot;order&quot;:&quot;7&quot;}},&quot;9463ce90-0d6d-48a7-955b-0eafe746e80f&quot;:{&quot;id&quot;:&quot;9463ce90-0d6d-48a7-955b-0eafe746e80f&quot;,&quot;name&quot;:&quot;Tomato (young plant)&quot;,&quot;displayName&quot;:&quot;&quot;,&quot;type&quot;:&quot;FIGURE_OBJECT&quot;,&quot;relativeTransform&quot;:{&quot;translate&quot;:{&quot;x&quot;:-362.42105263157896,&quot;y&quot;:-193.50000000000003},&quot;rotate&quot;:0,&quot;skewX&quot;:0,&quot;scale&quot;:{&quot;x&quot;:1.0515789473684214,&quot;y&quot;:1.0515789473684214}},&quot;image&quot;:{&quot;url&quot;:&quot;https://icons.biorender.com/biorender/648b3ce6c5ed7f002049b7f7/20230616135452/image/tomato-young-plant-01.png&quot;,&quot;fallbackUrl&quot;:&quot;https://res.cloudinary.com/dlcjuc3ej/image/upload/v1686923692/rkyrynaayxvjxz9ewuuz.svg#/keystone/api/icons/648b3ce6c5ed7f002049b7f7/20230616135452/image/tomato-young-plant-01.svg#/keystone/api/icons/648b3ce6c5ed7f002049b7f7/20230616135452/image/tomato-young-plant-01.svg#/keystone/api/icons/648b3ce6c5ed7f002049b7f7/20230616135452/image/tomato-young-plant-01.svg&quot;,&quot;isPremium&quot;:false,&quot;size&quot;:{&quot;x&quot;:100,&quot;y&quot;:135.71428571428572}},&quot;source&quot;:{&quot;id&quot;:&quot;648b3ce6c5ed7f002049b7f7&quot;,&quot;type&quot;:&quot;ASSETS&quot;},&quot;isPremium&quot;:false,&quot;parent&quot;:{&quot;type&quot;:&quot;CHILD&quot;,&quot;parentId&quot;:&quot;25d0b15c-090e-432f-8b17-d3ee35a75e04&quot;,&quot;order&quot;:&quot;1&quot;}},&quot;071052da-ecfc-44f2-91d2-a43b157802dc&quot;:{&quot;id&quot;:&quot;071052da-ecfc-44f2-91d2-a43b157802dc&quot;,&quot;name&quot;:&quot;Coccus&quot;,&quot;displayName&quot;:&quot;&quot;,&quot;type&quot;:&quot;FIGURE_OBJECT&quot;,&quot;relativeTransform&quot;:{&quot;translate&quot;:{&quot;x&quot;:-335.5,&quot;y&quot;:-228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2&quot;}},&quot;0fd8dea4-10d4-4eca-aa9f-d1c1887c591b&quot;:{&quot;id&quot;:&quot;0fd8dea4-10d4-4eca-aa9f-d1c1887c591b&quot;,&quot;name&quot;:&quot;Coccus&quot;,&quot;displayName&quot;:&quot;&quot;,&quot;type&quot;:&quot;FIGURE_OBJECT&quot;,&quot;relativeTransform&quot;:{&quot;translate&quot;:{&quot;x&quot;:-357.5,&quot;y&quot;:-180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3&quot;}},&quot;e10e8714-dcf8-4450-85b7-02b940d112bc&quot;:{&quot;id&quot;:&quot;e10e8714-dcf8-4450-85b7-02b940d112bc&quot;,&quot;name&quot;:&quot;Coccus&quot;,&quot;displayName&quot;:&quot;&quot;,&quot;type&quot;:&quot;FIGURE_OBJECT&quot;,&quot;relativeTransform&quot;:{&quot;translate&quot;:{&quot;x&quot;:-315.5,&quot;y&quot;:-208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5&quot;}},&quot;f0e233af-f130-4819-a54a-2cfbee755576&quot;:{&quot;id&quot;:&quot;f0e233af-f130-4819-a54a-2cfbee755576&quot;,&quot;name&quot;:&quot;Coccus&quot;,&quot;displayName&quot;:&quot;&quot;,&quot;type&quot;:&quot;FIGURE_OBJECT&quot;,&quot;relativeTransform&quot;:{&quot;translate&quot;:{&quot;x&quot;:-346.5,&quot;y&quot;:-250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6&quot;}},&quot;c99d3071-d616-417e-afb9-084caaa70d3b&quot;:{&quot;id&quot;:&quot;c99d3071-d616-417e-afb9-084caaa70d3b&quot;,&quot;name&quot;:&quot;Coccus&quot;,&quot;displayName&quot;:&quot;&quot;,&quot;type&quot;:&quot;FIGURE_OBJECT&quot;,&quot;relativeTransform&quot;:{&quot;translate&quot;:{&quot;x&quot;:-381.5,&quot;y&quot;:-198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7&quot;}},&quot;c65e6156-3a59-4b60-a825-04338a79d208&quot;:{&quot;id&quot;:&quot;c65e6156-3a59-4b60-a825-04338a79d208&quot;,&quot;name&quot;:&quot;Coccus&quot;,&quot;displayName&quot;:&quot;&quot;,&quot;type&quot;:&quot;FIGURE_OBJECT&quot;,&quot;relativeTransform&quot;:{&quot;translate&quot;:{&quot;x&quot;:-392.5,&quot;y&quot;:-239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8&quot;}},&quot;25d0b15c-090e-432f-8b17-d3ee35a75e04&quot;:{&quot;type&quot;:&quot;FIGURE_OBJECT&quot;,&quot;id&quot;:&quot;25d0b15c-090e-432f-8b17-d3ee35a75e04&quot;,&quot;parent&quot;:{&quot;type&quot;:&quot;CHILD&quot;,&quot;parentId&quot;:&quot;7b7e4984-9463-4fc4-81fa-65b50cc23e77&quot;,&quot;order&quot;:&quot;99&quot;},&quot;relativeTransform&quot;:{}},&quot;ac4cdecc-0bee-4a6d-b27e-b401ef2fae39&quot;:{&quot;type&quot;:&quot;FIGURE_OBJECT&quot;,&quot;id&quot;:&quot;ac4cdecc-0bee-4a6d-b27e-b401ef2fae39&quot;,&quot;relativeTransform&quot;:{&quot;translate&quot;:{&quot;x&quot;:-231.5,&quot;y&quot;:-199.5},&quot;rotate&quot;:0,&quot;skewX&quot;:0,&quot;scale&quot;:{&quot;x&quot;:1,&quot;y&quot;:1}},&quot;opacity&quot;:1,&quot;path&quot;:{&quot;type&quot;:&quot;POLY_LINE&quot;,&quot;points&quot;:[{&quot;x&quot;:-57.5,&quot;y&quot;:0},{&quot;x&quot;:57.5,&quot;y&quot;:0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7b7e4984-9463-4fc4-81fa-65b50cc23e77&quot;,&quot;order&quot;:&quot;995&quot;},&quot;connectorInfo&quot;:{&quot;connectedObjects&quot;:[],&quot;type&quot;:&quot;LINE&quot;,&quot;offset&quot;:{&quot;x&quot;:0,&quot;y&quot;:0},&quot;bending&quot;:0.1,&quot;firstElementIsHead&quot;:true,&quot;customized&quot;:false}},&quot;eea7b0d9-8596-4241-b525-e46224e54677&quot;:{&quot;relativeTransform&quot;:{&quot;translate&quot;:{&quot;x&quot;:21.54493002314885,&quot;y&quot;:-289.3802889155868},&quot;rotate&quot;:0,&quot;skewX&quot;:0,&quot;scale&quot;:{&quot;x&quot;:1,&quot;y&quot;:1}},&quot;type&quot;:&quot;FIGURE_OBJECT&quot;,&quot;id&quot;:&quot;eea7b0d9-8596-4241-b525-e46224e54677&quot;,&quot;parent&quot;:{&quot;type&quot;:&quot;CHILD&quot;,&quot;parentId&quot;:&quot;7b7e4984-9463-4fc4-81fa-65b50cc23e77&quot;,&quot;order&quot;:&quot;997&quot;},&quot;name&quot;:&quot;Eppendorf tube (2/3 liquid, closed, purified DNA)&quot;,&quot;displayName&quot;:&quot;Eppendorf tube (2/3 liquid, closed, purified DNA)&quot;,&quot;source&quot;:{&quot;id&quot;:&quot;649a24bd6053d8852968a94c&quot;,&quot;type&quot;:&quot;ASSETS&quot;},&quot;isPremium&quot;:true},&quot;c524e319-d620-4244-838c-a32609ff2054&quot;:{&quot;id&quot;:&quot;c524e319-d620-4244-838c-a32609ff2054&quot;,&quot;name&quot;:&quot;Eppendorf tube (2-3, closed)&quot;,&quot;displayName&quot;:&quot;Eppendorf tube (2/3 liquid, closed)&quot;,&quot;type&quot;:&quot;FIGURE_OBJECT&quot;,&quot;relativeTransform&quot;:{&quot;translate&quot;:{&quot;x&quot;:-149.70293002314884,&quot;y&quot;:95.88028891558676},&quot;rotate&quot;:0,&quot;skewX&quot;:0,&quot;scale&quot;:{&quot;x&quot;:1,&quot;y&quot;:1}},&quot;image&quot;:{&quot;url&quot;:&quot;https://icons.biorender.com/biorender/5e41d9e1e250000028d2f747/20200210223234/image/eppendorf-tube-2-3-closed.png&quot;,&quot;fallbackUrl&quot;:&quot;https://res.cloudinary.com/dlcjuc3ej/image/upload/v1581373954/nngdqp51odoekaeiuc07.svg#/keystone/api/icons/5e41d9e1e250000028d2f747/20200210223234/image/eppendorf-tube-2-3-closed.svg&quot;,&quot;isPremium&quot;:false,&quot;size&quot;:{&quot;x&quot;:50,&quot;y&quot;:108.64197530864197}},&quot;source&quot;:{&quot;id&quot;:&quot;5e41d9e1e250000028d2f747&quot;,&quot;type&quot;:&quot;ASSETS&quot;},&quot;isPremium&quot;:false,&quot;parent&quot;:{&quot;type&quot;:&quot;CHILD&quot;,&quot;parentId&quot;:&quot;eea7b0d9-8596-4241-b525-e46224e54677&quot;,&quot;order&quot;:&quot;1&quot;}},&quot;9c8ea1eb-3b53-43bb-a632-5bf4a1afc029&quot;:{&quot;relativeTransform&quot;:{&quot;translate&quot;:{&quot;x&quot;:-143.67565150044493,&quot;y&quot;:109.23830944009394},&quot;rotate&quot;:-0.6799351313605974,&quot;skewX&quot;:0,&quot;scale&quot;:{&quot;x&quot;:1,&quot;y&quot;:1}},&quot;type&quot;:&quot;FIGURE_OBJECT&quot;,&quot;id&quot;:&quot;9c8ea1eb-3b53-43bb-a632-5bf4a1afc029&quot;,&quot;name&quot;:&quot;dsDNA brush 3 (straight)&quot;,&quot;displayName&quot;:&quot;Simplified dsDNA brush (straight)&quot;,&quot;opacity&quot;:1,&quot;source&quot;:{&quot;id&quot;:&quot;5e75575f52bb9000abea6260&quot;,&quot;type&quot;:&quot;ASSETS&quot;},&quot;path&quot;:{&quot;type&quot;:&quot;POLY_LINE&quot;,&quot;points&quot;:[{&quot;x&quot;:-8.559496991294791,&quot;y&quot;:0},{&quot;x&quot;:8.559496991294786,&quot;y&quot;:0}],&quot;closed&quot;:false},&quot;pathStyles&quot;:[{&quot;type&quot;:&quot;FILL&quot;,&quot;fillStyle&quot;:&quot;rgba(0,0,0,0)&quot;},{&quot;type&quot;:&quot;STROKE&quot;,&quot;strokeStyle&quot;:&quot;rgba(0,0,0,0)&quot;,&quot;lineWidth&quot;:4.412664353661106,&quot;lineJoin&quot;:&quot;round&quot;}],&quot;pathSmoothing&quot;:{&quot;type&quot;:&quot;CATMULL_SMOOTHING&quot;,&quot;smoothing&quot;:0.2},&quot;pathPattern&quot;:{&quot;type&quot;:&quot;ROW&quot;,&quot;patternId&quot;:&quot;f532a18f-fcaf-4e90-9771-d1d24f456ad7&quot;,&quot;patternTransform&quot;:{&quot;translate&quot;:{&quot;x&quot;:-0.00002540549651012527,&quot;y&quot;:-0.5},&quot;rotate&quot;:0,&quot;skewX&quot;:0,&quot;scale&quot;:{&quot;x&quot;:0.005076142131979695,&quot;y&quot;:0.005076142131979695}},&quot;xUnits&quot;:&quot;STROKE_WIDTH&quot;,&quot;yUnits&quot;:&quot;STROKE_WIDTH&quot;,&quot;bending&quot;:true,&quot;repeat&quot;:{&quot;distance&quot;:1.8661421567655458,&quot;align&quot;:&quot;CENTER&quot;},&quot;isPremium&quot;:true},&quot;isLocked&quot;:false,&quot;parent&quot;:{&quot;type&quot;:&quot;CHILD&quot;,&quot;parentId&quot;:&quot;eea7b0d9-8596-4241-b525-e46224e54677&quot;,&quot;order&quot;:&quot;2&quot;},&quot;isPremium&quot;:true},&quot;f532a18f-fcaf-4e90-9771-d1d24f456ad7&quot;:{&quot;type&quot;:&quot;FIGURE_OBJECT&quot;,&quot;id&quot;:&quot;f532a18f-fcaf-4e90-9771-d1d24f456ad7&quot;,&quot;relativeTransform&quot;:{&quot;translate&quot;:{&quot;x&quot;:0,&quot;y&quot;:0},&quot;rotate&quot;:0,&quot;skewX&quot;:0,&quot;scale&quot;:{&quot;x&quot;:1,&quot;y&quot;:1}},&quot;source&quot;:{&quot;type&quot;:&quot;ASSETS&quot;,&quot;id&quot;:&quot;5e71324176df310028d1ed5d&quot;},&quot;name&quot;:&quot;dsDNA (simplified)&quot;},&quot;4c16448e-f83f-496f-85a4-f737bb9f34e5&quot;:{&quot;type&quot;:&quot;FIGURE_OBJECT&quot;,&quot;id&quot;:&quot;4c16448e-f83f-496f-85a4-f737bb9f34e5&quot;,&quot;parent&quot;:{&quot;type&quot;:&quot;CHILD&quot;,&quot;parentId&quot;:&quot;f532a18f-fcaf-4e90-9771-d1d24f456ad7&quot;,&quot;order&quot;:&quot;7&quot;},&quot;relativeTransform&quot;:{&quot;translate&quot;:{&quot;x&quot;:0,&quot;y&quot;:0},&quot;rotate&quot;:0,&quot;skewX&quot;:0,&quot;scale&quot;:{&quot;x&quot;:1,&quot;y&quot;:1}}},&quot;7c5ce5c3-0e14-4d57-a8f7-eda61a3bb4c3&quot;:{&quot;type&quot;:&quot;FIGURE_OBJECT&quot;,&quot;id&quot;:&quot;7c5ce5c3-0e14-4d57-a8f7-eda61a3bb4c3&quot;,&quot;parent&quot;:{&quot;type&quot;:&quot;CHILD&quot;,&quot;parentId&quot;:&quot;4c16448e-f83f-496f-85a4-f737bb9f34e5&quot;,&quot;order&quot;:&quot;2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.14,&quot;isEndPoint&quot;:true},{&quot;x&quot;:353.18,&quot;y&quot;:7.140000000000001,&quot;isEndPoint&quot;:false},{&quot;x&quot;:332.5,&quot;y&quot;:7.140000000000001,&quot;isEndPoint&quot;:false},{&quot;x&quot;:332.5,&quot;y&quot;:7.140000000000001,&quot;isEndPoint&quot;:true},{&quot;x&quot;:282,&quot;y&quot;:7.42,&quot;isEndPoint&quot;:false},{&quot;x&quot;:251.44,&quot;y&quot;:51,&quot;isEndPoint&quot;:false},{&quot;x&quot;:224.49,&quot;y&quot;:89.43,&quot;isEndPoint&quot;:true},{&quot;x&quot;:201.26000000000002,&quot;y&quot;:122.59,&quot;isEndPoint&quot;:false},{&quot;x&quot;:179.31,&quot;y&quot;:153.9,&quot;isEndPoint&quot;:false},{&quot;x&quot;:149.9,&quot;y&quot;:153.9,&quot;isEndPoint&quot;:true},{&quot;x&quot;:149.32,&quot;y&quot;:153.9,&quot;isEndPoint&quot;:true},{&quot;x&quot;:149.32,&quot;y&quot;:189.9,&quot;isEndPoint&quot;:true},{&quot;x&quot;:149.91,&quot;y&quot;:189.9,&quot;isEndPoint&quot;:true},{&quot;x&quot;:198.06,&quot;y&quot;:189.9,&quot;isEndPoint&quot;:false},{&quot;x&quot;:226.5,&quot;y&quot;:149.31,&quot;isEndPoint&quot;:false},{&quot;x&quot;:254.01999999999998,&quot;y&quot;:110.05000000000001,&quot;isEndPoint&quot;:true},{&quot;x&quot;:278.15,&quot;y&quot;:75.61000000000001,&quot;isEndPoint&quot;:false},{&quot;x&quot;:300.95,&quot;y&quot;:43.05000000000001,&quot;isEndPoint&quot;:false},{&quot;x&quot;:333.02,&quot;y&quot;:43.05000000000001,&quot;isEndPoint&quot;:true},{&quot;x&quot;:333.02,&quot;y&quot;:43.05000000000001,&quot;isEndPoint&quot;:true},{&quot;x&quot;:344.54999999999995,&quot;y&quot;:43.05000000000001,&quot;isEndPoint&quot;:false},{&quot;x&quot;:356.46999999999997,&quot;y&quot;:47.16000000000001,&quot;isEndPoint&quot;:false},{&quot;x&quot;:367.56,&quot;y&quot;:55.750000000000014,&quot;isEndPoint&quot;:true}],&quot;closed&quot;:true}},&quot;pathStyles&quot;:[{&quot;type&quot;:&quot;FILL&quot;,&quot;fillStyle&quot;:&quot;#002479&quot;}],&quot;opacity&quot;:1},&quot;6b3e2be0-51f5-4cb7-8e57-2cad8f751846&quot;:{&quot;type&quot;:&quot;FIGURE_OBJECT&quot;,&quot;id&quot;:&quot;6b3e2be0-51f5-4cb7-8e57-2cad8f751846&quot;,&quot;parent&quot;:{&quot;type&quot;:&quot;CHILD&quot;,&quot;parentId&quot;:&quot;4c16448e-f83f-496f-85a4-f737bb9f34e5&quot;,&quot;order&quot;:&quot;5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1.2,&quot;isEndPoint&quot;:true},{&quot;x&quot;:350.99,&quot;y&quot;:128.64999999999998,&quot;isEndPoint&quot;:false},{&quot;x&quot;:336.37,&quot;y&quot;:108.67999999999998,&quot;isEndPoint&quot;:false},{&quot;x&quot;:321.13,&quot;y&quot;:86.92999999999998,&quot;isEndPoint&quot;:true},{&quot;x&quot;:293.62,&quot;y&quot;:47.67,&quot;isEndPoint&quot;:false},{&quot;x&quot;:265.18,&quot;y&quot;:7.08,&quot;isEndPoint&quot;:false},{&quot;x&quot;:217,&quot;y&quot;:7.08,&quot;isEndPoint&quot;:true},{&quot;x&quot;:168.82,&quot;y&quot;:7.08,&quot;isEndPoint&quot;:false},{&quot;x&quot;:140.4,&quot;y&quot;:47.67,&quot;isEndPoint&quot;:false},{&quot;x&quot;:112.89,&quot;y&quot;:86.92999999999999,&quot;isEndPoint&quot;:true},{&quot;x&quot;:88.75,&quot;y&quot;:121.36999999999999,&quot;isEndPoint&quot;:false},{&quot;x&quot;:65.96000000000001,&quot;y&quot;:153.93,&quot;isEndPoint&quot;:false},{&quot;x&quot;:33.83,&quot;y&quot;:153.93,&quot;isEndPoint&quot;:true},{&quot;x&quot;:22.56,&quot;y&quot;:153.9,&quot;isEndPoint&quot;:false},{&quot;x&quot;:11,&quot;y&quot;:149.44,&quot;isEndPoint&quot;:false},{&quot;x&quot;:0.11,&quot;y&quot;:141.2,&quot;isEndPoint&quot;:true},{&quot;x&quot;:0,&quot;y&quot;:182.8,&quot;isEndPoint&quot;:true},{&quot;x&quot;:0.35,&quot;y&quot;:182.95000000000002,&quot;isEndPoint&quot;:true},{&quot;x&quot;:10.905530717350821,&quot;y&quot;:187.59644786408347,&quot;isEndPoint&quot;:false},{&quot;x&quot;:22.317101480766773,&quot;y&quot;:189.98095518778234,&quot;isEndPoint&quot;:false},{&quot;x&quot;:33.84999999999999,&quot;y&quot;:189.95000000000002,&quot;isEndPoint&quot;:true},{&quot;x&quot;:84.73999999999998,&quot;y&quot;:189.95000000000002,&quot;isEndPoint&quot;:false},{&quot;x&quot;:115.38999999999999,&quot;y&quot;:146.21,&quot;isEndPoint&quot;:false},{&quot;x&quot;:142.45,&quot;y&quot;:107.60000000000002,&quot;isEndPoint&quot;:true},{&quot;x&quot;:165.68,&quot;y&quot;:74.45,&quot;isEndPoint&quot;:false},{&quot;x&quot;:187.62,&quot;y&quot;:43.13,&quot;isEndPoint&quot;:false},{&quot;x&quot;:217,&quot;y&quot;:43.13,&quot;isEndPoint&quot;:true},{&quot;x&quot;:246.38,&quot;y&quot;:43.13,&quot;isEndPoint&quot;:false},{&quot;x&quot;:268.35,&quot;y&quot;:74.46000000000001,&quot;isEndPoint&quot;:false},{&quot;x&quot;:291.58,&quot;y&quot;:107.62,&quot;isEndPoint&quot;:true},{&quot;x&quot;:311.82,&quot;y&quot;:136.5,&quot;isEndPoint&quot;:false},{&quot;x&quot;:335.58,&quot;y&quot;:168.97,&quot;isEndPoint&quot;:false},{&quot;x&quot;:367.58,&quot;y&quot;:182.8,&quot;isEndPoint&quot;:true}],&quot;closed&quot;:true}},&quot;pathStyles&quot;:[{&quot;type&quot;:&quot;FILL&quot;,&quot;fillStyle&quot;:&quot;#184193&quot;}],&quot;opacity&quot;:1},&quot;31afc61c-4969-435e-9a3d-2ad6540465d1&quot;:{&quot;type&quot;:&quot;FIGURE_OBJECT&quot;,&quot;id&quot;:&quot;31afc61c-4969-435e-9a3d-2ad6540465d1&quot;,&quot;parent&quot;:{&quot;type&quot;:&quot;CHILD&quot;,&quot;parentId&quot;:&quot;4c16448e-f83f-496f-85a4-f737bb9f34e5&quot;,&quot;order&quot;:&quot;7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149.9,&quot;y&quot;:153.9,&quot;isEndPoint&quot;:true},{&quot;x&quot;:120.5,&quot;y&quot;:153.9,&quot;isEndPoint&quot;:false},{&quot;x&quot;:98.56,&quot;y&quot;:122.59,&quot;isEndPoint&quot;:false},{&quot;x&quot;:75.33000000000001,&quot;y&quot;:89.43,&quot;isEndPoint&quot;:true},{&quot;x&quot;:75.33000000000001,&quot;y&quot;:89.43,&quot;isEndPoint&quot;:true},{&quot;x&quot;:55.25,&quot;y&quot;:60.79,&quot;isEndPoint&quot;:false},{&quot;x&quot;:31.69,&quot;y&quot;:28.16,&quot;isEndPoint&quot;:false},{&quot;x&quot;:0,&quot;y&quot;:14.14,&quot;isEndPoint&quot;:true},{&quot;x&quot;:0,&quot;y&quot;:55.83,&quot;isEndPoint&quot;:true},{&quot;x&quot;:16.4,&quot;y&quot;:68.49,&quot;isEndPoint&quot;:false},{&quot;x&quot;:30.8,&quot;y&quot;:88.71000000000001,&quot;isEndPoint&quot;:false},{&quot;x&quot;:45.79,&quot;y&quot;:110.11,&quot;isEndPoint&quot;:true},{&quot;x&quot;:73.3,&quot;y&quot;:149.36,&quot;isEndPoint&quot;:false},{&quot;x&quot;:101.74,&quot;y&quot;:190,&quot;isEndPoint&quot;:false},{&quot;x&quot;:149.9,&quot;y&quot;:190,&quot;isEndPoint&quot;:true}],&quot;closed&quot;:true}},&quot;pathStyles&quot;:[{&quot;type&quot;:&quot;FILL&quot;,&quot;fillStyle&quot;:&quot;#002479&quot;}],&quot;opacity&quot;:1},&quot;ec6a3940-0330-4ef9-aa1f-f72d7b40799e&quot;:{&quot;relativeTransform&quot;:{&quot;translate&quot;:{&quot;x&quot;:-151.87049059560525,&quot;y&quot;:97.84308023383895},&quot;rotate&quot;:-2.105561685167923,&quot;skewX&quot;:0,&quot;scale&quot;:{&quot;x&quot;:1,&quot;y&quot;:1}},&quot;type&quot;:&quot;FIGURE_OBJECT&quot;,&quot;id&quot;:&quot;ec6a3940-0330-4ef9-aa1f-f72d7b40799e&quot;,&quot;name&quot;:&quot;dsDNA brush 3 (straight)&quot;,&quot;displayName&quot;:&quot;Simplified dsDNA brush (straight)&quot;,&quot;opacity&quot;:1,&quot;source&quot;:{&quot;id&quot;:&quot;5e75575f52bb9000abea6260&quot;,&quot;type&quot;:&quot;ASSETS&quot;},&quot;path&quot;:{&quot;type&quot;:&quot;POLY_LINE&quot;,&quot;points&quot;:[{&quot;x&quot;:-8.559496991294791,&quot;y&quot;:0},{&quot;x&quot;:8.559496991294786,&quot;y&quot;:0}],&quot;closed&quot;:false},&quot;pathStyles&quot;:[{&quot;type&quot;:&quot;FILL&quot;,&quot;fillStyle&quot;:&quot;rgba(0,0,0,0)&quot;},{&quot;type&quot;:&quot;STROKE&quot;,&quot;strokeStyle&quot;:&quot;rgba(0,0,0,0)&quot;,&quot;lineWidth&quot;:4.412664353661106,&quot;lineJoin&quot;:&quot;round&quot;}],&quot;pathSmoothing&quot;:{&quot;type&quot;:&quot;CATMULL_SMOOTHING&quot;,&quot;smoothing&quot;:0.2},&quot;pathPattern&quot;:{&quot;type&quot;:&quot;ROW&quot;,&quot;patternId&quot;:&quot;7b16fe1f-29e2-4277-bbeb-7ab4d194b61c&quot;,&quot;patternTransform&quot;:{&quot;translate&quot;:{&quot;x&quot;:-0.00002540549651012527,&quot;y&quot;:-0.5},&quot;rotate&quot;:0,&quot;skewX&quot;:0,&quot;scale&quot;:{&quot;x&quot;:0.005076142131979695,&quot;y&quot;:0.005076142131979695}},&quot;xUnits&quot;:&quot;STROKE_WIDTH&quot;,&quot;yUnits&quot;:&quot;STROKE_WIDTH&quot;,&quot;bending&quot;:true,&quot;repeat&quot;:{&quot;distance&quot;:1.8661421567655458,&quot;align&quot;:&quot;CENTER&quot;},&quot;isPremium&quot;:true},&quot;isLocked&quot;:false,&quot;parent&quot;:{&quot;type&quot;:&quot;CHILD&quot;,&quot;parentId&quot;:&quot;eea7b0d9-8596-4241-b525-e46224e54677&quot;,&quot;order&quot;:&quot;5&quot;},&quot;isPremium&quot;:true},&quot;7b16fe1f-29e2-4277-bbeb-7ab4d194b61c&quot;:{&quot;type&quot;:&quot;FIGURE_OBJECT&quot;,&quot;id&quot;:&quot;7b16fe1f-29e2-4277-bbeb-7ab4d194b61c&quot;,&quot;relativeTransform&quot;:{&quot;translate&quot;:{&quot;x&quot;:0,&quot;y&quot;:0},&quot;rotate&quot;:0,&quot;skewX&quot;:0,&quot;scale&quot;:{&quot;x&quot;:1,&quot;y&quot;:1}},&quot;source&quot;:{&quot;type&quot;:&quot;ASSETS&quot;,&quot;id&quot;:&quot;5e71324176df310028d1ed5d&quot;},&quot;name&quot;:&quot;dsDNA (simplified)&quot;},&quot;7eb0e35c-8383-4c1c-bed8-297c431907dc&quot;:{&quot;type&quot;:&quot;FIGURE_OBJECT&quot;,&quot;id&quot;:&quot;7eb0e35c-8383-4c1c-bed8-297c431907dc&quot;,&quot;parent&quot;:{&quot;type&quot;:&quot;CHILD&quot;,&quot;parentId&quot;:&quot;7b16fe1f-29e2-4277-bbeb-7ab4d194b61c&quot;,&quot;order&quot;:&quot;7&quot;},&quot;relativeTransform&quot;:{&quot;translate&quot;:{&quot;x&quot;:0,&quot;y&quot;:0},&quot;rotate&quot;:0,&quot;skewX&quot;:0,&quot;scale&quot;:{&quot;x&quot;:1,&quot;y&quot;:1}}},&quot;e123bdd1-35ac-401c-b7c5-762d1fee9ee4&quot;:{&quot;type&quot;:&quot;FIGURE_OBJECT&quot;,&quot;id&quot;:&quot;e123bdd1-35ac-401c-b7c5-762d1fee9ee4&quot;,&quot;parent&quot;:{&quot;type&quot;:&quot;CHILD&quot;,&quot;parentId&quot;:&quot;7eb0e35c-8383-4c1c-bed8-297c431907dc&quot;,&quot;order&quot;:&quot;2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.14,&quot;isEndPoint&quot;:true},{&quot;x&quot;:353.18,&quot;y&quot;:7.140000000000001,&quot;isEndPoint&quot;:false},{&quot;x&quot;:332.5,&quot;y&quot;:7.140000000000001,&quot;isEndPoint&quot;:false},{&quot;x&quot;:332.5,&quot;y&quot;:7.140000000000001,&quot;isEndPoint&quot;:true},{&quot;x&quot;:282,&quot;y&quot;:7.42,&quot;isEndPoint&quot;:false},{&quot;x&quot;:251.44,&quot;y&quot;:51,&quot;isEndPoint&quot;:false},{&quot;x&quot;:224.49,&quot;y&quot;:89.43,&quot;isEndPoint&quot;:true},{&quot;x&quot;:201.26000000000002,&quot;y&quot;:122.59,&quot;isEndPoint&quot;:false},{&quot;x&quot;:179.31,&quot;y&quot;:153.9,&quot;isEndPoint&quot;:false},{&quot;x&quot;:149.9,&quot;y&quot;:153.9,&quot;isEndPoint&quot;:true},{&quot;x&quot;:149.32,&quot;y&quot;:153.9,&quot;isEndPoint&quot;:true},{&quot;x&quot;:149.32,&quot;y&quot;:189.9,&quot;isEndPoint&quot;:true},{&quot;x&quot;:149.91,&quot;y&quot;:189.9,&quot;isEndPoint&quot;:true},{&quot;x&quot;:198.06,&quot;y&quot;:189.9,&quot;isEndPoint&quot;:false},{&quot;x&quot;:226.5,&quot;y&quot;:149.31,&quot;isEndPoint&quot;:false},{&quot;x&quot;:254.01999999999998,&quot;y&quot;:110.05000000000001,&quot;isEndPoint&quot;:true},{&quot;x&quot;:278.15,&quot;y&quot;:75.61000000000001,&quot;isEndPoint&quot;:false},{&quot;x&quot;:300.95,&quot;y&quot;:43.05000000000001,&quot;isEndPoint&quot;:false},{&quot;x&quot;:333.02,&quot;y&quot;:43.05000000000001,&quot;isEndPoint&quot;:true},{&quot;x&quot;:333.02,&quot;y&quot;:43.05000000000001,&quot;isEndPoint&quot;:true},{&quot;x&quot;:344.54999999999995,&quot;y&quot;:43.05000000000001,&quot;isEndPoint&quot;:false},{&quot;x&quot;:356.46999999999997,&quot;y&quot;:47.16000000000001,&quot;isEndPoint&quot;:false},{&quot;x&quot;:367.56,&quot;y&quot;:55.750000000000014,&quot;isEndPoint&quot;:true}],&quot;closed&quot;:true}},&quot;pathStyles&quot;:[{&quot;type&quot;:&quot;FILL&quot;,&quot;fillStyle&quot;:&quot;#002479&quot;}],&quot;opacity&quot;:1},&quot;2f47f14d-e4a4-4773-9dc6-1d385d9524a0&quot;:{&quot;type&quot;:&quot;FIGURE_OBJECT&quot;,&quot;id&quot;:&quot;2f47f14d-e4a4-4773-9dc6-1d385d9524a0&quot;,&quot;parent&quot;:{&quot;type&quot;:&quot;CHILD&quot;,&quot;parentId&quot;:&quot;7eb0e35c-8383-4c1c-bed8-297c431907dc&quot;,&quot;order&quot;:&quot;5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1.2,&quot;isEndPoint&quot;:true},{&quot;x&quot;:350.99,&quot;y&quot;:128.64999999999998,&quot;isEndPoint&quot;:false},{&quot;x&quot;:336.37,&quot;y&quot;:108.67999999999998,&quot;isEndPoint&quot;:false},{&quot;x&quot;:321.13,&quot;y&quot;:86.92999999999998,&quot;isEndPoint&quot;:true},{&quot;x&quot;:293.62,&quot;y&quot;:47.67,&quot;isEndPoint&quot;:false},{&quot;x&quot;:265.18,&quot;y&quot;:7.08,&quot;isEndPoint&quot;:false},{&quot;x&quot;:217,&quot;y&quot;:7.08,&quot;isEndPoint&quot;:true},{&quot;x&quot;:168.82,&quot;y&quot;:7.08,&quot;isEndPoint&quot;:false},{&quot;x&quot;:140.4,&quot;y&quot;:47.67,&quot;isEndPoint&quot;:false},{&quot;x&quot;:112.89,&quot;y&quot;:86.92999999999999,&quot;isEndPoint&quot;:true},{&quot;x&quot;:88.75,&quot;y&quot;:121.36999999999999,&quot;isEndPoint&quot;:false},{&quot;x&quot;:65.96000000000001,&quot;y&quot;:153.93,&quot;isEndPoint&quot;:false},{&quot;x&quot;:33.83,&quot;y&quot;:153.93,&quot;isEndPoint&quot;:true},{&quot;x&quot;:22.56,&quot;y&quot;:153.9,&quot;isEndPoint&quot;:false},{&quot;x&quot;:11,&quot;y&quot;:149.44,&quot;isEndPoint&quot;:false},{&quot;x&quot;:0.11,&quot;y&quot;:141.2,&quot;isEndPoint&quot;:true},{&quot;x&quot;:0,&quot;y&quot;:182.8,&quot;isEndPoint&quot;:true},{&quot;x&quot;:0.35,&quot;y&quot;:182.95000000000002,&quot;isEndPoint&quot;:true},{&quot;x&quot;:10.905530717350821,&quot;y&quot;:187.59644786408347,&quot;isEndPoint&quot;:false},{&quot;x&quot;:22.317101480766773,&quot;y&quot;:189.98095518778234,&quot;isEndPoint&quot;:false},{&quot;x&quot;:33.84999999999999,&quot;y&quot;:189.95000000000002,&quot;isEndPoint&quot;:true},{&quot;x&quot;:84.73999999999998,&quot;y&quot;:189.95000000000002,&quot;isEndPoint&quot;:false},{&quot;x&quot;:115.38999999999999,&quot;y&quot;:146.21,&quot;isEndPoint&quot;:false},{&quot;x&quot;:142.45,&quot;y&quot;:107.60000000000002,&quot;isEndPoint&quot;:true},{&quot;x&quot;:165.68,&quot;y&quot;:74.45,&quot;isEndPoint&quot;:false},{&quot;x&quot;:187.62,&quot;y&quot;:43.13,&quot;isEndPoint&quot;:false},{&quot;x&quot;:217,&quot;y&quot;:43.13,&quot;isEndPoint&quot;:true},{&quot;x&quot;:246.38,&quot;y&quot;:43.13,&quot;isEndPoint&quot;:false},{&quot;x&quot;:268.35,&quot;y&quot;:74.46000000000001,&quot;isEndPoint&quot;:false},{&quot;x&quot;:291.58,&quot;y&quot;:107.62,&quot;isEndPoint&quot;:true},{&quot;x&quot;:311.82,&quot;y&quot;:136.5,&quot;isEndPoint&quot;:false},{&quot;x&quot;:335.58,&quot;y&quot;:168.97,&quot;isEndPoint&quot;:false},{&quot;x&quot;:367.58,&quot;y&quot;:182.8,&quot;isEndPoint&quot;:true}],&quot;closed&quot;:true}},&quot;pathStyles&quot;:[{&quot;type&quot;:&quot;FILL&quot;,&quot;fillStyle&quot;:&quot;#184193&quot;}],&quot;opacity&quot;:1},&quot;77ed4572-91db-45f3-827d-202cd2647b17&quot;:{&quot;type&quot;:&quot;FIGURE_OBJECT&quot;,&quot;id&quot;:&quot;77ed4572-91db-45f3-827d-202cd2647b17&quot;,&quot;parent&quot;:{&quot;type&quot;:&quot;CHILD&quot;,&quot;parentId&quot;:&quot;7eb0e35c-8383-4c1c-bed8-297c431907dc&quot;,&quot;order&quot;:&quot;7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149.9,&quot;y&quot;:153.9,&quot;isEndPoint&quot;:true},{&quot;x&quot;:120.5,&quot;y&quot;:153.9,&quot;isEndPoint&quot;:false},{&quot;x&quot;:98.56,&quot;y&quot;:122.59,&quot;isEndPoint&quot;:false},{&quot;x&quot;:75.33000000000001,&quot;y&quot;:89.43,&quot;isEndPoint&quot;:true},{&quot;x&quot;:75.33000000000001,&quot;y&quot;:89.43,&quot;isEndPoint&quot;:true},{&quot;x&quot;:55.25,&quot;y&quot;:60.79,&quot;isEndPoint&quot;:false},{&quot;x&quot;:31.69,&quot;y&quot;:28.16,&quot;isEndPoint&quot;:false},{&quot;x&quot;:0,&quot;y&quot;:14.14,&quot;isEndPoint&quot;:true},{&quot;x&quot;:0,&quot;y&quot;:55.83,&quot;isEndPoint&quot;:true},{&quot;x&quot;:16.4,&quot;y&quot;:68.49,&quot;isEndPoint&quot;:false},{&quot;x&quot;:30.8,&quot;y&quot;:88.71000000000001,&quot;isEndPoint&quot;:false},{&quot;x&quot;:45.79,&quot;y&quot;:110.11,&quot;isEndPoint&quot;:true},{&quot;x&quot;:73.3,&quot;y&quot;:149.36,&quot;isEndPoint&quot;:false},{&quot;x&quot;:101.74,&quot;y&quot;:190,&quot;isEndPoint&quot;:false},{&quot;x&quot;:149.9,&quot;y&quot;:190,&quot;isEndPoint&quot;:true}],&quot;closed&quot;:true}},&quot;pathStyles&quot;:[{&quot;type&quot;:&quot;FILL&quot;,&quot;fillStyle&quot;:&quot;#002479&quot;}],&quot;opacity&quot;:1},&quot;7f7bb091-46f0-45d5-a78e-64d3b5d4883d&quot;:{&quot;relativeTransform&quot;:{&quot;translate&quot;:{&quot;x&quot;:-140.7300941988811,&quot;y&quot;:90.64663124977316},&quot;rotate&quot;:2.105561685167923,&quot;skewX&quot;:0,&quot;scale&quot;:{&quot;x&quot;:1,&quot;y&quot;:1}},&quot;type&quot;:&quot;FIGURE_OBJECT&quot;,&quot;id&quot;:&quot;7f7bb091-46f0-45d5-a78e-64d3b5d4883d&quot;,&quot;name&quot;:&quot;dsDNA brush 3 (straight)&quot;,&quot;displayName&quot;:&quot;Simplified dsDNA brush (straight)&quot;,&quot;opacity&quot;:1,&quot;source&quot;:{&quot;id&quot;:&quot;5e75575f52bb9000abea6260&quot;,&quot;type&quot;:&quot;ASSETS&quot;},&quot;path&quot;:{&quot;type&quot;:&quot;POLY_LINE&quot;,&quot;points&quot;:[{&quot;x&quot;:8.559496991294791,&quot;y&quot;:0},{&quot;x&quot;:-8.559496991294786,&quot;y&quot;:0}],&quot;closed&quot;:false},&quot;pathStyles&quot;:[{&quot;type&quot;:&quot;FILL&quot;,&quot;fillStyle&quot;:&quot;rgba(0,0,0,0)&quot;},{&quot;type&quot;:&quot;STROKE&quot;,&quot;strokeStyle&quot;:&quot;rgba(0,0,0,0)&quot;,&quot;lineWidth&quot;:4.412664353661106,&quot;lineJoin&quot;:&quot;round&quot;}],&quot;pathSmoothing&quot;:{&quot;type&quot;:&quot;CATMULL_SMOOTHING&quot;,&quot;smoothing&quot;:0.2},&quot;pathPattern&quot;:{&quot;type&quot;:&quot;ROW&quot;,&quot;patternId&quot;:&quot;b7e55654-6531-444f-900a-5ce552968a22&quot;,&quot;patternTransform&quot;:{&quot;translate&quot;:{&quot;x&quot;:-0.00002540549651012527,&quot;y&quot;:0.5},&quot;rotate&quot;:3.141592653589793,&quot;skewX&quot;:0,&quot;scale&quot;:{&quot;x&quot;:-0.005076142131979695,&quot;y&quot;:0.005076142131979695}},&quot;xUnits&quot;:&quot;STROKE_WIDTH&quot;,&quot;yUnits&quot;:&quot;STROKE_WIDTH&quot;,&quot;bending&quot;:true,&quot;repeat&quot;:{&quot;distance&quot;:1.8661421567655458,&quot;align&quot;:&quot;CENTER&quot;},&quot;isPremium&quot;:true},&quot;isLocked&quot;:false,&quot;parent&quot;:{&quot;type&quot;:&quot;CHILD&quot;,&quot;parentId&quot;:&quot;eea7b0d9-8596-4241-b525-e46224e54677&quot;,&quot;order&quot;:&quot;7&quot;},&quot;isPremium&quot;:true},&quot;b7e55654-6531-444f-900a-5ce552968a22&quot;:{&quot;type&quot;:&quot;FIGURE_OBJECT&quot;,&quot;id&quot;:&quot;b7e55654-6531-444f-900a-5ce552968a22&quot;,&quot;relativeTransform&quot;:{&quot;translate&quot;:{&quot;x&quot;:0,&quot;y&quot;:0},&quot;rotate&quot;:0,&quot;skewX&quot;:0,&quot;scale&quot;:{&quot;x&quot;:1,&quot;y&quot;:1}},&quot;source&quot;:{&quot;type&quot;:&quot;ASSETS&quot;,&quot;id&quot;:&quot;5e71324176df310028d1ed5d&quot;},&quot;name&quot;:&quot;dsDNA (simplified)&quot;},&quot;0f7def37-5cbd-4a2b-a3e2-66e3ce33a2c2&quot;:{&quot;type&quot;:&quot;FIGURE_OBJECT&quot;,&quot;id&quot;:&quot;0f7def37-5cbd-4a2b-a3e2-66e3ce33a2c2&quot;,&quot;parent&quot;:{&quot;type&quot;:&quot;CHILD&quot;,&quot;parentId&quot;:&quot;b7e55654-6531-444f-900a-5ce552968a22&quot;,&quot;order&quot;:&quot;7&quot;},&quot;relativeTransform&quot;:{&quot;translate&quot;:{&quot;x&quot;:0,&quot;y&quot;:0},&quot;rotate&quot;:0,&quot;skewX&quot;:0,&quot;scale&quot;:{&quot;x&quot;:1,&quot;y&quot;:1}}},&quot;50c60839-7aee-4ddc-8c05-136dcf1eb179&quot;:{&quot;type&quot;:&quot;FIGURE_OBJECT&quot;,&quot;id&quot;:&quot;50c60839-7aee-4ddc-8c05-136dcf1eb179&quot;,&quot;parent&quot;:{&quot;type&quot;:&quot;CHILD&quot;,&quot;parentId&quot;:&quot;0f7def37-5cbd-4a2b-a3e2-66e3ce33a2c2&quot;,&quot;order&quot;:&quot;2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.14,&quot;isEndPoint&quot;:true},{&quot;x&quot;:353.18,&quot;y&quot;:7.140000000000001,&quot;isEndPoint&quot;:false},{&quot;x&quot;:332.5,&quot;y&quot;:7.140000000000001,&quot;isEndPoint&quot;:false},{&quot;x&quot;:332.5,&quot;y&quot;:7.140000000000001,&quot;isEndPoint&quot;:true},{&quot;x&quot;:282,&quot;y&quot;:7.42,&quot;isEndPoint&quot;:false},{&quot;x&quot;:251.44,&quot;y&quot;:51,&quot;isEndPoint&quot;:false},{&quot;x&quot;:224.49,&quot;y&quot;:89.43,&quot;isEndPoint&quot;:true},{&quot;x&quot;:201.26000000000002,&quot;y&quot;:122.59,&quot;isEndPoint&quot;:false},{&quot;x&quot;:179.31,&quot;y&quot;:153.9,&quot;isEndPoint&quot;:false},{&quot;x&quot;:149.9,&quot;y&quot;:153.9,&quot;isEndPoint&quot;:true},{&quot;x&quot;:149.32,&quot;y&quot;:153.9,&quot;isEndPoint&quot;:true},{&quot;x&quot;:149.32,&quot;y&quot;:189.9,&quot;isEndPoint&quot;:true},{&quot;x&quot;:149.91,&quot;y&quot;:189.9,&quot;isEndPoint&quot;:true},{&quot;x&quot;:198.06,&quot;y&quot;:189.9,&quot;isEndPoint&quot;:false},{&quot;x&quot;:226.5,&quot;y&quot;:149.31,&quot;isEndPoint&quot;:false},{&quot;x&quot;:254.01999999999998,&quot;y&quot;:110.05000000000001,&quot;isEndPoint&quot;:true},{&quot;x&quot;:278.15,&quot;y&quot;:75.61000000000001,&quot;isEndPoint&quot;:false},{&quot;x&quot;:300.95,&quot;y&quot;:43.05000000000001,&quot;isEndPoint&quot;:false},{&quot;x&quot;:333.02,&quot;y&quot;:43.05000000000001,&quot;isEndPoint&quot;:true},{&quot;x&quot;:333.02,&quot;y&quot;:43.05000000000001,&quot;isEndPoint&quot;:true},{&quot;x&quot;:344.54999999999995,&quot;y&quot;:43.05000000000001,&quot;isEndPoint&quot;:false},{&quot;x&quot;:356.46999999999997,&quot;y&quot;:47.16000000000001,&quot;isEndPoint&quot;:false},{&quot;x&quot;:367.56,&quot;y&quot;:55.750000000000014,&quot;isEndPoint&quot;:true}],&quot;closed&quot;:true}},&quot;pathStyles&quot;:[{&quot;type&quot;:&quot;FILL&quot;,&quot;fillStyle&quot;:&quot;#002479&quot;}],&quot;opacity&quot;:1},&quot;69ebcb8d-c660-4750-b952-90dbbdccd0b4&quot;:{&quot;type&quot;:&quot;FIGURE_OBJECT&quot;,&quot;id&quot;:&quot;69ebcb8d-c660-4750-b952-90dbbdccd0b4&quot;,&quot;parent&quot;:{&quot;type&quot;:&quot;CHILD&quot;,&quot;parentId&quot;:&quot;0f7def37-5cbd-4a2b-a3e2-66e3ce33a2c2&quot;,&quot;order&quot;:&quot;5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1.2,&quot;isEndPoint&quot;:true},{&quot;x&quot;:350.99,&quot;y&quot;:128.64999999999998,&quot;isEndPoint&quot;:false},{&quot;x&quot;:336.37,&quot;y&quot;:108.67999999999998,&quot;isEndPoint&quot;:false},{&quot;x&quot;:321.13,&quot;y&quot;:86.92999999999998,&quot;isEndPoint&quot;:true},{&quot;x&quot;:293.62,&quot;y&quot;:47.67,&quot;isEndPoint&quot;:false},{&quot;x&quot;:265.18,&quot;y&quot;:7.08,&quot;isEndPoint&quot;:false},{&quot;x&quot;:217,&quot;y&quot;:7.08,&quot;isEndPoint&quot;:true},{&quot;x&quot;:168.82,&quot;y&quot;:7.08,&quot;isEndPoint&quot;:false},{&quot;x&quot;:140.4,&quot;y&quot;:47.67,&quot;isEndPoint&quot;:false},{&quot;x&quot;:112.89,&quot;y&quot;:86.92999999999999,&quot;isEndPoint&quot;:true},{&quot;x&quot;:88.75,&quot;y&quot;:121.36999999999999,&quot;isEndPoint&quot;:false},{&quot;x&quot;:65.96000000000001,&quot;y&quot;:153.93,&quot;isEndPoint&quot;:false},{&quot;x&quot;:33.83,&quot;y&quot;:153.93,&quot;isEndPoint&quot;:true},{&quot;x&quot;:22.56,&quot;y&quot;:153.9,&quot;isEndPoint&quot;:false},{&quot;x&quot;:11,&quot;y&quot;:149.44,&quot;isEndPoint&quot;:false},{&quot;x&quot;:0.11,&quot;y&quot;:141.2,&quot;isEndPoint&quot;:true},{&quot;x&quot;:0,&quot;y&quot;:182.8,&quot;isEndPoint&quot;:true},{&quot;x&quot;:0.35,&quot;y&quot;:182.95000000000002,&quot;isEndPoint&quot;:true},{&quot;x&quot;:10.905530717350821,&quot;y&quot;:187.59644786408347,&quot;isEndPoint&quot;:false},{&quot;x&quot;:22.317101480766773,&quot;y&quot;:189.98095518778234,&quot;isEndPoint&quot;:false},{&quot;x&quot;:33.84999999999999,&quot;y&quot;:189.95000000000002,&quot;isEndPoint&quot;:true},{&quot;x&quot;:84.73999999999998,&quot;y&quot;:189.95000000000002,&quot;isEndPoint&quot;:false},{&quot;x&quot;:115.38999999999999,&quot;y&quot;:146.21,&quot;isEndPoint&quot;:false},{&quot;x&quot;:142.45,&quot;y&quot;:107.60000000000002,&quot;isEndPoint&quot;:true},{&quot;x&quot;:165.68,&quot;y&quot;:74.45,&quot;isEndPoint&quot;:false},{&quot;x&quot;:187.62,&quot;y&quot;:43.13,&quot;isEndPoint&quot;:false},{&quot;x&quot;:217,&quot;y&quot;:43.13,&quot;isEndPoint&quot;:true},{&quot;x&quot;:246.38,&quot;y&quot;:43.13,&quot;isEndPoint&quot;:false},{&quot;x&quot;:268.35,&quot;y&quot;:74.46000000000001,&quot;isEndPoint&quot;:false},{&quot;x&quot;:291.58,&quot;y&quot;:107.62,&quot;isEndPoint&quot;:true},{&quot;x&quot;:311.82,&quot;y&quot;:136.5,&quot;isEndPoint&quot;:false},{&quot;x&quot;:335.58,&quot;y&quot;:168.97,&quot;isEndPoint&quot;:false},{&quot;x&quot;:367.58,&quot;y&quot;:182.8,&quot;isEndPoint&quot;:true}],&quot;closed&quot;:true}},&quot;pathStyles&quot;:[{&quot;type&quot;:&quot;FILL&quot;,&quot;fillStyle&quot;:&quot;#184193&quot;}],&quot;opacity&quot;:1},&quot;e9d52767-731b-4f4c-915e-868f3f30a921&quot;:{&quot;type&quot;:&quot;FIGURE_OBJECT&quot;,&quot;id&quot;:&quot;e9d52767-731b-4f4c-915e-868f3f30a921&quot;,&quot;parent&quot;:{&quot;type&quot;:&quot;CHILD&quot;,&quot;parentId&quot;:&quot;0f7def37-5cbd-4a2b-a3e2-66e3ce33a2c2&quot;,&quot;order&quot;:&quot;7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149.9,&quot;y&quot;:153.9,&quot;isEndPoint&quot;:true},{&quot;x&quot;:120.5,&quot;y&quot;:153.9,&quot;isEndPoint&quot;:false},{&quot;x&quot;:98.56,&quot;y&quot;:122.59,&quot;isEndPoint&quot;:false},{&quot;x&quot;:75.33000000000001,&quot;y&quot;:89.43,&quot;isEndPoint&quot;:true},{&quot;x&quot;:75.33000000000001,&quot;y&quot;:89.43,&quot;isEndPoint&quot;:true},{&quot;x&quot;:55.25,&quot;y&quot;:60.79,&quot;isEndPoint&quot;:false},{&quot;x&quot;:31.69,&quot;y&quot;:28.16,&quot;isEndPoint&quot;:false},{&quot;x&quot;:0,&quot;y&quot;:14.14,&quot;isEndPoint&quot;:true},{&quot;x&quot;:0,&quot;y&quot;:55.83,&quot;isEndPoint&quot;:true},{&quot;x&quot;:16.4,&quot;y&quot;:68.49,&quot;isEndPoint&quot;:false},{&quot;x&quot;:30.8,&quot;y&quot;:88.71000000000001,&quot;isEndPoint&quot;:false},{&quot;x&quot;:45.79,&quot;y&quot;:110.11,&quot;isEndPoint&quot;:true},{&quot;x&quot;:73.3,&quot;y&quot;:149.36,&quot;isEndPoint&quot;:false},{&quot;x&quot;:101.74,&quot;y&quot;:190,&quot;isEndPoint&quot;:false},{&quot;x&quot;:149.9,&quot;y&quot;:190,&quot;isEndPoint&quot;:true}],&quot;closed&quot;:true}},&quot;pathStyles&quot;:[{&quot;type&quot;:&quot;FILL&quot;,&quot;fillStyle&quot;:&quot;#002479&quot;}],&quot;opacity&quot;:1},&quot;384b6d59-a957-4432-afd3-6439a72e17b0&quot;:{&quot;id&quot;:&quot;384b6d59-a957-4432-afd3-6439a72e17b0&quot;,&quot;type&quot;:&quot;FIGURE_OBJECT&quot;,&quot;relativeTransform&quot;:{&quot;translate&quot;:{&quot;x&quot;:-418.3111572265625,&quot;y&quot;:-90.82133333333331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8.666666666666664,&quot;color&quot;:&quot;black&quot;,&quot;fontWeight&quot;:&quot;normal&quot;,&quot;fontStyle&quot;:&quot;normal&quot;,&quot;decoration&quot;:&quot;none&quot;},&quot;range&quot;:[0,13]}],&quot;text&quot;:&quot;DNA Extraction&quot;}],&quot;_lastCaretLocation&quot;:{&quot;lineIndex&quot;:0,&quot;runIndex&quot;:0,&quot;charIndex&quot;:4}},&quot;format&quot;:&quot;BETTER_TEXT&quot;,&quot;size&quot;:{&quot;x&quot;:83.377685546875,&quot;y&quot;:43.093333333333334},&quot;targetSize&quot;:{&quot;x&quot;:83.377685546875,&quot;y&quot;:43.093333333333334}},&quot;parent&quot;:{&quot;type&quot;:&quot;CHILD&quot;,&quot;parentId&quot;:&quot;7b7e4984-9463-4fc4-81fa-65b50cc23e77&quot;,&quot;order&quot;:&quot;998&quot;}},&quot;2fac9073-d264-4549-bb60-5a00f45efbac&quot;:{&quot;type&quot;:&quot;FIGURE_OBJECT&quot;,&quot;id&quot;:&quot;2fac9073-d264-4549-bb60-5a00f45efbac&quot;,&quot;relativeTransform&quot;:{&quot;translate&quot;:{&quot;x&quot;:0,&quot;y&quot;:0},&quot;rotate&quot;:0,&quot;skewX&quot;:0,&quot;scale&quot;:{&quot;x&quot;:1,&quot;y&quot;:1}},&quot;opacity&quot;:1,&quot;path&quot;:{&quot;type&quot;:&quot;POLY_LINE&quot;,&quot;points&quot;:[{&quot;x&quot;:-370.00000000000006,&quot;y&quot;:-122.14285714285714},{&quot;x&quot;:-370.00000000000006,&quot;y&quot;:-60.82142857142858},{&quot;x&quot;:-339,&quot;y&quot;:-60.82142857142858},{&quot;x&quot;:-311,&quot;y&quot;:-60.82142857142858},{&quot;x&quot;:-289,&quot;y&quot;:-60.82142857142858},{&quot;x&quot;:-288,&quot;y&quot;:-59.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7b7e4984-9463-4fc4-81fa-65b50cc23e77&quot;,&quot;order&quot;:&quot;999&quot;},&quot;connectorInfo&quot;:{&quot;connectedObjects&quot;:[{&quot;objectId&quot;:&quot;9463ce90-0d6d-48a7-955b-0eafe746e80f&quot;,&quot;coordinates&quot;:{&quot;x&quot;:0.4279279279279278,&quot;y&quot;:1}}],&quot;type&quot;:&quot;ELBOW&quot;,&quot;offset&quot;:{&quot;x&quot;:0,&quot;y&quot;:0},&quot;bending&quot;:0.1,&quot;firstElementIsHead&quot;:true,&quot;customized&quot;:true}},&quot;4aac909c-77fd-4882-8ccf-e0d8a57ffb1b&quot;:{&quot;id&quot;:&quot;4aac909c-77fd-4882-8ccf-e0d8a57ffb1b&quot;,&quot;name&quot;:&quot;ssDNA (fragment)&quot;,&quot;displayName&quot;:&quot;&quot;,&quot;type&quot;:&quot;FIGURE_OBJECT&quot;,&quot;relativeTransform&quot;:{&quot;translate&quot;:{&quot;x&quot;:10.000000000000114,&quot;y&quot;:9.999999999999886},&quot;rotate&quot;:1.5707963267948966,&quot;skewX&quot;:0,&quot;scale&quot;:{&quot;x&quot;:1,&quot;y&quot;:1}},&quot;image&quot;:{&quot;url&quot;:&quot;https://icons.biorender.com/biorender/5b6b4c11e0461e1400300b32/20180808200148/image/ssdna-fragment.png&quot;,&quot;fallbackUrl&quot;:&quot;https://res.cloudinary.com/dlcjuc3ej/image/upload/v1533758508/oemofy9hvnoaqemdfswt.svg#/keystone/api/icons/5b6b4c11e0461e1400300b32/20180808200148/image/ssdna-fragment.svg#/keystone/api/icons/5b6b4c11e0461e1400300b32/20180808200148/image/ssdna-fragment.svg&quot;,&quot;isPremium&quot;:false,&quot;size&quot;:{&quot;x&quot;:50,&quot;y&quot;:20.53571428571429}},&quot;source&quot;:{&quot;id&quot;:&quot;5b6b4c11e0461e1400300b32&quot;,&quot;type&quot;:&quot;ASSETS&quot;},&quot;isPremium&quot;:false,&quot;parent&quot;:{&quot;type&quot;:&quot;CHILD&quot;,&quot;parentId&quot;:&quot;7b7e4984-9463-4fc4-81fa-65b50cc23e77&quot;,&quot;order&quot;:&quot;9995&quot;}},&quot;2c2cfef3-ea3c-46e3-a733-32c42f210571&quot;:{&quot;id&quot;:&quot;2c2cfef3-ea3c-46e3-a733-32c42f210571&quot;,&quot;name&quot;:&quot;ssDNA (fragment)&quot;,&quot;displayName&quot;:&quot;&quot;,&quot;type&quot;:&quot;FIGURE_OBJECT&quot;,&quot;relativeTransform&quot;:{&quot;translate&quot;:{&quot;x&quot;:30.53606409102059,&quot;y&quot;:9.999616681672862},&quot;rotate&quot;:-1.5707963267948966,&quot;skewX&quot;:0,&quot;scale&quot;:{&quot;x&quot;:1,&quot;y&quot;:1}},&quot;image&quot;:{&quot;url&quot;:&quot;https://icons.biorender.com/biorender/5b6b4c11e0461e1400300b32/20180808200148/image/ssdna-fragment.png&quot;,&quot;fallbackUrl&quot;:&quot;https://res.cloudinary.com/dlcjuc3ej/image/upload/v1533758508/oemofy9hvnoaqemdfswt.svg#/keystone/api/icons/5b6b4c11e0461e1400300b32/20180808200148/image/ssdna-fragment.svg#/keystone/api/icons/5b6b4c11e0461e1400300b32/20180808200148/image/ssdna-fragment.svg&quot;,&quot;isPremium&quot;:false,&quot;size&quot;:{&quot;x&quot;:50,&quot;y&quot;:20.53571428571429}},&quot;source&quot;:{&quot;id&quot;:&quot;5b6b4c11e0461e1400300b32&quot;,&quot;type&quot;:&quot;ASSETS&quot;},&quot;isPremium&quot;:false,&quot;parent&quot;:{&quot;type&quot;:&quot;CHILD&quot;,&quot;parentId&quot;:&quot;7b7e4984-9463-4fc4-81fa-65b50cc23e77&quot;,&quot;order&quot;:&quot;9997&quot;}},&quot;3063cc25-7c43-40b3-b191-92144370fcea&quot;:{&quot;relativeTransform&quot;:{&quot;translate&quot;:{&quot;x&quot;:26.826797429807847,&quot;y&quot;:-121.34225275430614},&quot;rotate&quot;:3.141592653589793,&quot;skewX&quot;:0,&quot;scale&quot;:{&quot;x&quot;:1,&quot;y&quot;:1}},&quot;type&quot;:&quot;FIGURE_OBJECT&quot;,&quot;id&quot;:&quot;3063cc25-7c43-40b3-b191-92144370fcea&quot;,&quot;name&quot;:&quot;ssDNA brush 2 (arc, medium)&quot;,&quot;opacity&quot;:1,&quot;source&quot;:{&quot;id&quot;:&quot;6126a0160f59c500a0eb80cc&quot;,&quot;type&quot;:&quot;ASSETS&quot;},&quot;path&quot;:{&quot;type&quot;:&quot;POLY_LINE&quot;,&quot;points&quot;:[{&quot;x&quot;:-5.526386370554647,&quot;y&quot;:-116.10295336508557},{&quot;x&quot;:-5.526386370554654,&quot;y&quot;:-73.05169291431167},{&quot;x&quot;:-9.22364604964411,&quot;y&quot;:-66.05792091161186},{&quot;x&quot;:-1.9990874968636483,&quot;y&quot;:-59.40574327204149},{&quot;x&quot;:7.24318816652972,&quot;y&quot;:-56.20084322112548},{&quot;x&quot;:7.6846129748063134,&quot;y&quot;:-60.6012686486841},{&quot;x&quot;:19.327102104353646,&quot;y&quot;:-61.79679402532669},{&quot;x&quot;:19.32710210435365,&quot;y&quot;:-78.29838937867157},{&quot;x&quot;:19.32710210435365,&quot;y&quot;:-88.7755183282394},{&quot;x&quot;:13.290575407930318,&quot;y&quot;:-109.13334961026501}],&quot;closed&quot;:false,&quot;cornerRounding&quot;:{&quot;type&quot;:&quot;ARC_LENGTH&quot;,&quot;global&quot;:71.5477776801749},&quot;selectedObjectIds&quot;:[&quot;3063cc25-7c43-40b3-b191-92144370fcea&quot;]},&quot;pathStyles&quot;:[{&quot;type&quot;:&quot;FILL&quot;,&quot;fillStyle&quot;:&quot;rgba(0,0,0,0)&quot;},{&quot;type&quot;:&quot;STROKE&quot;,&quot;strokeStyle&quot;:&quot;rgba(0,0,0,0)&quot;,&quot;lineWidth&quot;:20.349089815444334,&quot;lineJoin&quot;:&quot;round&quot;}],&quot;pathPattern&quot;:{&quot;type&quot;:&quot;ROW&quot;,&quot;patternId&quot;:&quot;a332b0ad-3138-422a-923f-ed101c4985b2&quot;,&quot;patternTransform&quot;:{&quot;translate&quot;:{&quot;x&quot;:-0.003164556962025317,&quot;y&quot;:-0.5},&quot;rotate&quot;:0,&quot;skewX&quot;:0,&quot;scale&quot;:{&quot;x&quot;:0.012658227848101266,&quot;y&quot;:0.012658227848101266}},&quot;xUnits&quot;:&quot;STROKE_WIDTH&quot;,&quot;yUnits&quot;:&quot;STROKE_WIDTH&quot;,&quot;bending&quot;:true,&quot;repeat&quot;:{&quot;distance&quot;:0.6265822784810127,&quot;align&quot;:&quot;CENTER&quot;},&quot;isPremium&quot;:true},&quot;isLocked&quot;:false,&quot;parent&quot;:{&quot;type&quot;:&quot;CHILD&quot;,&quot;parentId&quot;:&quot;7b7e4984-9463-4fc4-81fa-65b50cc23e77&quot;,&quot;order&quot;:&quot;9998&quot;},&quot;isPremium&quot;:true,&quot;displayName&quot;:&quot;Unwound ssDNA brush (arc, medium)&quot;,&quot;connectorInfo&quot;:{&quot;connectedObjects&quot;:[],&quot;type&quot;:&quot;ELBOW&quot;,&quot;offset&quot;:{&quot;x&quot;:0,&quot;y&quot;:0},&quot;bending&quot;:0.1,&quot;firstElementIsHead&quot;:true,&quot;customized&quot;:true}},&quot;a332b0ad-3138-422a-923f-ed101c4985b2&quot;:{&quot;type&quot;:&quot;FIGURE_OBJECT&quot;,&quot;id&quot;:&quot;a332b0ad-3138-422a-923f-ed101c4985b2&quot;,&quot;relativeTransform&quot;:{&quot;translate&quot;:{&quot;x&quot;:0,&quot;y&quot;:0},&quot;rotate&quot;:0,&quot;skewX&quot;:0,&quot;scale&quot;:{&quot;x&quot;:1,&quot;y&quot;:1}},&quot;source&quot;:{&quot;type&quot;:&quot;ASSETS&quot;,&quot;id&quot;:&quot;5ee1532b88e8df0028d0e2f0&quot;},&quot;name&quot;:&quot;ssDNA (unwound, single, for brush)&quot;},&quot;a6d16e80-0ec5-47be-8253-f51a20207f06&quot;:{&quot;type&quot;:&quot;FIGURE_OBJECT&quot;,&quot;id&quot;:&quot;a6d16e80-0ec5-47be-8253-f51a20207f06&quot;,&quot;parent&quot;:{&quot;type&quot;:&quot;CHILD&quot;,&quot;parentId&quot;:&quot;a332b0ad-3138-422a-923f-ed101c4985b2&quot;,&quot;order&quot;:&quot;5&quot;},&quot;relativeTransform&quot;:{&quot;translate&quot;:{&quot;x&quot;:0,&quot;y&quot;:0},&quot;rotate&quot;:0,&quot;skewX&quot;:0,&quot;scale&quot;:{&quot;x&quot;:1,&quot;y&quot;:1}}},&quot;61ccdf80-77f7-4e34-82e6-78f2cf6545df&quot;:{&quot;type&quot;:&quot;FIGURE_OBJECT&quot;,&quot;id&quot;:&quot;61ccdf80-77f7-4e34-82e6-78f2cf6545df&quot;,&quot;parent&quot;:{&quot;type&quot;:&quot;CHILD&quot;,&quot;parentId&quot;:&quot;a6d16e80-0ec5-47be-8253-f51a20207f06&quot;,&quot;order&quot;:&quot;5&quot;},&quot;relativeTransform&quot;:{&quot;translate&quot;:{&quot;x&quot;:24.983,&quot;y&quot;:68.39},&quot;rotate&quot;:0,&quot;skewX&quot;:0,&quot;scale&quot;:{&quot;x&quot;:1,&quot;y&quot;:1}},&quot;path&quot;:{&quot;type&quot;:&quot;RECT&quot;,&quot;size&quot;:{&quot;x&quot;:50,&quot;y&quot;:22}},&quot;pathStyles&quot;:[{&quot;type&quot;:&quot;FILL&quot;,&quot;fillStyle&quot;:&quot;#005485&quot;}],&quot;opacity&quot;:1},&quot;efc64c62-8b6e-4678-97b7-e219fc9c229c&quot;:{&quot;type&quot;:&quot;FIGURE_OBJECT&quot;,&quot;id&quot;:&quot;efc64c62-8b6e-4678-97b7-e219fc9c229c&quot;,&quot;parent&quot;:{&quot;type&quot;:&quot;CHILD&quot;,&quot;parentId&quot;:&quot;a332b0ad-3138-422a-923f-ed101c4985b2&quot;,&quot;order&quot;:&quot;7&quot;},&quot;relativeTransform&quot;:{&quot;translate&quot;:{&quot;x&quot;:0,&quot;y&quot;:0},&quot;rotate&quot;:0,&quot;skewX&quot;:0,&quot;scale&quot;:{&quot;x&quot;:1,&quot;y&quot;:1}}},&quot;63795faf-2b08-45eb-8acb-fdca1f733418&quot;:{&quot;type&quot;:&quot;FIGURE_OBJECT&quot;,&quot;id&quot;:&quot;63795faf-2b08-45eb-8acb-fdca1f733418&quot;,&quot;parent&quot;:{&quot;type&quot;:&quot;CHILD&quot;,&quot;parentId&quot;:&quot;efc64c62-8b6e-4678-97b7-e219fc9c229c&quot;,&quot;order&quot;:&quot;5&quot;},&quot;relativeTransform&quot;:{&quot;translate&quot;:{&quot;x&quot;:24.983,&quot;y&quot;:29.22},&quot;rotate&quot;:0,&quot;skewX&quot;:0,&quot;scale&quot;:{&quot;x&quot;:1,&quot;y&quot;:1}},&quot;path&quot;:{&quot;type&quot;:&quot;RECT&quot;,&quot;size&quot;:{&quot;x&quot;:13,&quot;y&quot;:58.44}},&quot;pathStyles&quot;:[{&quot;type&quot;:&quot;FILL&quot;,&quot;fillStyle&quot;:&quot;#005485&quot;}],&quot;opacity&quot;:1},&quot;9a1ff0ee-2877-48a6-8e16-f148f1ddf80d&quot;:{&quot;relativeTransform&quot;:{&quot;translate&quot;:{&quot;x&quot;:-186.23364507479548,&quot;y&quot;:47.668386042103855},&quot;rotate&quot;:3.141592653589793,&quot;skewX&quot;:0,&quot;scale&quot;:{&quot;x&quot;:1,&quot;y&quot;:1}},&quot;type&quot;:&quot;FIGURE_OBJECT&quot;,&quot;id&quot;:&quot;9a1ff0ee-2877-48a6-8e16-f148f1ddf80d&quot;,&quot;name&quot;:&quot;ssDNA brush 2 (arc, medium)&quot;,&quot;opacity&quot;:1,&quot;source&quot;:{&quot;id&quot;:&quot;6126a0160f59c500a0eb80cc&quot;,&quot;type&quot;:&quot;ASSETS&quot;},&quot;path&quot;:{&quot;type&quot;:&quot;POLY_LINE&quot;,&quot;points&quot;:[{&quot;x&quot;:-8.826705441223567,&quot;y&quot;:-95.93207332758917},{&quot;x&quot;:-8.826705441223595,&quot;y&quot;:-43.34882127829104},{&quot;x&quot;:-22.90110827776715,&quot;y&quot;:-18.753347565356535},{&quot;x&quot;:-22.90110827776716,&quot;y&quot;:0},{&quot;x&quot;:-3.3164505940902824,&quot;y&quot;:2.4940618041343985},{&quot;x&quot;:16.026783033684598,&quot;y&quot;:0},{&quot;x&quot;:16.02678303368461,&quot;y&quot;:-28.793603318637054},{&quot;x&quot;:1.1894054821440534,&quot;y&quot;:-45.871370409542806},{&quot;x&quot;:1.1894054821440534,&quot;y&quot;:-95.93207332758917}],&quot;closed&quot;:false,&quot;cornerRounding&quot;:{&quot;type&quot;:&quot;ARC_LENGTH&quot;,&quot;global&quot;:119.55382107276459},&quot;selectedObjectIds&quot;:[&quot;e2f6d1a7-72d9-442a-a641-c32373247a37&quot;]},&quot;pathStyles&quot;:[{&quot;type&quot;:&quot;FILL&quot;,&quot;fillStyle&quot;:&quot;rgba(0,0,0,0)&quot;},{&quot;type&quot;:&quot;STROKE&quot;,&quot;strokeStyle&quot;:&quot;rgba(0,0,0,0)&quot;,&quot;lineWidth&quot;:20.349089815444334,&quot;lineJoin&quot;:&quot;round&quot;}],&quot;pathPattern&quot;:{&quot;type&quot;:&quot;ROW&quot;,&quot;patternId&quot;:&quot;353ddc48-152e-4b17-9b17-7809c713def1&quot;,&quot;patternTransform&quot;:{&quot;translate&quot;:{&quot;x&quot;:-0.003164556962025317,&quot;y&quot;:-0.5},&quot;rotate&quot;:0,&quot;skewX&quot;:0,&quot;scale&quot;:{&quot;x&quot;:0.012658227848101266,&quot;y&quot;:0.012658227848101266}},&quot;xUnits&quot;:&quot;STROKE_WIDTH&quot;,&quot;yUnits&quot;:&quot;STROKE_WIDTH&quot;,&quot;bending&quot;:true,&quot;repeat&quot;:{&quot;distance&quot;:0.6265822784810127,&quot;align&quot;:&quot;CENTER&quot;},&quot;isPremium&quot;:true},&quot;isLocked&quot;:false,&quot;parent&quot;:{&quot;type&quot;:&quot;CHILD&quot;,&quot;parentId&quot;:&quot;ab9812b4-0e36-4ff6-8238-af0f78b54aeb&quot;,&quot;order&quot;:&quot;2&quot;},&quot;isPremium&quot;:true,&quot;displayName&quot;:&quot;Unwound ssDNA brush (arc, medium)&quot;,&quot;connectorInfo&quot;:{&quot;connectedObjects&quot;:[],&quot;type&quot;:&quot;ELBOW&quot;,&quot;offset&quot;:{&quot;x&quot;:0,&quot;y&quot;:0},&quot;bending&quot;:0.1,&quot;firstElementIsHead&quot;:true,&quot;customized&quot;:true}},&quot;353ddc48-152e-4b17-9b17-7809c713def1&quot;:{&quot;type&quot;:&quot;FIGURE_OBJECT&quot;,&quot;id&quot;:&quot;353ddc48-152e-4b17-9b17-7809c713def1&quot;,&quot;relativeTransform&quot;:{&quot;translate&quot;:{&quot;x&quot;:0,&quot;y&quot;:0},&quot;rotate&quot;:0,&quot;skewX&quot;:0,&quot;scale&quot;:{&quot;x&quot;:1,&quot;y&quot;:1}},&quot;source&quot;:{&quot;type&quot;:&quot;ASSETS&quot;,&quot;id&quot;:&quot;5ee1532b88e8df0028d0e2f0&quot;},&quot;name&quot;:&quot;ssDNA (unwound, single, for brush)&quot;},&quot;9f596d27-2bf2-43d3-bc14-1a54124d6414&quot;:{&quot;type&quot;:&quot;FIGURE_OBJECT&quot;,&quot;id&quot;:&quot;9f596d27-2bf2-43d3-bc14-1a54124d6414&quot;,&quot;parent&quot;:{&quot;type&quot;:&quot;CHILD&quot;,&quot;parentId&quot;:&quot;353ddc48-152e-4b17-9b17-7809c713def1&quot;,&quot;order&quot;:&quot;5&quot;},&quot;relativeTransform&quot;:{&quot;translate&quot;:{&quot;x&quot;:0,&quot;y&quot;:0},&quot;rotate&quot;:0,&quot;skewX&quot;:0,&quot;scale&quot;:{&quot;x&quot;:1,&quot;y&quot;:1}}},&quot;f4333eb8-4c80-4d6a-bc50-a8152267b3c0&quot;:{&quot;type&quot;:&quot;FIGURE_OBJECT&quot;,&quot;id&quot;:&quot;f4333eb8-4c80-4d6a-bc50-a8152267b3c0&quot;,&quot;parent&quot;:{&quot;type&quot;:&quot;CHILD&quot;,&quot;parentId&quot;:&quot;9f596d27-2bf2-43d3-bc14-1a54124d6414&quot;,&quot;order&quot;:&quot;5&quot;},&quot;relativeTransform&quot;:{&quot;translate&quot;:{&quot;x&quot;:24.983,&quot;y&quot;:68.39},&quot;rotate&quot;:0,&quot;skewX&quot;:0,&quot;scale&quot;:{&quot;x&quot;:1,&quot;y&quot;:1}},&quot;path&quot;:{&quot;type&quot;:&quot;RECT&quot;,&quot;size&quot;:{&quot;x&quot;:50,&quot;y&quot;:22}},&quot;pathStyles&quot;:[{&quot;type&quot;:&quot;FILL&quot;,&quot;fillStyle&quot;:&quot;#005485&quot;}],&quot;opacity&quot;:1},&quot;4c6c41bd-e864-4af0-ad71-d2c9ff6d02b6&quot;:{&quot;type&quot;:&quot;FIGURE_OBJECT&quot;,&quot;id&quot;:&quot;4c6c41bd-e864-4af0-ad71-d2c9ff6d02b6&quot;,&quot;parent&quot;:{&quot;type&quot;:&quot;CHILD&quot;,&quot;parentId&quot;:&quot;353ddc48-152e-4b17-9b17-7809c713def1&quot;,&quot;order&quot;:&quot;7&quot;},&quot;relativeTransform&quot;:{&quot;translate&quot;:{&quot;x&quot;:0,&quot;y&quot;:0},&quot;rotate&quot;:0,&quot;skewX&quot;:0,&quot;scale&quot;:{&quot;x&quot;:1,&quot;y&quot;:1}}},&quot;fa1ca970-f347-4377-bb99-2a03682589ec&quot;:{&quot;type&quot;:&quot;FIGURE_OBJECT&quot;,&quot;id&quot;:&quot;fa1ca970-f347-4377-bb99-2a03682589ec&quot;,&quot;parent&quot;:{&quot;type&quot;:&quot;CHILD&quot;,&quot;parentId&quot;:&quot;4c6c41bd-e864-4af0-ad71-d2c9ff6d02b6&quot;,&quot;order&quot;:&quot;5&quot;},&quot;relativeTransform&quot;:{&quot;translate&quot;:{&quot;x&quot;:24.983,&quot;y&quot;:29.22},&quot;rotate&quot;:0,&quot;skewX&quot;:0,&quot;scale&quot;:{&quot;x&quot;:1,&quot;y&quot;:1}},&quot;path&quot;:{&quot;type&quot;:&quot;RECT&quot;,&quot;size&quot;:{&quot;x&quot;:13,&quot;y&quot;:58.44}},&quot;pathStyles&quot;:[{&quot;type&quot;:&quot;FILL&quot;,&quot;fillStyle&quot;:&quot;#005485&quot;}],&quot;opacity&quot;:1},&quot;0a5fcdb9-49ce-4fbd-9203-bf213888530d&quot;:{&quot;relativeTransform&quot;:{&quot;translate&quot;:{&quot;x&quot;:730.2455115423643,&quot;y&quot;:-67.90847815054047},&quot;rotate&quot;:0,&quot;skewX&quot;:0,&quot;scale&quot;:{&quot;x&quot;:1,&quot;y&quot;:1}},&quot;type&quot;:&quot;FIGURE_OBJECT&quot;,&quot;id&quot;:&quot;0a5fcdb9-49ce-4fbd-9203-bf213888530d&quot;,&quot;parent&quot;:{&quot;type&quot;:&quot;CHILD&quot;,&quot;parentId&quot;:&quot;7b7e4984-9463-4fc4-81fa-65b50cc23e77&quot;,&quot;order&quot;:&quot;5&quot;},&quot;name&quot;:&quot;DNA probe (molecular beacon)&quot;,&quot;displayName&quot;:&quot;DNA probe (molecular beacon)&quot;,&quot;source&quot;:{&quot;id&quot;:&quot;6490d9632d2897db32e02945&quot;,&quot;type&quot;:&quot;ASSETS&quot;},&quot;isPremium&quot;:true},&quot;b12ff8ff-a11e-465c-9607-91847601eda1&quot;:{&quot;id&quot;:&quot;b12ff8ff-a11e-465c-9607-91847601eda1&quot;,&quot;name&quot;:&quot;Fluorophore (glowing)&quot;,&quot;displayName&quot;:&quot;&quot;,&quot;type&quot;:&quot;FIGURE_OBJECT&quot;,&quot;relativeTransform&quot;:{&quot;translate&quot;:{&quot;x&quot;:-196.935,&quot;y&quot;:150.5},&quot;rotate&quot;:0,&quot;skewX&quot;:0,&quot;scale&quot;:{&quot;x&quot;:0.6199999999999997,&quot;y&quot;:0.6199999999999997}},&quot;image&quot;:{&quot;url&quot;:&quot;https://icons.biorender.com/biorender/63bc3b90e7456200216bd10d/20230109180631/image/fluorophore-glowing.png&quot;,&quot;fallbackUrl&quot;:&quot;https://res.cloudinary.com/dlcjuc3ej/image/upload/v1673287591/dhonwdgyc6wn0h3e6mgf.svg#/keystone/api/icons/63bc3b90e7456200216bd10d/20230109180631/image/fluorophore-glowing.svg&quot;,&quot;isPremium&quot;:false,&quot;size&quot;:{&quot;x&quot;:50,&quot;y&quot;:50}},&quot;source&quot;:{&quot;id&quot;:&quot;63bc3b90e7456200216bd10d&quot;,&quot;type&quot;:&quot;ASSETS&quot;},&quot;isPremium&quot;:false,&quot;parent&quot;:{&quot;type&quot;:&quot;CHILD&quot;,&quot;parentId&quot;:&quot;ab9812b4-0e36-4ff6-8238-af0f78b54aeb&quot;,&quot;order&quot;:&quot;5&quot;}},&quot;75534751-8511-4193-906c-41a87a1bc152&quot;:{&quot;id&quot;:&quot;75534751-8511-4193-906c-41a87a1bc152&quot;,&quot;name&quot;:&quot;Sphere&quot;,&quot;displayName&quot;:&quot;&quot;,&quot;type&quot;:&quot;FIGURE_OBJECT&quot;,&quot;relativeTransform&quot;:{&quot;translate&quot;:{&quot;x&quot;:-171.2965,&quot;y&quot;:150.2825},&quot;rotate&quot;:0,&quot;skewX&quot;:0,&quot;scale&quot;:{&quot;x&quot;:0.40553999999999973,&quot;y&quot;:0.40553999999999973}},&quot;image&quot;:{&quot;url&quot;:&quot;https://icons.biorender.com/biorender/5f4529c2929bce0028c9f87f/sphere.png&quot;,&quot;fallbackUrl&quot;:&quot;https://res.cloudinary.com/dlcjuc3ej/image/upload/v1598368171/soihczeyq35kxprwz6kd.svg#/keystone/api/icons/5f4529c2929bce0028c9f87f/sphere.svg#/keystone/api/icons/5f4529c2929bce0028c9f87f/sphere.svg#/keystone/api/icons/5f4529c2929bce0028c9f87f/sphere.svg&quot;,&quot;isPremium&quot;:false,&quot;size&quot;:{&quot;x&quot;:50,&quot;y&quot;:50}},&quot;source&quot;:{&quot;id&quot;:&quot;5b8847989629ce1400901caa&quot;,&quot;type&quot;:&quot;ASSETS&quot;},&quot;isPremium&quot;:false,&quot;parent&quot;:{&quot;type&quot;:&quot;CHILD&quot;,&quot;parentId&quot;:&quot;ab9812b4-0e36-4ff6-8238-af0f78b54aeb&quot;,&quot;order&quot;:&quot;7&quot;}},&quot;ab9812b4-0e36-4ff6-8238-af0f78b54aeb&quot;:{&quot;type&quot;:&quot;FIGURE_OBJECT&quot;,&quot;id&quot;:&quot;ab9812b4-0e36-4ff6-8238-af0f78b54aeb&quot;,&quot;parent&quot;:{&quot;type&quot;:&quot;CHILD&quot;,&quot;parentId&quot;:&quot;7b7e4984-9463-4fc4-81fa-65b50cc23e77&quot;,&quot;order&quot;:&quot;99997&quot;},&quot;relativeTransform&quot;:{}}}}"/>
    <we:property name="65400759b77c89622ec39fd8_1700070236146" value="{&quot;id&quot;:&quot;4a437cf1-cc13-41fd-abad-64e9dc1c9b2e&quot;,&quot;objects&quot;:{&quot;4a437cf1-cc13-41fd-abad-64e9dc1c9b2e&quot;:{&quot;id&quot;:&quot;4a437cf1-cc13-41fd-abad-64e9dc1c9b2e&quot;,&quot;type&quot;:&quot;FIGURE_OBJECT&quot;,&quot;document&quot;:{&quot;type&quot;:&quot;DOCUMENT_GROUP&quot;,&quot;canvasType&quot;:&quot;FIGURE&quot;,&quot;units&quot;:&quot;in&quot;}},&quot;3c6ea87e-e7f6-4c95-9926-521492df5164&quot;:{&quot;id&quot;:&quot;3c6ea87e-e7f6-4c95-9926-521492df5164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4a437cf1-cc13-41fd-abad-64e9dc1c9b2e&quot;,&quot;type&quot;:&quot;FRAME&quot;,&quot;order&quot;:&quot;5&quot;}},&quot;7b7e4984-9463-4fc4-81fa-65b50cc23e77&quot;:{&quot;id&quot;:&quot;7b7e4984-9463-4fc4-81fa-65b50cc23e77&quot;,&quot;type&quot;:&quot;FIGURE_OBJECT&quot;,&quot;document&quot;:{&quot;type&quot;:&quot;FIGURE&quot;,&quot;canvasType&quot;:&quot;FIGURE&quot;,&quot;units&quot;:&quot;in&quot;},&quot;parent&quot;:{&quot;parentId&quot;:&quot;4a437cf1-cc13-41fd-abad-64e9dc1c9b2e&quot;,&quot;type&quot;:&quot;DOCUMENT&quot;,&quot;order&quot;:&quot;5&quot;}},&quot;bb5cf74e-6a1b-4043-b7a4-6fd7b3b4616c&quot;:{&quot;id&quot;:&quot;bb5cf74e-6a1b-4043-b7a4-6fd7b3b4616c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7b7e4984-9463-4fc4-81fa-65b50cc23e77&quot;,&quot;order&quot;:&quot;5&quot;}},&quot;3072a4eb-bbd5-436b-9f71-ab373205701f&quot;:{&quot;id&quot;:&quot;3072a4eb-bbd5-436b-9f71-ab373205701f&quot;,&quot;type&quot;:&quot;FIGURE_OBJECT&quot;,&quot;guide&quot;:{&quot;type&quot;:&quot;GRID&quot;,&quot;distance&quot;:0.5,&quot;units&quot;:&quot;in&quot;},&quot;parent&quot;:{&quot;parentId&quot;:&quot;4a437cf1-cc13-41fd-abad-64e9dc1c9b2e&quot;,&quot;type&quot;:&quot;GUIDE&quot;,&quot;order&quot;:&quot;5&quot;}},&quot;d4bd7777-f03e-4a6e-b382-90344361d4d2&quot;:{&quot;id&quot;:&quot;d4bd7777-f03e-4a6e-b382-90344361d4d2&quot;,&quot;name&quot;:&quot;RNA (stem loop, small, short)&quot;,&quot;displayName&quot;:&quot;Short stem loop RNA&quot;,&quot;type&quot;:&quot;FIGURE_OBJECT&quot;,&quot;relativeTransform&quot;:{&quot;translate&quot;:{&quot;x&quot;:-324.2455115423642,&quot;y&quot;:-32.04826847091977},&quot;rotate&quot;:1.5707963267948966,&quot;skewX&quot;:0,&quot;scale&quot;:{&quot;x&quot;:0.9180916249940575,&quot;y&quot;:0.9180916249940575}},&quot;image&quot;:{&quot;url&quot;:&quot;https://icons.biorender.com/biorender/5d2f5bce1900ef0400b1d8a2/rna-stem-loop-small-short.png&quot;,&quot;fallbackUrl&quot;:&quot;https://res.cloudinary.com/dlcjuc3ej/image/upload/v1563384776/izjmqkirucjsajhj1qqa.svg#/keystone/api/icons/5d2f5bce1900ef0400b1d8a2/rna-stem-loop-small-short.svg&quot;,&quot;isPremium&quot;:false,&quot;size&quot;:{&quot;x&quot;:126,&quot;y&quot;:75.95744680851064}},&quot;source&quot;:{&quot;id&quot;:&quot;5d2f5b911900ef0400b1d88e&quot;,&quot;type&quot;:&quot;ASSETS&quot;},&quot;isPremium&quot;:false,&quot;parent&quot;:{&quot;type&quot;:&quot;CHILD&quot;,&quot;parentId&quot;:&quot;0a5fcdb9-49ce-4fbd-9203-bf213888530d&quot;,&quot;order&quot;:&quot;2&quot;}},&quot;9d7158e3-aa76-45f9-85eb-6da1c7f874a7&quot;:{&quot;type&quot;:&quot;FIGURE_OBJECT&quot;,&quot;id&quot;:&quot;9d7158e3-aa76-45f9-85eb-6da1c7f874a7&quot;,&quot;relativeTransform&quot;:{&quot;translate&quot;:{&quot;x&quot;:-310.36273233242946,&quot;y&quot;:33.18167866367205},&quot;rotate&quot;:0},&quot;opacity&quot;:1,&quot;path&quot;:{&quot;type&quot;:&quot;ELLIPSE&quot;,&quot;size&quot;:{&quot;x&quot;:-17.046636965908576,&quot;y&quot;:-17.046636965908558}},&quot;isLocked&quot;:false,&quot;pathStyles&quot;:[{&quot;type&quot;:&quot;FILL&quot;,&quot;fillStyle&quot;:&quot;rgb(155, 155, 155)&quot;},{&quot;type&quot;:&quot;STROKE&quot;,&quot;strokeStyle&quot;:&quot;rgba(0,0,0,0)&quot;,&quot;lineWidth&quot;:2.2666731540783633,&quot;lineJoin&quot;:&quot;round&quot;}],&quot;parent&quot;:{&quot;type&quot;:&quot;CHILD&quot;,&quot;parentId&quot;:&quot;0a5fcdb9-49ce-4fbd-9203-bf213888530d&quot;,&quot;order&quot;:&quot;5&quot;}},&quot;2dcb267b-0053-4045-b25f-bc1086e86a30&quot;:{&quot;type&quot;:&quot;FIGURE_OBJECT&quot;,&quot;id&quot;:&quot;2dcb267b-0053-4045-b25f-bc1086e86a30&quot;,&quot;relativeTransform&quot;:{&quot;translate&quot;:{&quot;x&quot;:-338.12837006749106,&quot;y&quot;:33.18162500091516},&quot;rotate&quot;:0},&quot;opacity&quot;:1,&quot;path&quot;:{&quot;type&quot;:&quot;ELLIPSE&quot;,&quot;size&quot;:{&quot;x&quot;:-17.046636965908576,&quot;y&quot;:-17.046636965908558}},&quot;isLocked&quot;:false,&quot;pathStyles&quot;:[{&quot;type&quot;:&quot;FILL&quot;,&quot;fillStyle&quot;:&quot;rgb(90, 195, 63)&quot;},{&quot;type&quot;:&quot;STROKE&quot;,&quot;strokeStyle&quot;:&quot;rgba(0,0,0,0)&quot;,&quot;lineWidth&quot;:2.2666731540783633,&quot;lineJoin&quot;:&quot;round&quot;}],&quot;parent&quot;:{&quot;type&quot;:&quot;CHILD&quot;,&quot;parentId&quot;:&quot;0a5fcdb9-49ce-4fbd-9203-bf213888530d&quot;,&quot;order&quot;:&quot;7&quot;}},&quot;9463ce90-0d6d-48a7-955b-0eafe746e80f&quot;:{&quot;id&quot;:&quot;9463ce90-0d6d-48a7-955b-0eafe746e80f&quot;,&quot;name&quot;:&quot;Tomato (young plant)&quot;,&quot;displayName&quot;:&quot;&quot;,&quot;type&quot;:&quot;FIGURE_OBJECT&quot;,&quot;relativeTransform&quot;:{&quot;translate&quot;:{&quot;x&quot;:-362.42105263157896,&quot;y&quot;:-193.50000000000003},&quot;rotate&quot;:0,&quot;skewX&quot;:0,&quot;scale&quot;:{&quot;x&quot;:1.0515789473684214,&quot;y&quot;:1.0515789473684214}},&quot;image&quot;:{&quot;url&quot;:&quot;https://icons.biorender.com/biorender/648b3ce6c5ed7f002049b7f7/20230616135452/image/tomato-young-plant-01.png&quot;,&quot;fallbackUrl&quot;:&quot;https://res.cloudinary.com/dlcjuc3ej/image/upload/v1686923692/rkyrynaayxvjxz9ewuuz.svg#/keystone/api/icons/648b3ce6c5ed7f002049b7f7/20230616135452/image/tomato-young-plant-01.svg#/keystone/api/icons/648b3ce6c5ed7f002049b7f7/20230616135452/image/tomato-young-plant-01.svg#/keystone/api/icons/648b3ce6c5ed7f002049b7f7/20230616135452/image/tomato-young-plant-01.svg&quot;,&quot;isPremium&quot;:false,&quot;size&quot;:{&quot;x&quot;:100,&quot;y&quot;:135.71428571428572}},&quot;source&quot;:{&quot;id&quot;:&quot;648b3ce6c5ed7f002049b7f7&quot;,&quot;type&quot;:&quot;ASSETS&quot;},&quot;isPremium&quot;:false,&quot;parent&quot;:{&quot;type&quot;:&quot;CHILD&quot;,&quot;parentId&quot;:&quot;25d0b15c-090e-432f-8b17-d3ee35a75e04&quot;,&quot;order&quot;:&quot;1&quot;}},&quot;071052da-ecfc-44f2-91d2-a43b157802dc&quot;:{&quot;id&quot;:&quot;071052da-ecfc-44f2-91d2-a43b157802dc&quot;,&quot;name&quot;:&quot;Coccus&quot;,&quot;displayName&quot;:&quot;&quot;,&quot;type&quot;:&quot;FIGURE_OBJECT&quot;,&quot;relativeTransform&quot;:{&quot;translate&quot;:{&quot;x&quot;:-335.5,&quot;y&quot;:-228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2&quot;}},&quot;0fd8dea4-10d4-4eca-aa9f-d1c1887c591b&quot;:{&quot;id&quot;:&quot;0fd8dea4-10d4-4eca-aa9f-d1c1887c591b&quot;,&quot;name&quot;:&quot;Coccus&quot;,&quot;displayName&quot;:&quot;&quot;,&quot;type&quot;:&quot;FIGURE_OBJECT&quot;,&quot;relativeTransform&quot;:{&quot;translate&quot;:{&quot;x&quot;:-357.5,&quot;y&quot;:-180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3&quot;}},&quot;e10e8714-dcf8-4450-85b7-02b940d112bc&quot;:{&quot;id&quot;:&quot;e10e8714-dcf8-4450-85b7-02b940d112bc&quot;,&quot;name&quot;:&quot;Coccus&quot;,&quot;displayName&quot;:&quot;&quot;,&quot;type&quot;:&quot;FIGURE_OBJECT&quot;,&quot;relativeTransform&quot;:{&quot;translate&quot;:{&quot;x&quot;:-315.5,&quot;y&quot;:-208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5&quot;}},&quot;f0e233af-f130-4819-a54a-2cfbee755576&quot;:{&quot;id&quot;:&quot;f0e233af-f130-4819-a54a-2cfbee755576&quot;,&quot;name&quot;:&quot;Coccus&quot;,&quot;displayName&quot;:&quot;&quot;,&quot;type&quot;:&quot;FIGURE_OBJECT&quot;,&quot;relativeTransform&quot;:{&quot;translate&quot;:{&quot;x&quot;:-346.5,&quot;y&quot;:-250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6&quot;}},&quot;c99d3071-d616-417e-afb9-084caaa70d3b&quot;:{&quot;id&quot;:&quot;c99d3071-d616-417e-afb9-084caaa70d3b&quot;,&quot;name&quot;:&quot;Coccus&quot;,&quot;displayName&quot;:&quot;&quot;,&quot;type&quot;:&quot;FIGURE_OBJECT&quot;,&quot;relativeTransform&quot;:{&quot;translate&quot;:{&quot;x&quot;:-381.5,&quot;y&quot;:-198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7&quot;}},&quot;c65e6156-3a59-4b60-a825-04338a79d208&quot;:{&quot;id&quot;:&quot;c65e6156-3a59-4b60-a825-04338a79d208&quot;,&quot;name&quot;:&quot;Coccus&quot;,&quot;displayName&quot;:&quot;&quot;,&quot;type&quot;:&quot;FIGURE_OBJECT&quot;,&quot;relativeTransform&quot;:{&quot;translate&quot;:{&quot;x&quot;:-392.5,&quot;y&quot;:-239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8&quot;}},&quot;25d0b15c-090e-432f-8b17-d3ee35a75e04&quot;:{&quot;type&quot;:&quot;FIGURE_OBJECT&quot;,&quot;id&quot;:&quot;25d0b15c-090e-432f-8b17-d3ee35a75e04&quot;,&quot;parent&quot;:{&quot;type&quot;:&quot;CHILD&quot;,&quot;parentId&quot;:&quot;7b7e4984-9463-4fc4-81fa-65b50cc23e77&quot;,&quot;order&quot;:&quot;99&quot;},&quot;relativeTransform&quot;:{}},&quot;ac4cdecc-0bee-4a6d-b27e-b401ef2fae39&quot;:{&quot;type&quot;:&quot;FIGURE_OBJECT&quot;,&quot;id&quot;:&quot;ac4cdecc-0bee-4a6d-b27e-b401ef2fae39&quot;,&quot;relativeTransform&quot;:{&quot;translate&quot;:{&quot;x&quot;:-231.5,&quot;y&quot;:-199.5},&quot;rotate&quot;:0,&quot;skewX&quot;:0,&quot;scale&quot;:{&quot;x&quot;:1,&quot;y&quot;:1}},&quot;opacity&quot;:1,&quot;path&quot;:{&quot;type&quot;:&quot;POLY_LINE&quot;,&quot;points&quot;:[{&quot;x&quot;:-57.5,&quot;y&quot;:0},{&quot;x&quot;:57.5,&quot;y&quot;:0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7b7e4984-9463-4fc4-81fa-65b50cc23e77&quot;,&quot;order&quot;:&quot;995&quot;},&quot;connectorInfo&quot;:{&quot;connectedObjects&quot;:[],&quot;type&quot;:&quot;LINE&quot;,&quot;offset&quot;:{&quot;x&quot;:0,&quot;y&quot;:0},&quot;bending&quot;:0.1,&quot;firstElementIsHead&quot;:true,&quot;customized&quot;:false}},&quot;eea7b0d9-8596-4241-b525-e46224e54677&quot;:{&quot;relativeTransform&quot;:{&quot;translate&quot;:{&quot;x&quot;:21.54493002314885,&quot;y&quot;:-289.3802889155868},&quot;rotate&quot;:0,&quot;skewX&quot;:0,&quot;scale&quot;:{&quot;x&quot;:1,&quot;y&quot;:1}},&quot;type&quot;:&quot;FIGURE_OBJECT&quot;,&quot;id&quot;:&quot;eea7b0d9-8596-4241-b525-e46224e54677&quot;,&quot;parent&quot;:{&quot;type&quot;:&quot;CHILD&quot;,&quot;parentId&quot;:&quot;7b7e4984-9463-4fc4-81fa-65b50cc23e77&quot;,&quot;order&quot;:&quot;997&quot;},&quot;name&quot;:&quot;Eppendorf tube (2/3 liquid, closed, purified DNA)&quot;,&quot;displayName&quot;:&quot;Eppendorf tube (2/3 liquid, closed, purified DNA)&quot;,&quot;source&quot;:{&quot;id&quot;:&quot;649a24bd6053d8852968a94c&quot;,&quot;type&quot;:&quot;ASSETS&quot;},&quot;isPremium&quot;:true},&quot;c524e319-d620-4244-838c-a32609ff2054&quot;:{&quot;id&quot;:&quot;c524e319-d620-4244-838c-a32609ff2054&quot;,&quot;name&quot;:&quot;Eppendorf tube (2-3, closed)&quot;,&quot;displayName&quot;:&quot;Eppendorf tube (2/3 liquid, closed)&quot;,&quot;type&quot;:&quot;FIGURE_OBJECT&quot;,&quot;relativeTransform&quot;:{&quot;translate&quot;:{&quot;x&quot;:-149.70293002314884,&quot;y&quot;:95.88028891558676},&quot;rotate&quot;:0,&quot;skewX&quot;:0,&quot;scale&quot;:{&quot;x&quot;:1,&quot;y&quot;:1}},&quot;image&quot;:{&quot;url&quot;:&quot;https://icons.biorender.com/biorender/5e41d9e1e250000028d2f747/20200210223234/image/eppendorf-tube-2-3-closed.png&quot;,&quot;fallbackUrl&quot;:&quot;https://res.cloudinary.com/dlcjuc3ej/image/upload/v1581373954/nngdqp51odoekaeiuc07.svg#/keystone/api/icons/5e41d9e1e250000028d2f747/20200210223234/image/eppendorf-tube-2-3-closed.svg&quot;,&quot;isPremium&quot;:false,&quot;size&quot;:{&quot;x&quot;:50,&quot;y&quot;:108.64197530864197}},&quot;source&quot;:{&quot;id&quot;:&quot;5e41d9e1e250000028d2f747&quot;,&quot;type&quot;:&quot;ASSETS&quot;},&quot;isPremium&quot;:false,&quot;parent&quot;:{&quot;type&quot;:&quot;CHILD&quot;,&quot;parentId&quot;:&quot;eea7b0d9-8596-4241-b525-e46224e54677&quot;,&quot;order&quot;:&quot;1&quot;}},&quot;9c8ea1eb-3b53-43bb-a632-5bf4a1afc029&quot;:{&quot;relativeTransform&quot;:{&quot;translate&quot;:{&quot;x&quot;:-143.67565150044493,&quot;y&quot;:109.23830944009394},&quot;rotate&quot;:-0.6799351313605974,&quot;skewX&quot;:0,&quot;scale&quot;:{&quot;x&quot;:1,&quot;y&quot;:1}},&quot;type&quot;:&quot;FIGURE_OBJECT&quot;,&quot;id&quot;:&quot;9c8ea1eb-3b53-43bb-a632-5bf4a1afc029&quot;,&quot;name&quot;:&quot;dsDNA brush 3 (straight)&quot;,&quot;displayName&quot;:&quot;Simplified dsDNA brush (straight)&quot;,&quot;opacity&quot;:1,&quot;source&quot;:{&quot;id&quot;:&quot;5e75575f52bb9000abea6260&quot;,&quot;type&quot;:&quot;ASSETS&quot;},&quot;path&quot;:{&quot;type&quot;:&quot;POLY_LINE&quot;,&quot;points&quot;:[{&quot;x&quot;:-8.559496991294791,&quot;y&quot;:0},{&quot;x&quot;:8.559496991294786,&quot;y&quot;:0}],&quot;closed&quot;:false},&quot;pathStyles&quot;:[{&quot;type&quot;:&quot;FILL&quot;,&quot;fillStyle&quot;:&quot;rgba(0,0,0,0)&quot;},{&quot;type&quot;:&quot;STROKE&quot;,&quot;strokeStyle&quot;:&quot;rgba(0,0,0,0)&quot;,&quot;lineWidth&quot;:4.412664353661106,&quot;lineJoin&quot;:&quot;round&quot;}],&quot;pathSmoothing&quot;:{&quot;type&quot;:&quot;CATMULL_SMOOTHING&quot;,&quot;smoothing&quot;:0.2},&quot;pathPattern&quot;:{&quot;type&quot;:&quot;ROW&quot;,&quot;patternId&quot;:&quot;f532a18f-fcaf-4e90-9771-d1d24f456ad7&quot;,&quot;patternTransform&quot;:{&quot;translate&quot;:{&quot;x&quot;:-0.00002540549651012527,&quot;y&quot;:-0.5},&quot;rotate&quot;:0,&quot;skewX&quot;:0,&quot;scale&quot;:{&quot;x&quot;:0.005076142131979695,&quot;y&quot;:0.005076142131979695}},&quot;xUnits&quot;:&quot;STROKE_WIDTH&quot;,&quot;yUnits&quot;:&quot;STROKE_WIDTH&quot;,&quot;bending&quot;:true,&quot;repeat&quot;:{&quot;distance&quot;:1.8661421567655458,&quot;align&quot;:&quot;CENTER&quot;},&quot;isPremium&quot;:true},&quot;isLocked&quot;:false,&quot;parent&quot;:{&quot;type&quot;:&quot;CHILD&quot;,&quot;parentId&quot;:&quot;eea7b0d9-8596-4241-b525-e46224e54677&quot;,&quot;order&quot;:&quot;2&quot;},&quot;isPremium&quot;:true},&quot;f532a18f-fcaf-4e90-9771-d1d24f456ad7&quot;:{&quot;type&quot;:&quot;FIGURE_OBJECT&quot;,&quot;id&quot;:&quot;f532a18f-fcaf-4e90-9771-d1d24f456ad7&quot;,&quot;relativeTransform&quot;:{&quot;translate&quot;:{&quot;x&quot;:0,&quot;y&quot;:0},&quot;rotate&quot;:0,&quot;skewX&quot;:0,&quot;scale&quot;:{&quot;x&quot;:1,&quot;y&quot;:1}},&quot;source&quot;:{&quot;type&quot;:&quot;ASSETS&quot;,&quot;id&quot;:&quot;5e71324176df310028d1ed5d&quot;},&quot;name&quot;:&quot;dsDNA (simplified)&quot;},&quot;4c16448e-f83f-496f-85a4-f737bb9f34e5&quot;:{&quot;type&quot;:&quot;FIGURE_OBJECT&quot;,&quot;id&quot;:&quot;4c16448e-f83f-496f-85a4-f737bb9f34e5&quot;,&quot;parent&quot;:{&quot;type&quot;:&quot;CHILD&quot;,&quot;parentId&quot;:&quot;f532a18f-fcaf-4e90-9771-d1d24f456ad7&quot;,&quot;order&quot;:&quot;7&quot;},&quot;relativeTransform&quot;:{&quot;translate&quot;:{&quot;x&quot;:0,&quot;y&quot;:0},&quot;rotate&quot;:0,&quot;skewX&quot;:0,&quot;scale&quot;:{&quot;x&quot;:1,&quot;y&quot;:1}}},&quot;7c5ce5c3-0e14-4d57-a8f7-eda61a3bb4c3&quot;:{&quot;type&quot;:&quot;FIGURE_OBJECT&quot;,&quot;id&quot;:&quot;7c5ce5c3-0e14-4d57-a8f7-eda61a3bb4c3&quot;,&quot;parent&quot;:{&quot;type&quot;:&quot;CHILD&quot;,&quot;parentId&quot;:&quot;4c16448e-f83f-496f-85a4-f737bb9f34e5&quot;,&quot;order&quot;:&quot;2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.14,&quot;isEndPoint&quot;:true},{&quot;x&quot;:353.18,&quot;y&quot;:7.140000000000001,&quot;isEndPoint&quot;:false},{&quot;x&quot;:332.5,&quot;y&quot;:7.140000000000001,&quot;isEndPoint&quot;:false},{&quot;x&quot;:332.5,&quot;y&quot;:7.140000000000001,&quot;isEndPoint&quot;:true},{&quot;x&quot;:282,&quot;y&quot;:7.42,&quot;isEndPoint&quot;:false},{&quot;x&quot;:251.44,&quot;y&quot;:51,&quot;isEndPoint&quot;:false},{&quot;x&quot;:224.49,&quot;y&quot;:89.43,&quot;isEndPoint&quot;:true},{&quot;x&quot;:201.26000000000002,&quot;y&quot;:122.59,&quot;isEndPoint&quot;:false},{&quot;x&quot;:179.31,&quot;y&quot;:153.9,&quot;isEndPoint&quot;:false},{&quot;x&quot;:149.9,&quot;y&quot;:153.9,&quot;isEndPoint&quot;:true},{&quot;x&quot;:149.32,&quot;y&quot;:153.9,&quot;isEndPoint&quot;:true},{&quot;x&quot;:149.32,&quot;y&quot;:189.9,&quot;isEndPoint&quot;:true},{&quot;x&quot;:149.91,&quot;y&quot;:189.9,&quot;isEndPoint&quot;:true},{&quot;x&quot;:198.06,&quot;y&quot;:189.9,&quot;isEndPoint&quot;:false},{&quot;x&quot;:226.5,&quot;y&quot;:149.31,&quot;isEndPoint&quot;:false},{&quot;x&quot;:254.01999999999998,&quot;y&quot;:110.05000000000001,&quot;isEndPoint&quot;:true},{&quot;x&quot;:278.15,&quot;y&quot;:75.61000000000001,&quot;isEndPoint&quot;:false},{&quot;x&quot;:300.95,&quot;y&quot;:43.05000000000001,&quot;isEndPoint&quot;:false},{&quot;x&quot;:333.02,&quot;y&quot;:43.05000000000001,&quot;isEndPoint&quot;:true},{&quot;x&quot;:333.02,&quot;y&quot;:43.05000000000001,&quot;isEndPoint&quot;:true},{&quot;x&quot;:344.54999999999995,&quot;y&quot;:43.05000000000001,&quot;isEndPoint&quot;:false},{&quot;x&quot;:356.46999999999997,&quot;y&quot;:47.16000000000001,&quot;isEndPoint&quot;:false},{&quot;x&quot;:367.56,&quot;y&quot;:55.750000000000014,&quot;isEndPoint&quot;:true}],&quot;closed&quot;:true}},&quot;pathStyles&quot;:[{&quot;type&quot;:&quot;FILL&quot;,&quot;fillStyle&quot;:&quot;#002479&quot;}],&quot;opacity&quot;:1},&quot;6b3e2be0-51f5-4cb7-8e57-2cad8f751846&quot;:{&quot;type&quot;:&quot;FIGURE_OBJECT&quot;,&quot;id&quot;:&quot;6b3e2be0-51f5-4cb7-8e57-2cad8f751846&quot;,&quot;parent&quot;:{&quot;type&quot;:&quot;CHILD&quot;,&quot;parentId&quot;:&quot;4c16448e-f83f-496f-85a4-f737bb9f34e5&quot;,&quot;order&quot;:&quot;5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1.2,&quot;isEndPoint&quot;:true},{&quot;x&quot;:350.99,&quot;y&quot;:128.64999999999998,&quot;isEndPoint&quot;:false},{&quot;x&quot;:336.37,&quot;y&quot;:108.67999999999998,&quot;isEndPoint&quot;:false},{&quot;x&quot;:321.13,&quot;y&quot;:86.92999999999998,&quot;isEndPoint&quot;:true},{&quot;x&quot;:293.62,&quot;y&quot;:47.67,&quot;isEndPoint&quot;:false},{&quot;x&quot;:265.18,&quot;y&quot;:7.08,&quot;isEndPoint&quot;:false},{&quot;x&quot;:217,&quot;y&quot;:7.08,&quot;isEndPoint&quot;:true},{&quot;x&quot;:168.82,&quot;y&quot;:7.08,&quot;isEndPoint&quot;:false},{&quot;x&quot;:140.4,&quot;y&quot;:47.67,&quot;isEndPoint&quot;:false},{&quot;x&quot;:112.89,&quot;y&quot;:86.92999999999999,&quot;isEndPoint&quot;:true},{&quot;x&quot;:88.75,&quot;y&quot;:121.36999999999999,&quot;isEndPoint&quot;:false},{&quot;x&quot;:65.96000000000001,&quot;y&quot;:153.93,&quot;isEndPoint&quot;:false},{&quot;x&quot;:33.83,&quot;y&quot;:153.93,&quot;isEndPoint&quot;:true},{&quot;x&quot;:22.56,&quot;y&quot;:153.9,&quot;isEndPoint&quot;:false},{&quot;x&quot;:11,&quot;y&quot;:149.44,&quot;isEndPoint&quot;:false},{&quot;x&quot;:0.11,&quot;y&quot;:141.2,&quot;isEndPoint&quot;:true},{&quot;x&quot;:0,&quot;y&quot;:182.8,&quot;isEndPoint&quot;:true},{&quot;x&quot;:0.35,&quot;y&quot;:182.95000000000002,&quot;isEndPoint&quot;:true},{&quot;x&quot;:10.905530717350821,&quot;y&quot;:187.59644786408347,&quot;isEndPoint&quot;:false},{&quot;x&quot;:22.317101480766773,&quot;y&quot;:189.98095518778234,&quot;isEndPoint&quot;:false},{&quot;x&quot;:33.84999999999999,&quot;y&quot;:189.95000000000002,&quot;isEndPoint&quot;:true},{&quot;x&quot;:84.73999999999998,&quot;y&quot;:189.95000000000002,&quot;isEndPoint&quot;:false},{&quot;x&quot;:115.38999999999999,&quot;y&quot;:146.21,&quot;isEndPoint&quot;:false},{&quot;x&quot;:142.45,&quot;y&quot;:107.60000000000002,&quot;isEndPoint&quot;:true},{&quot;x&quot;:165.68,&quot;y&quot;:74.45,&quot;isEndPoint&quot;:false},{&quot;x&quot;:187.62,&quot;y&quot;:43.13,&quot;isEndPoint&quot;:false},{&quot;x&quot;:217,&quot;y&quot;:43.13,&quot;isEndPoint&quot;:true},{&quot;x&quot;:246.38,&quot;y&quot;:43.13,&quot;isEndPoint&quot;:false},{&quot;x&quot;:268.35,&quot;y&quot;:74.46000000000001,&quot;isEndPoint&quot;:false},{&quot;x&quot;:291.58,&quot;y&quot;:107.62,&quot;isEndPoint&quot;:true},{&quot;x&quot;:311.82,&quot;y&quot;:136.5,&quot;isEndPoint&quot;:false},{&quot;x&quot;:335.58,&quot;y&quot;:168.97,&quot;isEndPoint&quot;:false},{&quot;x&quot;:367.58,&quot;y&quot;:182.8,&quot;isEndPoint&quot;:true}],&quot;closed&quot;:true}},&quot;pathStyles&quot;:[{&quot;type&quot;:&quot;FILL&quot;,&quot;fillStyle&quot;:&quot;#184193&quot;}],&quot;opacity&quot;:1},&quot;31afc61c-4969-435e-9a3d-2ad6540465d1&quot;:{&quot;type&quot;:&quot;FIGURE_OBJECT&quot;,&quot;id&quot;:&quot;31afc61c-4969-435e-9a3d-2ad6540465d1&quot;,&quot;parent&quot;:{&quot;type&quot;:&quot;CHILD&quot;,&quot;parentId&quot;:&quot;4c16448e-f83f-496f-85a4-f737bb9f34e5&quot;,&quot;order&quot;:&quot;7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149.9,&quot;y&quot;:153.9,&quot;isEndPoint&quot;:true},{&quot;x&quot;:120.5,&quot;y&quot;:153.9,&quot;isEndPoint&quot;:false},{&quot;x&quot;:98.56,&quot;y&quot;:122.59,&quot;isEndPoint&quot;:false},{&quot;x&quot;:75.33000000000001,&quot;y&quot;:89.43,&quot;isEndPoint&quot;:true},{&quot;x&quot;:75.33000000000001,&quot;y&quot;:89.43,&quot;isEndPoint&quot;:true},{&quot;x&quot;:55.25,&quot;y&quot;:60.79,&quot;isEndPoint&quot;:false},{&quot;x&quot;:31.69,&quot;y&quot;:28.16,&quot;isEndPoint&quot;:false},{&quot;x&quot;:0,&quot;y&quot;:14.14,&quot;isEndPoint&quot;:true},{&quot;x&quot;:0,&quot;y&quot;:55.83,&quot;isEndPoint&quot;:true},{&quot;x&quot;:16.4,&quot;y&quot;:68.49,&quot;isEndPoint&quot;:false},{&quot;x&quot;:30.8,&quot;y&quot;:88.71000000000001,&quot;isEndPoint&quot;:false},{&quot;x&quot;:45.79,&quot;y&quot;:110.11,&quot;isEndPoint&quot;:true},{&quot;x&quot;:73.3,&quot;y&quot;:149.36,&quot;isEndPoint&quot;:false},{&quot;x&quot;:101.74,&quot;y&quot;:190,&quot;isEndPoint&quot;:false},{&quot;x&quot;:149.9,&quot;y&quot;:190,&quot;isEndPoint&quot;:true}],&quot;closed&quot;:true}},&quot;pathStyles&quot;:[{&quot;type&quot;:&quot;FILL&quot;,&quot;fillStyle&quot;:&quot;#002479&quot;}],&quot;opacity&quot;:1},&quot;ec6a3940-0330-4ef9-aa1f-f72d7b40799e&quot;:{&quot;relativeTransform&quot;:{&quot;translate&quot;:{&quot;x&quot;:-151.87049059560525,&quot;y&quot;:97.84308023383895},&quot;rotate&quot;:-2.105561685167923,&quot;skewX&quot;:0,&quot;scale&quot;:{&quot;x&quot;:1,&quot;y&quot;:1}},&quot;type&quot;:&quot;FIGURE_OBJECT&quot;,&quot;id&quot;:&quot;ec6a3940-0330-4ef9-aa1f-f72d7b40799e&quot;,&quot;name&quot;:&quot;dsDNA brush 3 (straight)&quot;,&quot;displayName&quot;:&quot;Simplified dsDNA brush (straight)&quot;,&quot;opacity&quot;:1,&quot;source&quot;:{&quot;id&quot;:&quot;5e75575f52bb9000abea6260&quot;,&quot;type&quot;:&quot;ASSETS&quot;},&quot;path&quot;:{&quot;type&quot;:&quot;POLY_LINE&quot;,&quot;points&quot;:[{&quot;x&quot;:-8.559496991294791,&quot;y&quot;:0},{&quot;x&quot;:8.559496991294786,&quot;y&quot;:0}],&quot;closed&quot;:false},&quot;pathStyles&quot;:[{&quot;type&quot;:&quot;FILL&quot;,&quot;fillStyle&quot;:&quot;rgba(0,0,0,0)&quot;},{&quot;type&quot;:&quot;STROKE&quot;,&quot;strokeStyle&quot;:&quot;rgba(0,0,0,0)&quot;,&quot;lineWidth&quot;:4.412664353661106,&quot;lineJoin&quot;:&quot;round&quot;}],&quot;pathSmoothing&quot;:{&quot;type&quot;:&quot;CATMULL_SMOOTHING&quot;,&quot;smoothing&quot;:0.2},&quot;pathPattern&quot;:{&quot;type&quot;:&quot;ROW&quot;,&quot;patternId&quot;:&quot;7b16fe1f-29e2-4277-bbeb-7ab4d194b61c&quot;,&quot;patternTransform&quot;:{&quot;translate&quot;:{&quot;x&quot;:-0.00002540549651012527,&quot;y&quot;:-0.5},&quot;rotate&quot;:0,&quot;skewX&quot;:0,&quot;scale&quot;:{&quot;x&quot;:0.005076142131979695,&quot;y&quot;:0.005076142131979695}},&quot;xUnits&quot;:&quot;STROKE_WIDTH&quot;,&quot;yUnits&quot;:&quot;STROKE_WIDTH&quot;,&quot;bending&quot;:true,&quot;repeat&quot;:{&quot;distance&quot;:1.8661421567655458,&quot;align&quot;:&quot;CENTER&quot;},&quot;isPremium&quot;:true},&quot;isLocked&quot;:false,&quot;parent&quot;:{&quot;type&quot;:&quot;CHILD&quot;,&quot;parentId&quot;:&quot;eea7b0d9-8596-4241-b525-e46224e54677&quot;,&quot;order&quot;:&quot;5&quot;},&quot;isPremium&quot;:true},&quot;7b16fe1f-29e2-4277-bbeb-7ab4d194b61c&quot;:{&quot;type&quot;:&quot;FIGURE_OBJECT&quot;,&quot;id&quot;:&quot;7b16fe1f-29e2-4277-bbeb-7ab4d194b61c&quot;,&quot;relativeTransform&quot;:{&quot;translate&quot;:{&quot;x&quot;:0,&quot;y&quot;:0},&quot;rotate&quot;:0,&quot;skewX&quot;:0,&quot;scale&quot;:{&quot;x&quot;:1,&quot;y&quot;:1}},&quot;source&quot;:{&quot;type&quot;:&quot;ASSETS&quot;,&quot;id&quot;:&quot;5e71324176df310028d1ed5d&quot;},&quot;name&quot;:&quot;dsDNA (simplified)&quot;},&quot;7eb0e35c-8383-4c1c-bed8-297c431907dc&quot;:{&quot;type&quot;:&quot;FIGURE_OBJECT&quot;,&quot;id&quot;:&quot;7eb0e35c-8383-4c1c-bed8-297c431907dc&quot;,&quot;parent&quot;:{&quot;type&quot;:&quot;CHILD&quot;,&quot;parentId&quot;:&quot;7b16fe1f-29e2-4277-bbeb-7ab4d194b61c&quot;,&quot;order&quot;:&quot;7&quot;},&quot;relativeTransform&quot;:{&quot;translate&quot;:{&quot;x&quot;:0,&quot;y&quot;:0},&quot;rotate&quot;:0,&quot;skewX&quot;:0,&quot;scale&quot;:{&quot;x&quot;:1,&quot;y&quot;:1}}},&quot;e123bdd1-35ac-401c-b7c5-762d1fee9ee4&quot;:{&quot;type&quot;:&quot;FIGURE_OBJECT&quot;,&quot;id&quot;:&quot;e123bdd1-35ac-401c-b7c5-762d1fee9ee4&quot;,&quot;parent&quot;:{&quot;type&quot;:&quot;CHILD&quot;,&quot;parentId&quot;:&quot;7eb0e35c-8383-4c1c-bed8-297c431907dc&quot;,&quot;order&quot;:&quot;2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.14,&quot;isEndPoint&quot;:true},{&quot;x&quot;:353.18,&quot;y&quot;:7.140000000000001,&quot;isEndPoint&quot;:false},{&quot;x&quot;:332.5,&quot;y&quot;:7.140000000000001,&quot;isEndPoint&quot;:false},{&quot;x&quot;:332.5,&quot;y&quot;:7.140000000000001,&quot;isEndPoint&quot;:true},{&quot;x&quot;:282,&quot;y&quot;:7.42,&quot;isEndPoint&quot;:false},{&quot;x&quot;:251.44,&quot;y&quot;:51,&quot;isEndPoint&quot;:false},{&quot;x&quot;:224.49,&quot;y&quot;:89.43,&quot;isEndPoint&quot;:true},{&quot;x&quot;:201.26000000000002,&quot;y&quot;:122.59,&quot;isEndPoint&quot;:false},{&quot;x&quot;:179.31,&quot;y&quot;:153.9,&quot;isEndPoint&quot;:false},{&quot;x&quot;:149.9,&quot;y&quot;:153.9,&quot;isEndPoint&quot;:true},{&quot;x&quot;:149.32,&quot;y&quot;:153.9,&quot;isEndPoint&quot;:true},{&quot;x&quot;:149.32,&quot;y&quot;:189.9,&quot;isEndPoint&quot;:true},{&quot;x&quot;:149.91,&quot;y&quot;:189.9,&quot;isEndPoint&quot;:true},{&quot;x&quot;:198.06,&quot;y&quot;:189.9,&quot;isEndPoint&quot;:false},{&quot;x&quot;:226.5,&quot;y&quot;:149.31,&quot;isEndPoint&quot;:false},{&quot;x&quot;:254.01999999999998,&quot;y&quot;:110.05000000000001,&quot;isEndPoint&quot;:true},{&quot;x&quot;:278.15,&quot;y&quot;:75.61000000000001,&quot;isEndPoint&quot;:false},{&quot;x&quot;:300.95,&quot;y&quot;:43.05000000000001,&quot;isEndPoint&quot;:false},{&quot;x&quot;:333.02,&quot;y&quot;:43.05000000000001,&quot;isEndPoint&quot;:true},{&quot;x&quot;:333.02,&quot;y&quot;:43.05000000000001,&quot;isEndPoint&quot;:true},{&quot;x&quot;:344.54999999999995,&quot;y&quot;:43.05000000000001,&quot;isEndPoint&quot;:false},{&quot;x&quot;:356.46999999999997,&quot;y&quot;:47.16000000000001,&quot;isEndPoint&quot;:false},{&quot;x&quot;:367.56,&quot;y&quot;:55.750000000000014,&quot;isEndPoint&quot;:true}],&quot;closed&quot;:true}},&quot;pathStyles&quot;:[{&quot;type&quot;:&quot;FILL&quot;,&quot;fillStyle&quot;:&quot;#002479&quot;}],&quot;opacity&quot;:1},&quot;2f47f14d-e4a4-4773-9dc6-1d385d9524a0&quot;:{&quot;type&quot;:&quot;FIGURE_OBJECT&quot;,&quot;id&quot;:&quot;2f47f14d-e4a4-4773-9dc6-1d385d9524a0&quot;,&quot;parent&quot;:{&quot;type&quot;:&quot;CHILD&quot;,&quot;parentId&quot;:&quot;7eb0e35c-8383-4c1c-bed8-297c431907dc&quot;,&quot;order&quot;:&quot;5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1.2,&quot;isEndPoint&quot;:true},{&quot;x&quot;:350.99,&quot;y&quot;:128.64999999999998,&quot;isEndPoint&quot;:false},{&quot;x&quot;:336.37,&quot;y&quot;:108.67999999999998,&quot;isEndPoint&quot;:false},{&quot;x&quot;:321.13,&quot;y&quot;:86.92999999999998,&quot;isEndPoint&quot;:true},{&quot;x&quot;:293.62,&quot;y&quot;:47.67,&quot;isEndPoint&quot;:false},{&quot;x&quot;:265.18,&quot;y&quot;:7.08,&quot;isEndPoint&quot;:false},{&quot;x&quot;:217,&quot;y&quot;:7.08,&quot;isEndPoint&quot;:true},{&quot;x&quot;:168.82,&quot;y&quot;:7.08,&quot;isEndPoint&quot;:false},{&quot;x&quot;:140.4,&quot;y&quot;:47.67,&quot;isEndPoint&quot;:false},{&quot;x&quot;:112.89,&quot;y&quot;:86.92999999999999,&quot;isEndPoint&quot;:true},{&quot;x&quot;:88.75,&quot;y&quot;:121.36999999999999,&quot;isEndPoint&quot;:false},{&quot;x&quot;:65.96000000000001,&quot;y&quot;:153.93,&quot;isEndPoint&quot;:false},{&quot;x&quot;:33.83,&quot;y&quot;:153.93,&quot;isEndPoint&quot;:true},{&quot;x&quot;:22.56,&quot;y&quot;:153.9,&quot;isEndPoint&quot;:false},{&quot;x&quot;:11,&quot;y&quot;:149.44,&quot;isEndPoint&quot;:false},{&quot;x&quot;:0.11,&quot;y&quot;:141.2,&quot;isEndPoint&quot;:true},{&quot;x&quot;:0,&quot;y&quot;:182.8,&quot;isEndPoint&quot;:true},{&quot;x&quot;:0.35,&quot;y&quot;:182.95000000000002,&quot;isEndPoint&quot;:true},{&quot;x&quot;:10.905530717350821,&quot;y&quot;:187.59644786408347,&quot;isEndPoint&quot;:false},{&quot;x&quot;:22.317101480766773,&quot;y&quot;:189.98095518778234,&quot;isEndPoint&quot;:false},{&quot;x&quot;:33.84999999999999,&quot;y&quot;:189.95000000000002,&quot;isEndPoint&quot;:true},{&quot;x&quot;:84.73999999999998,&quot;y&quot;:189.95000000000002,&quot;isEndPoint&quot;:false},{&quot;x&quot;:115.38999999999999,&quot;y&quot;:146.21,&quot;isEndPoint&quot;:false},{&quot;x&quot;:142.45,&quot;y&quot;:107.60000000000002,&quot;isEndPoint&quot;:true},{&quot;x&quot;:165.68,&quot;y&quot;:74.45,&quot;isEndPoint&quot;:false},{&quot;x&quot;:187.62,&quot;y&quot;:43.13,&quot;isEndPoint&quot;:false},{&quot;x&quot;:217,&quot;y&quot;:43.13,&quot;isEndPoint&quot;:true},{&quot;x&quot;:246.38,&quot;y&quot;:43.13,&quot;isEndPoint&quot;:false},{&quot;x&quot;:268.35,&quot;y&quot;:74.46000000000001,&quot;isEndPoint&quot;:false},{&quot;x&quot;:291.58,&quot;y&quot;:107.62,&quot;isEndPoint&quot;:true},{&quot;x&quot;:311.82,&quot;y&quot;:136.5,&quot;isEndPoint&quot;:false},{&quot;x&quot;:335.58,&quot;y&quot;:168.97,&quot;isEndPoint&quot;:false},{&quot;x&quot;:367.58,&quot;y&quot;:182.8,&quot;isEndPoint&quot;:true}],&quot;closed&quot;:true}},&quot;pathStyles&quot;:[{&quot;type&quot;:&quot;FILL&quot;,&quot;fillStyle&quot;:&quot;#184193&quot;}],&quot;opacity&quot;:1},&quot;77ed4572-91db-45f3-827d-202cd2647b17&quot;:{&quot;type&quot;:&quot;FIGURE_OBJECT&quot;,&quot;id&quot;:&quot;77ed4572-91db-45f3-827d-202cd2647b17&quot;,&quot;parent&quot;:{&quot;type&quot;:&quot;CHILD&quot;,&quot;parentId&quot;:&quot;7eb0e35c-8383-4c1c-bed8-297c431907dc&quot;,&quot;order&quot;:&quot;7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149.9,&quot;y&quot;:153.9,&quot;isEndPoint&quot;:true},{&quot;x&quot;:120.5,&quot;y&quot;:153.9,&quot;isEndPoint&quot;:false},{&quot;x&quot;:98.56,&quot;y&quot;:122.59,&quot;isEndPoint&quot;:false},{&quot;x&quot;:75.33000000000001,&quot;y&quot;:89.43,&quot;isEndPoint&quot;:true},{&quot;x&quot;:75.33000000000001,&quot;y&quot;:89.43,&quot;isEndPoint&quot;:true},{&quot;x&quot;:55.25,&quot;y&quot;:60.79,&quot;isEndPoint&quot;:false},{&quot;x&quot;:31.69,&quot;y&quot;:28.16,&quot;isEndPoint&quot;:false},{&quot;x&quot;:0,&quot;y&quot;:14.14,&quot;isEndPoint&quot;:true},{&quot;x&quot;:0,&quot;y&quot;:55.83,&quot;isEndPoint&quot;:true},{&quot;x&quot;:16.4,&quot;y&quot;:68.49,&quot;isEndPoint&quot;:false},{&quot;x&quot;:30.8,&quot;y&quot;:88.71000000000001,&quot;isEndPoint&quot;:false},{&quot;x&quot;:45.79,&quot;y&quot;:110.11,&quot;isEndPoint&quot;:true},{&quot;x&quot;:73.3,&quot;y&quot;:149.36,&quot;isEndPoint&quot;:false},{&quot;x&quot;:101.74,&quot;y&quot;:190,&quot;isEndPoint&quot;:false},{&quot;x&quot;:149.9,&quot;y&quot;:190,&quot;isEndPoint&quot;:true}],&quot;closed&quot;:true}},&quot;pathStyles&quot;:[{&quot;type&quot;:&quot;FILL&quot;,&quot;fillStyle&quot;:&quot;#002479&quot;}],&quot;opacity&quot;:1},&quot;7f7bb091-46f0-45d5-a78e-64d3b5d4883d&quot;:{&quot;relativeTransform&quot;:{&quot;translate&quot;:{&quot;x&quot;:-140.7300941988811,&quot;y&quot;:90.64663124977316},&quot;rotate&quot;:2.105561685167923,&quot;skewX&quot;:0,&quot;scale&quot;:{&quot;x&quot;:1,&quot;y&quot;:1}},&quot;type&quot;:&quot;FIGURE_OBJECT&quot;,&quot;id&quot;:&quot;7f7bb091-46f0-45d5-a78e-64d3b5d4883d&quot;,&quot;name&quot;:&quot;dsDNA brush 3 (straight)&quot;,&quot;displayName&quot;:&quot;Simplified dsDNA brush (straight)&quot;,&quot;opacity&quot;:1,&quot;source&quot;:{&quot;id&quot;:&quot;5e75575f52bb9000abea6260&quot;,&quot;type&quot;:&quot;ASSETS&quot;},&quot;path&quot;:{&quot;type&quot;:&quot;POLY_LINE&quot;,&quot;points&quot;:[{&quot;x&quot;:8.559496991294791,&quot;y&quot;:0},{&quot;x&quot;:-8.559496991294786,&quot;y&quot;:0}],&quot;closed&quot;:false},&quot;pathStyles&quot;:[{&quot;type&quot;:&quot;FILL&quot;,&quot;fillStyle&quot;:&quot;rgba(0,0,0,0)&quot;},{&quot;type&quot;:&quot;STROKE&quot;,&quot;strokeStyle&quot;:&quot;rgba(0,0,0,0)&quot;,&quot;lineWidth&quot;:4.412664353661106,&quot;lineJoin&quot;:&quot;round&quot;}],&quot;pathSmoothing&quot;:{&quot;type&quot;:&quot;CATMULL_SMOOTHING&quot;,&quot;smoothing&quot;:0.2},&quot;pathPattern&quot;:{&quot;type&quot;:&quot;ROW&quot;,&quot;patternId&quot;:&quot;b7e55654-6531-444f-900a-5ce552968a22&quot;,&quot;patternTransform&quot;:{&quot;translate&quot;:{&quot;x&quot;:-0.00002540549651012527,&quot;y&quot;:0.5},&quot;rotate&quot;:3.141592653589793,&quot;skewX&quot;:0,&quot;scale&quot;:{&quot;x&quot;:-0.005076142131979695,&quot;y&quot;:0.005076142131979695}},&quot;xUnits&quot;:&quot;STROKE_WIDTH&quot;,&quot;yUnits&quot;:&quot;STROKE_WIDTH&quot;,&quot;bending&quot;:true,&quot;repeat&quot;:{&quot;distance&quot;:1.8661421567655458,&quot;align&quot;:&quot;CENTER&quot;},&quot;isPremium&quot;:true},&quot;isLocked&quot;:false,&quot;parent&quot;:{&quot;type&quot;:&quot;CHILD&quot;,&quot;parentId&quot;:&quot;eea7b0d9-8596-4241-b525-e46224e54677&quot;,&quot;order&quot;:&quot;7&quot;},&quot;isPremium&quot;:true},&quot;b7e55654-6531-444f-900a-5ce552968a22&quot;:{&quot;type&quot;:&quot;FIGURE_OBJECT&quot;,&quot;id&quot;:&quot;b7e55654-6531-444f-900a-5ce552968a22&quot;,&quot;relativeTransform&quot;:{&quot;translate&quot;:{&quot;x&quot;:0,&quot;y&quot;:0},&quot;rotate&quot;:0,&quot;skewX&quot;:0,&quot;scale&quot;:{&quot;x&quot;:1,&quot;y&quot;:1}},&quot;source&quot;:{&quot;type&quot;:&quot;ASSETS&quot;,&quot;id&quot;:&quot;5e71324176df310028d1ed5d&quot;},&quot;name&quot;:&quot;dsDNA (simplified)&quot;},&quot;0f7def37-5cbd-4a2b-a3e2-66e3ce33a2c2&quot;:{&quot;type&quot;:&quot;FIGURE_OBJECT&quot;,&quot;id&quot;:&quot;0f7def37-5cbd-4a2b-a3e2-66e3ce33a2c2&quot;,&quot;parent&quot;:{&quot;type&quot;:&quot;CHILD&quot;,&quot;parentId&quot;:&quot;b7e55654-6531-444f-900a-5ce552968a22&quot;,&quot;order&quot;:&quot;7&quot;},&quot;relativeTransform&quot;:{&quot;translate&quot;:{&quot;x&quot;:0,&quot;y&quot;:0},&quot;rotate&quot;:0,&quot;skewX&quot;:0,&quot;scale&quot;:{&quot;x&quot;:1,&quot;y&quot;:1}}},&quot;50c60839-7aee-4ddc-8c05-136dcf1eb179&quot;:{&quot;type&quot;:&quot;FIGURE_OBJECT&quot;,&quot;id&quot;:&quot;50c60839-7aee-4ddc-8c05-136dcf1eb179&quot;,&quot;parent&quot;:{&quot;type&quot;:&quot;CHILD&quot;,&quot;parentId&quot;:&quot;0f7def37-5cbd-4a2b-a3e2-66e3ce33a2c2&quot;,&quot;order&quot;:&quot;2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.14,&quot;isEndPoint&quot;:true},{&quot;x&quot;:353.18,&quot;y&quot;:7.140000000000001,&quot;isEndPoint&quot;:false},{&quot;x&quot;:332.5,&quot;y&quot;:7.140000000000001,&quot;isEndPoint&quot;:false},{&quot;x&quot;:332.5,&quot;y&quot;:7.140000000000001,&quot;isEndPoint&quot;:true},{&quot;x&quot;:282,&quot;y&quot;:7.42,&quot;isEndPoint&quot;:false},{&quot;x&quot;:251.44,&quot;y&quot;:51,&quot;isEndPoint&quot;:false},{&quot;x&quot;:224.49,&quot;y&quot;:89.43,&quot;isEndPoint&quot;:true},{&quot;x&quot;:201.26000000000002,&quot;y&quot;:122.59,&quot;isEndPoint&quot;:false},{&quot;x&quot;:179.31,&quot;y&quot;:153.9,&quot;isEndPoint&quot;:false},{&quot;x&quot;:149.9,&quot;y&quot;:153.9,&quot;isEndPoint&quot;:true},{&quot;x&quot;:149.32,&quot;y&quot;:153.9,&quot;isEndPoint&quot;:true},{&quot;x&quot;:149.32,&quot;y&quot;:189.9,&quot;isEndPoint&quot;:true},{&quot;x&quot;:149.91,&quot;y&quot;:189.9,&quot;isEndPoint&quot;:true},{&quot;x&quot;:198.06,&quot;y&quot;:189.9,&quot;isEndPoint&quot;:false},{&quot;x&quot;:226.5,&quot;y&quot;:149.31,&quot;isEndPoint&quot;:false},{&quot;x&quot;:254.01999999999998,&quot;y&quot;:110.05000000000001,&quot;isEndPoint&quot;:true},{&quot;x&quot;:278.15,&quot;y&quot;:75.61000000000001,&quot;isEndPoint&quot;:false},{&quot;x&quot;:300.95,&quot;y&quot;:43.05000000000001,&quot;isEndPoint&quot;:false},{&quot;x&quot;:333.02,&quot;y&quot;:43.05000000000001,&quot;isEndPoint&quot;:true},{&quot;x&quot;:333.02,&quot;y&quot;:43.05000000000001,&quot;isEndPoint&quot;:true},{&quot;x&quot;:344.54999999999995,&quot;y&quot;:43.05000000000001,&quot;isEndPoint&quot;:false},{&quot;x&quot;:356.46999999999997,&quot;y&quot;:47.16000000000001,&quot;isEndPoint&quot;:false},{&quot;x&quot;:367.56,&quot;y&quot;:55.750000000000014,&quot;isEndPoint&quot;:true}],&quot;closed&quot;:true}},&quot;pathStyles&quot;:[{&quot;type&quot;:&quot;FILL&quot;,&quot;fillStyle&quot;:&quot;#002479&quot;}],&quot;opacity&quot;:1},&quot;69ebcb8d-c660-4750-b952-90dbbdccd0b4&quot;:{&quot;type&quot;:&quot;FIGURE_OBJECT&quot;,&quot;id&quot;:&quot;69ebcb8d-c660-4750-b952-90dbbdccd0b4&quot;,&quot;parent&quot;:{&quot;type&quot;:&quot;CHILD&quot;,&quot;parentId&quot;:&quot;0f7def37-5cbd-4a2b-a3e2-66e3ce33a2c2&quot;,&quot;order&quot;:&quot;5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1.2,&quot;isEndPoint&quot;:true},{&quot;x&quot;:350.99,&quot;y&quot;:128.64999999999998,&quot;isEndPoint&quot;:false},{&quot;x&quot;:336.37,&quot;y&quot;:108.67999999999998,&quot;isEndPoint&quot;:false},{&quot;x&quot;:321.13,&quot;y&quot;:86.92999999999998,&quot;isEndPoint&quot;:true},{&quot;x&quot;:293.62,&quot;y&quot;:47.67,&quot;isEndPoint&quot;:false},{&quot;x&quot;:265.18,&quot;y&quot;:7.08,&quot;isEndPoint&quot;:false},{&quot;x&quot;:217,&quot;y&quot;:7.08,&quot;isEndPoint&quot;:true},{&quot;x&quot;:168.82,&quot;y&quot;:7.08,&quot;isEndPoint&quot;:false},{&quot;x&quot;:140.4,&quot;y&quot;:47.67,&quot;isEndPoint&quot;:false},{&quot;x&quot;:112.89,&quot;y&quot;:86.92999999999999,&quot;isEndPoint&quot;:true},{&quot;x&quot;:88.75,&quot;y&quot;:121.36999999999999,&quot;isEndPoint&quot;:false},{&quot;x&quot;:65.96000000000001,&quot;y&quot;:153.93,&quot;isEndPoint&quot;:false},{&quot;x&quot;:33.83,&quot;y&quot;:153.93,&quot;isEndPoint&quot;:true},{&quot;x&quot;:22.56,&quot;y&quot;:153.9,&quot;isEndPoint&quot;:false},{&quot;x&quot;:11,&quot;y&quot;:149.44,&quot;isEndPoint&quot;:false},{&quot;x&quot;:0.11,&quot;y&quot;:141.2,&quot;isEndPoint&quot;:true},{&quot;x&quot;:0,&quot;y&quot;:182.8,&quot;isEndPoint&quot;:true},{&quot;x&quot;:0.35,&quot;y&quot;:182.95000000000002,&quot;isEndPoint&quot;:true},{&quot;x&quot;:10.905530717350821,&quot;y&quot;:187.59644786408347,&quot;isEndPoint&quot;:false},{&quot;x&quot;:22.317101480766773,&quot;y&quot;:189.98095518778234,&quot;isEndPoint&quot;:false},{&quot;x&quot;:33.84999999999999,&quot;y&quot;:189.95000000000002,&quot;isEndPoint&quot;:true},{&quot;x&quot;:84.73999999999998,&quot;y&quot;:189.95000000000002,&quot;isEndPoint&quot;:false},{&quot;x&quot;:115.38999999999999,&quot;y&quot;:146.21,&quot;isEndPoint&quot;:false},{&quot;x&quot;:142.45,&quot;y&quot;:107.60000000000002,&quot;isEndPoint&quot;:true},{&quot;x&quot;:165.68,&quot;y&quot;:74.45,&quot;isEndPoint&quot;:false},{&quot;x&quot;:187.62,&quot;y&quot;:43.13,&quot;isEndPoint&quot;:false},{&quot;x&quot;:217,&quot;y&quot;:43.13,&quot;isEndPoint&quot;:true},{&quot;x&quot;:246.38,&quot;y&quot;:43.13,&quot;isEndPoint&quot;:false},{&quot;x&quot;:268.35,&quot;y&quot;:74.46000000000001,&quot;isEndPoint&quot;:false},{&quot;x&quot;:291.58,&quot;y&quot;:107.62,&quot;isEndPoint&quot;:true},{&quot;x&quot;:311.82,&quot;y&quot;:136.5,&quot;isEndPoint&quot;:false},{&quot;x&quot;:335.58,&quot;y&quot;:168.97,&quot;isEndPoint&quot;:false},{&quot;x&quot;:367.58,&quot;y&quot;:182.8,&quot;isEndPoint&quot;:true}],&quot;closed&quot;:true}},&quot;pathStyles&quot;:[{&quot;type&quot;:&quot;FILL&quot;,&quot;fillStyle&quot;:&quot;#184193&quot;}],&quot;opacity&quot;:1},&quot;e9d52767-731b-4f4c-915e-868f3f30a921&quot;:{&quot;type&quot;:&quot;FIGURE_OBJECT&quot;,&quot;id&quot;:&quot;e9d52767-731b-4f4c-915e-868f3f30a921&quot;,&quot;parent&quot;:{&quot;type&quot;:&quot;CHILD&quot;,&quot;parentId&quot;:&quot;0f7def37-5cbd-4a2b-a3e2-66e3ce33a2c2&quot;,&quot;order&quot;:&quot;7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149.9,&quot;y&quot;:153.9,&quot;isEndPoint&quot;:true},{&quot;x&quot;:120.5,&quot;y&quot;:153.9,&quot;isEndPoint&quot;:false},{&quot;x&quot;:98.56,&quot;y&quot;:122.59,&quot;isEndPoint&quot;:false},{&quot;x&quot;:75.33000000000001,&quot;y&quot;:89.43,&quot;isEndPoint&quot;:true},{&quot;x&quot;:75.33000000000001,&quot;y&quot;:89.43,&quot;isEndPoint&quot;:true},{&quot;x&quot;:55.25,&quot;y&quot;:60.79,&quot;isEndPoint&quot;:false},{&quot;x&quot;:31.69,&quot;y&quot;:28.16,&quot;isEndPoint&quot;:false},{&quot;x&quot;:0,&quot;y&quot;:14.14,&quot;isEndPoint&quot;:true},{&quot;x&quot;:0,&quot;y&quot;:55.83,&quot;isEndPoint&quot;:true},{&quot;x&quot;:16.4,&quot;y&quot;:68.49,&quot;isEndPoint&quot;:false},{&quot;x&quot;:30.8,&quot;y&quot;:88.71000000000001,&quot;isEndPoint&quot;:false},{&quot;x&quot;:45.79,&quot;y&quot;:110.11,&quot;isEndPoint&quot;:true},{&quot;x&quot;:73.3,&quot;y&quot;:149.36,&quot;isEndPoint&quot;:false},{&quot;x&quot;:101.74,&quot;y&quot;:190,&quot;isEndPoint&quot;:false},{&quot;x&quot;:149.9,&quot;y&quot;:190,&quot;isEndPoint&quot;:true}],&quot;closed&quot;:true}},&quot;pathStyles&quot;:[{&quot;type&quot;:&quot;FILL&quot;,&quot;fillStyle&quot;:&quot;#002479&quot;}],&quot;opacity&quot;:1},&quot;384b6d59-a957-4432-afd3-6439a72e17b0&quot;:{&quot;id&quot;:&quot;384b6d59-a957-4432-afd3-6439a72e17b0&quot;,&quot;type&quot;:&quot;FIGURE_OBJECT&quot;,&quot;relativeTransform&quot;:{&quot;translate&quot;:{&quot;x&quot;:-418.3111572265625,&quot;y&quot;:-90.82133333333331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8.666666666666664,&quot;color&quot;:&quot;black&quot;,&quot;fontWeight&quot;:&quot;normal&quot;,&quot;fontStyle&quot;:&quot;normal&quot;,&quot;decoration&quot;:&quot;none&quot;},&quot;range&quot;:[0,13]}],&quot;text&quot;:&quot;DNA Extraction&quot;}],&quot;_lastCaretLocation&quot;:{&quot;lineIndex&quot;:0,&quot;runIndex&quot;:0,&quot;charIndex&quot;:4}},&quot;format&quot;:&quot;BETTER_TEXT&quot;,&quot;size&quot;:{&quot;x&quot;:83.377685546875,&quot;y&quot;:43.093333333333334},&quot;targetSize&quot;:{&quot;x&quot;:83.377685546875,&quot;y&quot;:43.093333333333334}},&quot;parent&quot;:{&quot;type&quot;:&quot;CHILD&quot;,&quot;parentId&quot;:&quot;7b7e4984-9463-4fc4-81fa-65b50cc23e77&quot;,&quot;order&quot;:&quot;998&quot;}},&quot;2fac9073-d264-4549-bb60-5a00f45efbac&quot;:{&quot;type&quot;:&quot;FIGURE_OBJECT&quot;,&quot;id&quot;:&quot;2fac9073-d264-4549-bb60-5a00f45efbac&quot;,&quot;relativeTransform&quot;:{&quot;translate&quot;:{&quot;x&quot;:0,&quot;y&quot;:0},&quot;rotate&quot;:0,&quot;skewX&quot;:0,&quot;scale&quot;:{&quot;x&quot;:1,&quot;y&quot;:1}},&quot;opacity&quot;:1,&quot;path&quot;:{&quot;type&quot;:&quot;POLY_LINE&quot;,&quot;points&quot;:[{&quot;x&quot;:-370.00000000000006,&quot;y&quot;:-122.14285714285714},{&quot;x&quot;:-370.00000000000006,&quot;y&quot;:-60.82142857142858},{&quot;x&quot;:-339,&quot;y&quot;:-60.82142857142858},{&quot;x&quot;:-311,&quot;y&quot;:-60.82142857142858},{&quot;x&quot;:-289,&quot;y&quot;:-60.82142857142858},{&quot;x&quot;:-288,&quot;y&quot;:-59.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7b7e4984-9463-4fc4-81fa-65b50cc23e77&quot;,&quot;order&quot;:&quot;999&quot;},&quot;connectorInfo&quot;:{&quot;connectedObjects&quot;:[{&quot;objectId&quot;:&quot;9463ce90-0d6d-48a7-955b-0eafe746e80f&quot;,&quot;coordinates&quot;:{&quot;x&quot;:0.4279279279279278,&quot;y&quot;:1}}],&quot;type&quot;:&quot;ELBOW&quot;,&quot;offset&quot;:{&quot;x&quot;:0,&quot;y&quot;:0},&quot;bending&quot;:0.1,&quot;firstElementIsHead&quot;:true,&quot;customized&quot;:true}},&quot;4aac909c-77fd-4882-8ccf-e0d8a57ffb1b&quot;:{&quot;id&quot;:&quot;4aac909c-77fd-4882-8ccf-e0d8a57ffb1b&quot;,&quot;name&quot;:&quot;ssDNA (fragment)&quot;,&quot;displayName&quot;:&quot;&quot;,&quot;type&quot;:&quot;FIGURE_OBJECT&quot;,&quot;relativeTransform&quot;:{&quot;translate&quot;:{&quot;x&quot;:10.000000000000114,&quot;y&quot;:9.999999999999886},&quot;rotate&quot;:1.5707963267948966,&quot;skewX&quot;:0,&quot;scale&quot;:{&quot;x&quot;:1,&quot;y&quot;:1}},&quot;image&quot;:{&quot;url&quot;:&quot;https://icons.biorender.com/biorender/5b6b4c11e0461e1400300b32/20180808200148/image/ssdna-fragment.png&quot;,&quot;fallbackUrl&quot;:&quot;https://res.cloudinary.com/dlcjuc3ej/image/upload/v1533758508/oemofy9hvnoaqemdfswt.svg#/keystone/api/icons/5b6b4c11e0461e1400300b32/20180808200148/image/ssdna-fragment.svg#/keystone/api/icons/5b6b4c11e0461e1400300b32/20180808200148/image/ssdna-fragment.svg&quot;,&quot;isPremium&quot;:false,&quot;size&quot;:{&quot;x&quot;:50,&quot;y&quot;:20.53571428571429}},&quot;source&quot;:{&quot;id&quot;:&quot;5b6b4c11e0461e1400300b32&quot;,&quot;type&quot;:&quot;ASSETS&quot;},&quot;isPremium&quot;:false,&quot;parent&quot;:{&quot;type&quot;:&quot;CHILD&quot;,&quot;parentId&quot;:&quot;7b7e4984-9463-4fc4-81fa-65b50cc23e77&quot;,&quot;order&quot;:&quot;9995&quot;}},&quot;2c2cfef3-ea3c-46e3-a733-32c42f210571&quot;:{&quot;id&quot;:&quot;2c2cfef3-ea3c-46e3-a733-32c42f210571&quot;,&quot;name&quot;:&quot;ssDNA (fragment)&quot;,&quot;displayName&quot;:&quot;&quot;,&quot;type&quot;:&quot;FIGURE_OBJECT&quot;,&quot;relativeTransform&quot;:{&quot;translate&quot;:{&quot;x&quot;:30.53606409102059,&quot;y&quot;:9.999616681672862},&quot;rotate&quot;:-1.5707963267948966,&quot;skewX&quot;:0,&quot;scale&quot;:{&quot;x&quot;:1,&quot;y&quot;:1}},&quot;image&quot;:{&quot;url&quot;:&quot;https://icons.biorender.com/biorender/5b6b4c11e0461e1400300b32/20180808200148/image/ssdna-fragment.png&quot;,&quot;fallbackUrl&quot;:&quot;https://res.cloudinary.com/dlcjuc3ej/image/upload/v1533758508/oemofy9hvnoaqemdfswt.svg#/keystone/api/icons/5b6b4c11e0461e1400300b32/20180808200148/image/ssdna-fragment.svg#/keystone/api/icons/5b6b4c11e0461e1400300b32/20180808200148/image/ssdna-fragment.svg&quot;,&quot;isPremium&quot;:false,&quot;size&quot;:{&quot;x&quot;:50,&quot;y&quot;:20.53571428571429}},&quot;source&quot;:{&quot;id&quot;:&quot;5b6b4c11e0461e1400300b32&quot;,&quot;type&quot;:&quot;ASSETS&quot;},&quot;isPremium&quot;:false,&quot;parent&quot;:{&quot;type&quot;:&quot;CHILD&quot;,&quot;parentId&quot;:&quot;7b7e4984-9463-4fc4-81fa-65b50cc23e77&quot;,&quot;order&quot;:&quot;9997&quot;}},&quot;3063cc25-7c43-40b3-b191-92144370fcea&quot;:{&quot;relativeTransform&quot;:{&quot;translate&quot;:{&quot;x&quot;:26.826797429807847,&quot;y&quot;:-121.34225275430614},&quot;rotate&quot;:3.141592653589793,&quot;skewX&quot;:0,&quot;scale&quot;:{&quot;x&quot;:1,&quot;y&quot;:1}},&quot;type&quot;:&quot;FIGURE_OBJECT&quot;,&quot;id&quot;:&quot;3063cc25-7c43-40b3-b191-92144370fcea&quot;,&quot;name&quot;:&quot;ssDNA brush 2 (arc, medium)&quot;,&quot;opacity&quot;:1,&quot;source&quot;:{&quot;id&quot;:&quot;6126a0160f59c500a0eb80cc&quot;,&quot;type&quot;:&quot;ASSETS&quot;},&quot;path&quot;:{&quot;type&quot;:&quot;POLY_LINE&quot;,&quot;points&quot;:[{&quot;x&quot;:-5.526386370554647,&quot;y&quot;:-116.10295336508557},{&quot;x&quot;:-5.526386370554654,&quot;y&quot;:-73.05169291431167},{&quot;x&quot;:-9.22364604964411,&quot;y&quot;:-66.05792091161186},{&quot;x&quot;:-1.9990874968636483,&quot;y&quot;:-59.40574327204149},{&quot;x&quot;:7.24318816652972,&quot;y&quot;:-56.20084322112548},{&quot;x&quot;:7.6846129748063134,&quot;y&quot;:-60.6012686486841},{&quot;x&quot;:19.327102104353646,&quot;y&quot;:-61.79679402532669},{&quot;x&quot;:19.32710210435365,&quot;y&quot;:-78.29838937867157},{&quot;x&quot;:19.32710210435365,&quot;y&quot;:-88.7755183282394},{&quot;x&quot;:13.290575407930318,&quot;y&quot;:-109.13334961026501}],&quot;closed&quot;:false,&quot;cornerRounding&quot;:{&quot;type&quot;:&quot;ARC_LENGTH&quot;,&quot;global&quot;:71.5477776801749},&quot;selectedObjectIds&quot;:[&quot;3063cc25-7c43-40b3-b191-92144370fcea&quot;]},&quot;pathStyles&quot;:[{&quot;type&quot;:&quot;FILL&quot;,&quot;fillStyle&quot;:&quot;rgba(0,0,0,0)&quot;},{&quot;type&quot;:&quot;STROKE&quot;,&quot;strokeStyle&quot;:&quot;rgba(0,0,0,0)&quot;,&quot;lineWidth&quot;:20.349089815444334,&quot;lineJoin&quot;:&quot;round&quot;}],&quot;pathPattern&quot;:{&quot;type&quot;:&quot;ROW&quot;,&quot;patternId&quot;:&quot;a332b0ad-3138-422a-923f-ed101c4985b2&quot;,&quot;patternTransform&quot;:{&quot;translate&quot;:{&quot;x&quot;:-0.003164556962025317,&quot;y&quot;:-0.5},&quot;rotate&quot;:0,&quot;skewX&quot;:0,&quot;scale&quot;:{&quot;x&quot;:0.012658227848101266,&quot;y&quot;:0.012658227848101266}},&quot;xUnits&quot;:&quot;STROKE_WIDTH&quot;,&quot;yUnits&quot;:&quot;STROKE_WIDTH&quot;,&quot;bending&quot;:true,&quot;repeat&quot;:{&quot;distance&quot;:0.6265822784810127,&quot;align&quot;:&quot;CENTER&quot;},&quot;isPremium&quot;:true},&quot;isLocked&quot;:false,&quot;parent&quot;:{&quot;type&quot;:&quot;CHILD&quot;,&quot;parentId&quot;:&quot;7b7e4984-9463-4fc4-81fa-65b50cc23e77&quot;,&quot;order&quot;:&quot;9998&quot;},&quot;isPremium&quot;:true,&quot;displayName&quot;:&quot;Unwound ssDNA brush (arc, medium)&quot;,&quot;connectorInfo&quot;:{&quot;connectedObjects&quot;:[],&quot;type&quot;:&quot;ELBOW&quot;,&quot;offset&quot;:{&quot;x&quot;:0,&quot;y&quot;:0},&quot;bending&quot;:0.1,&quot;firstElementIsHead&quot;:true,&quot;customized&quot;:true}},&quot;a332b0ad-3138-422a-923f-ed101c4985b2&quot;:{&quot;type&quot;:&quot;FIGURE_OBJECT&quot;,&quot;id&quot;:&quot;a332b0ad-3138-422a-923f-ed101c4985b2&quot;,&quot;relativeTransform&quot;:{&quot;translate&quot;:{&quot;x&quot;:0,&quot;y&quot;:0},&quot;rotate&quot;:0,&quot;skewX&quot;:0,&quot;scale&quot;:{&quot;x&quot;:1,&quot;y&quot;:1}},&quot;source&quot;:{&quot;type&quot;:&quot;ASSETS&quot;,&quot;id&quot;:&quot;5ee1532b88e8df0028d0e2f0&quot;},&quot;name&quot;:&quot;ssDNA (unwound, single, for brush)&quot;},&quot;a6d16e80-0ec5-47be-8253-f51a20207f06&quot;:{&quot;type&quot;:&quot;FIGURE_OBJECT&quot;,&quot;id&quot;:&quot;a6d16e80-0ec5-47be-8253-f51a20207f06&quot;,&quot;parent&quot;:{&quot;type&quot;:&quot;CHILD&quot;,&quot;parentId&quot;:&quot;a332b0ad-3138-422a-923f-ed101c4985b2&quot;,&quot;order&quot;:&quot;5&quot;},&quot;relativeTransform&quot;:{&quot;translate&quot;:{&quot;x&quot;:0,&quot;y&quot;:0},&quot;rotate&quot;:0,&quot;skewX&quot;:0,&quot;scale&quot;:{&quot;x&quot;:1,&quot;y&quot;:1}}},&quot;61ccdf80-77f7-4e34-82e6-78f2cf6545df&quot;:{&quot;type&quot;:&quot;FIGURE_OBJECT&quot;,&quot;id&quot;:&quot;61ccdf80-77f7-4e34-82e6-78f2cf6545df&quot;,&quot;parent&quot;:{&quot;type&quot;:&quot;CHILD&quot;,&quot;parentId&quot;:&quot;a6d16e80-0ec5-47be-8253-f51a20207f06&quot;,&quot;order&quot;:&quot;5&quot;},&quot;relativeTransform&quot;:{&quot;translate&quot;:{&quot;x&quot;:24.983,&quot;y&quot;:68.39},&quot;rotate&quot;:0,&quot;skewX&quot;:0,&quot;scale&quot;:{&quot;x&quot;:1,&quot;y&quot;:1}},&quot;path&quot;:{&quot;type&quot;:&quot;RECT&quot;,&quot;size&quot;:{&quot;x&quot;:50,&quot;y&quot;:22}},&quot;pathStyles&quot;:[{&quot;type&quot;:&quot;FILL&quot;,&quot;fillStyle&quot;:&quot;#005485&quot;}],&quot;opacity&quot;:1},&quot;efc64c62-8b6e-4678-97b7-e219fc9c229c&quot;:{&quot;type&quot;:&quot;FIGURE_OBJECT&quot;,&quot;id&quot;:&quot;efc64c62-8b6e-4678-97b7-e219fc9c229c&quot;,&quot;parent&quot;:{&quot;type&quot;:&quot;CHILD&quot;,&quot;parentId&quot;:&quot;a332b0ad-3138-422a-923f-ed101c4985b2&quot;,&quot;order&quot;:&quot;7&quot;},&quot;relativeTransform&quot;:{&quot;translate&quot;:{&quot;x&quot;:0,&quot;y&quot;:0},&quot;rotate&quot;:0,&quot;skewX&quot;:0,&quot;scale&quot;:{&quot;x&quot;:1,&quot;y&quot;:1}}},&quot;63795faf-2b08-45eb-8acb-fdca1f733418&quot;:{&quot;type&quot;:&quot;FIGURE_OBJECT&quot;,&quot;id&quot;:&quot;63795faf-2b08-45eb-8acb-fdca1f733418&quot;,&quot;parent&quot;:{&quot;type&quot;:&quot;CHILD&quot;,&quot;parentId&quot;:&quot;efc64c62-8b6e-4678-97b7-e219fc9c229c&quot;,&quot;order&quot;:&quot;5&quot;},&quot;relativeTransform&quot;:{&quot;translate&quot;:{&quot;x&quot;:24.983,&quot;y&quot;:29.22},&quot;rotate&quot;:0,&quot;skewX&quot;:0,&quot;scale&quot;:{&quot;x&quot;:1,&quot;y&quot;:1}},&quot;path&quot;:{&quot;type&quot;:&quot;RECT&quot;,&quot;size&quot;:{&quot;x&quot;:13,&quot;y&quot;:58.44}},&quot;pathStyles&quot;:[{&quot;type&quot;:&quot;FILL&quot;,&quot;fillStyle&quot;:&quot;#005485&quot;}],&quot;opacity&quot;:1},&quot;9a1ff0ee-2877-48a6-8e16-f148f1ddf80d&quot;:{&quot;relativeTransform&quot;:{&quot;translate&quot;:{&quot;x&quot;:-186.23364507479548,&quot;y&quot;:47.668386042103855},&quot;rotate&quot;:3.141592653589793,&quot;skewX&quot;:0,&quot;scale&quot;:{&quot;x&quot;:1,&quot;y&quot;:1}},&quot;type&quot;:&quot;FIGURE_OBJECT&quot;,&quot;id&quot;:&quot;9a1ff0ee-2877-48a6-8e16-f148f1ddf80d&quot;,&quot;name&quot;:&quot;ssDNA brush 2 (arc, medium)&quot;,&quot;opacity&quot;:1,&quot;source&quot;:{&quot;id&quot;:&quot;6126a0160f59c500a0eb80cc&quot;,&quot;type&quot;:&quot;ASSETS&quot;},&quot;path&quot;:{&quot;type&quot;:&quot;POLY_LINE&quot;,&quot;points&quot;:[{&quot;x&quot;:-8.826705441223567,&quot;y&quot;:-95.93207332758917},{&quot;x&quot;:-8.826705441223595,&quot;y&quot;:-43.34882127829104},{&quot;x&quot;:-22.90110827776715,&quot;y&quot;:-18.753347565356535},{&quot;x&quot;:-22.90110827776716,&quot;y&quot;:0},{&quot;x&quot;:-3.3164505940902824,&quot;y&quot;:2.4940618041343985},{&quot;x&quot;:16.026783033684598,&quot;y&quot;:0},{&quot;x&quot;:16.02678303368461,&quot;y&quot;:-28.793603318637054},{&quot;x&quot;:1.1894054821440534,&quot;y&quot;:-45.871370409542806},{&quot;x&quot;:1.1894054821440534,&quot;y&quot;:-95.93207332758917}],&quot;closed&quot;:false,&quot;cornerRounding&quot;:{&quot;type&quot;:&quot;ARC_LENGTH&quot;,&quot;global&quot;:119.55382107276459},&quot;selectedObjectIds&quot;:[&quot;e2f6d1a7-72d9-442a-a641-c32373247a37&quot;]},&quot;pathStyles&quot;:[{&quot;type&quot;:&quot;FILL&quot;,&quot;fillStyle&quot;:&quot;rgba(0,0,0,0)&quot;},{&quot;type&quot;:&quot;STROKE&quot;,&quot;strokeStyle&quot;:&quot;rgba(0,0,0,0)&quot;,&quot;lineWidth&quot;:20.349089815444334,&quot;lineJoin&quot;:&quot;round&quot;}],&quot;pathPattern&quot;:{&quot;type&quot;:&quot;ROW&quot;,&quot;patternId&quot;:&quot;353ddc48-152e-4b17-9b17-7809c713def1&quot;,&quot;patternTransform&quot;:{&quot;translate&quot;:{&quot;x&quot;:-0.003164556962025317,&quot;y&quot;:-0.5},&quot;rotate&quot;:0,&quot;skewX&quot;:0,&quot;scale&quot;:{&quot;x&quot;:0.012658227848101266,&quot;y&quot;:0.012658227848101266}},&quot;xUnits&quot;:&quot;STROKE_WIDTH&quot;,&quot;yUnits&quot;:&quot;STROKE_WIDTH&quot;,&quot;bending&quot;:true,&quot;repeat&quot;:{&quot;distance&quot;:0.6265822784810127,&quot;align&quot;:&quot;CENTER&quot;},&quot;isPremium&quot;:true},&quot;isLocked&quot;:false,&quot;parent&quot;:{&quot;type&quot;:&quot;CHILD&quot;,&quot;parentId&quot;:&quot;ab9812b4-0e36-4ff6-8238-af0f78b54aeb&quot;,&quot;order&quot;:&quot;2&quot;},&quot;isPremium&quot;:true,&quot;displayName&quot;:&quot;Unwound ssDNA brush (arc, medium)&quot;,&quot;connectorInfo&quot;:{&quot;connectedObjects&quot;:[],&quot;type&quot;:&quot;ELBOW&quot;,&quot;offset&quot;:{&quot;x&quot;:0,&quot;y&quot;:0},&quot;bending&quot;:0.1,&quot;firstElementIsHead&quot;:true,&quot;customized&quot;:true}},&quot;353ddc48-152e-4b17-9b17-7809c713def1&quot;:{&quot;type&quot;:&quot;FIGURE_OBJECT&quot;,&quot;id&quot;:&quot;353ddc48-152e-4b17-9b17-7809c713def1&quot;,&quot;relativeTransform&quot;:{&quot;translate&quot;:{&quot;x&quot;:0,&quot;y&quot;:0},&quot;rotate&quot;:0,&quot;skewX&quot;:0,&quot;scale&quot;:{&quot;x&quot;:1,&quot;y&quot;:1}},&quot;source&quot;:{&quot;type&quot;:&quot;ASSETS&quot;,&quot;id&quot;:&quot;5ee1532b88e8df0028d0e2f0&quot;},&quot;name&quot;:&quot;ssDNA (unwound, single, for brush)&quot;},&quot;9f596d27-2bf2-43d3-bc14-1a54124d6414&quot;:{&quot;type&quot;:&quot;FIGURE_OBJECT&quot;,&quot;id&quot;:&quot;9f596d27-2bf2-43d3-bc14-1a54124d6414&quot;,&quot;parent&quot;:{&quot;type&quot;:&quot;CHILD&quot;,&quot;parentId&quot;:&quot;353ddc48-152e-4b17-9b17-7809c713def1&quot;,&quot;order&quot;:&quot;5&quot;},&quot;relativeTransform&quot;:{&quot;translate&quot;:{&quot;x&quot;:0,&quot;y&quot;:0},&quot;rotate&quot;:0,&quot;skewX&quot;:0,&quot;scale&quot;:{&quot;x&quot;:1,&quot;y&quot;:1}}},&quot;f4333eb8-4c80-4d6a-bc50-a8152267b3c0&quot;:{&quot;type&quot;:&quot;FIGURE_OBJECT&quot;,&quot;id&quot;:&quot;f4333eb8-4c80-4d6a-bc50-a8152267b3c0&quot;,&quot;parent&quot;:{&quot;type&quot;:&quot;CHILD&quot;,&quot;parentId&quot;:&quot;9f596d27-2bf2-43d3-bc14-1a54124d6414&quot;,&quot;order&quot;:&quot;5&quot;},&quot;relativeTransform&quot;:{&quot;translate&quot;:{&quot;x&quot;:24.983,&quot;y&quot;:68.39},&quot;rotate&quot;:0,&quot;skewX&quot;:0,&quot;scale&quot;:{&quot;x&quot;:1,&quot;y&quot;:1}},&quot;path&quot;:{&quot;type&quot;:&quot;RECT&quot;,&quot;size&quot;:{&quot;x&quot;:50,&quot;y&quot;:22}},&quot;pathStyles&quot;:[{&quot;type&quot;:&quot;FILL&quot;,&quot;fillStyle&quot;:&quot;#005485&quot;}],&quot;opacity&quot;:1},&quot;4c6c41bd-e864-4af0-ad71-d2c9ff6d02b6&quot;:{&quot;type&quot;:&quot;FIGURE_OBJECT&quot;,&quot;id&quot;:&quot;4c6c41bd-e864-4af0-ad71-d2c9ff6d02b6&quot;,&quot;parent&quot;:{&quot;type&quot;:&quot;CHILD&quot;,&quot;parentId&quot;:&quot;353ddc48-152e-4b17-9b17-7809c713def1&quot;,&quot;order&quot;:&quot;7&quot;},&quot;relativeTransform&quot;:{&quot;translate&quot;:{&quot;x&quot;:0,&quot;y&quot;:0},&quot;rotate&quot;:0,&quot;skewX&quot;:0,&quot;scale&quot;:{&quot;x&quot;:1,&quot;y&quot;:1}}},&quot;fa1ca970-f347-4377-bb99-2a03682589ec&quot;:{&quot;type&quot;:&quot;FIGURE_OBJECT&quot;,&quot;id&quot;:&quot;fa1ca970-f347-4377-bb99-2a03682589ec&quot;,&quot;parent&quot;:{&quot;type&quot;:&quot;CHILD&quot;,&quot;parentId&quot;:&quot;4c6c41bd-e864-4af0-ad71-d2c9ff6d02b6&quot;,&quot;order&quot;:&quot;5&quot;},&quot;relativeTransform&quot;:{&quot;translate&quot;:{&quot;x&quot;:24.983,&quot;y&quot;:29.22},&quot;rotate&quot;:0,&quot;skewX&quot;:0,&quot;scale&quot;:{&quot;x&quot;:1,&quot;y&quot;:1}},&quot;path&quot;:{&quot;type&quot;:&quot;RECT&quot;,&quot;size&quot;:{&quot;x&quot;:13,&quot;y&quot;:58.44}},&quot;pathStyles&quot;:[{&quot;type&quot;:&quot;FILL&quot;,&quot;fillStyle&quot;:&quot;#005485&quot;}],&quot;opacity&quot;:1},&quot;0a5fcdb9-49ce-4fbd-9203-bf213888530d&quot;:{&quot;relativeTransform&quot;:{&quot;translate&quot;:{&quot;x&quot;:730.2455115423643,&quot;y&quot;:-67.90847815054047},&quot;rotate&quot;:0,&quot;skewX&quot;:0,&quot;scale&quot;:{&quot;x&quot;:1,&quot;y&quot;:1}},&quot;type&quot;:&quot;FIGURE_OBJECT&quot;,&quot;id&quot;:&quot;0a5fcdb9-49ce-4fbd-9203-bf213888530d&quot;,&quot;parent&quot;:{&quot;type&quot;:&quot;CHILD&quot;,&quot;parentId&quot;:&quot;7b7e4984-9463-4fc4-81fa-65b50cc23e77&quot;,&quot;order&quot;:&quot;5&quot;},&quot;name&quot;:&quot;DNA probe (molecular beacon)&quot;,&quot;displayName&quot;:&quot;DNA probe (molecular beacon)&quot;,&quot;source&quot;:{&quot;id&quot;:&quot;6490d9632d2897db32e02945&quot;,&quot;type&quot;:&quot;ASSETS&quot;},&quot;isPremium&quot;:true},&quot;b12ff8ff-a11e-465c-9607-91847601eda1&quot;:{&quot;id&quot;:&quot;b12ff8ff-a11e-465c-9607-91847601eda1&quot;,&quot;name&quot;:&quot;Fluorophore (glowing)&quot;,&quot;displayName&quot;:&quot;&quot;,&quot;type&quot;:&quot;FIGURE_OBJECT&quot;,&quot;relativeTransform&quot;:{&quot;translate&quot;:{&quot;x&quot;:-196.935,&quot;y&quot;:150.5},&quot;rotate&quot;:0,&quot;skewX&quot;:0,&quot;scale&quot;:{&quot;x&quot;:0.6199999999999997,&quot;y&quot;:0.6199999999999997}},&quot;image&quot;:{&quot;url&quot;:&quot;https://icons.biorender.com/biorender/63bc3b90e7456200216bd10d/20230109180631/image/fluorophore-glowing.png&quot;,&quot;fallbackUrl&quot;:&quot;https://res.cloudinary.com/dlcjuc3ej/image/upload/v1673287591/dhonwdgyc6wn0h3e6mgf.svg#/keystone/api/icons/63bc3b90e7456200216bd10d/20230109180631/image/fluorophore-glowing.svg&quot;,&quot;isPremium&quot;:false,&quot;size&quot;:{&quot;x&quot;:50,&quot;y&quot;:50}},&quot;source&quot;:{&quot;id&quot;:&quot;63bc3b90e7456200216bd10d&quot;,&quot;type&quot;:&quot;ASSETS&quot;},&quot;isPremium&quot;:false,&quot;parent&quot;:{&quot;type&quot;:&quot;CHILD&quot;,&quot;parentId&quot;:&quot;ab9812b4-0e36-4ff6-8238-af0f78b54aeb&quot;,&quot;order&quot;:&quot;5&quot;}},&quot;75534751-8511-4193-906c-41a87a1bc152&quot;:{&quot;id&quot;:&quot;75534751-8511-4193-906c-41a87a1bc152&quot;,&quot;name&quot;:&quot;Sphere&quot;,&quot;displayName&quot;:&quot;&quot;,&quot;type&quot;:&quot;FIGURE_OBJECT&quot;,&quot;relativeTransform&quot;:{&quot;translate&quot;:{&quot;x&quot;:-171.2965,&quot;y&quot;:150.2825},&quot;rotate&quot;:0,&quot;skewX&quot;:0,&quot;scale&quot;:{&quot;x&quot;:0.40553999999999973,&quot;y&quot;:0.40553999999999973}},&quot;image&quot;:{&quot;url&quot;:&quot;https://icons.biorender.com/biorender/5f4529c2929bce0028c9f87f/sphere.png&quot;,&quot;fallbackUrl&quot;:&quot;https://res.cloudinary.com/dlcjuc3ej/image/upload/v1598368171/soihczeyq35kxprwz6kd.svg#/keystone/api/icons/5f4529c2929bce0028c9f87f/sphere.svg#/keystone/api/icons/5f4529c2929bce0028c9f87f/sphere.svg#/keystone/api/icons/5f4529c2929bce0028c9f87f/sphere.svg&quot;,&quot;isPremium&quot;:false,&quot;size&quot;:{&quot;x&quot;:50,&quot;y&quot;:50}},&quot;source&quot;:{&quot;id&quot;:&quot;5b8847989629ce1400901caa&quot;,&quot;type&quot;:&quot;ASSETS&quot;},&quot;isPremium&quot;:false,&quot;parent&quot;:{&quot;type&quot;:&quot;CHILD&quot;,&quot;parentId&quot;:&quot;ab9812b4-0e36-4ff6-8238-af0f78b54aeb&quot;,&quot;order&quot;:&quot;7&quot;}},&quot;ab9812b4-0e36-4ff6-8238-af0f78b54aeb&quot;:{&quot;type&quot;:&quot;FIGURE_OBJECT&quot;,&quot;id&quot;:&quot;ab9812b4-0e36-4ff6-8238-af0f78b54aeb&quot;,&quot;parent&quot;:{&quot;type&quot;:&quot;CHILD&quot;,&quot;parentId&quot;:&quot;7b7e4984-9463-4fc4-81fa-65b50cc23e77&quot;,&quot;order&quot;:&quot;99997&quot;},&quot;relativeTransform&quot;:{}},&quot;cdfd3903-7181-453b-aa28-3c25273f4fda&quot;:{&quot;relativeTransform&quot;:{&quot;translate&quot;:{&quot;x&quot;:459.0493815197228,&quot;y&quot;:232.89787715377787},&quot;rotate&quot;:0,&quot;skewX&quot;:0,&quot;scale&quot;:{&quot;x&quot;:1,&quot;y&quot;:1}},&quot;type&quot;:&quot;FIGURE_OBJECT&quot;,&quot;id&quot;:&quot;cdfd3903-7181-453b-aa28-3c25273f4fda&quot;,&quot;parent&quot;:{&quot;type&quot;:&quot;CHILD&quot;,&quot;parentId&quot;:&quot;7b7e4984-9463-4fc4-81fa-65b50cc23e77&quot;,&quot;order&quot;:&quot;99998&quot;},&quot;name&quot;:&quot;DNA probe (TaqMan)&quot;,&quot;displayName&quot;:&quot;DNA probe (TaqMan)&quot;,&quot;source&quot;:{&quot;id&quot;:&quot;6490da1f907d00975590daea&quot;,&quot;type&quot;:&quot;ASSETS&quot;},&quot;isPremium&quot;:true},&quot;5aa5a72f-180d-46a6-aa01-58c0a73d9f6c&quot;:{&quot;relativeTransform&quot;:{&quot;translate&quot;:{&quot;x&quot;:252.0920931484995,&quot;y&quot;:56.480171411290655},&quot;rotate&quot;:0,&quot;skewX&quot;:0,&quot;scale&quot;:{&quot;x&quot;:1,&quot;y&quot;:1}},&quot;type&quot;:&quot;FIGURE_OBJECT&quot;,&quot;id&quot;:&quot;5aa5a72f-180d-46a6-aa01-58c0a73d9f6c&quot;,&quot;parent&quot;:{&quot;type&quot;:&quot;CHILD&quot;,&quot;parentId&quot;:&quot;cdfd3903-7181-453b-aa28-3c25273f4fda&quot;,&quot;order&quot;:&quot;2&quot;},&quot;name&quot;:&quot;DNA probe (FISH, single-stranded)&quot;,&quot;displayName&quot;:&quot;DNA probe (FISH, single-stranded)&quot;,&quot;source&quot;:{&quot;id&quot;:&quot;647e4ac19611224dab43fb82&quot;,&quot;type&quot;:&quot;ASSETS&quot;},&quot;isPremium&quot;:true},&quot;061422a5-e605-4d1c-9609-0fdabddce0ca&quot;:{&quot;type&quot;:&quot;FIGURE_OBJECT&quot;,&quot;id&quot;:&quot;061422a5-e605-4d1c-9609-0fdabddce0ca&quot;,&quot;name&quot;:&quot;ssDNA (medium)&quot;,&quot;relativeTransform&quot;:{&quot;translate&quot;:{&quot;x&quot;:-611.7582966579345,&quot;y&quot;:-124.6129079922843},&quot;rotate&quot;:3.141592653589793,&quot;skewX&quot;:4.056472853012411e-32,&quot;scale&quot;:{&quot;x&quot;:0.7795625017915643,&quot;y&quot;:0.7795625017915642}},&quot;opacity&quot;:1,&quot;image&quot;:{&quot;url&quot;:&quot;https://icons.biorender.com/biorender/5b6b4cc3c820301400b3389c/ssdna-medium.png&quot;,&quot;size&quot;:{&quot;x&quot;:224,&quot;y&quot;:30},&quot;isPremium&quot;:false,&quot;fallbackUrl&quot;:&quot;https://res.cloudinary.com/dlcjuc3ej/image/upload/v1533758616/il6ifryiqkiprwyb2bvz.svg#/keystone/api/icons/5b6b4cc3c820301400b3389c/ssdna-medium.svg&quot;},&quot;source&quot;:{&quot;id&quot;:&quot;5b6b4c71c820301400b33886&quot;,&quot;type&quot;:&quot;ASSETS&quot;},&quot;pathStyles&quot;:[{&quot;type&quot;:&quot;FILL&quot;,&quot;fillStyle&quot;:&quot;rgb(0,0,0)&quot;}],&quot;isLocked&quot;:false,&quot;parent&quot;:{&quot;type&quot;:&quot;CHILD&quot;,&quot;parentId&quot;:&quot;5aa5a72f-180d-46a6-aa01-58c0a73d9f6c&quot;,&quot;order&quot;:&quot;2&quot;}},&quot;27e31889-1c57-4d5a-97d0-2462197b86be&quot;:{&quot;type&quot;:&quot;FIGURE_OBJECT&quot;,&quot;id&quot;:&quot;27e31889-1c57-4d5a-97d0-2462197b86be&quot;,&quot;relativeTransform&quot;:{&quot;translate&quot;:{&quot;x&quot;:-33.38,&quot;y&quot;:0},&quot;rotate&quot;:0,&quot;skewX&quot;:0,&quot;scale&quot;:{&quot;x&quot;:0.7,&quot;y&quot;:1}},&quot;opacity&quot;:1,&quot;path&quot;:{&quot;type&quot;:&quot;RECT&quot;,&quot;size&quot;:{&quot;x&quot;:224,&quot;y&quot;:30}},&quot;pathStyles&quot;:[{&quot;type&quot;:&quot;FILL&quot;,&quot;fillStyle&quot;:&quot;#fff&quot;}],&quot;isFrozen&quot;:true,&quot;isLocked&quot;:false,&quot;parent&quot;:{&quot;type&quot;:&quot;CROP&quot;,&quot;parentId&quot;:&quot;061422a5-e605-4d1c-9609-0fdabddce0ca&quot;,&quot;order&quot;:&quot;5&quot;}},&quot;829dee25-e4f7-4971-b846-75fe5595ff80&quot;:{&quot;type&quot;:&quot;FIGURE_OBJECT&quot;,&quot;id&quot;:&quot;829dee25-e4f7-4971-b846-75fe5595ff80&quot;,&quot;relativeTransform&quot;:{&quot;translate&quot;:{&quot;x&quot;:-593.6377854387064,&quot;y&quot;:-130.4869744468057},&quot;rotate&quot;:0},&quot;opacity&quot;:1,&quot;path&quot;:{&quot;type&quot;:&quot;POLY_LINE&quot;,&quot;points&quot;:[{&quot;x&quot;:-67.98144605407286,&quot;y&quot;:0},{&quot;x&quot;:76.73837777348696,&quot;y&quot;:0}],&quot;closed&quot;:false},&quot;pathStyles&quot;:[{&quot;type&quot;:&quot;FILL&quot;,&quot;fillStyle&quot;:&quot;rgba(0,0,0,0)&quot;},{&quot;type&quot;:&quot;STROKE&quot;,&quot;strokeStyle&quot;:&quot;rgba(176, 12, 12, 1)&quot;,&quot;lineWidth&quot;:4.3429006410662465,&quot;lineJoin&quot;:&quot;round&quot;}],&quot;isLocked&quot;:false,&quot;parent&quot;:{&quot;type&quot;:&quot;CHILD&quot;,&quot;parentId&quot;:&quot;5aa5a72f-180d-46a6-aa01-58c0a73d9f6c&quot;,&quot;order&quot;:&quot;5&quot;},&quot;connectorInfo&quot;:{&quot;connectedObjects&quot;:[],&quot;type&quot;:&quot;LINE&quot;,&quot;offset&quot;:{&quot;x&quot;:0,&quot;y&quot;:0},&quot;bending&quot;:0.1,&quot;firstElementIsHead&quot;:true,&quot;customized&quot;:false}},&quot;f9701da3-996a-4a84-90a6-a552fc552dea&quot;:{&quot;type&quot;:&quot;FIGURE_OBJECT&quot;,&quot;id&quot;:&quot;f9701da3-996a-4a84-90a6-a552fc552dea&quot;,&quot;relativeTransform&quot;:{&quot;translate&quot;:{&quot;x&quot;:-662.288446294809,&quot;y&quot;:-130.48678111165134},&quot;rotate&quot;:0,&quot;skewX&quot;:0,&quot;scale&quot;:{&quot;x&quot;:1,&quot;y&quot;:1}},&quot;opacity&quot;:1,&quot;path&quot;:{&quot;type&quot;:&quot;ELLIPSE&quot;,&quot;size&quot;:{&quot;x&quot;:-18.567468106485464,&quot;y&quot;:-18.567468106485446}},&quot;isLocked&quot;:false,&quot;pathStyles&quot;:[{&quot;type&quot;:&quot;FILL&quot;,&quot;fillStyle&quot;:&quot;rgb(90, 195, 63)&quot;},{&quot;type&quot;:&quot;STROKE&quot;,&quot;strokeStyle&quot;:&quot;rgba(0,0,0,0)&quot;,&quot;lineWidth&quot;:2.468896450387547,&quot;lineJoin&quot;:&quot;round&quot;}],&quot;parent&quot;:{&quot;type&quot;:&quot;CHILD&quot;,&quot;parentId&quot;:&quot;5aa5a72f-180d-46a6-aa01-58c0a73d9f6c&quot;,&quot;order&quot;:&quot;7&quot;}},&quot;427934c5-c1e2-4c8d-89b6-25d600b14dde&quot;:{&quot;type&quot;:&quot;FIGURE_OBJECT&quot;,&quot;id&quot;:&quot;427934c5-c1e2-4c8d-89b6-25d600b14dde&quot;,&quot;relativeTransform&quot;:{&quot;translate&quot;:{&quot;x&quot;:-256.406409893136,&quot;y&quot;:-74.07272120019283},&quot;rotate&quot;:0,&quot;skewX&quot;:0,&quot;scale&quot;:{&quot;x&quot;:1,&quot;y&quot;:1}},&quot;opacity&quot;:1,&quot;path&quot;:{&quot;type&quot;:&quot;ELLIPSE&quot;,&quot;size&quot;:{&quot;x&quot;:-18.567468106485464,&quot;y&quot;:-18.567468106485446}},&quot;isLocked&quot;:false,&quot;pathStyles&quot;:[{&quot;type&quot;:&quot;FILL&quot;,&quot;fillStyle&quot;:&quot;rgb(155, 155, 155)&quot;},{&quot;type&quot;:&quot;STROKE&quot;,&quot;strokeStyle&quot;:&quot;rgba(0,0,0,0)&quot;,&quot;lineWidth&quot;:2.468896450387547,&quot;lineJoin&quot;:&quot;round&quot;}],&quot;parent&quot;:{&quot;type&quot;:&quot;CHILD&quot;,&quot;parentId&quot;:&quot;cdfd3903-7181-453b-aa28-3c25273f4fda&quot;,&quot;order&quot;:&quot;5&quot;}}}}"/>
    <we:property name="65400759b77c89622ec39fd8_1700070530011" value="{&quot;id&quot;:&quot;4a437cf1-cc13-41fd-abad-64e9dc1c9b2e&quot;,&quot;objects&quot;:{&quot;4a437cf1-cc13-41fd-abad-64e9dc1c9b2e&quot;:{&quot;id&quot;:&quot;4a437cf1-cc13-41fd-abad-64e9dc1c9b2e&quot;,&quot;type&quot;:&quot;FIGURE_OBJECT&quot;,&quot;document&quot;:{&quot;type&quot;:&quot;DOCUMENT_GROUP&quot;,&quot;canvasType&quot;:&quot;FIGURE&quot;,&quot;units&quot;:&quot;in&quot;}},&quot;3c6ea87e-e7f6-4c95-9926-521492df5164&quot;:{&quot;id&quot;:&quot;3c6ea87e-e7f6-4c95-9926-521492df5164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4a437cf1-cc13-41fd-abad-64e9dc1c9b2e&quot;,&quot;type&quot;:&quot;FRAME&quot;,&quot;order&quot;:&quot;5&quot;}},&quot;7b7e4984-9463-4fc4-81fa-65b50cc23e77&quot;:{&quot;id&quot;:&quot;7b7e4984-9463-4fc4-81fa-65b50cc23e77&quot;,&quot;type&quot;:&quot;FIGURE_OBJECT&quot;,&quot;document&quot;:{&quot;type&quot;:&quot;FIGURE&quot;,&quot;canvasType&quot;:&quot;FIGURE&quot;,&quot;units&quot;:&quot;in&quot;},&quot;parent&quot;:{&quot;parentId&quot;:&quot;4a437cf1-cc13-41fd-abad-64e9dc1c9b2e&quot;,&quot;type&quot;:&quot;DOCUMENT&quot;,&quot;order&quot;:&quot;5&quot;}},&quot;bb5cf74e-6a1b-4043-b7a4-6fd7b3b4616c&quot;:{&quot;id&quot;:&quot;bb5cf74e-6a1b-4043-b7a4-6fd7b3b4616c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7b7e4984-9463-4fc4-81fa-65b50cc23e77&quot;,&quot;order&quot;:&quot;5&quot;}},&quot;3072a4eb-bbd5-436b-9f71-ab373205701f&quot;:{&quot;id&quot;:&quot;3072a4eb-bbd5-436b-9f71-ab373205701f&quot;,&quot;type&quot;:&quot;FIGURE_OBJECT&quot;,&quot;guide&quot;:{&quot;type&quot;:&quot;GRID&quot;,&quot;distance&quot;:0.5,&quot;units&quot;:&quot;in&quot;},&quot;parent&quot;:{&quot;parentId&quot;:&quot;4a437cf1-cc13-41fd-abad-64e9dc1c9b2e&quot;,&quot;type&quot;:&quot;GUIDE&quot;,&quot;order&quot;:&quot;5&quot;}},&quot;d4bd7777-f03e-4a6e-b382-90344361d4d2&quot;:{&quot;id&quot;:&quot;d4bd7777-f03e-4a6e-b382-90344361d4d2&quot;,&quot;name&quot;:&quot;RNA (stem loop, small, short)&quot;,&quot;displayName&quot;:&quot;Short stem loop RNA&quot;,&quot;type&quot;:&quot;FIGURE_OBJECT&quot;,&quot;relativeTransform&quot;:{&quot;translate&quot;:{&quot;x&quot;:-324.2455115423642,&quot;y&quot;:-32.04826847091977},&quot;rotate&quot;:1.5707963267948966,&quot;skewX&quot;:0,&quot;scale&quot;:{&quot;x&quot;:0.9180916249940575,&quot;y&quot;:0.9180916249940575}},&quot;image&quot;:{&quot;url&quot;:&quot;https://icons.biorender.com/biorender/5d2f5bce1900ef0400b1d8a2/rna-stem-loop-small-short.png&quot;,&quot;fallbackUrl&quot;:&quot;https://res.cloudinary.com/dlcjuc3ej/image/upload/v1563384776/izjmqkirucjsajhj1qqa.svg#/keystone/api/icons/5d2f5bce1900ef0400b1d8a2/rna-stem-loop-small-short.svg&quot;,&quot;isPremium&quot;:false,&quot;size&quot;:{&quot;x&quot;:126,&quot;y&quot;:75.95744680851064}},&quot;source&quot;:{&quot;id&quot;:&quot;5d2f5b911900ef0400b1d88e&quot;,&quot;type&quot;:&quot;ASSETS&quot;},&quot;isPremium&quot;:false,&quot;parent&quot;:{&quot;type&quot;:&quot;CHILD&quot;,&quot;parentId&quot;:&quot;0a5fcdb9-49ce-4fbd-9203-bf213888530d&quot;,&quot;order&quot;:&quot;2&quot;}},&quot;9d7158e3-aa76-45f9-85eb-6da1c7f874a7&quot;:{&quot;type&quot;:&quot;FIGURE_OBJECT&quot;,&quot;id&quot;:&quot;9d7158e3-aa76-45f9-85eb-6da1c7f874a7&quot;,&quot;relativeTransform&quot;:{&quot;translate&quot;:{&quot;x&quot;:-310.36273233242946,&quot;y&quot;:33.18167866367205},&quot;rotate&quot;:0},&quot;opacity&quot;:1,&quot;path&quot;:{&quot;type&quot;:&quot;ELLIPSE&quot;,&quot;size&quot;:{&quot;x&quot;:-17.046636965908576,&quot;y&quot;:-17.046636965908558}},&quot;isLocked&quot;:false,&quot;pathStyles&quot;:[{&quot;type&quot;:&quot;FILL&quot;,&quot;fillStyle&quot;:&quot;rgb(155, 155, 155)&quot;},{&quot;type&quot;:&quot;STROKE&quot;,&quot;strokeStyle&quot;:&quot;rgba(0,0,0,0)&quot;,&quot;lineWidth&quot;:2.2666731540783633,&quot;lineJoin&quot;:&quot;round&quot;}],&quot;parent&quot;:{&quot;type&quot;:&quot;CHILD&quot;,&quot;parentId&quot;:&quot;0a5fcdb9-49ce-4fbd-9203-bf213888530d&quot;,&quot;order&quot;:&quot;5&quot;}},&quot;2dcb267b-0053-4045-b25f-bc1086e86a30&quot;:{&quot;type&quot;:&quot;FIGURE_OBJECT&quot;,&quot;id&quot;:&quot;2dcb267b-0053-4045-b25f-bc1086e86a30&quot;,&quot;relativeTransform&quot;:{&quot;translate&quot;:{&quot;x&quot;:-338.12837006749106,&quot;y&quot;:33.18162500091516},&quot;rotate&quot;:0},&quot;opacity&quot;:1,&quot;path&quot;:{&quot;type&quot;:&quot;ELLIPSE&quot;,&quot;size&quot;:{&quot;x&quot;:-17.046636965908576,&quot;y&quot;:-17.046636965908558}},&quot;isLocked&quot;:false,&quot;pathStyles&quot;:[{&quot;type&quot;:&quot;FILL&quot;,&quot;fillStyle&quot;:&quot;rgb(90, 195, 63)&quot;},{&quot;type&quot;:&quot;STROKE&quot;,&quot;strokeStyle&quot;:&quot;rgba(0,0,0,0)&quot;,&quot;lineWidth&quot;:2.2666731540783633,&quot;lineJoin&quot;:&quot;round&quot;}],&quot;parent&quot;:{&quot;type&quot;:&quot;CHILD&quot;,&quot;parentId&quot;:&quot;0a5fcdb9-49ce-4fbd-9203-bf213888530d&quot;,&quot;order&quot;:&quot;7&quot;}},&quot;9463ce90-0d6d-48a7-955b-0eafe746e80f&quot;:{&quot;id&quot;:&quot;9463ce90-0d6d-48a7-955b-0eafe746e80f&quot;,&quot;name&quot;:&quot;Tomato (young plant)&quot;,&quot;displayName&quot;:&quot;&quot;,&quot;type&quot;:&quot;FIGURE_OBJECT&quot;,&quot;relativeTransform&quot;:{&quot;translate&quot;:{&quot;x&quot;:-362.42105263157896,&quot;y&quot;:-193.50000000000003},&quot;rotate&quot;:0,&quot;skewX&quot;:0,&quot;scale&quot;:{&quot;x&quot;:1.0515789473684214,&quot;y&quot;:1.0515789473684214}},&quot;image&quot;:{&quot;url&quot;:&quot;https://icons.biorender.com/biorender/648b3ce6c5ed7f002049b7f7/20230616135452/image/tomato-young-plant-01.png&quot;,&quot;fallbackUrl&quot;:&quot;https://res.cloudinary.com/dlcjuc3ej/image/upload/v1686923692/rkyrynaayxvjxz9ewuuz.svg#/keystone/api/icons/648b3ce6c5ed7f002049b7f7/20230616135452/image/tomato-young-plant-01.svg#/keystone/api/icons/648b3ce6c5ed7f002049b7f7/20230616135452/image/tomato-young-plant-01.svg#/keystone/api/icons/648b3ce6c5ed7f002049b7f7/20230616135452/image/tomato-young-plant-01.svg&quot;,&quot;isPremium&quot;:false,&quot;size&quot;:{&quot;x&quot;:100,&quot;y&quot;:135.71428571428572}},&quot;source&quot;:{&quot;id&quot;:&quot;648b3ce6c5ed7f002049b7f7&quot;,&quot;type&quot;:&quot;ASSETS&quot;},&quot;isPremium&quot;:false,&quot;parent&quot;:{&quot;type&quot;:&quot;CHILD&quot;,&quot;parentId&quot;:&quot;25d0b15c-090e-432f-8b17-d3ee35a75e04&quot;,&quot;order&quot;:&quot;1&quot;}},&quot;071052da-ecfc-44f2-91d2-a43b157802dc&quot;:{&quot;id&quot;:&quot;071052da-ecfc-44f2-91d2-a43b157802dc&quot;,&quot;name&quot;:&quot;Coccus&quot;,&quot;displayName&quot;:&quot;&quot;,&quot;type&quot;:&quot;FIGURE_OBJECT&quot;,&quot;relativeTransform&quot;:{&quot;translate&quot;:{&quot;x&quot;:-335.5,&quot;y&quot;:-228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2&quot;}},&quot;0fd8dea4-10d4-4eca-aa9f-d1c1887c591b&quot;:{&quot;id&quot;:&quot;0fd8dea4-10d4-4eca-aa9f-d1c1887c591b&quot;,&quot;name&quot;:&quot;Coccus&quot;,&quot;displayName&quot;:&quot;&quot;,&quot;type&quot;:&quot;FIGURE_OBJECT&quot;,&quot;relativeTransform&quot;:{&quot;translate&quot;:{&quot;x&quot;:-357.5,&quot;y&quot;:-180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3&quot;}},&quot;e10e8714-dcf8-4450-85b7-02b940d112bc&quot;:{&quot;id&quot;:&quot;e10e8714-dcf8-4450-85b7-02b940d112bc&quot;,&quot;name&quot;:&quot;Coccus&quot;,&quot;displayName&quot;:&quot;&quot;,&quot;type&quot;:&quot;FIGURE_OBJECT&quot;,&quot;relativeTransform&quot;:{&quot;translate&quot;:{&quot;x&quot;:-315.5,&quot;y&quot;:-208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5&quot;}},&quot;f0e233af-f130-4819-a54a-2cfbee755576&quot;:{&quot;id&quot;:&quot;f0e233af-f130-4819-a54a-2cfbee755576&quot;,&quot;name&quot;:&quot;Coccus&quot;,&quot;displayName&quot;:&quot;&quot;,&quot;type&quot;:&quot;FIGURE_OBJECT&quot;,&quot;relativeTransform&quot;:{&quot;translate&quot;:{&quot;x&quot;:-346.5,&quot;y&quot;:-250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6&quot;}},&quot;c99d3071-d616-417e-afb9-084caaa70d3b&quot;:{&quot;id&quot;:&quot;c99d3071-d616-417e-afb9-084caaa70d3b&quot;,&quot;name&quot;:&quot;Coccus&quot;,&quot;displayName&quot;:&quot;&quot;,&quot;type&quot;:&quot;FIGURE_OBJECT&quot;,&quot;relativeTransform&quot;:{&quot;translate&quot;:{&quot;x&quot;:-381.5,&quot;y&quot;:-198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7&quot;}},&quot;c65e6156-3a59-4b60-a825-04338a79d208&quot;:{&quot;id&quot;:&quot;c65e6156-3a59-4b60-a825-04338a79d208&quot;,&quot;name&quot;:&quot;Coccus&quot;,&quot;displayName&quot;:&quot;&quot;,&quot;type&quot;:&quot;FIGURE_OBJECT&quot;,&quot;relativeTransform&quot;:{&quot;translate&quot;:{&quot;x&quot;:-392.5,&quot;y&quot;:-239.297},&quot;rotate&quot;:0,&quot;skewX&quot;:0,&quot;scale&quot;:{&quot;x&quot;:0.21999999999999975,&quot;y&quot;:0.21999999999999975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25d0b15c-090e-432f-8b17-d3ee35a75e04&quot;,&quot;order&quot;:&quot;8&quot;}},&quot;25d0b15c-090e-432f-8b17-d3ee35a75e04&quot;:{&quot;type&quot;:&quot;FIGURE_OBJECT&quot;,&quot;id&quot;:&quot;25d0b15c-090e-432f-8b17-d3ee35a75e04&quot;,&quot;parent&quot;:{&quot;type&quot;:&quot;CHILD&quot;,&quot;parentId&quot;:&quot;7b7e4984-9463-4fc4-81fa-65b50cc23e77&quot;,&quot;order&quot;:&quot;99&quot;},&quot;relativeTransform&quot;:{}},&quot;ac4cdecc-0bee-4a6d-b27e-b401ef2fae39&quot;:{&quot;type&quot;:&quot;FIGURE_OBJECT&quot;,&quot;id&quot;:&quot;ac4cdecc-0bee-4a6d-b27e-b401ef2fae39&quot;,&quot;relativeTransform&quot;:{&quot;translate&quot;:{&quot;x&quot;:-231.5,&quot;y&quot;:-199.5},&quot;rotate&quot;:0,&quot;skewX&quot;:0,&quot;scale&quot;:{&quot;x&quot;:1,&quot;y&quot;:1}},&quot;opacity&quot;:1,&quot;path&quot;:{&quot;type&quot;:&quot;POLY_LINE&quot;,&quot;points&quot;:[{&quot;x&quot;:-57.5,&quot;y&quot;:0},{&quot;x&quot;:57.5,&quot;y&quot;:0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7b7e4984-9463-4fc4-81fa-65b50cc23e77&quot;,&quot;order&quot;:&quot;995&quot;},&quot;connectorInfo&quot;:{&quot;connectedObjects&quot;:[],&quot;type&quot;:&quot;LINE&quot;,&quot;offset&quot;:{&quot;x&quot;:0,&quot;y&quot;:0},&quot;bending&quot;:0.1,&quot;firstElementIsHead&quot;:true,&quot;customized&quot;:false}},&quot;eea7b0d9-8596-4241-b525-e46224e54677&quot;:{&quot;relativeTransform&quot;:{&quot;translate&quot;:{&quot;x&quot;:21.54493002314885,&quot;y&quot;:-289.3802889155868},&quot;rotate&quot;:0,&quot;skewX&quot;:0,&quot;scale&quot;:{&quot;x&quot;:1,&quot;y&quot;:1}},&quot;type&quot;:&quot;FIGURE_OBJECT&quot;,&quot;id&quot;:&quot;eea7b0d9-8596-4241-b525-e46224e54677&quot;,&quot;parent&quot;:{&quot;type&quot;:&quot;CHILD&quot;,&quot;parentId&quot;:&quot;7b7e4984-9463-4fc4-81fa-65b50cc23e77&quot;,&quot;order&quot;:&quot;997&quot;},&quot;name&quot;:&quot;Eppendorf tube (2/3 liquid, closed, purified DNA)&quot;,&quot;displayName&quot;:&quot;Eppendorf tube (2/3 liquid, closed, purified DNA)&quot;,&quot;source&quot;:{&quot;id&quot;:&quot;649a24bd6053d8852968a94c&quot;,&quot;type&quot;:&quot;ASSETS&quot;},&quot;isPremium&quot;:true},&quot;c524e319-d620-4244-838c-a32609ff2054&quot;:{&quot;id&quot;:&quot;c524e319-d620-4244-838c-a32609ff2054&quot;,&quot;name&quot;:&quot;Eppendorf tube (2-3, closed)&quot;,&quot;displayName&quot;:&quot;Eppendorf tube (2/3 liquid, closed)&quot;,&quot;type&quot;:&quot;FIGURE_OBJECT&quot;,&quot;relativeTransform&quot;:{&quot;translate&quot;:{&quot;x&quot;:-149.70293002314884,&quot;y&quot;:95.88028891558676},&quot;rotate&quot;:0,&quot;skewX&quot;:0,&quot;scale&quot;:{&quot;x&quot;:1,&quot;y&quot;:1}},&quot;image&quot;:{&quot;url&quot;:&quot;https://icons.biorender.com/biorender/5e41d9e1e250000028d2f747/20200210223234/image/eppendorf-tube-2-3-closed.png&quot;,&quot;fallbackUrl&quot;:&quot;https://res.cloudinary.com/dlcjuc3ej/image/upload/v1581373954/nngdqp51odoekaeiuc07.svg#/keystone/api/icons/5e41d9e1e250000028d2f747/20200210223234/image/eppendorf-tube-2-3-closed.svg&quot;,&quot;isPremium&quot;:false,&quot;size&quot;:{&quot;x&quot;:50,&quot;y&quot;:108.64197530864197}},&quot;source&quot;:{&quot;id&quot;:&quot;5e41d9e1e250000028d2f747&quot;,&quot;type&quot;:&quot;ASSETS&quot;},&quot;isPremium&quot;:false,&quot;parent&quot;:{&quot;type&quot;:&quot;CHILD&quot;,&quot;parentId&quot;:&quot;eea7b0d9-8596-4241-b525-e46224e54677&quot;,&quot;order&quot;:&quot;1&quot;}},&quot;9c8ea1eb-3b53-43bb-a632-5bf4a1afc029&quot;:{&quot;relativeTransform&quot;:{&quot;translate&quot;:{&quot;x&quot;:-143.67565150044493,&quot;y&quot;:109.23830944009394},&quot;rotate&quot;:-0.6799351313605974,&quot;skewX&quot;:0,&quot;scale&quot;:{&quot;x&quot;:1,&quot;y&quot;:1}},&quot;type&quot;:&quot;FIGURE_OBJECT&quot;,&quot;id&quot;:&quot;9c8ea1eb-3b53-43bb-a632-5bf4a1afc029&quot;,&quot;name&quot;:&quot;dsDNA brush 3 (straight)&quot;,&quot;displayName&quot;:&quot;Simplified dsDNA brush (straight)&quot;,&quot;opacity&quot;:1,&quot;source&quot;:{&quot;id&quot;:&quot;5e75575f52bb9000abea6260&quot;,&quot;type&quot;:&quot;ASSETS&quot;},&quot;path&quot;:{&quot;type&quot;:&quot;POLY_LINE&quot;,&quot;points&quot;:[{&quot;x&quot;:-8.559496991294791,&quot;y&quot;:0},{&quot;x&quot;:8.559496991294786,&quot;y&quot;:0}],&quot;closed&quot;:false},&quot;pathStyles&quot;:[{&quot;type&quot;:&quot;FILL&quot;,&quot;fillStyle&quot;:&quot;rgba(0,0,0,0)&quot;},{&quot;type&quot;:&quot;STROKE&quot;,&quot;strokeStyle&quot;:&quot;rgba(0,0,0,0)&quot;,&quot;lineWidth&quot;:4.412664353661106,&quot;lineJoin&quot;:&quot;round&quot;}],&quot;pathSmoothing&quot;:{&quot;type&quot;:&quot;CATMULL_SMOOTHING&quot;,&quot;smoothing&quot;:0.2},&quot;pathPattern&quot;:{&quot;type&quot;:&quot;ROW&quot;,&quot;patternId&quot;:&quot;f532a18f-fcaf-4e90-9771-d1d24f456ad7&quot;,&quot;patternTransform&quot;:{&quot;translate&quot;:{&quot;x&quot;:-0.00002540549651012527,&quot;y&quot;:-0.5},&quot;rotate&quot;:0,&quot;skewX&quot;:0,&quot;scale&quot;:{&quot;x&quot;:0.005076142131979695,&quot;y&quot;:0.005076142131979695}},&quot;xUnits&quot;:&quot;STROKE_WIDTH&quot;,&quot;yUnits&quot;:&quot;STROKE_WIDTH&quot;,&quot;bending&quot;:true,&quot;repeat&quot;:{&quot;distance&quot;:1.8661421567655458,&quot;align&quot;:&quot;CENTER&quot;},&quot;isPremium&quot;:true},&quot;isLocked&quot;:false,&quot;parent&quot;:{&quot;type&quot;:&quot;CHILD&quot;,&quot;parentId&quot;:&quot;eea7b0d9-8596-4241-b525-e46224e54677&quot;,&quot;order&quot;:&quot;2&quot;},&quot;isPremium&quot;:true},&quot;f532a18f-fcaf-4e90-9771-d1d24f456ad7&quot;:{&quot;type&quot;:&quot;FIGURE_OBJECT&quot;,&quot;id&quot;:&quot;f532a18f-fcaf-4e90-9771-d1d24f456ad7&quot;,&quot;relativeTransform&quot;:{&quot;translate&quot;:{&quot;x&quot;:0,&quot;y&quot;:0},&quot;rotate&quot;:0,&quot;skewX&quot;:0,&quot;scale&quot;:{&quot;x&quot;:1,&quot;y&quot;:1}},&quot;source&quot;:{&quot;type&quot;:&quot;ASSETS&quot;,&quot;id&quot;:&quot;5e71324176df310028d1ed5d&quot;},&quot;name&quot;:&quot;dsDNA (simplified)&quot;},&quot;4c16448e-f83f-496f-85a4-f737bb9f34e5&quot;:{&quot;type&quot;:&quot;FIGURE_OBJECT&quot;,&quot;id&quot;:&quot;4c16448e-f83f-496f-85a4-f737bb9f34e5&quot;,&quot;parent&quot;:{&quot;type&quot;:&quot;CHILD&quot;,&quot;parentId&quot;:&quot;f532a18f-fcaf-4e90-9771-d1d24f456ad7&quot;,&quot;order&quot;:&quot;7&quot;},&quot;relativeTransform&quot;:{&quot;translate&quot;:{&quot;x&quot;:0,&quot;y&quot;:0},&quot;rotate&quot;:0,&quot;skewX&quot;:0,&quot;scale&quot;:{&quot;x&quot;:1,&quot;y&quot;:1}}},&quot;7c5ce5c3-0e14-4d57-a8f7-eda61a3bb4c3&quot;:{&quot;type&quot;:&quot;FIGURE_OBJECT&quot;,&quot;id&quot;:&quot;7c5ce5c3-0e14-4d57-a8f7-eda61a3bb4c3&quot;,&quot;parent&quot;:{&quot;type&quot;:&quot;CHILD&quot;,&quot;parentId&quot;:&quot;4c16448e-f83f-496f-85a4-f737bb9f34e5&quot;,&quot;order&quot;:&quot;2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.14,&quot;isEndPoint&quot;:true},{&quot;x&quot;:353.18,&quot;y&quot;:7.140000000000001,&quot;isEndPoint&quot;:false},{&quot;x&quot;:332.5,&quot;y&quot;:7.140000000000001,&quot;isEndPoint&quot;:false},{&quot;x&quot;:332.5,&quot;y&quot;:7.140000000000001,&quot;isEndPoint&quot;:true},{&quot;x&quot;:282,&quot;y&quot;:7.42,&quot;isEndPoint&quot;:false},{&quot;x&quot;:251.44,&quot;y&quot;:51,&quot;isEndPoint&quot;:false},{&quot;x&quot;:224.49,&quot;y&quot;:89.43,&quot;isEndPoint&quot;:true},{&quot;x&quot;:201.26000000000002,&quot;y&quot;:122.59,&quot;isEndPoint&quot;:false},{&quot;x&quot;:179.31,&quot;y&quot;:153.9,&quot;isEndPoint&quot;:false},{&quot;x&quot;:149.9,&quot;y&quot;:153.9,&quot;isEndPoint&quot;:true},{&quot;x&quot;:149.32,&quot;y&quot;:153.9,&quot;isEndPoint&quot;:true},{&quot;x&quot;:149.32,&quot;y&quot;:189.9,&quot;isEndPoint&quot;:true},{&quot;x&quot;:149.91,&quot;y&quot;:189.9,&quot;isEndPoint&quot;:true},{&quot;x&quot;:198.06,&quot;y&quot;:189.9,&quot;isEndPoint&quot;:false},{&quot;x&quot;:226.5,&quot;y&quot;:149.31,&quot;isEndPoint&quot;:false},{&quot;x&quot;:254.01999999999998,&quot;y&quot;:110.05000000000001,&quot;isEndPoint&quot;:true},{&quot;x&quot;:278.15,&quot;y&quot;:75.61000000000001,&quot;isEndPoint&quot;:false},{&quot;x&quot;:300.95,&quot;y&quot;:43.05000000000001,&quot;isEndPoint&quot;:false},{&quot;x&quot;:333.02,&quot;y&quot;:43.05000000000001,&quot;isEndPoint&quot;:true},{&quot;x&quot;:333.02,&quot;y&quot;:43.05000000000001,&quot;isEndPoint&quot;:true},{&quot;x&quot;:344.54999999999995,&quot;y&quot;:43.05000000000001,&quot;isEndPoint&quot;:false},{&quot;x&quot;:356.46999999999997,&quot;y&quot;:47.16000000000001,&quot;isEndPoint&quot;:false},{&quot;x&quot;:367.56,&quot;y&quot;:55.750000000000014,&quot;isEndPoint&quot;:true}],&quot;closed&quot;:true}},&quot;pathStyles&quot;:[{&quot;type&quot;:&quot;FILL&quot;,&quot;fillStyle&quot;:&quot;#002479&quot;}],&quot;opacity&quot;:1},&quot;6b3e2be0-51f5-4cb7-8e57-2cad8f751846&quot;:{&quot;type&quot;:&quot;FIGURE_OBJECT&quot;,&quot;id&quot;:&quot;6b3e2be0-51f5-4cb7-8e57-2cad8f751846&quot;,&quot;parent&quot;:{&quot;type&quot;:&quot;CHILD&quot;,&quot;parentId&quot;:&quot;4c16448e-f83f-496f-85a4-f737bb9f34e5&quot;,&quot;order&quot;:&quot;5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1.2,&quot;isEndPoint&quot;:true},{&quot;x&quot;:350.99,&quot;y&quot;:128.64999999999998,&quot;isEndPoint&quot;:false},{&quot;x&quot;:336.37,&quot;y&quot;:108.67999999999998,&quot;isEndPoint&quot;:false},{&quot;x&quot;:321.13,&quot;y&quot;:86.92999999999998,&quot;isEndPoint&quot;:true},{&quot;x&quot;:293.62,&quot;y&quot;:47.67,&quot;isEndPoint&quot;:false},{&quot;x&quot;:265.18,&quot;y&quot;:7.08,&quot;isEndPoint&quot;:false},{&quot;x&quot;:217,&quot;y&quot;:7.08,&quot;isEndPoint&quot;:true},{&quot;x&quot;:168.82,&quot;y&quot;:7.08,&quot;isEndPoint&quot;:false},{&quot;x&quot;:140.4,&quot;y&quot;:47.67,&quot;isEndPoint&quot;:false},{&quot;x&quot;:112.89,&quot;y&quot;:86.92999999999999,&quot;isEndPoint&quot;:true},{&quot;x&quot;:88.75,&quot;y&quot;:121.36999999999999,&quot;isEndPoint&quot;:false},{&quot;x&quot;:65.96000000000001,&quot;y&quot;:153.93,&quot;isEndPoint&quot;:false},{&quot;x&quot;:33.83,&quot;y&quot;:153.93,&quot;isEndPoint&quot;:true},{&quot;x&quot;:22.56,&quot;y&quot;:153.9,&quot;isEndPoint&quot;:false},{&quot;x&quot;:11,&quot;y&quot;:149.44,&quot;isEndPoint&quot;:false},{&quot;x&quot;:0.11,&quot;y&quot;:141.2,&quot;isEndPoint&quot;:true},{&quot;x&quot;:0,&quot;y&quot;:182.8,&quot;isEndPoint&quot;:true},{&quot;x&quot;:0.35,&quot;y&quot;:182.95000000000002,&quot;isEndPoint&quot;:true},{&quot;x&quot;:10.905530717350821,&quot;y&quot;:187.59644786408347,&quot;isEndPoint&quot;:false},{&quot;x&quot;:22.317101480766773,&quot;y&quot;:189.98095518778234,&quot;isEndPoint&quot;:false},{&quot;x&quot;:33.84999999999999,&quot;y&quot;:189.95000000000002,&quot;isEndPoint&quot;:true},{&quot;x&quot;:84.73999999999998,&quot;y&quot;:189.95000000000002,&quot;isEndPoint&quot;:false},{&quot;x&quot;:115.38999999999999,&quot;y&quot;:146.21,&quot;isEndPoint&quot;:false},{&quot;x&quot;:142.45,&quot;y&quot;:107.60000000000002,&quot;isEndPoint&quot;:true},{&quot;x&quot;:165.68,&quot;y&quot;:74.45,&quot;isEndPoint&quot;:false},{&quot;x&quot;:187.62,&quot;y&quot;:43.13,&quot;isEndPoint&quot;:false},{&quot;x&quot;:217,&quot;y&quot;:43.13,&quot;isEndPoint&quot;:true},{&quot;x&quot;:246.38,&quot;y&quot;:43.13,&quot;isEndPoint&quot;:false},{&quot;x&quot;:268.35,&quot;y&quot;:74.46000000000001,&quot;isEndPoint&quot;:false},{&quot;x&quot;:291.58,&quot;y&quot;:107.62,&quot;isEndPoint&quot;:true},{&quot;x&quot;:311.82,&quot;y&quot;:136.5,&quot;isEndPoint&quot;:false},{&quot;x&quot;:335.58,&quot;y&quot;:168.97,&quot;isEndPoint&quot;:false},{&quot;x&quot;:367.58,&quot;y&quot;:182.8,&quot;isEndPoint&quot;:true}],&quot;closed&quot;:true}},&quot;pathStyles&quot;:[{&quot;type&quot;:&quot;FILL&quot;,&quot;fillStyle&quot;:&quot;#184193&quot;}],&quot;opacity&quot;:1},&quot;31afc61c-4969-435e-9a3d-2ad6540465d1&quot;:{&quot;type&quot;:&quot;FIGURE_OBJECT&quot;,&quot;id&quot;:&quot;31afc61c-4969-435e-9a3d-2ad6540465d1&quot;,&quot;parent&quot;:{&quot;type&quot;:&quot;CHILD&quot;,&quot;parentId&quot;:&quot;4c16448e-f83f-496f-85a4-f737bb9f34e5&quot;,&quot;order&quot;:&quot;7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149.9,&quot;y&quot;:153.9,&quot;isEndPoint&quot;:true},{&quot;x&quot;:120.5,&quot;y&quot;:153.9,&quot;isEndPoint&quot;:false},{&quot;x&quot;:98.56,&quot;y&quot;:122.59,&quot;isEndPoint&quot;:false},{&quot;x&quot;:75.33000000000001,&quot;y&quot;:89.43,&quot;isEndPoint&quot;:true},{&quot;x&quot;:75.33000000000001,&quot;y&quot;:89.43,&quot;isEndPoint&quot;:true},{&quot;x&quot;:55.25,&quot;y&quot;:60.79,&quot;isEndPoint&quot;:false},{&quot;x&quot;:31.69,&quot;y&quot;:28.16,&quot;isEndPoint&quot;:false},{&quot;x&quot;:0,&quot;y&quot;:14.14,&quot;isEndPoint&quot;:true},{&quot;x&quot;:0,&quot;y&quot;:55.83,&quot;isEndPoint&quot;:true},{&quot;x&quot;:16.4,&quot;y&quot;:68.49,&quot;isEndPoint&quot;:false},{&quot;x&quot;:30.8,&quot;y&quot;:88.71000000000001,&quot;isEndPoint&quot;:false},{&quot;x&quot;:45.79,&quot;y&quot;:110.11,&quot;isEndPoint&quot;:true},{&quot;x&quot;:73.3,&quot;y&quot;:149.36,&quot;isEndPoint&quot;:false},{&quot;x&quot;:101.74,&quot;y&quot;:190,&quot;isEndPoint&quot;:false},{&quot;x&quot;:149.9,&quot;y&quot;:190,&quot;isEndPoint&quot;:true}],&quot;closed&quot;:true}},&quot;pathStyles&quot;:[{&quot;type&quot;:&quot;FILL&quot;,&quot;fillStyle&quot;:&quot;#002479&quot;}],&quot;opacity&quot;:1},&quot;ec6a3940-0330-4ef9-aa1f-f72d7b40799e&quot;:{&quot;relativeTransform&quot;:{&quot;translate&quot;:{&quot;x&quot;:-151.87049059560525,&quot;y&quot;:97.84308023383895},&quot;rotate&quot;:-2.105561685167923,&quot;skewX&quot;:0,&quot;scale&quot;:{&quot;x&quot;:1,&quot;y&quot;:1}},&quot;type&quot;:&quot;FIGURE_OBJECT&quot;,&quot;id&quot;:&quot;ec6a3940-0330-4ef9-aa1f-f72d7b40799e&quot;,&quot;name&quot;:&quot;dsDNA brush 3 (straight)&quot;,&quot;displayName&quot;:&quot;Simplified dsDNA brush (straight)&quot;,&quot;opacity&quot;:1,&quot;source&quot;:{&quot;id&quot;:&quot;5e75575f52bb9000abea6260&quot;,&quot;type&quot;:&quot;ASSETS&quot;},&quot;path&quot;:{&quot;type&quot;:&quot;POLY_LINE&quot;,&quot;points&quot;:[{&quot;x&quot;:-8.559496991294791,&quot;y&quot;:0},{&quot;x&quot;:8.559496991294786,&quot;y&quot;:0}],&quot;closed&quot;:false},&quot;pathStyles&quot;:[{&quot;type&quot;:&quot;FILL&quot;,&quot;fillStyle&quot;:&quot;rgba(0,0,0,0)&quot;},{&quot;type&quot;:&quot;STROKE&quot;,&quot;strokeStyle&quot;:&quot;rgba(0,0,0,0)&quot;,&quot;lineWidth&quot;:4.412664353661106,&quot;lineJoin&quot;:&quot;round&quot;}],&quot;pathSmoothing&quot;:{&quot;type&quot;:&quot;CATMULL_SMOOTHING&quot;,&quot;smoothing&quot;:0.2},&quot;pathPattern&quot;:{&quot;type&quot;:&quot;ROW&quot;,&quot;patternId&quot;:&quot;7b16fe1f-29e2-4277-bbeb-7ab4d194b61c&quot;,&quot;patternTransform&quot;:{&quot;translate&quot;:{&quot;x&quot;:-0.00002540549651012527,&quot;y&quot;:-0.5},&quot;rotate&quot;:0,&quot;skewX&quot;:0,&quot;scale&quot;:{&quot;x&quot;:0.005076142131979695,&quot;y&quot;:0.005076142131979695}},&quot;xUnits&quot;:&quot;STROKE_WIDTH&quot;,&quot;yUnits&quot;:&quot;STROKE_WIDTH&quot;,&quot;bending&quot;:true,&quot;repeat&quot;:{&quot;distance&quot;:1.8661421567655458,&quot;align&quot;:&quot;CENTER&quot;},&quot;isPremium&quot;:true},&quot;isLocked&quot;:false,&quot;parent&quot;:{&quot;type&quot;:&quot;CHILD&quot;,&quot;parentId&quot;:&quot;eea7b0d9-8596-4241-b525-e46224e54677&quot;,&quot;order&quot;:&quot;5&quot;},&quot;isPremium&quot;:true},&quot;7b16fe1f-29e2-4277-bbeb-7ab4d194b61c&quot;:{&quot;type&quot;:&quot;FIGURE_OBJECT&quot;,&quot;id&quot;:&quot;7b16fe1f-29e2-4277-bbeb-7ab4d194b61c&quot;,&quot;relativeTransform&quot;:{&quot;translate&quot;:{&quot;x&quot;:0,&quot;y&quot;:0},&quot;rotate&quot;:0,&quot;skewX&quot;:0,&quot;scale&quot;:{&quot;x&quot;:1,&quot;y&quot;:1}},&quot;source&quot;:{&quot;type&quot;:&quot;ASSETS&quot;,&quot;id&quot;:&quot;5e71324176df310028d1ed5d&quot;},&quot;name&quot;:&quot;dsDNA (simplified)&quot;},&quot;7eb0e35c-8383-4c1c-bed8-297c431907dc&quot;:{&quot;type&quot;:&quot;FIGURE_OBJECT&quot;,&quot;id&quot;:&quot;7eb0e35c-8383-4c1c-bed8-297c431907dc&quot;,&quot;parent&quot;:{&quot;type&quot;:&quot;CHILD&quot;,&quot;parentId&quot;:&quot;7b16fe1f-29e2-4277-bbeb-7ab4d194b61c&quot;,&quot;order&quot;:&quot;7&quot;},&quot;relativeTransform&quot;:{&quot;translate&quot;:{&quot;x&quot;:0,&quot;y&quot;:0},&quot;rotate&quot;:0,&quot;skewX&quot;:0,&quot;scale&quot;:{&quot;x&quot;:1,&quot;y&quot;:1}}},&quot;e123bdd1-35ac-401c-b7c5-762d1fee9ee4&quot;:{&quot;type&quot;:&quot;FIGURE_OBJECT&quot;,&quot;id&quot;:&quot;e123bdd1-35ac-401c-b7c5-762d1fee9ee4&quot;,&quot;parent&quot;:{&quot;type&quot;:&quot;CHILD&quot;,&quot;parentId&quot;:&quot;7eb0e35c-8383-4c1c-bed8-297c431907dc&quot;,&quot;order&quot;:&quot;2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.14,&quot;isEndPoint&quot;:true},{&quot;x&quot;:353.18,&quot;y&quot;:7.140000000000001,&quot;isEndPoint&quot;:false},{&quot;x&quot;:332.5,&quot;y&quot;:7.140000000000001,&quot;isEndPoint&quot;:false},{&quot;x&quot;:332.5,&quot;y&quot;:7.140000000000001,&quot;isEndPoint&quot;:true},{&quot;x&quot;:282,&quot;y&quot;:7.42,&quot;isEndPoint&quot;:false},{&quot;x&quot;:251.44,&quot;y&quot;:51,&quot;isEndPoint&quot;:false},{&quot;x&quot;:224.49,&quot;y&quot;:89.43,&quot;isEndPoint&quot;:true},{&quot;x&quot;:201.26000000000002,&quot;y&quot;:122.59,&quot;isEndPoint&quot;:false},{&quot;x&quot;:179.31,&quot;y&quot;:153.9,&quot;isEndPoint&quot;:false},{&quot;x&quot;:149.9,&quot;y&quot;:153.9,&quot;isEndPoint&quot;:true},{&quot;x&quot;:149.32,&quot;y&quot;:153.9,&quot;isEndPoint&quot;:true},{&quot;x&quot;:149.32,&quot;y&quot;:189.9,&quot;isEndPoint&quot;:true},{&quot;x&quot;:149.91,&quot;y&quot;:189.9,&quot;isEndPoint&quot;:true},{&quot;x&quot;:198.06,&quot;y&quot;:189.9,&quot;isEndPoint&quot;:false},{&quot;x&quot;:226.5,&quot;y&quot;:149.31,&quot;isEndPoint&quot;:false},{&quot;x&quot;:254.01999999999998,&quot;y&quot;:110.05000000000001,&quot;isEndPoint&quot;:true},{&quot;x&quot;:278.15,&quot;y&quot;:75.61000000000001,&quot;isEndPoint&quot;:false},{&quot;x&quot;:300.95,&quot;y&quot;:43.05000000000001,&quot;isEndPoint&quot;:false},{&quot;x&quot;:333.02,&quot;y&quot;:43.05000000000001,&quot;isEndPoint&quot;:true},{&quot;x&quot;:333.02,&quot;y&quot;:43.05000000000001,&quot;isEndPoint&quot;:true},{&quot;x&quot;:344.54999999999995,&quot;y&quot;:43.05000000000001,&quot;isEndPoint&quot;:false},{&quot;x&quot;:356.46999999999997,&quot;y&quot;:47.16000000000001,&quot;isEndPoint&quot;:false},{&quot;x&quot;:367.56,&quot;y&quot;:55.750000000000014,&quot;isEndPoint&quot;:true}],&quot;closed&quot;:true}},&quot;pathStyles&quot;:[{&quot;type&quot;:&quot;FILL&quot;,&quot;fillStyle&quot;:&quot;#002479&quot;}],&quot;opacity&quot;:1},&quot;2f47f14d-e4a4-4773-9dc6-1d385d9524a0&quot;:{&quot;type&quot;:&quot;FIGURE_OBJECT&quot;,&quot;id&quot;:&quot;2f47f14d-e4a4-4773-9dc6-1d385d9524a0&quot;,&quot;parent&quot;:{&quot;type&quot;:&quot;CHILD&quot;,&quot;parentId&quot;:&quot;7eb0e35c-8383-4c1c-bed8-297c431907dc&quot;,&quot;order&quot;:&quot;5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1.2,&quot;isEndPoint&quot;:true},{&quot;x&quot;:350.99,&quot;y&quot;:128.64999999999998,&quot;isEndPoint&quot;:false},{&quot;x&quot;:336.37,&quot;y&quot;:108.67999999999998,&quot;isEndPoint&quot;:false},{&quot;x&quot;:321.13,&quot;y&quot;:86.92999999999998,&quot;isEndPoint&quot;:true},{&quot;x&quot;:293.62,&quot;y&quot;:47.67,&quot;isEndPoint&quot;:false},{&quot;x&quot;:265.18,&quot;y&quot;:7.08,&quot;isEndPoint&quot;:false},{&quot;x&quot;:217,&quot;y&quot;:7.08,&quot;isEndPoint&quot;:true},{&quot;x&quot;:168.82,&quot;y&quot;:7.08,&quot;isEndPoint&quot;:false},{&quot;x&quot;:140.4,&quot;y&quot;:47.67,&quot;isEndPoint&quot;:false},{&quot;x&quot;:112.89,&quot;y&quot;:86.92999999999999,&quot;isEndPoint&quot;:true},{&quot;x&quot;:88.75,&quot;y&quot;:121.36999999999999,&quot;isEndPoint&quot;:false},{&quot;x&quot;:65.96000000000001,&quot;y&quot;:153.93,&quot;isEndPoint&quot;:false},{&quot;x&quot;:33.83,&quot;y&quot;:153.93,&quot;isEndPoint&quot;:true},{&quot;x&quot;:22.56,&quot;y&quot;:153.9,&quot;isEndPoint&quot;:false},{&quot;x&quot;:11,&quot;y&quot;:149.44,&quot;isEndPoint&quot;:false},{&quot;x&quot;:0.11,&quot;y&quot;:141.2,&quot;isEndPoint&quot;:true},{&quot;x&quot;:0,&quot;y&quot;:182.8,&quot;isEndPoint&quot;:true},{&quot;x&quot;:0.35,&quot;y&quot;:182.95000000000002,&quot;isEndPoint&quot;:true},{&quot;x&quot;:10.905530717350821,&quot;y&quot;:187.59644786408347,&quot;isEndPoint&quot;:false},{&quot;x&quot;:22.317101480766773,&quot;y&quot;:189.98095518778234,&quot;isEndPoint&quot;:false},{&quot;x&quot;:33.84999999999999,&quot;y&quot;:189.95000000000002,&quot;isEndPoint&quot;:true},{&quot;x&quot;:84.73999999999998,&quot;y&quot;:189.95000000000002,&quot;isEndPoint&quot;:false},{&quot;x&quot;:115.38999999999999,&quot;y&quot;:146.21,&quot;isEndPoint&quot;:false},{&quot;x&quot;:142.45,&quot;y&quot;:107.60000000000002,&quot;isEndPoint&quot;:true},{&quot;x&quot;:165.68,&quot;y&quot;:74.45,&quot;isEndPoint&quot;:false},{&quot;x&quot;:187.62,&quot;y&quot;:43.13,&quot;isEndPoint&quot;:false},{&quot;x&quot;:217,&quot;y&quot;:43.13,&quot;isEndPoint&quot;:true},{&quot;x&quot;:246.38,&quot;y&quot;:43.13,&quot;isEndPoint&quot;:false},{&quot;x&quot;:268.35,&quot;y&quot;:74.46000000000001,&quot;isEndPoint&quot;:false},{&quot;x&quot;:291.58,&quot;y&quot;:107.62,&quot;isEndPoint&quot;:true},{&quot;x&quot;:311.82,&quot;y&quot;:136.5,&quot;isEndPoint&quot;:false},{&quot;x&quot;:335.58,&quot;y&quot;:168.97,&quot;isEndPoint&quot;:false},{&quot;x&quot;:367.58,&quot;y&quot;:182.8,&quot;isEndPoint&quot;:true}],&quot;closed&quot;:true}},&quot;pathStyles&quot;:[{&quot;type&quot;:&quot;FILL&quot;,&quot;fillStyle&quot;:&quot;#184193&quot;}],&quot;opacity&quot;:1},&quot;77ed4572-91db-45f3-827d-202cd2647b17&quot;:{&quot;type&quot;:&quot;FIGURE_OBJECT&quot;,&quot;id&quot;:&quot;77ed4572-91db-45f3-827d-202cd2647b17&quot;,&quot;parent&quot;:{&quot;type&quot;:&quot;CHILD&quot;,&quot;parentId&quot;:&quot;7eb0e35c-8383-4c1c-bed8-297c431907dc&quot;,&quot;order&quot;:&quot;7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149.9,&quot;y&quot;:153.9,&quot;isEndPoint&quot;:true},{&quot;x&quot;:120.5,&quot;y&quot;:153.9,&quot;isEndPoint&quot;:false},{&quot;x&quot;:98.56,&quot;y&quot;:122.59,&quot;isEndPoint&quot;:false},{&quot;x&quot;:75.33000000000001,&quot;y&quot;:89.43,&quot;isEndPoint&quot;:true},{&quot;x&quot;:75.33000000000001,&quot;y&quot;:89.43,&quot;isEndPoint&quot;:true},{&quot;x&quot;:55.25,&quot;y&quot;:60.79,&quot;isEndPoint&quot;:false},{&quot;x&quot;:31.69,&quot;y&quot;:28.16,&quot;isEndPoint&quot;:false},{&quot;x&quot;:0,&quot;y&quot;:14.14,&quot;isEndPoint&quot;:true},{&quot;x&quot;:0,&quot;y&quot;:55.83,&quot;isEndPoint&quot;:true},{&quot;x&quot;:16.4,&quot;y&quot;:68.49,&quot;isEndPoint&quot;:false},{&quot;x&quot;:30.8,&quot;y&quot;:88.71000000000001,&quot;isEndPoint&quot;:false},{&quot;x&quot;:45.79,&quot;y&quot;:110.11,&quot;isEndPoint&quot;:true},{&quot;x&quot;:73.3,&quot;y&quot;:149.36,&quot;isEndPoint&quot;:false},{&quot;x&quot;:101.74,&quot;y&quot;:190,&quot;isEndPoint&quot;:false},{&quot;x&quot;:149.9,&quot;y&quot;:190,&quot;isEndPoint&quot;:true}],&quot;closed&quot;:true}},&quot;pathStyles&quot;:[{&quot;type&quot;:&quot;FILL&quot;,&quot;fillStyle&quot;:&quot;#002479&quot;}],&quot;opacity&quot;:1},&quot;7f7bb091-46f0-45d5-a78e-64d3b5d4883d&quot;:{&quot;relativeTransform&quot;:{&quot;translate&quot;:{&quot;x&quot;:-140.7300941988811,&quot;y&quot;:90.64663124977316},&quot;rotate&quot;:2.105561685167923,&quot;skewX&quot;:0,&quot;scale&quot;:{&quot;x&quot;:1,&quot;y&quot;:1}},&quot;type&quot;:&quot;FIGURE_OBJECT&quot;,&quot;id&quot;:&quot;7f7bb091-46f0-45d5-a78e-64d3b5d4883d&quot;,&quot;name&quot;:&quot;dsDNA brush 3 (straight)&quot;,&quot;displayName&quot;:&quot;Simplified dsDNA brush (straight)&quot;,&quot;opacity&quot;:1,&quot;source&quot;:{&quot;id&quot;:&quot;5e75575f52bb9000abea6260&quot;,&quot;type&quot;:&quot;ASSETS&quot;},&quot;path&quot;:{&quot;type&quot;:&quot;POLY_LINE&quot;,&quot;points&quot;:[{&quot;x&quot;:8.559496991294791,&quot;y&quot;:0},{&quot;x&quot;:-8.559496991294786,&quot;y&quot;:0}],&quot;closed&quot;:false},&quot;pathStyles&quot;:[{&quot;type&quot;:&quot;FILL&quot;,&quot;fillStyle&quot;:&quot;rgba(0,0,0,0)&quot;},{&quot;type&quot;:&quot;STROKE&quot;,&quot;strokeStyle&quot;:&quot;rgba(0,0,0,0)&quot;,&quot;lineWidth&quot;:4.412664353661106,&quot;lineJoin&quot;:&quot;round&quot;}],&quot;pathSmoothing&quot;:{&quot;type&quot;:&quot;CATMULL_SMOOTHING&quot;,&quot;smoothing&quot;:0.2},&quot;pathPattern&quot;:{&quot;type&quot;:&quot;ROW&quot;,&quot;patternId&quot;:&quot;b7e55654-6531-444f-900a-5ce552968a22&quot;,&quot;patternTransform&quot;:{&quot;translate&quot;:{&quot;x&quot;:-0.00002540549651012527,&quot;y&quot;:0.5},&quot;rotate&quot;:3.141592653589793,&quot;skewX&quot;:0,&quot;scale&quot;:{&quot;x&quot;:-0.005076142131979695,&quot;y&quot;:0.005076142131979695}},&quot;xUnits&quot;:&quot;STROKE_WIDTH&quot;,&quot;yUnits&quot;:&quot;STROKE_WIDTH&quot;,&quot;bending&quot;:true,&quot;repeat&quot;:{&quot;distance&quot;:1.8661421567655458,&quot;align&quot;:&quot;CENTER&quot;},&quot;isPremium&quot;:true},&quot;isLocked&quot;:false,&quot;parent&quot;:{&quot;type&quot;:&quot;CHILD&quot;,&quot;parentId&quot;:&quot;eea7b0d9-8596-4241-b525-e46224e54677&quot;,&quot;order&quot;:&quot;7&quot;},&quot;isPremium&quot;:true},&quot;b7e55654-6531-444f-900a-5ce552968a22&quot;:{&quot;type&quot;:&quot;FIGURE_OBJECT&quot;,&quot;id&quot;:&quot;b7e55654-6531-444f-900a-5ce552968a22&quot;,&quot;relativeTransform&quot;:{&quot;translate&quot;:{&quot;x&quot;:0,&quot;y&quot;:0},&quot;rotate&quot;:0,&quot;skewX&quot;:0,&quot;scale&quot;:{&quot;x&quot;:1,&quot;y&quot;:1}},&quot;source&quot;:{&quot;type&quot;:&quot;ASSETS&quot;,&quot;id&quot;:&quot;5e71324176df310028d1ed5d&quot;},&quot;name&quot;:&quot;dsDNA (simplified)&quot;},&quot;0f7def37-5cbd-4a2b-a3e2-66e3ce33a2c2&quot;:{&quot;type&quot;:&quot;FIGURE_OBJECT&quot;,&quot;id&quot;:&quot;0f7def37-5cbd-4a2b-a3e2-66e3ce33a2c2&quot;,&quot;parent&quot;:{&quot;type&quot;:&quot;CHILD&quot;,&quot;parentId&quot;:&quot;b7e55654-6531-444f-900a-5ce552968a22&quot;,&quot;order&quot;:&quot;7&quot;},&quot;relativeTransform&quot;:{&quot;translate&quot;:{&quot;x&quot;:0,&quot;y&quot;:0},&quot;rotate&quot;:0,&quot;skewX&quot;:0,&quot;scale&quot;:{&quot;x&quot;:1,&quot;y&quot;:1}}},&quot;50c60839-7aee-4ddc-8c05-136dcf1eb179&quot;:{&quot;type&quot;:&quot;FIGURE_OBJECT&quot;,&quot;id&quot;:&quot;50c60839-7aee-4ddc-8c05-136dcf1eb179&quot;,&quot;parent&quot;:{&quot;type&quot;:&quot;CHILD&quot;,&quot;parentId&quot;:&quot;0f7def37-5cbd-4a2b-a3e2-66e3ce33a2c2&quot;,&quot;order&quot;:&quot;2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.14,&quot;isEndPoint&quot;:true},{&quot;x&quot;:353.18,&quot;y&quot;:7.140000000000001,&quot;isEndPoint&quot;:false},{&quot;x&quot;:332.5,&quot;y&quot;:7.140000000000001,&quot;isEndPoint&quot;:false},{&quot;x&quot;:332.5,&quot;y&quot;:7.140000000000001,&quot;isEndPoint&quot;:true},{&quot;x&quot;:282,&quot;y&quot;:7.42,&quot;isEndPoint&quot;:false},{&quot;x&quot;:251.44,&quot;y&quot;:51,&quot;isEndPoint&quot;:false},{&quot;x&quot;:224.49,&quot;y&quot;:89.43,&quot;isEndPoint&quot;:true},{&quot;x&quot;:201.26000000000002,&quot;y&quot;:122.59,&quot;isEndPoint&quot;:false},{&quot;x&quot;:179.31,&quot;y&quot;:153.9,&quot;isEndPoint&quot;:false},{&quot;x&quot;:149.9,&quot;y&quot;:153.9,&quot;isEndPoint&quot;:true},{&quot;x&quot;:149.32,&quot;y&quot;:153.9,&quot;isEndPoint&quot;:true},{&quot;x&quot;:149.32,&quot;y&quot;:189.9,&quot;isEndPoint&quot;:true},{&quot;x&quot;:149.91,&quot;y&quot;:189.9,&quot;isEndPoint&quot;:true},{&quot;x&quot;:198.06,&quot;y&quot;:189.9,&quot;isEndPoint&quot;:false},{&quot;x&quot;:226.5,&quot;y&quot;:149.31,&quot;isEndPoint&quot;:false},{&quot;x&quot;:254.01999999999998,&quot;y&quot;:110.05000000000001,&quot;isEndPoint&quot;:true},{&quot;x&quot;:278.15,&quot;y&quot;:75.61000000000001,&quot;isEndPoint&quot;:false},{&quot;x&quot;:300.95,&quot;y&quot;:43.05000000000001,&quot;isEndPoint&quot;:false},{&quot;x&quot;:333.02,&quot;y&quot;:43.05000000000001,&quot;isEndPoint&quot;:true},{&quot;x&quot;:333.02,&quot;y&quot;:43.05000000000001,&quot;isEndPoint&quot;:true},{&quot;x&quot;:344.54999999999995,&quot;y&quot;:43.05000000000001,&quot;isEndPoint&quot;:false},{&quot;x&quot;:356.46999999999997,&quot;y&quot;:47.16000000000001,&quot;isEndPoint&quot;:false},{&quot;x&quot;:367.56,&quot;y&quot;:55.750000000000014,&quot;isEndPoint&quot;:true}],&quot;closed&quot;:true}},&quot;pathStyles&quot;:[{&quot;type&quot;:&quot;FILL&quot;,&quot;fillStyle&quot;:&quot;#002479&quot;}],&quot;opacity&quot;:1},&quot;69ebcb8d-c660-4750-b952-90dbbdccd0b4&quot;:{&quot;type&quot;:&quot;FIGURE_OBJECT&quot;,&quot;id&quot;:&quot;69ebcb8d-c660-4750-b952-90dbbdccd0b4&quot;,&quot;parent&quot;:{&quot;type&quot;:&quot;CHILD&quot;,&quot;parentId&quot;:&quot;0f7def37-5cbd-4a2b-a3e2-66e3ce33a2c2&quot;,&quot;order&quot;:&quot;5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367.63,&quot;y&quot;:141.2,&quot;isEndPoint&quot;:true},{&quot;x&quot;:350.99,&quot;y&quot;:128.64999999999998,&quot;isEndPoint&quot;:false},{&quot;x&quot;:336.37,&quot;y&quot;:108.67999999999998,&quot;isEndPoint&quot;:false},{&quot;x&quot;:321.13,&quot;y&quot;:86.92999999999998,&quot;isEndPoint&quot;:true},{&quot;x&quot;:293.62,&quot;y&quot;:47.67,&quot;isEndPoint&quot;:false},{&quot;x&quot;:265.18,&quot;y&quot;:7.08,&quot;isEndPoint&quot;:false},{&quot;x&quot;:217,&quot;y&quot;:7.08,&quot;isEndPoint&quot;:true},{&quot;x&quot;:168.82,&quot;y&quot;:7.08,&quot;isEndPoint&quot;:false},{&quot;x&quot;:140.4,&quot;y&quot;:47.67,&quot;isEndPoint&quot;:false},{&quot;x&quot;:112.89,&quot;y&quot;:86.92999999999999,&quot;isEndPoint&quot;:true},{&quot;x&quot;:88.75,&quot;y&quot;:121.36999999999999,&quot;isEndPoint&quot;:false},{&quot;x&quot;:65.96000000000001,&quot;y&quot;:153.93,&quot;isEndPoint&quot;:false},{&quot;x&quot;:33.83,&quot;y&quot;:153.93,&quot;isEndPoint&quot;:true},{&quot;x&quot;:22.56,&quot;y&quot;:153.9,&quot;isEndPoint&quot;:false},{&quot;x&quot;:11,&quot;y&quot;:149.44,&quot;isEndPoint&quot;:false},{&quot;x&quot;:0.11,&quot;y&quot;:141.2,&quot;isEndPoint&quot;:true},{&quot;x&quot;:0,&quot;y&quot;:182.8,&quot;isEndPoint&quot;:true},{&quot;x&quot;:0.35,&quot;y&quot;:182.95000000000002,&quot;isEndPoint&quot;:true},{&quot;x&quot;:10.905530717350821,&quot;y&quot;:187.59644786408347,&quot;isEndPoint&quot;:false},{&quot;x&quot;:22.317101480766773,&quot;y&quot;:189.98095518778234,&quot;isEndPoint&quot;:false},{&quot;x&quot;:33.84999999999999,&quot;y&quot;:189.95000000000002,&quot;isEndPoint&quot;:true},{&quot;x&quot;:84.73999999999998,&quot;y&quot;:189.95000000000002,&quot;isEndPoint&quot;:false},{&quot;x&quot;:115.38999999999999,&quot;y&quot;:146.21,&quot;isEndPoint&quot;:false},{&quot;x&quot;:142.45,&quot;y&quot;:107.60000000000002,&quot;isEndPoint&quot;:true},{&quot;x&quot;:165.68,&quot;y&quot;:74.45,&quot;isEndPoint&quot;:false},{&quot;x&quot;:187.62,&quot;y&quot;:43.13,&quot;isEndPoint&quot;:false},{&quot;x&quot;:217,&quot;y&quot;:43.13,&quot;isEndPoint&quot;:true},{&quot;x&quot;:246.38,&quot;y&quot;:43.13,&quot;isEndPoint&quot;:false},{&quot;x&quot;:268.35,&quot;y&quot;:74.46000000000001,&quot;isEndPoint&quot;:false},{&quot;x&quot;:291.58,&quot;y&quot;:107.62,&quot;isEndPoint&quot;:true},{&quot;x&quot;:311.82,&quot;y&quot;:136.5,&quot;isEndPoint&quot;:false},{&quot;x&quot;:335.58,&quot;y&quot;:168.97,&quot;isEndPoint&quot;:false},{&quot;x&quot;:367.58,&quot;y&quot;:182.8,&quot;isEndPoint&quot;:true}],&quot;closed&quot;:true}},&quot;pathStyles&quot;:[{&quot;type&quot;:&quot;FILL&quot;,&quot;fillStyle&quot;:&quot;#184193&quot;}],&quot;opacity&quot;:1},&quot;e9d52767-731b-4f4c-915e-868f3f30a921&quot;:{&quot;type&quot;:&quot;FIGURE_OBJECT&quot;,&quot;id&quot;:&quot;e9d52767-731b-4f4c-915e-868f3f30a921&quot;,&quot;parent&quot;:{&quot;type&quot;:&quot;CHILD&quot;,&quot;parentId&quot;:&quot;0f7def37-5cbd-4a2b-a3e2-66e3ce33a2c2&quot;,&quot;order&quot;:&quot;7&quot;}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149.9,&quot;y&quot;:153.9,&quot;isEndPoint&quot;:true},{&quot;x&quot;:120.5,&quot;y&quot;:153.9,&quot;isEndPoint&quot;:false},{&quot;x&quot;:98.56,&quot;y&quot;:122.59,&quot;isEndPoint&quot;:false},{&quot;x&quot;:75.33000000000001,&quot;y&quot;:89.43,&quot;isEndPoint&quot;:true},{&quot;x&quot;:75.33000000000001,&quot;y&quot;:89.43,&quot;isEndPoint&quot;:true},{&quot;x&quot;:55.25,&quot;y&quot;:60.79,&quot;isEndPoint&quot;:false},{&quot;x&quot;:31.69,&quot;y&quot;:28.16,&quot;isEndPoint&quot;:false},{&quot;x&quot;:0,&quot;y&quot;:14.14,&quot;isEndPoint&quot;:true},{&quot;x&quot;:0,&quot;y&quot;:55.83,&quot;isEndPoint&quot;:true},{&quot;x&quot;:16.4,&quot;y&quot;:68.49,&quot;isEndPoint&quot;:false},{&quot;x&quot;:30.8,&quot;y&quot;:88.71000000000001,&quot;isEndPoint&quot;:false},{&quot;x&quot;:45.79,&quot;y&quot;:110.11,&quot;isEndPoint&quot;:true},{&quot;x&quot;:73.3,&quot;y&quot;:149.36,&quot;isEndPoint&quot;:false},{&quot;x&quot;:101.74,&quot;y&quot;:190,&quot;isEndPoint&quot;:false},{&quot;x&quot;:149.9,&quot;y&quot;:190,&quot;isEndPoint&quot;:true}],&quot;closed&quot;:true}},&quot;pathStyles&quot;:[{&quot;type&quot;:&quot;FILL&quot;,&quot;fillStyle&quot;:&quot;#002479&quot;}],&quot;opacity&quot;:1},&quot;384b6d59-a957-4432-afd3-6439a72e17b0&quot;:{&quot;id&quot;:&quot;384b6d59-a957-4432-afd3-6439a72e17b0&quot;,&quot;type&quot;:&quot;FIGURE_OBJECT&quot;,&quot;relativeTransform&quot;:{&quot;translate&quot;:{&quot;x&quot;:-418.3111572265625,&quot;y&quot;:-90.82133333333331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8.666666666666664,&quot;color&quot;:&quot;black&quot;,&quot;fontWeight&quot;:&quot;normal&quot;,&quot;fontStyle&quot;:&quot;normal&quot;,&quot;decoration&quot;:&quot;none&quot;},&quot;range&quot;:[0,13]}],&quot;text&quot;:&quot;DNA Extraction&quot;}],&quot;_lastCaretLocation&quot;:{&quot;lineIndex&quot;:0,&quot;runIndex&quot;:0,&quot;charIndex&quot;:4}},&quot;format&quot;:&quot;BETTER_TEXT&quot;,&quot;size&quot;:{&quot;x&quot;:83.377685546875,&quot;y&quot;:43.093333333333334},&quot;targetSize&quot;:{&quot;x&quot;:83.377685546875,&quot;y&quot;:43.093333333333334}},&quot;parent&quot;:{&quot;type&quot;:&quot;CHILD&quot;,&quot;parentId&quot;:&quot;7b7e4984-9463-4fc4-81fa-65b50cc23e77&quot;,&quot;order&quot;:&quot;998&quot;}},&quot;2fac9073-d264-4549-bb60-5a00f45efbac&quot;:{&quot;type&quot;:&quot;FIGURE_OBJECT&quot;,&quot;id&quot;:&quot;2fac9073-d264-4549-bb60-5a00f45efbac&quot;,&quot;relativeTransform&quot;:{&quot;translate&quot;:{&quot;x&quot;:0,&quot;y&quot;:0},&quot;rotate&quot;:0,&quot;skewX&quot;:0,&quot;scale&quot;:{&quot;x&quot;:1,&quot;y&quot;:1}},&quot;opacity&quot;:1,&quot;path&quot;:{&quot;type&quot;:&quot;POLY_LINE&quot;,&quot;points&quot;:[{&quot;x&quot;:-370.00000000000006,&quot;y&quot;:-122.14285714285714},{&quot;x&quot;:-370.00000000000006,&quot;y&quot;:-60.82142857142858},{&quot;x&quot;:-339,&quot;y&quot;:-60.82142857142858},{&quot;x&quot;:-311,&quot;y&quot;:-60.82142857142858},{&quot;x&quot;:-289,&quot;y&quot;:-60.82142857142858},{&quot;x&quot;:-288,&quot;y&quot;:-59.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7b7e4984-9463-4fc4-81fa-65b50cc23e77&quot;,&quot;order&quot;:&quot;999&quot;},&quot;connectorInfo&quot;:{&quot;connectedObjects&quot;:[{&quot;objectId&quot;:&quot;9463ce90-0d6d-48a7-955b-0eafe746e80f&quot;,&quot;coordinates&quot;:{&quot;x&quot;:0.4279279279279278,&quot;y&quot;:1}}],&quot;type&quot;:&quot;ELBOW&quot;,&quot;offset&quot;:{&quot;x&quot;:0,&quot;y&quot;:0},&quot;bending&quot;:0.1,&quot;firstElementIsHead&quot;:true,&quot;customized&quot;:true}},&quot;4aac909c-77fd-4882-8ccf-e0d8a57ffb1b&quot;:{&quot;id&quot;:&quot;4aac909c-77fd-4882-8ccf-e0d8a57ffb1b&quot;,&quot;name&quot;:&quot;ssDNA (fragment)&quot;,&quot;displayName&quot;:&quot;&quot;,&quot;type&quot;:&quot;FIGURE_OBJECT&quot;,&quot;relativeTransform&quot;:{&quot;translate&quot;:{&quot;x&quot;:10.000000000000114,&quot;y&quot;:9.999999999999886},&quot;rotate&quot;:1.5707963267948966,&quot;skewX&quot;:0,&quot;scale&quot;:{&quot;x&quot;:1,&quot;y&quot;:1}},&quot;image&quot;:{&quot;url&quot;:&quot;https://icons.biorender.com/biorender/5b6b4c11e0461e1400300b32/20180808200148/image/ssdna-fragment.png&quot;,&quot;fallbackUrl&quot;:&quot;https://res.cloudinary.com/dlcjuc3ej/image/upload/v1533758508/oemofy9hvnoaqemdfswt.svg#/keystone/api/icons/5b6b4c11e0461e1400300b32/20180808200148/image/ssdna-fragment.svg#/keystone/api/icons/5b6b4c11e0461e1400300b32/20180808200148/image/ssdna-fragment.svg&quot;,&quot;isPremium&quot;:false,&quot;size&quot;:{&quot;x&quot;:50,&quot;y&quot;:20.53571428571429}},&quot;source&quot;:{&quot;id&quot;:&quot;5b6b4c11e0461e1400300b32&quot;,&quot;type&quot;:&quot;ASSETS&quot;},&quot;isPremium&quot;:false,&quot;parent&quot;:{&quot;type&quot;:&quot;CHILD&quot;,&quot;parentId&quot;:&quot;7b7e4984-9463-4fc4-81fa-65b50cc23e77&quot;,&quot;order&quot;:&quot;9995&quot;}},&quot;2c2cfef3-ea3c-46e3-a733-32c42f210571&quot;:{&quot;id&quot;:&quot;2c2cfef3-ea3c-46e3-a733-32c42f210571&quot;,&quot;name&quot;:&quot;ssDNA (fragment)&quot;,&quot;displayName&quot;:&quot;&quot;,&quot;type&quot;:&quot;FIGURE_OBJECT&quot;,&quot;relativeTransform&quot;:{&quot;translate&quot;:{&quot;x&quot;:30.53606409102059,&quot;y&quot;:9.999616681672862},&quot;rotate&quot;:-1.5707963267948966,&quot;skewX&quot;:0,&quot;scale&quot;:{&quot;x&quot;:1,&quot;y&quot;:1}},&quot;image&quot;:{&quot;url&quot;:&quot;https://icons.biorender.com/biorender/5b6b4c11e0461e1400300b32/20180808200148/image/ssdna-fragment.png&quot;,&quot;fallbackUrl&quot;:&quot;https://res.cloudinary.com/dlcjuc3ej/image/upload/v1533758508/oemofy9hvnoaqemdfswt.svg#/keystone/api/icons/5b6b4c11e0461e1400300b32/20180808200148/image/ssdna-fragment.svg#/keystone/api/icons/5b6b4c11e0461e1400300b32/20180808200148/image/ssdna-fragment.svg&quot;,&quot;isPremium&quot;:false,&quot;size&quot;:{&quot;x&quot;:50,&quot;y&quot;:20.53571428571429}},&quot;source&quot;:{&quot;id&quot;:&quot;5b6b4c11e0461e1400300b32&quot;,&quot;type&quot;:&quot;ASSETS&quot;},&quot;isPremium&quot;:false,&quot;parent&quot;:{&quot;type&quot;:&quot;CHILD&quot;,&quot;parentId&quot;:&quot;7b7e4984-9463-4fc4-81fa-65b50cc23e77&quot;,&quot;order&quot;:&quot;9997&quot;}},&quot;3063cc25-7c43-40b3-b191-92144370fcea&quot;:{&quot;relativeTransform&quot;:{&quot;translate&quot;:{&quot;x&quot;:26.826797429807847,&quot;y&quot;:-121.34225275430614},&quot;rotate&quot;:3.141592653589793,&quot;skewX&quot;:0,&quot;scale&quot;:{&quot;x&quot;:1,&quot;y&quot;:1}},&quot;type&quot;:&quot;FIGURE_OBJECT&quot;,&quot;id&quot;:&quot;3063cc25-7c43-40b3-b191-92144370fcea&quot;,&quot;name&quot;:&quot;ssDNA brush 2 (arc, medium)&quot;,&quot;opacity&quot;:1,&quot;source&quot;:{&quot;id&quot;:&quot;6126a0160f59c500a0eb80cc&quot;,&quot;type&quot;:&quot;ASSETS&quot;},&quot;path&quot;:{&quot;type&quot;:&quot;POLY_LINE&quot;,&quot;points&quot;:[{&quot;x&quot;:-5.526386370554647,&quot;y&quot;:-116.10295336508557},{&quot;x&quot;:-5.526386370554654,&quot;y&quot;:-73.05169291431167},{&quot;x&quot;:-9.22364604964411,&quot;y&quot;:-66.05792091161186},{&quot;x&quot;:-1.9990874968636483,&quot;y&quot;:-59.40574327204149},{&quot;x&quot;:7.24318816652972,&quot;y&quot;:-56.20084322112548},{&quot;x&quot;:7.6846129748063134,&quot;y&quot;:-60.6012686486841},{&quot;x&quot;:19.327102104353646,&quot;y&quot;:-61.79679402532669},{&quot;x&quot;:19.32710210435365,&quot;y&quot;:-78.29838937867157},{&quot;x&quot;:19.32710210435365,&quot;y&quot;:-88.7755183282394},{&quot;x&quot;:13.290575407930318,&quot;y&quot;:-109.13334961026501}],&quot;closed&quot;:false,&quot;cornerRounding&quot;:{&quot;type&quot;:&quot;ARC_LENGTH&quot;,&quot;global&quot;:71.5477776801749},&quot;selectedObjectIds&quot;:[&quot;3063cc25-7c43-40b3-b191-92144370fcea&quot;]},&quot;pathStyles&quot;:[{&quot;type&quot;:&quot;FILL&quot;,&quot;fillStyle&quot;:&quot;rgba(0,0,0,0)&quot;},{&quot;type&quot;:&quot;STROKE&quot;,&quot;strokeStyle&quot;:&quot;rgba(0,0,0,0)&quot;,&quot;lineWidth&quot;:20.349089815444334,&quot;lineJoin&quot;:&quot;round&quot;}],&quot;pathPattern&quot;:{&quot;type&quot;:&quot;ROW&quot;,&quot;patternId&quot;:&quot;a332b0ad-3138-422a-923f-ed101c4985b2&quot;,&quot;patternTransform&quot;:{&quot;translate&quot;:{&quot;x&quot;:-0.003164556962025317,&quot;y&quot;:-0.5},&quot;rotate&quot;:0,&quot;skewX&quot;:0,&quot;scale&quot;:{&quot;x&quot;:0.012658227848101266,&quot;y&quot;:0.012658227848101266}},&quot;xUnits&quot;:&quot;STROKE_WIDTH&quot;,&quot;yUnits&quot;:&quot;STROKE_WIDTH&quot;,&quot;bending&quot;:true,&quot;repeat&quot;:{&quot;distance&quot;:0.6265822784810127,&quot;align&quot;:&quot;CENTER&quot;},&quot;isPremium&quot;:true},&quot;isLocked&quot;:false,&quot;parent&quot;:{&quot;type&quot;:&quot;CHILD&quot;,&quot;parentId&quot;:&quot;7b7e4984-9463-4fc4-81fa-65b50cc23e77&quot;,&quot;order&quot;:&quot;9998&quot;},&quot;isPremium&quot;:true,&quot;displayName&quot;:&quot;Unwound ssDNA brush (arc, medium)&quot;,&quot;connectorInfo&quot;:{&quot;connectedObjects&quot;:[],&quot;type&quot;:&quot;ELBOW&quot;,&quot;offset&quot;:{&quot;x&quot;:0,&quot;y&quot;:0},&quot;bending&quot;:0.1,&quot;firstElementIsHead&quot;:true,&quot;customized&quot;:true}},&quot;a332b0ad-3138-422a-923f-ed101c4985b2&quot;:{&quot;type&quot;:&quot;FIGURE_OBJECT&quot;,&quot;id&quot;:&quot;a332b0ad-3138-422a-923f-ed101c4985b2&quot;,&quot;relativeTransform&quot;:{&quot;translate&quot;:{&quot;x&quot;:0,&quot;y&quot;:0},&quot;rotate&quot;:0,&quot;skewX&quot;:0,&quot;scale&quot;:{&quot;x&quot;:1,&quot;y&quot;:1}},&quot;source&quot;:{&quot;type&quot;:&quot;ASSETS&quot;,&quot;id&quot;:&quot;5ee1532b88e8df0028d0e2f0&quot;},&quot;name&quot;:&quot;ssDNA (unwound, single, for brush)&quot;},&quot;a6d16e80-0ec5-47be-8253-f51a20207f06&quot;:{&quot;type&quot;:&quot;FIGURE_OBJECT&quot;,&quot;id&quot;:&quot;a6d16e80-0ec5-47be-8253-f51a20207f06&quot;,&quot;parent&quot;:{&quot;type&quot;:&quot;CHILD&quot;,&quot;parentId&quot;:&quot;a332b0ad-3138-422a-923f-ed101c4985b2&quot;,&quot;order&quot;:&quot;5&quot;},&quot;relativeTransform&quot;:{&quot;translate&quot;:{&quot;x&quot;:0,&quot;y&quot;:0},&quot;rotate&quot;:0,&quot;skewX&quot;:0,&quot;scale&quot;:{&quot;x&quot;:1,&quot;y&quot;:1}}},&quot;61ccdf80-77f7-4e34-82e6-78f2cf6545df&quot;:{&quot;type&quot;:&quot;FIGURE_OBJECT&quot;,&quot;id&quot;:&quot;61ccdf80-77f7-4e34-82e6-78f2cf6545df&quot;,&quot;parent&quot;:{&quot;type&quot;:&quot;CHILD&quot;,&quot;parentId&quot;:&quot;a6d16e80-0ec5-47be-8253-f51a20207f06&quot;,&quot;order&quot;:&quot;5&quot;},&quot;relativeTransform&quot;:{&quot;translate&quot;:{&quot;x&quot;:24.983,&quot;y&quot;:68.39},&quot;rotate&quot;:0,&quot;skewX&quot;:0,&quot;scale&quot;:{&quot;x&quot;:1,&quot;y&quot;:1}},&quot;path&quot;:{&quot;type&quot;:&quot;RECT&quot;,&quot;size&quot;:{&quot;x&quot;:50,&quot;y&quot;:22}},&quot;pathStyles&quot;:[{&quot;type&quot;:&quot;FILL&quot;,&quot;fillStyle&quot;:&quot;#005485&quot;}],&quot;opacity&quot;:1},&quot;efc64c62-8b6e-4678-97b7-e219fc9c229c&quot;:{&quot;type&quot;:&quot;FIGURE_OBJECT&quot;,&quot;id&quot;:&quot;efc64c62-8b6e-4678-97b7-e219fc9c229c&quot;,&quot;parent&quot;:{&quot;type&quot;:&quot;CHILD&quot;,&quot;parentId&quot;:&quot;a332b0ad-3138-422a-923f-ed101c4985b2&quot;,&quot;order&quot;:&quot;7&quot;},&quot;relativeTransform&quot;:{&quot;translate&quot;:{&quot;x&quot;:0,&quot;y&quot;:0},&quot;rotate&quot;:0,&quot;skewX&quot;:0,&quot;scale&quot;:{&quot;x&quot;:1,&quot;y&quot;:1}}},&quot;63795faf-2b08-45eb-8acb-fdca1f733418&quot;:{&quot;type&quot;:&quot;FIGURE_OBJECT&quot;,&quot;id&quot;:&quot;63795faf-2b08-45eb-8acb-fdca1f733418&quot;,&quot;parent&quot;:{&quot;type&quot;:&quot;CHILD&quot;,&quot;parentId&quot;:&quot;efc64c62-8b6e-4678-97b7-e219fc9c229c&quot;,&quot;order&quot;:&quot;5&quot;},&quot;relativeTransform&quot;:{&quot;translate&quot;:{&quot;x&quot;:24.983,&quot;y&quot;:29.22},&quot;rotate&quot;:0,&quot;skewX&quot;:0,&quot;scale&quot;:{&quot;x&quot;:1,&quot;y&quot;:1}},&quot;path&quot;:{&quot;type&quot;:&quot;RECT&quot;,&quot;size&quot;:{&quot;x&quot;:13,&quot;y&quot;:58.44}},&quot;pathStyles&quot;:[{&quot;type&quot;:&quot;FILL&quot;,&quot;fillStyle&quot;:&quot;#005485&quot;}],&quot;opacity&quot;:1},&quot;9a1ff0ee-2877-48a6-8e16-f148f1ddf80d&quot;:{&quot;relativeTransform&quot;:{&quot;translate&quot;:{&quot;x&quot;:-186.23364507479548,&quot;y&quot;:47.668386042103855},&quot;rotate&quot;:3.141592653589793,&quot;skewX&quot;:0,&quot;scale&quot;:{&quot;x&quot;:1,&quot;y&quot;:1}},&quot;type&quot;:&quot;FIGURE_OBJECT&quot;,&quot;id&quot;:&quot;9a1ff0ee-2877-48a6-8e16-f148f1ddf80d&quot;,&quot;name&quot;:&quot;ssDNA brush 2 (arc, medium)&quot;,&quot;opacity&quot;:1,&quot;source&quot;:{&quot;id&quot;:&quot;6126a0160f59c500a0eb80cc&quot;,&quot;type&quot;:&quot;ASSETS&quot;},&quot;path&quot;:{&quot;type&quot;:&quot;POLY_LINE&quot;,&quot;points&quot;:[{&quot;x&quot;:-8.826705441223567,&quot;y&quot;:-95.93207332758917},{&quot;x&quot;:-8.826705441223595,&quot;y&quot;:-43.34882127829104},{&quot;x&quot;:-22.90110827776715,&quot;y&quot;:-18.753347565356535},{&quot;x&quot;:-22.90110827776716,&quot;y&quot;:0},{&quot;x&quot;:-3.3164505940902824,&quot;y&quot;:2.4940618041343985},{&quot;x&quot;:16.026783033684598,&quot;y&quot;:0},{&quot;x&quot;:16.02678303368461,&quot;y&quot;:-28.793603318637054},{&quot;x&quot;:1.1894054821440534,&quot;y&quot;:-45.871370409542806},{&quot;x&quot;:1.1894054821440534,&quot;y&quot;:-95.93207332758917}],&quot;closed&quot;:false,&quot;cornerRounding&quot;:{&quot;type&quot;:&quot;ARC_LENGTH&quot;,&quot;global&quot;:119.55382107276459},&quot;selectedObjectIds&quot;:[&quot;e2f6d1a7-72d9-442a-a641-c32373247a37&quot;]},&quot;pathStyles&quot;:[{&quot;type&quot;:&quot;FILL&quot;,&quot;fillStyle&quot;:&quot;rgba(0,0,0,0)&quot;},{&quot;type&quot;:&quot;STROKE&quot;,&quot;strokeStyle&quot;:&quot;rgba(0,0,0,0)&quot;,&quot;lineWidth&quot;:20.349089815444334,&quot;lineJoin&quot;:&quot;round&quot;}],&quot;pathPattern&quot;:{&quot;type&quot;:&quot;ROW&quot;,&quot;patternId&quot;:&quot;353ddc48-152e-4b17-9b17-7809c713def1&quot;,&quot;patternTransform&quot;:{&quot;translate&quot;:{&quot;x&quot;:-0.003164556962025317,&quot;y&quot;:-0.5},&quot;rotate&quot;:0,&quot;skewX&quot;:0,&quot;scale&quot;:{&quot;x&quot;:0.012658227848101266,&quot;y&quot;:0.012658227848101266}},&quot;xUnits&quot;:&quot;STROKE_WIDTH&quot;,&quot;yUnits&quot;:&quot;STROKE_WIDTH&quot;,&quot;bending&quot;:true,&quot;repeat&quot;:{&quot;distance&quot;:0.6265822784810127,&quot;align&quot;:&quot;CENTER&quot;},&quot;isPremium&quot;:true},&quot;isLocked&quot;:false,&quot;parent&quot;:{&quot;type&quot;:&quot;CHILD&quot;,&quot;parentId&quot;:&quot;ab9812b4-0e36-4ff6-8238-af0f78b54aeb&quot;,&quot;order&quot;:&quot;2&quot;},&quot;isPremium&quot;:true,&quot;displayName&quot;:&quot;Unwound ssDNA brush (arc, medium)&quot;,&quot;connectorInfo&quot;:{&quot;connectedObjects&quot;:[],&quot;type&quot;:&quot;ELBOW&quot;,&quot;offset&quot;:{&quot;x&quot;:0,&quot;y&quot;:0},&quot;bending&quot;:0.1,&quot;firstElementIsHead&quot;:true,&quot;customized&quot;:true}},&quot;353ddc48-152e-4b17-9b17-7809c713def1&quot;:{&quot;type&quot;:&quot;FIGURE_OBJECT&quot;,&quot;id&quot;:&quot;353ddc48-152e-4b17-9b17-7809c713def1&quot;,&quot;relativeTransform&quot;:{&quot;translate&quot;:{&quot;x&quot;:0,&quot;y&quot;:0},&quot;rotate&quot;:0,&quot;skewX&quot;:0,&quot;scale&quot;:{&quot;x&quot;:1,&quot;y&quot;:1}},&quot;source&quot;:{&quot;type&quot;:&quot;ASSETS&quot;,&quot;id&quot;:&quot;5ee1532b88e8df0028d0e2f0&quot;},&quot;name&quot;:&quot;ssDNA (unwound, single, for brush)&quot;},&quot;9f596d27-2bf2-43d3-bc14-1a54124d6414&quot;:{&quot;type&quot;:&quot;FIGURE_OBJECT&quot;,&quot;id&quot;:&quot;9f596d27-2bf2-43d3-bc14-1a54124d6414&quot;,&quot;parent&quot;:{&quot;type&quot;:&quot;CHILD&quot;,&quot;parentId&quot;:&quot;353ddc48-152e-4b17-9b17-7809c713def1&quot;,&quot;order&quot;:&quot;5&quot;},&quot;relativeTransform&quot;:{&quot;translate&quot;:{&quot;x&quot;:0,&quot;y&quot;:0},&quot;rotate&quot;:0,&quot;skewX&quot;:0,&quot;scale&quot;:{&quot;x&quot;:1,&quot;y&quot;:1}}},&quot;f4333eb8-4c80-4d6a-bc50-a8152267b3c0&quot;:{&quot;type&quot;:&quot;FIGURE_OBJECT&quot;,&quot;id&quot;:&quot;f4333eb8-4c80-4d6a-bc50-a8152267b3c0&quot;,&quot;parent&quot;:{&quot;type&quot;:&quot;CHILD&quot;,&quot;parentId&quot;:&quot;9f596d27-2bf2-43d3-bc14-1a54124d6414&quot;,&quot;order&quot;:&quot;5&quot;},&quot;relativeTransform&quot;:{&quot;translate&quot;:{&quot;x&quot;:24.983,&quot;y&quot;:68.39},&quot;rotate&quot;:0,&quot;skewX&quot;:0,&quot;scale&quot;:{&quot;x&quot;:1,&quot;y&quot;:1}},&quot;path&quot;:{&quot;type&quot;:&quot;RECT&quot;,&quot;size&quot;:{&quot;x&quot;:50,&quot;y&quot;:22}},&quot;pathStyles&quot;:[{&quot;type&quot;:&quot;FILL&quot;,&quot;fillStyle&quot;:&quot;#005485&quot;}],&quot;opacity&quot;:1},&quot;4c6c41bd-e864-4af0-ad71-d2c9ff6d02b6&quot;:{&quot;type&quot;:&quot;FIGURE_OBJECT&quot;,&quot;id&quot;:&quot;4c6c41bd-e864-4af0-ad71-d2c9ff6d02b6&quot;,&quot;parent&quot;:{&quot;type&quot;:&quot;CHILD&quot;,&quot;parentId&quot;:&quot;353ddc48-152e-4b17-9b17-7809c713def1&quot;,&quot;order&quot;:&quot;7&quot;},&quot;relativeTransform&quot;:{&quot;translate&quot;:{&quot;x&quot;:0,&quot;y&quot;:0},&quot;rotate&quot;:0,&quot;skewX&quot;:0,&quot;scale&quot;:{&quot;x&quot;:1,&quot;y&quot;:1}}},&quot;fa1ca970-f347-4377-bb99-2a03682589ec&quot;:{&quot;type&quot;:&quot;FIGURE_OBJECT&quot;,&quot;id&quot;:&quot;fa1ca970-f347-4377-bb99-2a03682589ec&quot;,&quot;parent&quot;:{&quot;type&quot;:&quot;CHILD&quot;,&quot;parentId&quot;:&quot;4c6c41bd-e864-4af0-ad71-d2c9ff6d02b6&quot;,&quot;order&quot;:&quot;5&quot;},&quot;relativeTransform&quot;:{&quot;translate&quot;:{&quot;x&quot;:24.983,&quot;y&quot;:29.22},&quot;rotate&quot;:0,&quot;skewX&quot;:0,&quot;scale&quot;:{&quot;x&quot;:1,&quot;y&quot;:1}},&quot;path&quot;:{&quot;type&quot;:&quot;RECT&quot;,&quot;size&quot;:{&quot;x&quot;:13,&quot;y&quot;:58.44}},&quot;pathStyles&quot;:[{&quot;type&quot;:&quot;FILL&quot;,&quot;fillStyle&quot;:&quot;#005485&quot;}],&quot;opacity&quot;:1},&quot;0a5fcdb9-49ce-4fbd-9203-bf213888530d&quot;:{&quot;relativeTransform&quot;:{&quot;translate&quot;:{&quot;x&quot;:730.2455115423643,&quot;y&quot;:-67.90847815054047},&quot;rotate&quot;:0,&quot;skewX&quot;:0,&quot;scale&quot;:{&quot;x&quot;:1,&quot;y&quot;:1}},&quot;type&quot;:&quot;FIGURE_OBJECT&quot;,&quot;id&quot;:&quot;0a5fcdb9-49ce-4fbd-9203-bf213888530d&quot;,&quot;parent&quot;:{&quot;type&quot;:&quot;CHILD&quot;,&quot;parentId&quot;:&quot;7b7e4984-9463-4fc4-81fa-65b50cc23e77&quot;,&quot;order&quot;:&quot;5&quot;},&quot;name&quot;:&quot;DNA probe (molecular beacon)&quot;,&quot;displayName&quot;:&quot;DNA probe (molecular beacon)&quot;,&quot;source&quot;:{&quot;id&quot;:&quot;6490d9632d2897db32e02945&quot;,&quot;type&quot;:&quot;ASSETS&quot;},&quot;isPremium&quot;:true},&quot;b12ff8ff-a11e-465c-9607-91847601eda1&quot;:{&quot;id&quot;:&quot;b12ff8ff-a11e-465c-9607-91847601eda1&quot;,&quot;name&quot;:&quot;Fluorophore (glowing)&quot;,&quot;displayName&quot;:&quot;&quot;,&quot;type&quot;:&quot;FIGURE_OBJECT&quot;,&quot;relativeTransform&quot;:{&quot;translate&quot;:{&quot;x&quot;:-196.935,&quot;y&quot;:150.5},&quot;rotate&quot;:0,&quot;skewX&quot;:0,&quot;scale&quot;:{&quot;x&quot;:0.6199999999999997,&quot;y&quot;:0.6199999999999997}},&quot;image&quot;:{&quot;url&quot;:&quot;https://icons.biorender.com/biorender/63bc3b90e7456200216bd10d/20230109180631/image/fluorophore-glowing.png&quot;,&quot;fallbackUrl&quot;:&quot;https://res.cloudinary.com/dlcjuc3ej/image/upload/v1673287591/dhonwdgyc6wn0h3e6mgf.svg#/keystone/api/icons/63bc3b90e7456200216bd10d/20230109180631/image/fluorophore-glowing.svg&quot;,&quot;isPremium&quot;:false,&quot;size&quot;:{&quot;x&quot;:50,&quot;y&quot;:50}},&quot;source&quot;:{&quot;id&quot;:&quot;63bc3b90e7456200216bd10d&quot;,&quot;type&quot;:&quot;ASSETS&quot;},&quot;isPremium&quot;:false,&quot;parent&quot;:{&quot;type&quot;:&quot;CHILD&quot;,&quot;parentId&quot;:&quot;ab9812b4-0e36-4ff6-8238-af0f78b54aeb&quot;,&quot;order&quot;:&quot;5&quot;}},&quot;75534751-8511-4193-906c-41a87a1bc152&quot;:{&quot;id&quot;:&quot;75534751-8511-4193-906c-41a87a1bc152&quot;,&quot;name&quot;:&quot;Sphere&quot;,&quot;displayName&quot;:&quot;&quot;,&quot;type&quot;:&quot;FIGURE_OBJECT&quot;,&quot;relativeTransform&quot;:{&quot;translate&quot;:{&quot;x&quot;:-171.2965,&quot;y&quot;:150.2825},&quot;rotate&quot;:0,&quot;skewX&quot;:0,&quot;scale&quot;:{&quot;x&quot;:0.40553999999999973,&quot;y&quot;:0.40553999999999973}},&quot;image&quot;:{&quot;url&quot;:&quot;https://icons.biorender.com/biorender/5f4529c2929bce0028c9f87f/sphere.png&quot;,&quot;fallbackUrl&quot;:&quot;https://res.cloudinary.com/dlcjuc3ej/image/upload/v1598368171/soihczeyq35kxprwz6kd.svg#/keystone/api/icons/5f4529c2929bce0028c9f87f/sphere.svg#/keystone/api/icons/5f4529c2929bce0028c9f87f/sphere.svg#/keystone/api/icons/5f4529c2929bce0028c9f87f/sphere.svg&quot;,&quot;isPremium&quot;:false,&quot;size&quot;:{&quot;x&quot;:50,&quot;y&quot;:50}},&quot;source&quot;:{&quot;id&quot;:&quot;5b8847989629ce1400901caa&quot;,&quot;type&quot;:&quot;ASSETS&quot;},&quot;isPremium&quot;:false,&quot;parent&quot;:{&quot;type&quot;:&quot;CHILD&quot;,&quot;parentId&quot;:&quot;ab9812b4-0e36-4ff6-8238-af0f78b54aeb&quot;,&quot;order&quot;:&quot;7&quot;}},&quot;ab9812b4-0e36-4ff6-8238-af0f78b54aeb&quot;:{&quot;type&quot;:&quot;FIGURE_OBJECT&quot;,&quot;id&quot;:&quot;ab9812b4-0e36-4ff6-8238-af0f78b54aeb&quot;,&quot;parent&quot;:{&quot;type&quot;:&quot;CHILD&quot;,&quot;parentId&quot;:&quot;7b7e4984-9463-4fc4-81fa-65b50cc23e77&quot;,&quot;order&quot;:&quot;99997&quot;},&quot;relativeTransform&quot;:{}},&quot;cdfd3903-7181-453b-aa28-3c25273f4fda&quot;:{&quot;relativeTransform&quot;:{&quot;translate&quot;:{&quot;x&quot;:459.0493815197228,&quot;y&quot;:232.89787715377787},&quot;rotate&quot;:0,&quot;skewX&quot;:0,&quot;scale&quot;:{&quot;x&quot;:1,&quot;y&quot;:1}},&quot;type&quot;:&quot;FIGURE_OBJECT&quot;,&quot;id&quot;:&quot;cdfd3903-7181-453b-aa28-3c25273f4fda&quot;,&quot;parent&quot;:{&quot;type&quot;:&quot;CHILD&quot;,&quot;parentId&quot;:&quot;7b7e4984-9463-4fc4-81fa-65b50cc23e77&quot;,&quot;order&quot;:&quot;99998&quot;},&quot;name&quot;:&quot;DNA probe (TaqMan)&quot;,&quot;displayName&quot;:&quot;DNA probe (TaqMan)&quot;,&quot;source&quot;:{&quot;id&quot;:&quot;6490da1f907d00975590daea&quot;,&quot;type&quot;:&quot;ASSETS&quot;},&quot;isPremium&quot;:true},&quot;5aa5a72f-180d-46a6-aa01-58c0a73d9f6c&quot;:{&quot;relativeTransform&quot;:{&quot;translate&quot;:{&quot;x&quot;:252.0920931484995,&quot;y&quot;:56.480171411290655},&quot;rotate&quot;:0,&quot;skewX&quot;:0,&quot;scale&quot;:{&quot;x&quot;:1,&quot;y&quot;:1}},&quot;type&quot;:&quot;FIGURE_OBJECT&quot;,&quot;id&quot;:&quot;5aa5a72f-180d-46a6-aa01-58c0a73d9f6c&quot;,&quot;parent&quot;:{&quot;type&quot;:&quot;CHILD&quot;,&quot;parentId&quot;:&quot;cdfd3903-7181-453b-aa28-3c25273f4fda&quot;,&quot;order&quot;:&quot;2&quot;},&quot;name&quot;:&quot;DNA probe (FISH, single-stranded)&quot;,&quot;displayName&quot;:&quot;DNA probe (FISH, single-stranded)&quot;,&quot;source&quot;:{&quot;id&quot;:&quot;647e4ac19611224dab43fb82&quot;,&quot;type&quot;:&quot;ASSETS&quot;},&quot;isPremium&quot;:true},&quot;061422a5-e605-4d1c-9609-0fdabddce0ca&quot;:{&quot;type&quot;:&quot;FIGURE_OBJECT&quot;,&quot;id&quot;:&quot;061422a5-e605-4d1c-9609-0fdabddce0ca&quot;,&quot;name&quot;:&quot;ssDNA (medium)&quot;,&quot;relativeTransform&quot;:{&quot;translate&quot;:{&quot;x&quot;:-611.7582966579345,&quot;y&quot;:-124.6129079922843},&quot;rotate&quot;:3.141592653589793,&quot;skewX&quot;:4.056472853012411e-32,&quot;scale&quot;:{&quot;x&quot;:0.7795625017915643,&quot;y&quot;:0.7795625017915642}},&quot;opacity&quot;:1,&quot;image&quot;:{&quot;url&quot;:&quot;https://icons.biorender.com/biorender/5b6b4cc3c820301400b3389c/ssdna-medium.png&quot;,&quot;size&quot;:{&quot;x&quot;:224,&quot;y&quot;:30},&quot;isPremium&quot;:false,&quot;fallbackUrl&quot;:&quot;https://res.cloudinary.com/dlcjuc3ej/image/upload/v1533758616/il6ifryiqkiprwyb2bvz.svg#/keystone/api/icons/5b6b4cc3c820301400b3389c/ssdna-medium.svg&quot;},&quot;source&quot;:{&quot;id&quot;:&quot;5b6b4c71c820301400b33886&quot;,&quot;type&quot;:&quot;ASSETS&quot;},&quot;pathStyles&quot;:[{&quot;type&quot;:&quot;FILL&quot;,&quot;fillStyle&quot;:&quot;rgb(0,0,0)&quot;}],&quot;isLocked&quot;:false,&quot;parent&quot;:{&quot;type&quot;:&quot;CHILD&quot;,&quot;parentId&quot;:&quot;5aa5a72f-180d-46a6-aa01-58c0a73d9f6c&quot;,&quot;order&quot;:&quot;2&quot;}},&quot;27e31889-1c57-4d5a-97d0-2462197b86be&quot;:{&quot;type&quot;:&quot;FIGURE_OBJECT&quot;,&quot;id&quot;:&quot;27e31889-1c57-4d5a-97d0-2462197b86be&quot;,&quot;relativeTransform&quot;:{&quot;translate&quot;:{&quot;x&quot;:-33.38,&quot;y&quot;:0},&quot;rotate&quot;:0,&quot;skewX&quot;:0,&quot;scale&quot;:{&quot;x&quot;:0.7,&quot;y&quot;:1}},&quot;opacity&quot;:1,&quot;path&quot;:{&quot;type&quot;:&quot;RECT&quot;,&quot;size&quot;:{&quot;x&quot;:224,&quot;y&quot;:30}},&quot;pathStyles&quot;:[{&quot;type&quot;:&quot;FILL&quot;,&quot;fillStyle&quot;:&quot;#fff&quot;}],&quot;isFrozen&quot;:true,&quot;isLocked&quot;:false,&quot;parent&quot;:{&quot;type&quot;:&quot;CROP&quot;,&quot;parentId&quot;:&quot;061422a5-e605-4d1c-9609-0fdabddce0ca&quot;,&quot;order&quot;:&quot;5&quot;}},&quot;829dee25-e4f7-4971-b846-75fe5595ff80&quot;:{&quot;type&quot;:&quot;FIGURE_OBJECT&quot;,&quot;id&quot;:&quot;829dee25-e4f7-4971-b846-75fe5595ff80&quot;,&quot;relativeTransform&quot;:{&quot;translate&quot;:{&quot;x&quot;:-593.6377854387064,&quot;y&quot;:-130.4869744468057},&quot;rotate&quot;:0},&quot;opacity&quot;:1,&quot;path&quot;:{&quot;type&quot;:&quot;POLY_LINE&quot;,&quot;points&quot;:[{&quot;x&quot;:-67.98144605407286,&quot;y&quot;:0},{&quot;x&quot;:76.73837777348696,&quot;y&quot;:0}],&quot;closed&quot;:false},&quot;pathStyles&quot;:[{&quot;type&quot;:&quot;FILL&quot;,&quot;fillStyle&quot;:&quot;rgba(0,0,0,0)&quot;},{&quot;type&quot;:&quot;STROKE&quot;,&quot;strokeStyle&quot;:&quot;rgba(176, 12, 12, 1)&quot;,&quot;lineWidth&quot;:4.3429006410662465,&quot;lineJoin&quot;:&quot;round&quot;}],&quot;isLocked&quot;:false,&quot;parent&quot;:{&quot;type&quot;:&quot;CHILD&quot;,&quot;parentId&quot;:&quot;5aa5a72f-180d-46a6-aa01-58c0a73d9f6c&quot;,&quot;order&quot;:&quot;5&quot;},&quot;connectorInfo&quot;:{&quot;connectedObjects&quot;:[],&quot;type&quot;:&quot;LINE&quot;,&quot;offset&quot;:{&quot;x&quot;:0,&quot;y&quot;:0},&quot;bending&quot;:0.1,&quot;firstElementIsHead&quot;:true,&quot;customized&quot;:false}},&quot;f9701da3-996a-4a84-90a6-a552fc552dea&quot;:{&quot;type&quot;:&quot;FIGURE_OBJECT&quot;,&quot;id&quot;:&quot;f9701da3-996a-4a84-90a6-a552fc552dea&quot;,&quot;relativeTransform&quot;:{&quot;translate&quot;:{&quot;x&quot;:-662.288446294809,&quot;y&quot;:-130.48678111165134},&quot;rotate&quot;:0,&quot;skewX&quot;:0,&quot;scale&quot;:{&quot;x&quot;:1,&quot;y&quot;:1}},&quot;opacity&quot;:1,&quot;path&quot;:{&quot;type&quot;:&quot;ELLIPSE&quot;,&quot;size&quot;:{&quot;x&quot;:-18.567468106485464,&quot;y&quot;:-18.567468106485446}},&quot;isLocked&quot;:false,&quot;pathStyles&quot;:[{&quot;type&quot;:&quot;FILL&quot;,&quot;fillStyle&quot;:&quot;rgb(90, 195, 63)&quot;},{&quot;type&quot;:&quot;STROKE&quot;,&quot;strokeStyle&quot;:&quot;rgba(0,0,0,0)&quot;,&quot;lineWidth&quot;:2.468896450387547,&quot;lineJoin&quot;:&quot;round&quot;}],&quot;parent&quot;:{&quot;type&quot;:&quot;CHILD&quot;,&quot;parentId&quot;:&quot;5aa5a72f-180d-46a6-aa01-58c0a73d9f6c&quot;,&quot;order&quot;:&quot;7&quot;}},&quot;427934c5-c1e2-4c8d-89b6-25d600b14dde&quot;:{&quot;type&quot;:&quot;FIGURE_OBJECT&quot;,&quot;id&quot;:&quot;427934c5-c1e2-4c8d-89b6-25d600b14dde&quot;,&quot;relativeTransform&quot;:{&quot;translate&quot;:{&quot;x&quot;:-256.406409893136,&quot;y&quot;:-74.07272120019283},&quot;rotate&quot;:0,&quot;skewX&quot;:0,&quot;scale&quot;:{&quot;x&quot;:1,&quot;y&quot;:1}},&quot;opacity&quot;:1,&quot;path&quot;:{&quot;type&quot;:&quot;ELLIPSE&quot;,&quot;size&quot;:{&quot;x&quot;:-18.567468106485464,&quot;y&quot;:-18.567468106485446}},&quot;isLocked&quot;:false,&quot;pathStyles&quot;:[{&quot;type&quot;:&quot;FILL&quot;,&quot;fillStyle&quot;:&quot;rgb(155, 155, 155)&quot;},{&quot;type&quot;:&quot;STROKE&quot;,&quot;strokeStyle&quot;:&quot;rgba(0,0,0,0)&quot;,&quot;lineWidth&quot;:2.468896450387547,&quot;lineJoin&quot;:&quot;round&quot;}],&quot;parent&quot;:{&quot;type&quot;:&quot;CHILD&quot;,&quot;parentId&quot;:&quot;cdfd3903-7181-453b-aa28-3c25273f4fda&quot;,&quot;order&quot;:&quot;5&quot;}},&quot;929abde5-807d-4413-a48a-80cf9db454f1&quot;:{&quot;id&quot;:&quot;929abde5-807d-4413-a48a-80cf9db454f1&quot;,&quot;name&quot;:&quot;Laser beam (cone 2)&quot;,&quot;type&quot;:&quot;FIGURE_OBJECT&quot;,&quot;relativeTransform&quot;:{&quot;translate&quot;:{&quot;x&quot;:79.00000000000003,&quot;y&quot;:-224},&quot;rotate&quot;:3.141592653589793,&quot;skewX&quot;:0,&quot;scale&quot;:{&quot;x&quot;:1,&quot;y&quot;:1}},&quot;image&quot;:{&quot;url&quot;:&quot;https://icons.biorender.com/biorender/5a9d6f2ba7596b0014af6782/20180305162450/image/laser-beam-cone-2.png&quot;,&quot;fallbackUrl&quot;:&quot;https://res.cloudinary.com/dlcjuc3ej/image/upload/v1520267090/lowxaal7792ega1o6fff.svg#/keystone/api/icons/5a9d6f2ba7596b0014af6782/20180305162450/image/laser-beam-cone-2.svg&quot;,&quot;isPremium&quot;:false,&quot;size&quot;:{&quot;x&quot;:100,&quot;y&quot;:22.63109475620975}},&quot;source&quot;:{&quot;id&quot;:&quot;5a9d6f2ba7596b0014af6782&quot;,&quot;type&quot;:&quot;ASSETS&quot;},&quot;isPremium&quot;:false,&quot;parent&quot;:{&quot;type&quot;:&quot;CHILD&quot;,&quot;parentId&quot;:&quot;7b7e4984-9463-4fc4-81fa-65b50cc23e77&quot;,&quot;order&quot;:&quot;99999&quot;}}}}"/>
    <we:property name="6540112e1883d13807d0b43b_1724784879031" value="{&quot;id&quot;:&quot;546dd0bf-f4d9-4b9f-a09f-b59e0e4f7d41&quot;,&quot;objects&quot;:{&quot;546dd0bf-f4d9-4b9f-a09f-b59e0e4f7d41&quot;:{&quot;id&quot;:&quot;546dd0bf-f4d9-4b9f-a09f-b59e0e4f7d41&quot;,&quot;type&quot;:&quot;FIGURE_OBJECT&quot;,&quot;document&quot;:{&quot;type&quot;:&quot;DOCUMENT_GROUP&quot;,&quot;canvasType&quot;:&quot;FIGURE&quot;,&quot;units&quot;:&quot;in&quot;}},&quot;d6399890-d525-420c-9ea8-730f6ade3c8d&quot;:{&quot;id&quot;:&quot;d6399890-d525-420c-9ea8-730f6ade3c8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546dd0bf-f4d9-4b9f-a09f-b59e0e4f7d41&quot;,&quot;type&quot;:&quot;FRAME&quot;,&quot;order&quot;:&quot;5&quot;}},&quot;ac4bfdb8-c638-4ab9-9da2-3040bcbea76a&quot;:{&quot;id&quot;:&quot;ac4bfdb8-c638-4ab9-9da2-3040bcbea76a&quot;,&quot;type&quot;:&quot;FIGURE_OBJECT&quot;,&quot;document&quot;:{&quot;type&quot;:&quot;FIGURE&quot;,&quot;canvasType&quot;:&quot;FIGURE&quot;,&quot;units&quot;:&quot;in&quot;},&quot;parent&quot;:{&quot;parentId&quot;:&quot;546dd0bf-f4d9-4b9f-a09f-b59e0e4f7d41&quot;,&quot;type&quot;:&quot;DOCUMENT&quot;,&quot;order&quot;:&quot;5&quot;}},&quot;df2a4c60-6949-4604-a856-cc530250e89b&quot;:{&quot;id&quot;:&quot;df2a4c60-6949-4604-a856-cc530250e89b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ac4bfdb8-c638-4ab9-9da2-3040bcbea76a&quot;,&quot;order&quot;:&quot;5&quot;}},&quot;12dbbb95-15c5-4342-b0ca-52cf2ae14f69&quot;:{&quot;id&quot;:&quot;12dbbb95-15c5-4342-b0ca-52cf2ae14f69&quot;,&quot;type&quot;:&quot;FIGURE_OBJECT&quot;,&quot;guide&quot;:{&quot;type&quot;:&quot;GRID&quot;,&quot;distance&quot;:0.5,&quot;units&quot;:&quot;in&quot;},&quot;parent&quot;:{&quot;parentId&quot;:&quot;546dd0bf-f4d9-4b9f-a09f-b59e0e4f7d41&quot;,&quot;type&quot;:&quot;GUIDE&quot;,&quot;order&quot;:&quot;5&quot;}},&quot;d7027c0a-5ec8-4945-9b0f-4a795f1210e1&quot;:{&quot;type&quot;:&quot;FIGURE_OBJECT&quot;,&quot;id&quot;:&quot;d7027c0a-5ec8-4945-9b0f-4a795f1210e1&quot;,&quot;relativeTransform&quot;:{&quot;translate&quot;:{&quot;x&quot;:-179.8673978881886,&quot;y&quot;:-121.56175820577883},&quot;rotate&quot;:0,&quot;skewX&quot;:0,&quot;scale&quot;:{&quot;x&quot;:1,&quot;y&quot;:1}},&quot;opacity&quot;:1,&quot;path&quot;:{&quot;type&quot;:&quot;POLY_LINE&quot;,&quot;points&quot;:[{&quot;x&quot;:-55.55537365965458,&quot;y&quot;:-56.10542686420561},{&quot;x&quot;:55.55537365965458,&quot;y&quot;:56.10542686420561}],&quot;closed&quot;:false},&quot;pathStyles&quot;:[{&quot;type&quot;:&quot;FILL&quot;,&quot;fillStyle&quot;:&quot;rgba(0,0,0,0)&quot;},{&quot;type&quot;:&quot;STROKE&quot;,&quot;strokeStyle&quot;:{&quot;units&quot;:&quot;PATH_LENGTH&quot;,&quot;stops&quot;:{&quot;0&quot;:&quot;#23232300&quot;,&quot;1&quot;:&quot;#232323&quot;,&quot;0.45&quot;:&quot;#232323&quot;}}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ac4bfdb8-c638-4ab9-9da2-3040bcbea76a&quot;,&quot;order&quot;:&quot;97&quot;},&quot;connectorInfo&quot;:{&quot;connectedObjects&quot;:[],&quot;type&quot;:&quot;LINE&quot;,&quot;offset&quot;:{&quot;x&quot;:0,&quot;y&quot;:0},&quot;bending&quot;:0.1,&quot;firstElementIsHead&quot;:true,&quot;customized&quot;:false}},&quot;81099d66-8189-4776-b4c4-64b4efc01aeb&quot;:{&quot;type&quot;:&quot;FIGURE_OBJECT&quot;,&quot;id&quot;:&quot;81099d66-8189-4776-b4c4-64b4efc01aeb&quot;,&quot;relativeTransform&quot;:{&quot;translate&quot;:{&quot;x&quot;:-173.8168126381272,&quot;y&quot;:-24.752394204796587},&quot;rotate&quot;:0,&quot;skewX&quot;:0,&quot;scale&quot;:{&quot;x&quot;:1,&quot;y&quot;:1}},&quot;opacity&quot;:1,&quot;path&quot;:{&quot;type&quot;:&quot;POLY_LINE&quot;,&quot;points&quot;:[{&quot;x&quot;:-44.004256364082835,&quot;y&quot;:0},{&quot;x&quot;:44.004256364082835,&quot;y&quot;:0}],&quot;closed&quot;:false},&quot;pathStyles&quot;:[{&quot;type&quot;:&quot;FILL&quot;,&quot;fillStyle&quot;:&quot;rgba(0,0,0,0)&quot;},{&quot;type&quot;:&quot;STROKE&quot;,&quot;strokeStyle&quot;:{&quot;units&quot;:&quot;PATH_LENGTH&quot;,&quot;stops&quot;:{&quot;0&quot;:&quot;#23232300&quot;,&quot;1&quot;:&quot;#232323&quot;,&quot;0.45&quot;:&quot;#232323&quot;}}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ac4bfdb8-c638-4ab9-9da2-3040bcbea76a&quot;,&quot;order&quot;:&quot;98&quot;},&quot;connectorInfo&quot;:{&quot;connectedObjects&quot;:[],&quot;type&quot;:&quot;LINE&quot;,&quot;offset&quot;:{&quot;x&quot;:0,&quot;y&quot;:0},&quot;bending&quot;:0.1,&quot;firstElementIsHead&quot;:true,&quot;customized&quot;:false}},&quot;046c4eff-c967-4d85-84bc-21604284f2b1&quot;:{&quot;type&quot;:&quot;FIGURE_OBJECT&quot;,&quot;id&quot;:&quot;046c4eff-c967-4d85-84bc-21604284f2b1&quot;,&quot;relativeTransform&quot;:{&quot;translate&quot;:{&quot;x&quot;:-167.76622738806583,&quot;y&quot;:75.90734222804292},&quot;rotate&quot;:0,&quot;skewX&quot;:0,&quot;scale&quot;:{&quot;x&quot;:1,&quot;y&quot;:1}},&quot;opacity&quot;:1,&quot;path&quot;:{&quot;type&quot;:&quot;POLY_LINE&quot;,&quot;points&quot;:[{&quot;x&quot;:-46.754522386838005,&quot;y&quot;:70.95686338708356},{&quot;x&quot;:46.754522386838005,&quot;y&quot;:-70.95686338708356}],&quot;closed&quot;:false},&quot;pathStyles&quot;:[{&quot;type&quot;:&quot;FILL&quot;,&quot;fillStyle&quot;:&quot;rgba(0,0,0,0)&quot;},{&quot;type&quot;:&quot;STROKE&quot;,&quot;strokeStyle&quot;:{&quot;units&quot;:&quot;PATH_LENGTH&quot;,&quot;stops&quot;:{&quot;0&quot;:&quot;#23232300&quot;,&quot;1&quot;:&quot;#232323&quot;,&quot;0.45&quot;:&quot;#232323&quot;}}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ac4bfdb8-c638-4ab9-9da2-3040bcbea76a&quot;,&quot;order&quot;:&quot;99&quot;},&quot;connectorInfo&quot;:{&quot;connectedObjects&quot;:[],&quot;type&quot;:&quot;LINE&quot;,&quot;offset&quot;:{&quot;x&quot;:0,&quot;y&quot;:0},&quot;bending&quot;:0.1,&quot;firstElementIsHead&quot;:true,&quot;customized&quot;:false}},&quot;8ab5de31-6fc4-41d9-964c-3026763c78aa&quot;:{&quot;id&quot;:&quot;8ab5de31-6fc4-41d9-964c-3026763c78aa&quot;,&quot;name&quot;:&quot;Eppendorf tube (2-3, open)&quot;,&quot;displayName&quot;:&quot;Eppendorf tube (2/3 liquid, open)&quot;,&quot;type&quot;:&quot;FIGURE_OBJECT&quot;,&quot;relativeTransform&quot;:{&quot;translate&quot;:{&quot;x&quot;:-73.12919350085947,&quot;y&quot;:-32.21093713677663},&quot;rotate&quot;:0,&quot;skewX&quot;:0,&quot;scale&quot;:{&quot;x&quot;:1,&quot;y&quot;:1}},&quot;image&quot;:{&quot;url&quot;:&quot;https://icons.biorender.com/biorender/5e41d859e250000028d2f6a4/20200210222612/image/eppendorf-tube-2-3-open.png&quot;,&quot;fallbackUrl&quot;:&quot;https://res.cloudinary.com/dlcjuc3ej/image/upload/v1581373572/tlmmnlxyp6muwbuigef0.svg#/keystone/api/icons/5e41d859e250000028d2f6a4/20200210222612/image/eppendorf-tube-2-3-open.svg&quot;,&quot;isPremium&quot;:false,&quot;size&quot;:{&quot;x&quot;:80,&quot;y&quot;:142.90322580645162}},&quot;source&quot;:{&quot;id&quot;:&quot;5e41d859e250000028d2f6a4&quot;,&quot;type&quot;:&quot;ASSETS&quot;},&quot;isPremium&quot;:false,&quot;parent&quot;:{&quot;type&quot;:&quot;CHILD&quot;,&quot;parentId&quot;:&quot;ac4bfdb8-c638-4ab9-9da2-3040bcbea76a&quot;,&quot;order&quot;:&quot;995&quot;}},&quot;6632e7c3-5537-4ee3-b74b-f983e80a1376&quot;:{&quot;id&quot;:&quot;6632e7c3-5537-4ee3-b74b-f983e80a1376&quot;,&quot;name&quot;:&quot;Cas12&quot;,&quot;displayName&quot;:&quot;&quot;,&quot;type&quot;:&quot;FIGURE_OBJECT&quot;,&quot;relativeTransform&quot;:{&quot;translate&quot;:{&quot;x&quot;:17.7007452814139,&quot;y&quot;:-168.39185864445915},&quot;rotate&quot;:0,&quot;skewX&quot;:0,&quot;scale&quot;:{&quot;x&quot;:0.8239829828976554,&quot;y&quot;:0.8239829828976555}},&quot;image&quot;:{&quot;url&quot;:&quot;https://icons.biorender.com/biorender/5c9ea205297d0833006c34da/20190329225535/image/cas12.png&quot;,&quot;fallbackUrl&quot;:&quot;https://res.cloudinary.com/dlcjuc3ej/image/upload/v1553900135/u6p3arlxmdxeapmvvnso.svg#/keystone/api/icons/5c9ea205297d0833006c34da/20190329225535/image/cas12.svg&quot;,&quot;isPremium&quot;:false,&quot;size&quot;:{&quot;x&quot;:100,&quot;y&quot;:73.01587301587303}},&quot;source&quot;:{&quot;id&quot;:&quot;5c9ea205297d0833006c34da&quot;,&quot;type&quot;:&quot;ASSETS&quot;},&quot;isPremium&quot;:false,&quot;parent&quot;:{&quot;type&quot;:&quot;CHILD&quot;,&quot;parentId&quot;:&quot;ac4bfdb8-c638-4ab9-9da2-3040bcbea76a&quot;,&quot;order&quot;:&quot;997&quot;}},&quot;84022431-eadc-4e90-8d25-7a119ce7d152&quot;:{&quot;id&quot;:&quot;84022431-eadc-4e90-8d25-7a119ce7d152&quot;,&quot;name&quot;:&quot;Single guided RNA (sgRNA)&quot;,&quot;displayName&quot;:&quot;&quot;,&quot;type&quot;:&quot;FIGURE_OBJECT&quot;,&quot;relativeTransform&quot;:{&quot;translate&quot;:{&quot;x&quot;:23.806279989757265,&quot;y&quot;:-181.41892772028908},&quot;rotate&quot;:0,&quot;skewX&quot;:0,&quot;scale&quot;:{&quot;x&quot;:0.350937249435102,&quot;y&quot;:0.350937249435102}},&quot;image&quot;:{&quot;url&quot;:&quot;https://icons.biorender.com/biorender/5cbf83e837bbd33300fae9f2/20190423213152/image/single-guided-rna-sgrna.png&quot;,&quot;fallbackUrl&quot;:&quot;https://res.cloudinary.com/dlcjuc3ej/image/upload/v1556055112/n8aesfvieovx7ue0ddxs.svg#/keystone/api/icons/5cbf83e837bbd33300fae9f2/20190423213152/image/single-guided-rna-sgrna.svg&quot;,&quot;isPremium&quot;:false,&quot;size&quot;:{&quot;x&quot;:200,&quot;y&quot;:109.97150997150997}},&quot;source&quot;:{&quot;id&quot;:&quot;5cbf83e837bbd33300fae9f2&quot;,&quot;type&quot;:&quot;ASSETS&quot;},&quot;isPremium&quot;:false,&quot;parent&quot;:{&quot;type&quot;:&quot;CHILD&quot;,&quot;parentId&quot;:&quot;ac4bfdb8-c638-4ab9-9da2-3040bcbea76a&quot;,&quot;order&quot;:&quot;998&quot;}},&quot;58be51f5-114a-49ad-87aa-9af60532a663&quot;:{&quot;type&quot;:&quot;FIGURE_OBJECT&quot;,&quot;id&quot;:&quot;58be51f5-114a-49ad-87aa-9af60532a663&quot;,&quot;relativeTransform&quot;:{&quot;translate&quot;:{&quot;x&quot;:0,&quot;y&quot;:0},&quot;rotate&quot;:0,&quot;skewX&quot;:0,&quot;scale&quot;:{&quot;x&quot;:1,&quot;y&quot;:1}},&quot;opacity&quot;:1,&quot;path&quot;:{&quot;type&quot;:&quot;POLY_LINE&quot;,&quot;points&quot;:[{&quot;x&quot;:-7.700744863714476,&quot;y&quot;:-138.3099402212114},{&quot;x&quot;:-39.60383072767456,&quot;y&quot;:-81.95792747810424}],&quot;closed&quot;:false},&quot;pathStyles&quot;:[{&quot;type&quot;:&quot;FILL&quot;,&quot;fillStyle&quot;:&quot;rgba(0,0,0,0)&quot;},{&quot;type&quot;:&quot;STROKE&quot;,&quot;strokeStyle&quot;:{&quot;units&quot;:&quot;PATH_LENGTH&quot;,&quot;stops&quot;:{&quot;0&quot;:&quot;#23232300&quot;,&quot;1&quot;:&quot;#232323&quot;,&quot;0.45&quot;:&quot;#232323&quot;}}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ac4bfdb8-c638-4ab9-9da2-3040bcbea76a&quot;,&quot;order&quot;:&quot;9998&quot;},&quot;connectorInfo&quot;:{&quot;connectedObjects&quot;:[{&quot;objectId&quot;:&quot;6632e7c3-5537-4ee3-b74b-f983e80a1376&quot;,&quot;coordinates&quot;:{&quot;x&quot;:0.19172312205040493,&quot;y&quot;:1}}],&quot;type&quot;:&quot;LINE&quot;,&quot;offset&quot;:{&quot;x&quot;:0,&quot;y&quot;:0},&quot;bending&quot;:0.1,&quot;firstElementIsHead&quot;:true,&quot;customized&quot;:false}},&quot;ee92f32e-14fe-499b-96dd-c581c6c47479&quot;:{&quot;type&quot;:&quot;FIGURE_OBJECT&quot;,&quot;id&quot;:&quot;ee92f32e-14fe-499b-96dd-c581c6c47479&quot;,&quot;relativeTransform&quot;:{&quot;translate&quot;:{&quot;x&quot;:-63.806171727920116,&quot;y&quot;:-109.46058770565605},&quot;rotate&quot;:0,&quot;skewX&quot;:0,&quot;scale&quot;:{&quot;x&quot;:1,&quot;y&quot;:1}},&quot;opacity&quot;:1,&quot;path&quot;:{&quot;type&quot;:&quot;POLY_LINE&quot;,&quot;points&quot;:[{&quot;x&quot;:-8.800851272816601,&quot;y&quot;:-25.30244740934762},{&quot;x&quot;:8.800851272816601,&quot;y&quot;:25.30244740934762}],&quot;closed&quot;:false},&quot;pathStyles&quot;:[{&quot;type&quot;:&quot;FILL&quot;,&quot;fillStyle&quot;:&quot;rgba(0,0,0,0)&quot;},{&quot;type&quot;:&quot;STROKE&quot;,&quot;strokeStyle&quot;:{&quot;units&quot;:&quot;PATH_LENGTH&quot;,&quot;stops&quot;:{&quot;0&quot;:&quot;#23232300&quot;,&quot;1&quot;:&quot;#232323&quot;,&quot;0.45&quot;:&quot;#232323&quot;}}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ac4bfdb8-c638-4ab9-9da2-3040bcbea76a&quot;,&quot;order&quot;:&quot;9999&quot;},&quot;connectorInfo&quot;:{&quot;connectedObjects&quot;:[],&quot;type&quot;:&quot;LINE&quot;,&quot;offset&quot;:{&quot;x&quot;:0,&quot;y&quot;:0},&quot;bending&quot;:0.1,&quot;firstElementIsHead&quot;:true,&quot;customized&quot;:false}},&quot;fea97115-2252-4a88-a063-54293ee74934&quot;:{&quot;type&quot;:&quot;FIGURE_OBJECT&quot;,&quot;id&quot;:&quot;fea97115-2252-4a88-a063-54293ee74934&quot;,&quot;relativeTransform&quot;:{&quot;translate&quot;:{&quot;x&quot;:55.555373659654606,&quot;y&quot;:-21.452074977490383},&quot;rotate&quot;:0,&quot;skewX&quot;:0,&quot;scale&quot;:{&quot;x&quot;:1,&quot;y&quot;:1}},&quot;opacity&quot;:1,&quot;path&quot;:{&quot;type&quot;:&quot;POLY_LINE&quot;,&quot;points&quot;:[{&quot;x&quot;:-66.55643775067529,&quot;y&quot;:0},{&quot;x&quot;:66.55643775067529,&quot;y&quot;:0}],&quot;closed&quot;:false},&quot;pathStyles&quot;:[{&quot;type&quot;:&quot;FILL&quot;,&quot;fillStyle&quot;:&quot;rgba(0,0,0,0)&quot;},{&quot;type&quot;:&quot;STROKE&quot;,&quot;strokeStyle&quot;:{&quot;units&quot;:&quot;PATH_LENGTH&quot;,&quot;stops&quot;:{&quot;0&quot;:&quot;#23232300&quot;,&quot;1&quot;:&quot;#232323&quot;,&quot;0.45&quot;:&quot;#232323&quot;}},&quot;lineWidth&quot;:2,&quot;lineJoin&quot;:&quot;round&quot;}],&quot;isLocked&quot;:false,&quot;parent&quot;:{&quot;type&quot;:&quot;CHILD&quot;,&quot;parentId&quot;:&quot;ac4bfdb8-c638-4ab9-9da2-3040bcbea76a&quot;,&quot;order&quot;:&quot;99995&quot;},&quot;connectorInfo&quot;:{&quot;connectedObjects&quot;:[],&quot;type&quot;:&quot;LINE&quot;,&quot;offset&quot;:{&quot;x&quot;:0,&quot;y&quot;:0},&quot;bending&quot;:0.1,&quot;firstElementIsHead&quot;:true,&quot;customized&quot;:false}},&quot;94118305-a3f8-4d24-8193-98f97820b0e5&quot;:{&quot;relativeTransform&quot;:{&quot;translate&quot;:{&quot;x&quot;:313.02926250306956,&quot;y&quot;:-157.95836772218405},&quot;rotate&quot;:0,&quot;skewX&quot;:0,&quot;scale&quot;:{&quot;x&quot;:1,&quot;y&quot;:1}},&quot;type&quot;:&quot;FIGURE_OBJECT&quot;,&quot;id&quot;:&quot;94118305-a3f8-4d24-8193-98f97820b0e5&quot;,&quot;name&quot;:&quot;RT-PCR (5. Results)&quot;,&quot;displayName&quot;:&quot;RT-PCR (5. Results)&quot;,&quot;opacity&quot;:1,&quot;source&quot;:{&quot;id&quot;:&quot;5ed59fd2e51fa400ac1b816e&quot;,&quot;type&quot;:&quot;ASSETS&quot;},&quot;pathStyles&quot;:[{&quot;type&quot;:&quot;FILL&quot;,&quot;fillStyle&quot;:&quot;rgb(0,0,0)&quot;}],&quot;isLocked&quot;:false,&quot;parent&quot;:{&quot;type&quot;:&quot;CHILD&quot;,&quot;parentId&quot;:&quot;ac4bfdb8-c638-4ab9-9da2-3040bcbea76a&quot;,&quot;order&quot;:&quot;99997&quot;},&quot;isPremium&quot;:true},&quot;f75f727a-4d09-48a2-b316-34c6fe04be90&quot;:{&quot;type&quot;:&quot;FIGURE_OBJECT&quot;,&quot;id&quot;:&quot;f75f727a-4d09-48a2-b316-34c6fe04be90&quot;,&quot;relativeTransform&quot;:{&quot;translate&quot;:{&quot;x&quot;:9.447721656577869,&quot;y&quot;:47.28777176488552},&quot;rotate&quot;:0,&quot;skewX&quot;:0,&quot;scale&quot;:{&quot;x&quot;:1,&quot;y&quot;:1}},&quot;opacity&quot;:1,&quot;path&quot;:{&quot;type&quot;:&quot;POLY_LINE&quot;,&quot;points&quot;:[{&quot;x&quot;:-79.72972510925001,&quot;y&quot;:3.5763655094212936},{&quot;x&quot;:-27.246925304255228,&quot;y&quot;:-2.446986927498756},{&quot;x&quot;:79.72972510924978,&quot;y&quot;:-2.446986927498756}],&quot;closed&quot;:false},&quot;pathStyles&quot;:[{&quot;type&quot;:&quot;FILL&quot;,&quot;fillStyle&quot;:&quot;transparent&quot;},{&quot;type&quot;:&quot;STROKE&quot;,&quot;strokeStyle&quot;:&quot;rgba(23,23,23,1)&quot;,&quot;lineWidth&quot;:2.1932641008095426,&quot;lineJoin&quot;:&quot;round&quot;}],&quot;pathSmoothing&quot;:{&quot;type&quot;:&quot;CATMULL_SMOOTHING&quot;,&quot;smoothing&quot;:0.2},&quot;isLocked&quot;:false,&quot;parent&quot;:{&quot;type&quot;:&quot;CHILD&quot;,&quot;parentId&quot;:&quot;94118305-a3f8-4d24-8193-98f97820b0e5&quot;,&quot;order&quot;:&quot;05&quot;}},&quot;4a0464b8-d59d-4420-94db-5e513c626761&quot;:{&quot;type&quot;:&quot;FIGURE_OBJECT&quot;,&quot;id&quot;:&quot;4a0464b8-d59d-4420-94db-5e513c626761&quot;,&quot;relativeTransform&quot;:{&quot;translate&quot;:{&quot;x&quot;:8.014820989532609,&quot;y&quot;:-7.093434415732872},&quot;rotate&quot;:0,&quot;skewX&quot;:0,&quot;scale&quot;:{&quot;x&quot;:1,&quot;y&quot;:1}},&quot;opacity&quot;:1,&quot;path&quot;:{&quot;type&quot;:&quot;POLY_LINE&quot;,&quot;points&quot;:[{&quot;x&quot;:-78.99363678914051,&quot;y&quot;:56.61971654250533},{&quot;x&quot;:-10.126780426804316,&quot;y&quot;:48.17018333161013},{&quot;x&quot;:10.502044197400664,&quot;y&quot;:-51.14038913516629},{&quot;x&quot;:78.99363678914051,&quot;y&quot;:-56.61971654250556}],&quot;closed&quot;:false,&quot;cornerRounding&quot;:{&quot;type&quot;:&quot;ARC_LENGTH&quot;,&quot;global&quot;:60.72816473099967}},&quot;pathStyles&quot;:[{&quot;type&quot;:&quot;FILL&quot;,&quot;fillStyle&quot;:&quot;rgba(0,0,0,0)&quot;},{&quot;type&quot;:&quot;STROKE&quot;,&quot;strokeStyle&quot;:&quot;rgba(65,207,26,1)&quot;,&quot;lineWidth&quot;:2.2830530863913467,&quot;lineJoin&quot;:&quot;round&quot;}],&quot;isLocked&quot;:false,&quot;parent&quot;:{&quot;type&quot;:&quot;CHILD&quot;,&quot;parentId&quot;:&quot;94118305-a3f8-4d24-8193-98f97820b0e5&quot;,&quot;order&quot;:&quot;1&quot;}},&quot;305ee8c2-01f3-4432-b658-cdafb3917ad9&quot;:{&quot;type&quot;:&quot;FIGURE_OBJECT&quot;,&quot;id&quot;:&quot;305ee8c2-01f3-4432-b658-cdafb3917ad9&quot;,&quot;relativeTransform&quot;:{&quot;translate&quot;:{&quot;x&quot;:9.418207501366624,&quot;y&quot;:-10.84303591875755},&quot;rotate&quot;:0,&quot;skewX&quot;:0,&quot;scale&quot;:{&quot;x&quot;:1,&quot;y&quot;:1}},&quot;opacity&quot;:1,&quot;path&quot;:{&quot;type&quot;:&quot;POLY_LINE&quot;,&quot;points&quot;:[{&quot;x&quot;:-80.68893937661983,&quot;y&quot;:-62.383608044456196},{&quot;x&quot;:-80.68893937661983,&quot;y&quot;:62.38360804445642},{&quot;x&quot;:80.68893937661983,&quot;y&quot;:62.38360804445642}],&quot;closed&quot;:false},&quot;pathStyles&quot;:[{&quot;type&quot;:&quot;FILL&quot;,&quot;fillStyle&quot;:&quot;transparent&quot;},{&quot;type&quot;:&quot;STROKE&quot;,&quot;strokeStyle&quot;:&quot;#232323&quot;,&quot;lineWidth&quot;:1.462176067206362,&quot;lineJoin&quot;:&quot;round&quot;,&quot;dashArray&quot;:[0,0]}],&quot;isLocked&quot;:false,&quot;parent&quot;:{&quot;type&quot;:&quot;CHILD&quot;,&quot;parentId&quot;:&quot;94118305-a3f8-4d24-8193-98f97820b0e5&quot;,&quot;order&quot;:&quot;2&quot;}},&quot;c3975fb3-6250-4d91-8774-06b53c8ccd1d&quot;:{&quot;type&quot;:&quot;FIGURE_OBJECT&quot;,&quot;id&quot;:&quot;c3975fb3-6250-4d91-8774-06b53c8ccd1d&quot;,&quot;relativeTransform&quot;:{&quot;translate&quot;:{&quot;x&quot;:-84.32125470240699,&quot;y&quot;:-10.749864532871378},&quot;rotate&quot;:-1.5707963267948966,&quot;skewX&quot;:0,&quot;scale&quot;:{&quot;x&quot;:1,&quot;y&quot;:1}},&quot;opacity&quot;:1,&quot;pathStyles&quot;:[{&quot;type&quot;:&quot;FILL&quot;,&quot;fillStyle&quot;:&quot;#232323&quot;}],&quot;text&quot;:{&quot;textData&quot;:{&quot;lineSpacing&quot;:&quot;normal&quot;,&quot;alignment&quot;:&quot;center&quot;,&quot;lines&quot;:[{&quot;runs&quot;:[{&quot;style&quot;:{&quot;fontFamily&quot;:&quot;Roboto&quot;,&quot;fontSize&quot;:10.41555090935666,&quot;color&quot;:&quot;#232323&quot;,&quot;fontWeight&quot;:&quot;bold&quot;,&quot;fontStyle&quot;:&quot;normal&quot;,&quot;decoration&quot;:&quot;none&quot;,&quot;script&quot;:&quot;none&quot;},&quot;range&quot;:[0,11]}],&quot;text&quot;:&quot;Fluorescence&quot;,&quot;baseStyle&quot;:{&quot;fontFamily&quot;:&quot;Roboto&quot;,&quot;fontSize&quot;:10.41555090935666,&quot;color&quot;:&quot;#232323&quot;,&quot;fontWeight&quot;:&quot;bold&quot;,&quot;fontStyle&quot;:&quot;normal&quot;,&quot;decoration&quot;:&quot;none&quot;,&quot;script&quot;:&quot;none&quot;}}],&quot;verticalAlign&quot;:&quot;TOP&quot;},&quot;size&quot;:{&quot;x&quot;:124.6806304697282,&quot;y&quot;:13.756802515335567},&quot;targetSize&quot;:{&quot;x&quot;:124.6806304697282,&quot;y&quot;:13.756802515335567},&quot;format&quot;:&quot;BETTER_TEXT&quot;,&quot;verticalAlign&quot;:&quot;TOP&quot;},&quot;isLocked&quot;:false,&quot;parent&quot;:{&quot;type&quot;:&quot;CHILD&quot;,&quot;parentId&quot;:&quot;94118305-a3f8-4d24-8193-98f97820b0e5&quot;,&quot;order&quot;:&quot;3&quot;}},&quot;8956bc78-7bb2-4cd8-9fbc-482271aff67a&quot;:{&quot;type&quot;:&quot;FIGURE_OBJECT&quot;,&quot;id&quot;:&quot;8956bc78-7bb2-4cd8-9fbc-482271aff67a&quot;,&quot;relativeTransform&quot;:{&quot;translate&quot;:{&quot;x&quot;:7.675304831392623,&quot;y&quot;:15.741901959258257},&quot;rotate&quot;:0,&quot;skewX&quot;:0,&quot;scale&quot;:{&quot;x&quot;:1,&quot;y&quot;:1}},&quot;opacity&quot;:1,&quot;path&quot;:{&quot;type&quot;:&quot;POLY_LINE&quot;,&quot;points&quot;:[{&quot;x&quot;:-79.50499640420344,&quot;y&quot;:0},{&quot;x&quot;:79.50499640420367,&quot;y&quot;:0}],&quot;closed&quot;:false},&quot;pathStyles&quot;:[{&quot;type&quot;:&quot;FILL&quot;,&quot;fillStyle&quot;:&quot;rgba(0,0,0,0)&quot;},{&quot;type&quot;:&quot;STROKE&quot;,&quot;strokeStyle&quot;:&quot;rgba(129,134,137,1)&quot;,&quot;lineWidth&quot;:1.3698318518348076,&quot;lineJoin&quot;:&quot;round&quot;,&quot;dashArray&quot;:[4.5661061727826935,4.5661061727826935]}],&quot;isLocked&quot;:false,&quot;parent&quot;:{&quot;type&quot;:&quot;CHILD&quot;,&quot;parentId&quot;:&quot;94118305-a3f8-4d24-8193-98f97820b0e5&quot;,&quot;order&quot;:&quot;5&quot;}},&quot;9953c497-1e99-4267-9d17-f6474f14b253&quot;:{&quot;type&quot;:&quot;FIGURE_OBJECT&quot;,&quot;id&quot;:&quot;9953c497-1e99-4267-9d17-f6474f14b253&quot;,&quot;relativeTransform&quot;:{&quot;translate&quot;:{&quot;x&quot;:8.537146119549107,&quot;y&quot;:66.21177851006796},&quot;rotate&quot;:0,&quot;skewX&quot;:0,&quot;scale&quot;:{&quot;x&quot;:1,&quot;y&quot;:1}},&quot;opacity&quot;:1,&quot;pathStyles&quot;:[{&quot;type&quot;:&quot;FILL&quot;,&quot;fillStyle&quot;:&quot;#232323&quot;}],&quot;text&quot;:{&quot;textData&quot;:{&quot;lineSpacing&quot;:&quot;normal&quot;,&quot;alignment&quot;:&quot;center&quot;,&quot;lines&quot;:[{&quot;runs&quot;:[{&quot;style&quot;:{&quot;fontFamily&quot;:&quot;Roboto&quot;,&quot;fontSize&quot;:10.41555090935666,&quot;color&quot;:&quot;#232323&quot;,&quot;fontWeight&quot;:&quot;bold&quot;,&quot;fontStyle&quot;:&quot;normal&quot;,&quot;decoration&quot;:&quot;none&quot;,&quot;script&quot;:&quot;none&quot;},&quot;range&quot;:[0,12]}],&quot;text&quot;:&quot;Time (2-3hrs)&quot;}],&quot;verticalAlign&quot;:&quot;TOP&quot;,&quot;_lastCaretLocation&quot;:{&quot;lineIndex&quot;:0,&quot;runIndex&quot;:-1,&quot;charIndex&quot;:-1,&quot;endOfLine&quot;:true}},&quot;size&quot;:{&quot;x&quot;:160.63222834654243,&quot;y&quot;:13.756802515335567},&quot;targetSize&quot;:{&quot;x&quot;:160.63222834654243,&quot;y&quot;:13.756802515335567},&quot;format&quot;:&quot;BETTER_TEXT&quot;,&quot;verticalAlign&quot;:&quot;TOP&quot;},&quot;isLocked&quot;:false,&quot;parent&quot;:{&quot;type&quot;:&quot;CHILD&quot;,&quot;parentId&quot;:&quot;94118305-a3f8-4d24-8193-98f97820b0e5&quot;,&quot;order&quot;:&quot;55&quot;}},&quot;f3c478cf-020c-4a85-9403-a0a2a2c87951&quot;:{&quot;type&quot;:&quot;FIGURE_OBJECT&quot;,&quot;id&quot;:&quot;f3c478cf-020c-4a85-9403-a0a2a2c87951&quot;,&quot;relativeTransform&quot;:{&quot;translate&quot;:{&quot;x&quot;:62.03822589500049,&quot;y&quot;:5.671437468211971},&quot;rotate&quot;:0,&quot;skewX&quot;:0,&quot;scale&quot;:{&quot;x&quot;:1,&quot;y&quot;:1}},&quot;opacity&quot;:1,&quot;pathStyles&quot;:[{&quot;type&quot;:&quot;FILL&quot;,&quot;fillStyle&quot;:&quot;rgba(129,134,137,1)&quot;}],&quot;text&quot;:{&quot;textData&quot;:{&quot;lineSpacing&quot;:&quot;normal&quot;,&quot;alignment&quot;:&quot;right&quot;,&quot;lines&quot;:[{&quot;runs&quot;:[{&quot;style&quot;:{&quot;fontFamily&quot;:&quot;Roboto&quot;,&quot;fontSize&quot;:10.41555090935666,&quot;color&quot;:&quot;rgba(129,134,137,1)&quot;,&quot;fontWeight&quot;:&quot;normal&quot;,&quot;fontStyle&quot;:&quot;normal&quot;,&quot;decoration&quot;:&quot;none&quot;,&quot;script&quot;:&quot;none&quot;},&quot;range&quot;:[0,8]}],&quot;text&quot;:&quot;Threshold&quot;,&quot;baseStyle&quot;:{&quot;fontFamily&quot;:&quot;Roboto&quot;,&quot;fontSize&quot;:10.41555090935666,&quot;color&quot;:&quot;rgba(129,134,137,1)&quot;,&quot;fontWeight&quot;:&quot;normal&quot;,&quot;fontStyle&quot;:&quot;normal&quot;,&quot;decoration&quot;:&quot;none&quot;,&quot;script&quot;:&quot;none&quot;}}],&quot;verticalAlign&quot;:&quot;TOP&quot;},&quot;size&quot;:{&quot;x&quot;:56.32286013014833,&quot;y&quot;:13.756802515335567},&quot;targetSize&quot;:{&quot;x&quot;:56.32286013014833,&quot;y&quot;:13.756802515335567},&quot;format&quot;:&quot;BETTER_TEXT&quot;,&quot;verticalAlign&quot;:&quot;TOP&quot;},&quot;isLocked&quot;:false,&quot;parent&quot;:{&quot;type&quot;:&quot;CHILD&quot;,&quot;parentId&quot;:&quot;94118305-a3f8-4d24-8193-98f97820b0e5&quot;,&quot;order&quot;:&quot;6&quot;}},&quot;d5b919be-ac05-4965-96e0-71db8a63d498&quot;:{&quot;type&quot;:&quot;FIGURE_OBJECT&quot;,&quot;id&quot;:&quot;d5b919be-ac05-4965-96e0-71db8a63d498&quot;,&quot;relativeTransform&quot;:{&quot;translate&quot;:{&quot;x&quot;:44.741900240473846,&quot;y&quot;:31.870322958807108},&quot;rotate&quot;:0,&quot;skewX&quot;:0,&quot;scale&quot;:{&quot;x&quot;:1,&quot;y&quot;:1}},&quot;opacity&quot;:1,&quot;pathStyles&quot;:[{&quot;type&quot;:&quot;FILL&quot;,&quot;fillStyle&quot;:&quot;rgba(23,23,23,1)&quot;}],&quot;text&quot;:{&quot;textData&quot;:{&quot;lineSpacing&quot;:&quot;normal&quot;,&quot;alignment&quot;:&quot;right&quot;,&quot;lines&quot;:[{&quot;runs&quot;:[{&quot;style&quot;:{&quot;fontFamily&quot;:&quot;Roboto&quot;,&quot;fontSize&quot;:10.41555090935666,&quot;color&quot;:&quot;rgba(23,23,23,1)&quot;,&quot;fontWeight&quot;:&quot;bold&quot;,&quot;fontStyle&quot;:&quot;normal&quot;,&quot;decoration&quot;:&quot;none&quot;,&quot;script&quot;:&quot;none&quot;},&quot;range&quot;:[0,11]}],&quot;text&quot;:&quot;No Detection&quot;}],&quot;verticalAlign&quot;:&quot;TOP&quot;,&quot;_lastCaretLocation&quot;:{&quot;lineIndex&quot;:0,&quot;runIndex&quot;:-1,&quot;charIndex&quot;:-1,&quot;endOfLine&quot;:true}},&quot;size&quot;:{&quot;x&quot;:90.91551143920161,&quot;y&quot;:19.2674144979666},&quot;targetSize&quot;:{&quot;x&quot;:90.91551143920161,&quot;y&quot;:19.2674144979666},&quot;format&quot;:&quot;BETTER_TEXT&quot;,&quot;verticalAlign&quot;:&quot;TOP&quot;},&quot;isLocked&quot;:false,&quot;parent&quot;:{&quot;type&quot;:&quot;CHILD&quot;,&quot;parentId&quot;:&quot;94118305-a3f8-4d24-8193-98f97820b0e5&quot;,&quot;order&quot;:&quot;7&quot;}},&quot;e702e856-6e2a-46ba-bee2-44be57a43809&quot;:{&quot;type&quot;:&quot;FIGURE_OBJECT&quot;,&quot;id&quot;:&quot;e702e856-6e2a-46ba-bee2-44be57a43809&quot;,&quot;relativeTransform&quot;:{&quot;translate&quot;:{&quot;x&quot;:58.9377460773523,&quot;y&quot;:-43.3601408286033},&quot;rotate&quot;:0,&quot;skewX&quot;:0,&quot;scale&quot;:{&quot;x&quot;:1,&quot;y&quot;:1}},&quot;opacity&quot;:1,&quot;pathStyles&quot;:[{&quot;type&quot;:&quot;FILL&quot;,&quot;fillStyle&quot;:&quot;rgba(30,133,0,1)&quot;}],&quot;text&quot;:{&quot;textData&quot;:{&quot;lineSpacing&quot;:&quot;normal&quot;,&quot;alignment&quot;:&quot;right&quot;,&quot;lines&quot;:[{&quot;runs&quot;:[{&quot;style&quot;:{&quot;fontFamily&quot;:&quot;Roboto&quot;,&quot;fontSize&quot;:10.41555090935666,&quot;color&quot;:&quot;rgba(30,133,0,1)&quot;,&quot;fontWeight&quot;:&quot;bold&quot;,&quot;fontStyle&quot;:&quot;normal&quot;,&quot;decoration&quot;:&quot;none&quot;,&quot;script&quot;:&quot;none&quot;},&quot;range&quot;:[0,8]}],&quot;text&quot;:&quot;Detection&quot;}],&quot;verticalAlign&quot;:&quot;TOP&quot;,&quot;_lastCaretLocation&quot;:{&quot;lineIndex&quot;:0,&quot;runIndex&quot;:-1,&quot;charIndex&quot;:-1,&quot;endOfLine&quot;:true}},&quot;size&quot;:{&quot;x&quot;:62.52381976544473,&quot;y&quot;:13.756802515335567},&quot;targetSize&quot;:{&quot;x&quot;:62.52381976544473,&quot;y&quot;:13.756802515335567},&quot;format&quot;:&quot;BETTER_TEXT&quot;,&quot;verticalAlign&quot;:&quot;TOP&quot;},&quot;isLocked&quot;:false,&quot;parent&quot;:{&quot;type&quot;:&quot;CHILD&quot;,&quot;parentId&quot;:&quot;94118305-a3f8-4d24-8193-98f97820b0e5&quot;,&quot;order&quot;:&quot;8&quot;}},&quot;802873b1-dbe3-4cec-80d9-6da6c40b71c3&quot;:{&quot;type&quot;:&quot;FIGURE_OBJECT&quot;,&quot;id&quot;:&quot;802873b1-dbe3-4cec-80d9-6da6c40b71c3&quot;,&quot;relativeTransform&quot;:{&quot;translate&quot;:{&quot;x&quot;:169.41638700171893,&quot;y&quot;:-52.25505443234837},&quot;rotate&quot;:0,&quot;skewX&quot;:0,&quot;scale&quot;:{&quot;x&quot;:1,&quot;y&quot;:1}},&quot;opacity&quot;:1,&quot;path&quot;:{&quot;type&quot;:&quot;POLY_LINE&quot;,&quot;points&quot;:[{&quot;x&quot;:-49.504788409593175,&quot;y&quot;:30.80297945485799},{&quot;x&quot;:49.504788409593175,&quot;y&quot;:-30.80297945485799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ac4bfdb8-c638-4ab9-9da2-3040bcbea76a&quot;,&quot;order&quot;:&quot;99998&quot;},&quot;connectorInfo&quot;:{&quot;connectedObjects&quot;:[],&quot;type&quot;:&quot;LINE&quot;,&quot;offset&quot;:{&quot;x&quot;:0,&quot;y&quot;:0},&quot;bending&quot;:0.1,&quot;firstElementIsHead&quot;:true,&quot;customized&quot;:false}},&quot;af0c2c02-d366-4a3b-a616-5cd94546c1c6&quot;:{&quot;relativeTransform&quot;:{&quot;translate&quot;:{&quot;x&quot;:294.92756094947237,&quot;y&quot;:96.46356402696364},&quot;rotate&quot;:0,&quot;skewX&quot;:0,&quot;scale&quot;:{&quot;x&quot;:1,&quot;y&quot;:1}},&quot;type&quot;:&quot;FIGURE_OBJECT&quot;,&quot;id&quot;:&quot;af0c2c02-d366-4a3b-a616-5cd94546c1c6&quot;,&quot;name&quot;:&quot;Lateral flow test (positive)&quot;,&quot;displayName&quot;:&quot;Positive lateral flow test&quot;,&quot;opacity&quot;:1,&quot;source&quot;:{&quot;id&quot;:&quot;5daf4d8fe9d60b007f4b514a&quot;,&quot;type&quot;:&quot;ASSETS&quot;},&quot;pathStyles&quot;:[{&quot;type&quot;:&quot;FILL&quot;,&quot;fillStyle&quot;:&quot;rgb(0,0,0)&quot;}],&quot;isLocked&quot;:false,&quot;parent&quot;:{&quot;type&quot;:&quot;CHILD&quot;,&quot;parentId&quot;:&quot;ac4bfdb8-c638-4ab9-9da2-3040bcbea76a&quot;,&quot;order&quot;:&quot;99999&quot;},&quot;isPremium&quot;:true},&quot;86182055-68b3-46ad-9da8-6c4e178c009c&quot;:{&quot;type&quot;:&quot;FIGURE_OBJECT&quot;,&quot;id&quot;:&quot;86182055-68b3-46ad-9da8-6c4e178c009c&quot;,&quot;name&quot;:&quot;Invalid Lateral Flow test 2&quot;,&quot;relativeTransform&quot;:{&quot;translate&quot;:{&quot;x&quot;:0,&quot;y&quot;:-1.6540286207541908e-14},&quot;rotate&quot;:0,&quot;skewX&quot;:0,&quot;scale&quot;:{&quot;x&quot;:0.25524543174646075,&quot;y&quot;:0.25524543174646075}},&quot;opacity&quot;:1,&quot;image&quot;:{&quot;url&quot;:&quot;https://icons.biorender.com/biorender/5ce7e41b053c6b330009f982/20190524123154/image/invalid-lateral-flow-test-2.png&quot;,&quot;fallbackUrl&quot;:&quot;https://res.cloudinary.com/dlcjuc3ej/image/upload/v1558701114/scrv8w4lteskpkk4t6sz.svg#/keystone/api/icons/5ce7e41b053c6b330009f982/20190524123154/image/invalid-lateral-flow-test-2.svg&quot;,&quot;size&quot;:{&quot;x&quot;:228,&quot;y&quot;:438},&quot;isPremium&quot;:false},&quot;source&quot;:{&quot;id&quot;:&quot;5ce7e41b053c6b330009f982&quot;,&quot;type&quot;:&quot;ASSETS&quot;},&quot;pathStyles&quot;:[{&quot;type&quot;:&quot;FILL&quot;,&quot;fillStyle&quot;:&quot;rgb(0,0,0)&quot;}],&quot;isLocked&quot;:false,&quot;parent&quot;:{&quot;type&quot;:&quot;CHILD&quot;,&quot;parentId&quot;:&quot;af0c2c02-d366-4a3b-a616-5cd94546c1c6&quot;,&quot;order&quot;:&quot;2&quot;}},&quot;7bb4615d-5245-49b8-a0d8-1a98c642a1f2&quot;:{&quot;type&quot;:&quot;FIGURE_OBJECT&quot;,&quot;id&quot;:&quot;7bb4615d-5245-49b8-a0d8-1a98c642a1f2&quot;,&quot;relativeTransform&quot;:{&quot;translate&quot;:{&quot;x&quot;:-1.4402591797787534,&quot;y&quot;:0.0002313815214343921},&quot;rotate&quot;:0},&quot;opacity&quot;:1,&quot;path&quot;:{&quot;type&quot;:&quot;POLY_LINE&quot;,&quot;points&quot;:[{&quot;x&quot;:-6.959591206842411,&quot;y&quot;:0},{&quot;x&quot;:6.959591206842411,&quot;y&quot;:0}],&quot;closed&quot;:false},&quot;pathStyles&quot;:[{&quot;type&quot;:&quot;FILL&quot;,&quot;fillStyle&quot;:&quot;transparent&quot;},{&quot;type&quot;:&quot;STROKE&quot;,&quot;strokeStyle&quot;:&quot;rgba(229, 72, 72, 1)&quot;,&quot;lineWidth&quot;:1.7458787531457913,&quot;lineJoin&quot;:&quot;round&quot;}],&quot;isLocked&quot;:false,&quot;parent&quot;:{&quot;type&quot;:&quot;CHILD&quot;,&quot;parentId&quot;:&quot;af0c2c02-d366-4a3b-a616-5cd94546c1c6&quot;,&quot;order&quot;:&quot;5&quot;}},&quot;3c555a1d-bf96-497b-8347-9f98c75ded31&quot;:{&quot;type&quot;:&quot;FIGURE_OBJECT&quot;,&quot;id&quot;:&quot;3c555a1d-bf96-497b-8347-9f98c75ded31&quot;,&quot;relativeTransform&quot;:{&quot;translate&quot;:{&quot;x&quot;:-1.440195716997624,&quot;y&quot;:-18.419371423751084},&quot;rotate&quot;:0},&quot;opacity&quot;:1,&quot;path&quot;:{&quot;type&quot;:&quot;POLY_LINE&quot;,&quot;points&quot;:[{&quot;x&quot;:-6.959591206842411,&quot;y&quot;:0},{&quot;x&quot;:6.959591206842411,&quot;y&quot;:0}],&quot;closed&quot;:false},&quot;pathStyles&quot;:[{&quot;type&quot;:&quot;FILL&quot;,&quot;fillStyle&quot;:&quot;transparent&quot;},{&quot;type&quot;:&quot;STROKE&quot;,&quot;strokeStyle&quot;:&quot;rgba(229, 72, 72, 1)&quot;,&quot;lineWidth&quot;:1.7458787531457913,&quot;lineJoin&quot;:&quot;round&quot;}],&quot;isLocked&quot;:false,&quot;parent&quot;:{&quot;type&quot;:&quot;CHILD&quot;,&quot;parentId&quot;:&quot;af0c2c02-d366-4a3b-a616-5cd94546c1c6&quot;,&quot;order&quot;:&quot;7&quot;}},&quot;acacdfee-6d9e-4d71-8a6d-6c97856d0c6e&quot;:{&quot;relativeTransform&quot;:{&quot;translate&quot;:{&quot;x&quot;:379.6363189894363,&quot;y&quot;:97.01340438720425},&quot;rotate&quot;:0},&quot;type&quot;:&quot;FIGURE_OBJECT&quot;,&quot;id&quot;:&quot;acacdfee-6d9e-4d71-8a6d-6c97856d0c6e&quot;,&quot;name&quot;:&quot;Lateral flow test (negative)&quot;,&quot;displayName&quot;:&quot;Negative lateral flow test&quot;,&quot;opacity&quot;:1,&quot;source&quot;:{&quot;id&quot;:&quot;5daf4e54e9d60b007f4b5206&quot;,&quot;type&quot;:&quot;ASSETS&quot;},&quot;pathStyles&quot;:[{&quot;type&quot;:&quot;FILL&quot;,&quot;fillStyle&quot;:&quot;rgb(0,0,0)&quot;}],&quot;isLocked&quot;:false,&quot;parent&quot;:{&quot;type&quot;:&quot;CHILD&quot;,&quot;parentId&quot;:&quot;ac4bfdb8-c638-4ab9-9da2-3040bcbea76a&quot;,&quot;order&quot;:&quot;999995&quot;},&quot;isPremium&quot;:true},&quot;a1cae92e-b0e1-4ed5-88ea-df4e3e0685f6&quot;:{&quot;type&quot;:&quot;FIGURE_OBJECT&quot;,&quot;id&quot;:&quot;a1cae92e-b0e1-4ed5-88ea-df4e3e0685f6&quot;,&quot;name&quot;:&quot;Invalid Lateral Flow test 2&quot;,&quot;relativeTransform&quot;:{&quot;translate&quot;:{&quot;x&quot;:0,&quot;y&quot;:4.913258095593272e-14},&quot;rotate&quot;:0,&quot;skewX&quot;:0,&quot;scale&quot;:{&quot;x&quot;:0.25273377339739733,&quot;y&quot;:0.25273377339739733}},&quot;opacity&quot;:1,&quot;image&quot;:{&quot;url&quot;:&quot;https://icons.biorender.com/biorender/5ce7e41b053c6b330009f982/20190524123154/image/invalid-lateral-flow-test-2.png&quot;,&quot;fallbackUrl&quot;:&quot;https://res.cloudinary.com/dlcjuc3ej/image/upload/v1558701114/scrv8w4lteskpkk4t6sz.svg#/keystone/api/icons/5ce7e41b053c6b330009f982/20190524123154/image/invalid-lateral-flow-test-2.svg&quot;,&quot;size&quot;:{&quot;x&quot;:228,&quot;y&quot;:438},&quot;isPremium&quot;:false},&quot;source&quot;:{&quot;id&quot;:&quot;5ce7e41b053c6b330009f982&quot;,&quot;type&quot;:&quot;ASSETS&quot;},&quot;pathStyles&quot;:[{&quot;type&quot;:&quot;FILL&quot;,&quot;fillStyle&quot;:&quot;rgb(0,0,0)&quot;}],&quot;isLocked&quot;:false,&quot;parent&quot;:{&quot;type&quot;:&quot;CHILD&quot;,&quot;parentId&quot;:&quot;acacdfee-6d9e-4d71-8a6d-6c97856d0c6e&quot;,&quot;order&quot;:&quot;2&quot;}},&quot;0b4606ac-0817-408f-b28b-71493b28e1ae&quot;:{&quot;type&quot;:&quot;FIGURE_OBJECT&quot;,&quot;id&quot;:&quot;0b4606ac-0817-408f-b28b-71493b28e1ae&quot;,&quot;relativeTransform&quot;:{&quot;translate&quot;:{&quot;x&quot;:-1.4260239468228086,&quot;y&quot;:-18.238121684218296},&quot;rotate&quot;:0},&quot;opacity&quot;:1,&quot;path&quot;:{&quot;type&quot;:&quot;POLY_LINE&quot;,&quot;points&quot;:[{&quot;x&quot;:-6.891107648719039,&quot;y&quot;:0},{&quot;x&quot;:6.891107648719039,&quot;y&quot;:0}],&quot;closed&quot;:false},&quot;pathStyles&quot;:[{&quot;type&quot;:&quot;FILL&quot;,&quot;fillStyle&quot;:&quot;transparent&quot;},{&quot;type&quot;:&quot;STROKE&quot;,&quot;strokeStyle&quot;:&quot;rgba(229, 72, 72, 1)&quot;,&quot;lineWidth&quot;:1.7286990100381978,&quot;lineJoin&quot;:&quot;round&quot;}],&quot;isLocked&quot;:false,&quot;parent&quot;:{&quot;type&quot;:&quot;CHILD&quot;,&quot;parentId&quot;:&quot;acacdfee-6d9e-4d71-8a6d-6c97856d0c6e&quot;,&quot;order&quot;:&quot;5&quot;}},&quot;30adc7b7-810a-4624-8e57-10e442119ab6&quot;:{&quot;type&quot;:&quot;FIGURE_OBJECT&quot;,&quot;id&quot;:&quot;30adc7b7-810a-4624-8e57-10e442119ab6&quot;,&quot;relativeTransform&quot;:{&quot;translate&quot;:{&quot;x&quot;:168.31628059261686,&quot;y&quot;:15.951542931980043},&quot;rotate&quot;:0,&quot;skewX&quot;:0,&quot;scale&quot;:{&quot;x&quot;:1,&quot;y&quot;:1}},&quot;opacity&quot;:1,&quot;path&quot;:{&quot;type&quot;:&quot;POLY_LINE&quot;,&quot;points&quot;:[{&quot;x&quot;:-46.20446918228697,&quot;y&quot;:-35.20340509126629},{&quot;x&quot;:46.20446918228697,&quot;y&quot;:35.20340509126629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ac4bfdb8-c638-4ab9-9da2-3040bcbea76a&quot;,&quot;order&quot;:&quot;999997&quot;},&quot;connectorInfo&quot;:{&quot;connectedObjects&quot;:[],&quot;type&quot;:&quot;LINE&quot;,&quot;offset&quot;:{&quot;x&quot;:0,&quot;y&quot;:0},&quot;bending&quot;:0.1,&quot;firstElementIsHead&quot;:true,&quot;customized&quot;:false}},&quot;90070272-7b63-4daf-9cac-d49ce55c8104&quot;:{&quot;relativeTransform&quot;:{&quot;translate&quot;:{&quot;x&quot;:-24.4455525852877,&quot;y&quot;:-151.91218597406404},&quot;rotate&quot;:0,&quot;skewX&quot;:0,&quot;scale&quot;:{&quot;x&quot;:1,&quot;y&quot;:1}},&quot;type&quot;:&quot;FIGURE_OBJECT&quot;,&quot;id&quot;:&quot;90070272-7b63-4daf-9cac-d49ce55c8104&quot;,&quot;parent&quot;:{&quot;type&quot;:&quot;CHILD&quot;,&quot;parentId&quot;:&quot;ac4bfdb8-c638-4ab9-9da2-3040bcbea76a&quot;,&quot;order&quot;:&quot;999999998&quot;},&quot;name&quot;:&quot;DNA probe (molecular beacon)&quot;,&quot;displayName&quot;:&quot;DNA probe (molecular beacon)&quot;,&quot;source&quot;:{&quot;id&quot;:&quot;6490d9632d2897db32e02945&quot;,&quot;type&quot;:&quot;ASSETS&quot;},&quot;isPremium&quot;:true},&quot;2983d2ce-16b7-4f7a-9b5e-62aaf5194857&quot;:{&quot;id&quot;:&quot;2983d2ce-16b7-4f7a-9b5e-62aaf5194857&quot;,&quot;name&quot;:&quot;RNA (stem loop, small, short)&quot;,&quot;displayName&quot;:&quot;Short stem loop RNA&quot;,&quot;type&quot;:&quot;FIGURE_OBJECT&quot;,&quot;relativeTransform&quot;:{&quot;translate&quot;:{&quot;x&quot;:-100.71946354914112,&quot;y&quot;:-9.955062732296772},&quot;rotate&quot;:1.5707963267948966,&quot;skewX&quot;:0,&quot;scale&quot;:{&quot;x&quot;:0.2851841973648388,&quot;y&quot;:0.2851841973648388}},&quot;image&quot;:{&quot;url&quot;:&quot;https://icons.biorender.com/biorender/5d2f5bce1900ef0400b1d8a2/rna-stem-loop-small-short.png&quot;,&quot;fallbackUrl&quot;:&quot;https://res.cloudinary.com/dlcjuc3ej/image/upload/v1563384776/izjmqkirucjsajhj1qqa.svg#/keystone/api/icons/5d2f5bce1900ef0400b1d8a2/rna-stem-loop-small-short.svg&quot;,&quot;isPremium&quot;:false,&quot;size&quot;:{&quot;x&quot;:126,&quot;y&quot;:75.95744680851064}},&quot;source&quot;:{&quot;id&quot;:&quot;5d2f5b911900ef0400b1d88e&quot;,&quot;type&quot;:&quot;ASSETS&quot;},&quot;isPremium&quot;:false,&quot;parent&quot;:{&quot;type&quot;:&quot;CHILD&quot;,&quot;parentId&quot;:&quot;90070272-7b63-4daf-9cac-d49ce55c8104&quot;,&quot;order&quot;:&quot;2&quot;}},&quot;530c7921-9898-4fae-9815-f6f2c732b488&quot;:{&quot;type&quot;:&quot;FIGURE_OBJECT&quot;,&quot;id&quot;:&quot;530c7921-9898-4fae-9815-f6f2c732b488&quot;,&quot;relativeTransform&quot;:{&quot;translate&quot;:{&quot;x&quot;:-96.40709522075763,&quot;y&quot;:10.307130725627262},&quot;rotate&quot;:0},&quot;opacity&quot;:1,&quot;path&quot;:{&quot;type&quot;:&quot;ELLIPSE&quot;,&quot;size&quot;:{&quot;x&quot;:-5.2951484890453,&quot;y&quot;:-5.295148489045295}},&quot;isLocked&quot;:false,&quot;pathStyles&quot;:[{&quot;type&quot;:&quot;FILL&quot;,&quot;fillStyle&quot;:&quot;rgb(155, 155, 155)&quot;},{&quot;type&quot;:&quot;STROKE&quot;,&quot;strokeStyle&quot;:&quot;rgba(0,0,0,0)&quot;,&quot;lineWidth&quot;:0.7040902525806721,&quot;lineJoin&quot;:&quot;round&quot;}],&quot;parent&quot;:{&quot;type&quot;:&quot;CHILD&quot;,&quot;parentId&quot;:&quot;90070272-7b63-4daf-9cac-d49ce55c8104&quot;,&quot;order&quot;:&quot;5&quot;}},&quot;93b96959-7f36-4afd-99fc-fdc74a5420d9&quot;:{&quot;type&quot;:&quot;FIGURE_OBJECT&quot;,&quot;id&quot;:&quot;93b96959-7f36-4afd-99fc-fdc74a5420d9&quot;,&quot;relativeTransform&quot;:{&quot;translate&quot;:{&quot;x&quot;:-105.03185651497778,&quot;y&quot;:10.3071140565173},&quot;rotate&quot;:0},&quot;opacity&quot;:1,&quot;path&quot;:{&quot;type&quot;:&quot;ELLIPSE&quot;,&quot;size&quot;:{&quot;x&quot;:-5.2951484890453,&quot;y&quot;:-5.295148489045295}},&quot;isLocked&quot;:false,&quot;pathStyles&quot;:[{&quot;type&quot;:&quot;FILL&quot;,&quot;fillStyle&quot;:&quot;rgb(90, 195, 63)&quot;},{&quot;type&quot;:&quot;STROKE&quot;,&quot;strokeStyle&quot;:&quot;rgba(0,0,0,0)&quot;,&quot;lineWidth&quot;:0.7040902525806721,&quot;lineJoin&quot;:&quot;round&quot;}],&quot;parent&quot;:{&quot;type&quot;:&quot;CHILD&quot;,&quot;parentId&quot;:&quot;90070272-7b63-4daf-9cac-d49ce55c8104&quot;,&quot;order&quot;:&quot;7&quot;}},&quot;484c6def-0fa0-4d6f-b013-059e9647a5f4&quot;:{&quot;relativeTransform&quot;:{&quot;translate&quot;:{&quot;x&quot;:2.2594474147123123,&quot;y&quot;:-134.20018597406406},&quot;rotate&quot;:0,&quot;skewX&quot;:0,&quot;scale&quot;:{&quot;x&quot;:1,&quot;y&quot;:1}},&quot;type&quot;:&quot;FIGURE_OBJECT&quot;,&quot;id&quot;:&quot;484c6def-0fa0-4d6f-b013-059e9647a5f4&quot;,&quot;parent&quot;:{&quot;type&quot;:&quot;CHILD&quot;,&quot;parentId&quot;:&quot;ac4bfdb8-c638-4ab9-9da2-3040bcbea76a&quot;,&quot;order&quot;:&quot;999999999&quot;},&quot;name&quot;:&quot;DNA probe (molecular beacon)&quot;,&quot;displayName&quot;:&quot;DNA probe (molecular beacon)&quot;,&quot;source&quot;:{&quot;id&quot;:&quot;6490d9632d2897db32e02945&quot;,&quot;type&quot;:&quot;ASSETS&quot;},&quot;isPremium&quot;:true},&quot;c5147500-dd60-4a00-8383-4607618e7a0f&quot;:{&quot;id&quot;:&quot;c5147500-dd60-4a00-8383-4607618e7a0f&quot;,&quot;name&quot;:&quot;RNA (stem loop, small, short)&quot;,&quot;displayName&quot;:&quot;Short stem loop RNA&quot;,&quot;type&quot;:&quot;FIGURE_OBJECT&quot;,&quot;relativeTransform&quot;:{&quot;translate&quot;:{&quot;x&quot;:-100.71946354914112,&quot;y&quot;:-9.955062732296772},&quot;rotate&quot;:1.5707963267948966,&quot;skewX&quot;:0,&quot;scale&quot;:{&quot;x&quot;:0.2851841973648388,&quot;y&quot;:0.2851841973648388}},&quot;image&quot;:{&quot;url&quot;:&quot;https://icons.biorender.com/biorender/5d2f5bce1900ef0400b1d8a2/rna-stem-loop-small-short.png&quot;,&quot;fallbackUrl&quot;:&quot;https://res.cloudinary.com/dlcjuc3ej/image/upload/v1563384776/izjmqkirucjsajhj1qqa.svg#/keystone/api/icons/5d2f5bce1900ef0400b1d8a2/rna-stem-loop-small-short.svg&quot;,&quot;isPremium&quot;:false,&quot;size&quot;:{&quot;x&quot;:126,&quot;y&quot;:75.95744680851064}},&quot;source&quot;:{&quot;id&quot;:&quot;5d2f5b911900ef0400b1d88e&quot;,&quot;type&quot;:&quot;ASSETS&quot;},&quot;isPremium&quot;:false,&quot;parent&quot;:{&quot;type&quot;:&quot;CHILD&quot;,&quot;parentId&quot;:&quot;484c6def-0fa0-4d6f-b013-059e9647a5f4&quot;,&quot;order&quot;:&quot;2&quot;}},&quot;fd02037c-f1fd-4c69-94c2-059bd7bb873f&quot;:{&quot;type&quot;:&quot;FIGURE_OBJECT&quot;,&quot;id&quot;:&quot;fd02037c-f1fd-4c69-94c2-059bd7bb873f&quot;,&quot;relativeTransform&quot;:{&quot;translate&quot;:{&quot;x&quot;:-96.40709522075763,&quot;y&quot;:10.307130725627262},&quot;rotate&quot;:0},&quot;opacity&quot;:1,&quot;path&quot;:{&quot;type&quot;:&quot;ELLIPSE&quot;,&quot;size&quot;:{&quot;x&quot;:-5.2951484890453,&quot;y&quot;:-5.295148489045295}},&quot;isLocked&quot;:false,&quot;pathStyles&quot;:[{&quot;type&quot;:&quot;FILL&quot;,&quot;fillStyle&quot;:&quot;rgb(155, 155, 155)&quot;},{&quot;type&quot;:&quot;STROKE&quot;,&quot;strokeStyle&quot;:&quot;rgba(0,0,0,0)&quot;,&quot;lineWidth&quot;:0.7040902525806721,&quot;lineJoin&quot;:&quot;round&quot;}],&quot;parent&quot;:{&quot;type&quot;:&quot;CHILD&quot;,&quot;parentId&quot;:&quot;484c6def-0fa0-4d6f-b013-059e9647a5f4&quot;,&quot;order&quot;:&quot;5&quot;}},&quot;d83136b2-cbfb-41a8-9e08-02d5eb827ce9&quot;:{&quot;type&quot;:&quot;FIGURE_OBJECT&quot;,&quot;id&quot;:&quot;d83136b2-cbfb-41a8-9e08-02d5eb827ce9&quot;,&quot;relativeTransform&quot;:{&quot;translate&quot;:{&quot;x&quot;:-105.03185651497778,&quot;y&quot;:10.3071140565173},&quot;rotate&quot;:0},&quot;opacity&quot;:1,&quot;path&quot;:{&quot;type&quot;:&quot;ELLIPSE&quot;,&quot;size&quot;:{&quot;x&quot;:-5.2951484890453,&quot;y&quot;:-5.295148489045295}},&quot;isLocked&quot;:false,&quot;pathStyles&quot;:[{&quot;type&quot;:&quot;FILL&quot;,&quot;fillStyle&quot;:&quot;rgb(90, 195, 63)&quot;},{&quot;type&quot;:&quot;STROKE&quot;,&quot;strokeStyle&quot;:&quot;rgba(0,0,0,0)&quot;,&quot;lineWidth&quot;:0.7040902525806721,&quot;lineJoin&quot;:&quot;round&quot;}],&quot;parent&quot;:{&quot;type&quot;:&quot;CHILD&quot;,&quot;parentId&quot;:&quot;484c6def-0fa0-4d6f-b013-059e9647a5f4&quot;,&quot;order&quot;:&quot;7&quot;}},&quot;d0353830-1d02-4f42-8de2-467256c53091&quot;:{&quot;relativeTransform&quot;:{&quot;translate&quot;:{&quot;x&quot;:28.96444741471231,&quot;y&quot;:-159.50618597406404},&quot;rotate&quot;:0,&quot;skewX&quot;:0,&quot;scale&quot;:{&quot;x&quot;:1,&quot;y&quot;:1}},&quot;type&quot;:&quot;FIGURE_OBJECT&quot;,&quot;id&quot;:&quot;d0353830-1d02-4f42-8de2-467256c53091&quot;,&quot;parent&quot;:{&quot;type&quot;:&quot;CHILD&quot;,&quot;parentId&quot;:&quot;ac4bfdb8-c638-4ab9-9da2-3040bcbea76a&quot;,&quot;order&quot;:&quot;9999999995&quot;},&quot;name&quot;:&quot;DNA probe (molecular beacon)&quot;,&quot;displayName&quot;:&quot;DNA probe (molecular beacon)&quot;,&quot;source&quot;:{&quot;id&quot;:&quot;6490d9632d2897db32e02945&quot;,&quot;type&quot;:&quot;ASSETS&quot;},&quot;isPremium&quot;:true},&quot;8d65a2ee-e1bc-45e0-b1bc-19bbffbd7cf1&quot;:{&quot;id&quot;:&quot;8d65a2ee-e1bc-45e0-b1bc-19bbffbd7cf1&quot;,&quot;name&quot;:&quot;RNA (stem loop, small, short)&quot;,&quot;displayName&quot;:&quot;Short stem loop RNA&quot;,&quot;type&quot;:&quot;FIGURE_OBJECT&quot;,&quot;relativeTransform&quot;:{&quot;translate&quot;:{&quot;x&quot;:-100.71946354914112,&quot;y&quot;:-9.955062732296772},&quot;rotate&quot;:1.5707963267948966,&quot;skewX&quot;:0,&quot;scale&quot;:{&quot;x&quot;:0.2851841973648388,&quot;y&quot;:0.2851841973648388}},&quot;image&quot;:{&quot;url&quot;:&quot;https://icons.biorender.com/biorender/5d2f5bce1900ef0400b1d8a2/rna-stem-loop-small-short.png&quot;,&quot;fallbackUrl&quot;:&quot;https://res.cloudinary.com/dlcjuc3ej/image/upload/v1563384776/izjmqkirucjsajhj1qqa.svg#/keystone/api/icons/5d2f5bce1900ef0400b1d8a2/rna-stem-loop-small-short.svg&quot;,&quot;isPremium&quot;:false,&quot;size&quot;:{&quot;x&quot;:126,&quot;y&quot;:75.95744680851064}},&quot;source&quot;:{&quot;id&quot;:&quot;5d2f5b911900ef0400b1d88e&quot;,&quot;type&quot;:&quot;ASSETS&quot;},&quot;isPremium&quot;:false,&quot;parent&quot;:{&quot;type&quot;:&quot;CHILD&quot;,&quot;parentId&quot;:&quot;d0353830-1d02-4f42-8de2-467256c53091&quot;,&quot;order&quot;:&quot;2&quot;}},&quot;5b238766-d401-4e45-bac3-a8f70e4e91c1&quot;:{&quot;type&quot;:&quot;FIGURE_OBJECT&quot;,&quot;id&quot;:&quot;5b238766-d401-4e45-bac3-a8f70e4e91c1&quot;,&quot;relativeTransform&quot;:{&quot;translate&quot;:{&quot;x&quot;:-96.40709522075763,&quot;y&quot;:10.307130725627262},&quot;rotate&quot;:0},&quot;opacity&quot;:1,&quot;path&quot;:{&quot;type&quot;:&quot;ELLIPSE&quot;,&quot;size&quot;:{&quot;x&quot;:-5.2951484890453,&quot;y&quot;:-5.295148489045295}},&quot;isLocked&quot;:false,&quot;pathStyles&quot;:[{&quot;type&quot;:&quot;FILL&quot;,&quot;fillStyle&quot;:&quot;rgb(155, 155, 155)&quot;},{&quot;type&quot;:&quot;STROKE&quot;,&quot;strokeStyle&quot;:&quot;rgba(0,0,0,0)&quot;,&quot;lineWidth&quot;:0.7040902525806721,&quot;lineJoin&quot;:&quot;round&quot;}],&quot;parent&quot;:{&quot;type&quot;:&quot;CHILD&quot;,&quot;parentId&quot;:&quot;d0353830-1d02-4f42-8de2-467256c53091&quot;,&quot;order&quot;:&quot;5&quot;}},&quot;fba5e035-d2b5-4c35-a587-44ebe6b8d3e1&quot;:{&quot;type&quot;:&quot;FIGURE_OBJECT&quot;,&quot;id&quot;:&quot;fba5e035-d2b5-4c35-a587-44ebe6b8d3e1&quot;,&quot;relativeTransform&quot;:{&quot;translate&quot;:{&quot;x&quot;:-105.03185651497778,&quot;y&quot;:10.3071140565173},&quot;rotate&quot;:0},&quot;opacity&quot;:1,&quot;path&quot;:{&quot;type&quot;:&quot;ELLIPSE&quot;,&quot;size&quot;:{&quot;x&quot;:-5.2951484890453,&quot;y&quot;:-5.295148489045295}},&quot;isLocked&quot;:false,&quot;pathStyles&quot;:[{&quot;type&quot;:&quot;FILL&quot;,&quot;fillStyle&quot;:&quot;rgb(90, 195, 63)&quot;},{&quot;type&quot;:&quot;STROKE&quot;,&quot;strokeStyle&quot;:&quot;rgba(0,0,0,0)&quot;,&quot;lineWidth&quot;:0.7040902525806721,&quot;lineJoin&quot;:&quot;round&quot;}],&quot;parent&quot;:{&quot;type&quot;:&quot;CHILD&quot;,&quot;parentId&quot;:&quot;d0353830-1d02-4f42-8de2-467256c53091&quot;,&quot;order&quot;:&quot;7&quot;}},&quot;f0aba57d-f11e-4460-bbab-ec29a81347b0&quot;:{&quot;id&quot;:&quot;f0aba57d-f11e-4460-bbab-ec29a81347b0&quot;,&quot;name&quot;:&quot;Tomato (young plant)&quot;,&quot;displayName&quot;:&quot;&quot;,&quot;type&quot;:&quot;FIGURE_OBJECT&quot;,&quot;relativeTransform&quot;:{&quot;translate&quot;:{&quot;x&quot;:-338.237,&quot;y&quot;:-181.41899999999998},&quot;rotate&quot;:0,&quot;skewX&quot;:0,&quot;scale&quot;:{&quot;x&quot;:1,&quot;y&quot;:1}},&quot;image&quot;:{&quot;url&quot;:&quot;https://icons.biorender.com/biorender/648b3ce6c5ed7f002049b7f7/20230616135452/image/tomato-young-plant-01.png&quot;,&quot;fallbackUrl&quot;:&quot;https://res.cloudinary.com/dlcjuc3ej/image/upload/v1686923692/rkyrynaayxvjxz9ewuuz.svg#/keystone/api/icons/648b3ce6c5ed7f002049b7f7/20230616135452/image/tomato-young-plant-01.svg#/keystone/api/icons/648b3ce6c5ed7f002049b7f7/20230616135452/image/tomato-young-plant-01.svg#/keystone/api/icons/648b3ce6c5ed7f002049b7f7/20230616135452/image/tomato-young-plant-01.svg&quot;,&quot;isPremium&quot;:false,&quot;size&quot;:{&quot;x&quot;:100,&quot;y&quot;:135.71428571428572}},&quot;source&quot;:{&quot;id&quot;:&quot;648b3ce6c5ed7f002049b7f7&quot;,&quot;type&quot;:&quot;ASSETS&quot;},&quot;isPremium&quot;:false,&quot;parent&quot;:{&quot;type&quot;:&quot;CHILD&quot;,&quot;parentId&quot;:&quot;14690bd0-5dfc-4dd7-aa5b-3de6075ae3a9&quot;,&quot;order&quot;:&quot;1&quot;}},&quot;3e087161-99e2-45d0-8f91-088f73c2efcc&quot;:{&quot;id&quot;:&quot;3e087161-99e2-45d0-8f91-088f73c2efcc&quot;,&quot;name&quot;:&quot;Coccus&quot;,&quot;displayName&quot;:&quot;&quot;,&quot;type&quot;:&quot;FIGURE_OBJECT&quot;,&quot;relativeTransform&quot;:{&quot;translate&quot;:{&quot;x&quot;:-322.57,&quot;y&quot;:-234.747},&quot;rotate&quot;:0,&quot;skewX&quot;:0,&quot;scale&quot;:{&quot;x&quot;:0.21500000000000036,&quot;y&quot;:0.21500000000000036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14690bd0-5dfc-4dd7-aa5b-3de6075ae3a9&quot;,&quot;order&quot;:&quot;2&quot;}},&quot;47136ffe-70e1-49d2-b83a-3c09d18f47db&quot;:{&quot;id&quot;:&quot;47136ffe-70e1-49d2-b83a-3c09d18f47db&quot;,&quot;name&quot;:&quot;Coccus&quot;,&quot;displayName&quot;:&quot;&quot;,&quot;type&quot;:&quot;FIGURE_OBJECT&quot;,&quot;relativeTransform&quot;:{&quot;translate&quot;:{&quot;x&quot;:-333.32,&quot;y&quot;:-215.855},&quot;rotate&quot;:0,&quot;skewX&quot;:0,&quot;scale&quot;:{&quot;x&quot;:0.21500000000000036,&quot;y&quot;:0.21500000000000036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14690bd0-5dfc-4dd7-aa5b-3de6075ae3a9&quot;,&quot;order&quot;:&quot;3&quot;}},&quot;5802dd60-0758-4f60-be85-2cc2f8490b31&quot;:{&quot;id&quot;:&quot;5802dd60-0758-4f60-be85-2cc2f8490b31&quot;,&quot;name&quot;:&quot;Coccus&quot;,&quot;displayName&quot;:&quot;&quot;,&quot;type&quot;:&quot;FIGURE_OBJECT&quot;,&quot;relativeTransform&quot;:{&quot;translate&quot;:{&quot;x&quot;:-302.57,&quot;y&quot;:-214.747},&quot;rotate&quot;:0,&quot;skewX&quot;:0,&quot;scale&quot;:{&quot;x&quot;:0.21500000000000036,&quot;y&quot;:0.21500000000000036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14690bd0-5dfc-4dd7-aa5b-3de6075ae3a9&quot;,&quot;order&quot;:&quot;5&quot;}},&quot;ec448b99-95d7-482d-83b4-3635b8e99918&quot;:{&quot;id&quot;:&quot;ec448b99-95d7-482d-83b4-3635b8e99918&quot;,&quot;name&quot;:&quot;Coccus&quot;,&quot;displayName&quot;:&quot;&quot;,&quot;type&quot;:&quot;FIGURE_OBJECT&quot;,&quot;relativeTransform&quot;:{&quot;translate&quot;:{&quot;x&quot;:-336.534,&quot;y&quot;:-193.194},&quot;rotate&quot;:0,&quot;skewX&quot;:0,&quot;scale&quot;:{&quot;x&quot;:0.21500000000000036,&quot;y&quot;:0.21500000000000036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14690bd0-5dfc-4dd7-aa5b-3de6075ae3a9&quot;,&quot;order&quot;:&quot;6&quot;}},&quot;d786f456-fe1d-404a-9728-4eb874fef501&quot;:{&quot;id&quot;:&quot;d786f456-fe1d-404a-9728-4eb874fef501&quot;,&quot;name&quot;:&quot;Coccus&quot;,&quot;displayName&quot;:&quot;&quot;,&quot;type&quot;:&quot;FIGURE_OBJECT&quot;,&quot;relativeTransform&quot;:{&quot;translate&quot;:{&quot;x&quot;:-359.57,&quot;y&quot;:-206.09},&quot;rotate&quot;:0,&quot;skewX&quot;:0,&quot;scale&quot;:{&quot;x&quot;:0.21500000000000036,&quot;y&quot;:0.21500000000000036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14690bd0-5dfc-4dd7-aa5b-3de6075ae3a9&quot;,&quot;order&quot;:&quot;7&quot;}},&quot;87fcf6a1-8e3e-424b-a5f6-af73a1e01cea&quot;:{&quot;id&quot;:&quot;87fcf6a1-8e3e-424b-a5f6-af73a1e01cea&quot;,&quot;name&quot;:&quot;Coccus&quot;,&quot;displayName&quot;:&quot;&quot;,&quot;type&quot;:&quot;FIGURE_OBJECT&quot;,&quot;relativeTransform&quot;:{&quot;translate&quot;:{&quot;x&quot;:-313.32,&quot;y&quot;:-172.758},&quot;rotate&quot;:0,&quot;skewX&quot;:0,&quot;scale&quot;:{&quot;x&quot;:0.21500000000000036,&quot;y&quot;:0.21500000000000036}},&quot;image&quot;:{&quot;url&quot;:&quot;https://icons.biorender.com/biorender/5b072120bd399f0014847df8/coccus.png&quot;,&quot;fallbackUrl&quot;:&quot;https://res.cloudinary.com/dlcjuc3ej/image/upload/v1527193882/b5dff8qdjk09v6hn3vgi.svg#/keystone/api/icons/5b072120bd399f0014847df8/coccus.svg#/keystone/api/icons/5b072120bd399f0014847df8/coccus.svg&quot;,&quot;isPremium&quot;:false,&quot;size&quot;:{&quot;x&quot;:50,&quot;y&quot;:50}},&quot;source&quot;:{&quot;id&quot;:&quot;5a5d13e34c65870014a0314e&quot;,&quot;type&quot;:&quot;ASSETS&quot;},&quot;isPremium&quot;:false,&quot;parent&quot;:{&quot;type&quot;:&quot;CHILD&quot;,&quot;parentId&quot;:&quot;14690bd0-5dfc-4dd7-aa5b-3de6075ae3a9&quot;,&quot;order&quot;:&quot;8&quot;}},&quot;14690bd0-5dfc-4dd7-aa5b-3de6075ae3a9&quot;:{&quot;type&quot;:&quot;FIGURE_OBJECT&quot;,&quot;id&quot;:&quot;14690bd0-5dfc-4dd7-aa5b-3de6075ae3a9&quot;,&quot;parent&quot;:{&quot;type&quot;:&quot;CHILD&quot;,&quot;parentId&quot;:&quot;ac4bfdb8-c638-4ab9-9da2-3040bcbea76a&quot;,&quot;order&quot;:&quot;99999999999&quot;},&quot;relativeTransform&quot;:{&quot;translate&quot;:{&quot;x&quot;:0,&quot;y&quot;:-17.5},&quot;rotate&quot;:0,&quot;skewX&quot;:0,&quot;scale&quot;:{&quot;x&quot;:1,&quot;y&quot;:1}}},&quot;26df5c93-17ac-4532-ac4e-b46d4505ca81&quot;:{&quot;id&quot;:&quot;26df5c93-17ac-4532-ac4e-b46d4505ca81&quot;,&quot;name&quot;:&quot;Tomato (young plant)&quot;,&quot;displayName&quot;:&quot;&quot;,&quot;type&quot;:&quot;FIGURE_OBJECT&quot;,&quot;relativeTransform&quot;:{&quot;translate&quot;:{&quot;x&quot;:-338.083,&quot;y&quot;:157.94},&quot;rotate&quot;:0,&quot;skewX&quot;:0,&quot;scale&quot;:{&quot;x&quot;:1,&quot;y&quot;:1}},&quot;image&quot;:{&quot;url&quot;:&quot;https://icons.biorender.com/biorender/648b3ce6c5ed7f002049b7f7/20230616135452/image/tomato-young-plant-01.png&quot;,&quot;fallbackUrl&quot;:&quot;https://res.cloudinary.com/dlcjuc3ej/image/upload/v1686923692/rkyrynaayxvjxz9ewuuz.svg#/keystone/api/icons/648b3ce6c5ed7f002049b7f7/20230616135452/image/tomato-young-plant-01.svg#/keystone/api/icons/648b3ce6c5ed7f002049b7f7/20230616135452/image/tomato-young-plant-01.svg#/keystone/api/icons/648b3ce6c5ed7f002049b7f7/20230616135452/image/tomato-young-plant-01.svg&quot;,&quot;isPremium&quot;:false,&quot;size&quot;:{&quot;x&quot;:100,&quot;y&quot;:135.71428571428572}},&quot;source&quot;:{&quot;id&quot;:&quot;648b3ce6c5ed7f002049b7f7&quot;,&quot;type&quot;:&quot;ASSETS&quot;},&quot;isPremium&quot;:false,&quot;parent&quot;:{&quot;type&quot;:&quot;CHILD&quot;,&quot;parentId&quot;:&quot;ac4bfdb8-c638-4ab9-9da2-3040bcbea76a&quot;,&quot;order&quot;:&quot;999999999995&quot;}},&quot;65d1af2e-a598-4034-87eb-8022291a2ae0&quot;:{&quot;id&quot;:&quot;65d1af2e-a598-4034-87eb-8022291a2ae0&quot;,&quot;name&quot;:&quot;Marine research vessel&quot;,&quot;displayName&quot;:&quot;&quot;,&quot;type&quot;:&quot;FIGURE_OBJECT&quot;,&quot;relativeTransform&quot;:{&quot;translate&quot;:{&quot;x&quot;:-331.729,&quot;y&quot;:-28.24000000000001},&quot;rotate&quot;:0,&quot;skewX&quot;:0,&quot;scale&quot;:{&quot;x&quot;:0.348,&quot;y&quot;:0.348}},&quot;image&quot;:{&quot;url&quot;:&quot;https://icons.biorender.com/biorender/620fd2df63f7700029ea3da8/20220218171510/image/marine-research-vessel.png&quot;,&quot;fallbackUrl&quot;:&quot;https://res.cloudinary.com/dlcjuc3ej/image/upload/v1645204510/wvvti49gj842ybpyljhe.svg#/keystone/api/icons/620fd2df63f7700029ea3da8/20220218171510/image/marine-research-vessel.svg&quot;,&quot;isPremium&quot;:false,&quot;size&quot;:{&quot;x&quot;:500,&quot;y&quot;:185}},&quot;source&quot;:{&quot;id&quot;:&quot;620fd2df63f7700029ea3da8&quot;,&quot;type&quot;:&quot;ASSETS&quot;},&quot;isPremium&quot;:false,&quot;parent&quot;:{&quot;type&quot;:&quot;CHILD&quot;,&quot;parentId&quot;:&quot;ac4bfdb8-c638-4ab9-9da2-3040bcbea76a&quot;,&quot;order&quot;:&quot;999999999997&quot;}}}}"/>
    <we:property name="has-seen-first-time-experience" value="true"/>
    <we:property name="has-user-completed-add" value="true"/>
    <we:property name="pptx_export_from_biorender" value="false"/>
  </we:properties>
  <we:bindings/>
  <we:snapshot xmlns:r="http://schemas.openxmlformats.org/officeDocument/2006/relationships"/>
  <we:extLst>
    <a:ext xmlns:a="http://schemas.openxmlformats.org/drawingml/2006/main" uri="{0858819E-0033-43BF-8937-05EC82904868}">
      <we:backgroundApp state="1" runtimeId="Taskpane.Url"/>
    </a:ext>
  </we:extLst>
</we:webextension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1583E8DD7E2AC4BB10D50E0635BAA18" ma:contentTypeVersion="10" ma:contentTypeDescription="Create a new document." ma:contentTypeScope="" ma:versionID="7704742c0581916a523e455e02e066f4">
  <xsd:schema xmlns:xsd="http://www.w3.org/2001/XMLSchema" xmlns:xs="http://www.w3.org/2001/XMLSchema" xmlns:p="http://schemas.microsoft.com/office/2006/metadata/properties" xmlns:ns3="1c632ae3-5977-4571-a758-36ab4d054882" xmlns:ns4="c6dbf757-b5fd-4e92-992c-85dd03cde89a" targetNamespace="http://schemas.microsoft.com/office/2006/metadata/properties" ma:root="true" ma:fieldsID="4297007c9121ad1b5d893e8d3735bb41" ns3:_="" ns4:_="">
    <xsd:import namespace="1c632ae3-5977-4571-a758-36ab4d054882"/>
    <xsd:import namespace="c6dbf757-b5fd-4e92-992c-85dd03cde89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SearchProperties" minOccurs="0"/>
                <xsd:element ref="ns3:MediaServiceObjectDetectorVersions" minOccurs="0"/>
                <xsd:element ref="ns3:_activity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c632ae3-5977-4571-a758-36ab4d05488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SearchProperties" ma:index="12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4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6dbf757-b5fd-4e92-992c-85dd03cde89a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7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c632ae3-5977-4571-a758-36ab4d054882" xsi:nil="true"/>
  </documentManagement>
</p:properties>
</file>

<file path=customXml/itemProps1.xml><?xml version="1.0" encoding="utf-8"?>
<ds:datastoreItem xmlns:ds="http://schemas.openxmlformats.org/officeDocument/2006/customXml" ds:itemID="{9CF4372D-2E2A-4828-A2F3-C3A38F3DC207}">
  <ds:schemaRefs>
    <ds:schemaRef ds:uri="1c632ae3-5977-4571-a758-36ab4d054882"/>
    <ds:schemaRef ds:uri="c6dbf757-b5fd-4e92-992c-85dd03cde89a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33561477-A3F3-4D73-ADB9-8D81087DDC8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07C937C-A75E-4189-8DEA-37F95D434B3D}">
  <ds:schemaRefs>
    <ds:schemaRef ds:uri="http://purl.org/dc/terms/"/>
    <ds:schemaRef ds:uri="http://schemas.microsoft.com/office/2006/documentManagement/types"/>
    <ds:schemaRef ds:uri="http://purl.org/dc/elements/1.1/"/>
    <ds:schemaRef ds:uri="http://purl.org/dc/dcmitype/"/>
    <ds:schemaRef ds:uri="http://www.w3.org/XML/1998/namespace"/>
    <ds:schemaRef ds:uri="c6dbf757-b5fd-4e92-992c-85dd03cde89a"/>
    <ds:schemaRef ds:uri="http://schemas.openxmlformats.org/package/2006/metadata/core-properties"/>
    <ds:schemaRef ds:uri="http://schemas.microsoft.com/office/infopath/2007/PartnerControls"/>
    <ds:schemaRef ds:uri="1c632ae3-5977-4571-a758-36ab4d054882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10</TotalTime>
  <Words>259</Words>
  <Application>Microsoft Macintosh PowerPoint</Application>
  <PresentationFormat>On-screen Show (4:3)</PresentationFormat>
  <Paragraphs>15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rial</vt:lpstr>
      <vt:lpstr>Calibri</vt:lpstr>
      <vt:lpstr>Calibri Light</vt:lpstr>
      <vt:lpstr>Office Theme</vt:lpstr>
      <vt:lpstr>Supp. Fig 1. Phylogenetic tree of phytoplasma samples ordered from International Phytoplasma Working Group (IPWG; Bologna, Italy). Alignment is based on 16S gene sequence pulled from NCBI-BLAST, with no outgroup. 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 Ryan Lagner</dc:creator>
  <cp:lastModifiedBy>Joseph Lagner </cp:lastModifiedBy>
  <cp:revision>27</cp:revision>
  <dcterms:created xsi:type="dcterms:W3CDTF">2023-11-06T19:06:13Z</dcterms:created>
  <dcterms:modified xsi:type="dcterms:W3CDTF">2024-10-30T03:36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1583E8DD7E2AC4BB10D50E0635BAA18</vt:lpwstr>
  </property>
</Properties>
</file>